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8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9.xml" ContentType="application/vnd.openxmlformats-officedocument.themeOverr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10.xml" ContentType="application/vnd.openxmlformats-officedocument.themeOverrid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theme/themeOverride11.xml" ContentType="application/vnd.openxmlformats-officedocument.themeOverr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theme/themeOverride12.xml" ContentType="application/vnd.openxmlformats-officedocument.themeOverrid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theme/themeOverride13.xml" ContentType="application/vnd.openxmlformats-officedocument.themeOverr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theme/themeOverride14.xml" ContentType="application/vnd.openxmlformats-officedocument.themeOverrid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theme/themeOverride15.xml" ContentType="application/vnd.openxmlformats-officedocument.themeOverrid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theme/themeOverride16.xml" ContentType="application/vnd.openxmlformats-officedocument.themeOverrid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theme/themeOverride17.xml" ContentType="application/vnd.openxmlformats-officedocument.themeOverrid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theme/themeOverride18.xml" ContentType="application/vnd.openxmlformats-officedocument.themeOverrid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theme/themeOverride19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72" r:id="rId1"/>
  </p:sldMasterIdLst>
  <p:notesMasterIdLst>
    <p:notesMasterId r:id="rId11"/>
  </p:notesMasterIdLst>
  <p:sldIdLst>
    <p:sldId id="287" r:id="rId2"/>
    <p:sldId id="288" r:id="rId3"/>
    <p:sldId id="289" r:id="rId4"/>
    <p:sldId id="290" r:id="rId5"/>
    <p:sldId id="283" r:id="rId6"/>
    <p:sldId id="291" r:id="rId7"/>
    <p:sldId id="285" r:id="rId8"/>
    <p:sldId id="292" r:id="rId9"/>
    <p:sldId id="286" r:id="rId10"/>
  </p:sldIdLst>
  <p:sldSz cx="10080625" cy="1187926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781" autoAdjust="0"/>
    <p:restoredTop sz="94660"/>
  </p:normalViewPr>
  <p:slideViewPr>
    <p:cSldViewPr snapToGrid="0">
      <p:cViewPr varScale="1">
        <p:scale>
          <a:sx n="64" d="100"/>
          <a:sy n="64" d="100"/>
        </p:scale>
        <p:origin x="58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0.xm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1.xm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2.xm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3.xml"/><Relationship Id="rId2" Type="http://schemas.microsoft.com/office/2011/relationships/chartColorStyle" Target="colors13.xml"/><Relationship Id="rId1" Type="http://schemas.microsoft.com/office/2011/relationships/chartStyle" Target="style13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4.xml"/><Relationship Id="rId2" Type="http://schemas.microsoft.com/office/2011/relationships/chartColorStyle" Target="colors14.xml"/><Relationship Id="rId1" Type="http://schemas.microsoft.com/office/2011/relationships/chartStyle" Target="style14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5.xml"/><Relationship Id="rId2" Type="http://schemas.microsoft.com/office/2011/relationships/chartColorStyle" Target="colors15.xml"/><Relationship Id="rId1" Type="http://schemas.microsoft.com/office/2011/relationships/chartStyle" Target="style15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6.xml"/><Relationship Id="rId2" Type="http://schemas.microsoft.com/office/2011/relationships/chartColorStyle" Target="colors16.xml"/><Relationship Id="rId1" Type="http://schemas.microsoft.com/office/2011/relationships/chartStyle" Target="style16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7.xml"/><Relationship Id="rId2" Type="http://schemas.microsoft.com/office/2011/relationships/chartColorStyle" Target="colors17.xml"/><Relationship Id="rId1" Type="http://schemas.microsoft.com/office/2011/relationships/chartStyle" Target="style17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8.xml"/><Relationship Id="rId2" Type="http://schemas.microsoft.com/office/2011/relationships/chartColorStyle" Target="colors18.xml"/><Relationship Id="rId1" Type="http://schemas.microsoft.com/office/2011/relationships/chartStyle" Target="style18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9.xml"/><Relationship Id="rId2" Type="http://schemas.microsoft.com/office/2011/relationships/chartColorStyle" Target="colors19.xml"/><Relationship Id="rId1" Type="http://schemas.microsoft.com/office/2011/relationships/chartStyle" Target="style19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9.xm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oleObject" Target="file:///C:\Users\owner\Desktop\RNA%20CALC%20MUSCLE1%20(Autosaved)%20&#1502;&#1504;&#1493;&#1512;&#1502;&#1500;%20&#1500;1%20(1)%20CHOW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liver per1 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per1 '!$AF$34:$AL$34</c:f>
                <c:numCache>
                  <c:formatCode>General</c:formatCode>
                  <c:ptCount val="7"/>
                  <c:pt idx="0">
                    <c:v>0.39972196323441433</c:v>
                  </c:pt>
                  <c:pt idx="1">
                    <c:v>0.14504842093422535</c:v>
                  </c:pt>
                  <c:pt idx="2">
                    <c:v>0.2122882251857795</c:v>
                  </c:pt>
                  <c:pt idx="3">
                    <c:v>7.1725228515204367E-2</c:v>
                  </c:pt>
                  <c:pt idx="4">
                    <c:v>0.10147163461014312</c:v>
                  </c:pt>
                  <c:pt idx="5">
                    <c:v>0.17776806781734761</c:v>
                  </c:pt>
                  <c:pt idx="6">
                    <c:v>0.39972196323441433</c:v>
                  </c:pt>
                </c:numCache>
              </c:numRef>
            </c:plus>
            <c:minus>
              <c:numRef>
                <c:f>'liver per1 '!$AF$34:$AL$34</c:f>
                <c:numCache>
                  <c:formatCode>General</c:formatCode>
                  <c:ptCount val="7"/>
                  <c:pt idx="0">
                    <c:v>0.39972196323441433</c:v>
                  </c:pt>
                  <c:pt idx="1">
                    <c:v>0.14504842093422535</c:v>
                  </c:pt>
                  <c:pt idx="2">
                    <c:v>0.2122882251857795</c:v>
                  </c:pt>
                  <c:pt idx="3">
                    <c:v>7.1725228515204367E-2</c:v>
                  </c:pt>
                  <c:pt idx="4">
                    <c:v>0.10147163461014312</c:v>
                  </c:pt>
                  <c:pt idx="5">
                    <c:v>0.17776806781734761</c:v>
                  </c:pt>
                  <c:pt idx="6">
                    <c:v>0.399721963234414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per1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per1 '!$K$40:$Q$40</c:f>
              <c:numCache>
                <c:formatCode>0.00</c:formatCode>
                <c:ptCount val="7"/>
                <c:pt idx="0">
                  <c:v>2.070543824123845</c:v>
                </c:pt>
                <c:pt idx="1">
                  <c:v>1.0588976479023109</c:v>
                </c:pt>
                <c:pt idx="2">
                  <c:v>1.4440528512260411</c:v>
                </c:pt>
                <c:pt idx="3">
                  <c:v>1</c:v>
                </c:pt>
                <c:pt idx="4">
                  <c:v>1.1044724661983769</c:v>
                </c:pt>
                <c:pt idx="5">
                  <c:v>1.8556578345063401</c:v>
                </c:pt>
                <c:pt idx="6">
                  <c:v>2.07054382412384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C0D-48C2-91A1-F11764A90536}"/>
            </c:ext>
          </c:extLst>
        </c:ser>
        <c:ser>
          <c:idx val="2"/>
          <c:order val="1"/>
          <c:tx>
            <c:strRef>
              <c:f>'liver per1 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per1 '!$Y$34:$AE$34</c:f>
                <c:numCache>
                  <c:formatCode>General</c:formatCode>
                  <c:ptCount val="7"/>
                  <c:pt idx="0">
                    <c:v>0.14514794933849851</c:v>
                  </c:pt>
                  <c:pt idx="1">
                    <c:v>8.7608451994376335E-2</c:v>
                  </c:pt>
                  <c:pt idx="2">
                    <c:v>0.14946544115179775</c:v>
                  </c:pt>
                  <c:pt idx="3">
                    <c:v>0.19665502732680293</c:v>
                  </c:pt>
                  <c:pt idx="4">
                    <c:v>5.5950666233831763E-2</c:v>
                  </c:pt>
                  <c:pt idx="5">
                    <c:v>0.31958618335889005</c:v>
                  </c:pt>
                  <c:pt idx="6">
                    <c:v>0.14514794933849851</c:v>
                  </c:pt>
                </c:numCache>
              </c:numRef>
            </c:plus>
            <c:minus>
              <c:numRef>
                <c:f>'liver per1 '!$Y$34:$AE$34</c:f>
                <c:numCache>
                  <c:formatCode>General</c:formatCode>
                  <c:ptCount val="7"/>
                  <c:pt idx="0">
                    <c:v>0.14514794933849851</c:v>
                  </c:pt>
                  <c:pt idx="1">
                    <c:v>8.7608451994376335E-2</c:v>
                  </c:pt>
                  <c:pt idx="2">
                    <c:v>0.14946544115179775</c:v>
                  </c:pt>
                  <c:pt idx="3">
                    <c:v>0.19665502732680293</c:v>
                  </c:pt>
                  <c:pt idx="4">
                    <c:v>5.5950666233831763E-2</c:v>
                  </c:pt>
                  <c:pt idx="5">
                    <c:v>0.31958618335889005</c:v>
                  </c:pt>
                  <c:pt idx="6">
                    <c:v>0.145147949338498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per1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per1 '!$K$39:$Q$39</c:f>
              <c:numCache>
                <c:formatCode>0.00</c:formatCode>
                <c:ptCount val="7"/>
                <c:pt idx="0">
                  <c:v>2.2043782509337051</c:v>
                </c:pt>
                <c:pt idx="1">
                  <c:v>1.2363170978722557</c:v>
                </c:pt>
                <c:pt idx="2">
                  <c:v>2.569140924608627</c:v>
                </c:pt>
                <c:pt idx="3">
                  <c:v>1</c:v>
                </c:pt>
                <c:pt idx="4">
                  <c:v>1.1398642307447193</c:v>
                </c:pt>
                <c:pt idx="5">
                  <c:v>1.8916521385533036</c:v>
                </c:pt>
                <c:pt idx="6">
                  <c:v>2.204378250933705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C0D-48C2-91A1-F11764A90536}"/>
            </c:ext>
          </c:extLst>
        </c:ser>
        <c:ser>
          <c:idx val="1"/>
          <c:order val="2"/>
          <c:tx>
            <c:strRef>
              <c:f>'liver per1 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per1 '!$R$34:$X$34</c:f>
                <c:numCache>
                  <c:formatCode>General</c:formatCode>
                  <c:ptCount val="7"/>
                  <c:pt idx="0">
                    <c:v>3.705279528004992E-2</c:v>
                  </c:pt>
                  <c:pt idx="1">
                    <c:v>4.5950372798941735E-2</c:v>
                  </c:pt>
                  <c:pt idx="2">
                    <c:v>9.0489423541578795E-2</c:v>
                  </c:pt>
                  <c:pt idx="3">
                    <c:v>0.19310726642761381</c:v>
                  </c:pt>
                  <c:pt idx="4">
                    <c:v>0.38737998400901569</c:v>
                  </c:pt>
                  <c:pt idx="5">
                    <c:v>0.3198386666923973</c:v>
                  </c:pt>
                  <c:pt idx="6">
                    <c:v>3.705279528004992E-2</c:v>
                  </c:pt>
                </c:numCache>
              </c:numRef>
            </c:plus>
            <c:minus>
              <c:numRef>
                <c:f>'liver per1 '!$R$34:$X$34</c:f>
                <c:numCache>
                  <c:formatCode>General</c:formatCode>
                  <c:ptCount val="7"/>
                  <c:pt idx="0">
                    <c:v>3.705279528004992E-2</c:v>
                  </c:pt>
                  <c:pt idx="1">
                    <c:v>4.5950372798941735E-2</c:v>
                  </c:pt>
                  <c:pt idx="2">
                    <c:v>9.0489423541578795E-2</c:v>
                  </c:pt>
                  <c:pt idx="3">
                    <c:v>0.19310726642761381</c:v>
                  </c:pt>
                  <c:pt idx="4">
                    <c:v>0.38737998400901569</c:v>
                  </c:pt>
                  <c:pt idx="5">
                    <c:v>0.3198386666923973</c:v>
                  </c:pt>
                  <c:pt idx="6">
                    <c:v>3.70527952800499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per1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per1 '!$K$38:$Q$38</c:f>
              <c:numCache>
                <c:formatCode>0.00</c:formatCode>
                <c:ptCount val="7"/>
                <c:pt idx="0">
                  <c:v>1</c:v>
                </c:pt>
                <c:pt idx="1">
                  <c:v>1.2369231932317011</c:v>
                </c:pt>
                <c:pt idx="2">
                  <c:v>1.2018966946599663</c:v>
                </c:pt>
                <c:pt idx="3">
                  <c:v>1.1590277926943977</c:v>
                </c:pt>
                <c:pt idx="4">
                  <c:v>2.0823930461817977</c:v>
                </c:pt>
                <c:pt idx="5">
                  <c:v>1.5753498054652519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4C0D-48C2-91A1-F11764A90536}"/>
            </c:ext>
          </c:extLst>
        </c:ser>
        <c:ser>
          <c:idx val="0"/>
          <c:order val="3"/>
          <c:tx>
            <c:strRef>
              <c:f>'liver per1 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per1 '!$K$34:$Q$34</c:f>
                <c:numCache>
                  <c:formatCode>General</c:formatCode>
                  <c:ptCount val="7"/>
                  <c:pt idx="0">
                    <c:v>0.10664822137519238</c:v>
                  </c:pt>
                  <c:pt idx="1">
                    <c:v>0.18095956437366956</c:v>
                  </c:pt>
                  <c:pt idx="2">
                    <c:v>0.10330604216960947</c:v>
                  </c:pt>
                  <c:pt idx="3">
                    <c:v>3.4368959255961361E-2</c:v>
                  </c:pt>
                  <c:pt idx="4">
                    <c:v>0.19852726809494856</c:v>
                  </c:pt>
                  <c:pt idx="5">
                    <c:v>8.0081140247189209E-2</c:v>
                  </c:pt>
                  <c:pt idx="6">
                    <c:v>0.10664822137519238</c:v>
                  </c:pt>
                </c:numCache>
              </c:numRef>
            </c:plus>
            <c:minus>
              <c:numRef>
                <c:f>'liver per1 '!$K$34:$Q$34</c:f>
                <c:numCache>
                  <c:formatCode>General</c:formatCode>
                  <c:ptCount val="7"/>
                  <c:pt idx="0">
                    <c:v>0.10664822137519238</c:v>
                  </c:pt>
                  <c:pt idx="1">
                    <c:v>0.18095956437366956</c:v>
                  </c:pt>
                  <c:pt idx="2">
                    <c:v>0.10330604216960947</c:v>
                  </c:pt>
                  <c:pt idx="3">
                    <c:v>3.4368959255961361E-2</c:v>
                  </c:pt>
                  <c:pt idx="4">
                    <c:v>0.19852726809494856</c:v>
                  </c:pt>
                  <c:pt idx="5">
                    <c:v>8.0081140247189209E-2</c:v>
                  </c:pt>
                  <c:pt idx="6">
                    <c:v>0.106648221375192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per1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per1 '!$K$37:$Q$37</c:f>
              <c:numCache>
                <c:formatCode>0.00</c:formatCode>
                <c:ptCount val="7"/>
                <c:pt idx="0">
                  <c:v>1</c:v>
                </c:pt>
                <c:pt idx="1">
                  <c:v>1.9861125721056221</c:v>
                </c:pt>
                <c:pt idx="2">
                  <c:v>2.9345584509385376</c:v>
                </c:pt>
                <c:pt idx="3">
                  <c:v>1.6806886879176439</c:v>
                </c:pt>
                <c:pt idx="4">
                  <c:v>1.3226416057570991</c:v>
                </c:pt>
                <c:pt idx="5">
                  <c:v>2.014214771716043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4C0D-48C2-91A1-F11764A905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.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muscle cry1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cry1'!$AG$34:$AL$34</c:f>
                <c:numCache>
                  <c:formatCode>General</c:formatCode>
                  <c:ptCount val="6"/>
                  <c:pt idx="0">
                    <c:v>0.15878243225798841</c:v>
                  </c:pt>
                  <c:pt idx="1">
                    <c:v>5.905097024936859E-2</c:v>
                  </c:pt>
                  <c:pt idx="2">
                    <c:v>0.10472888130793123</c:v>
                  </c:pt>
                  <c:pt idx="3">
                    <c:v>8.7605384620064161E-2</c:v>
                  </c:pt>
                  <c:pt idx="4">
                    <c:v>8.7829536720952839E-2</c:v>
                  </c:pt>
                  <c:pt idx="5">
                    <c:v>7.7218906983167968E-2</c:v>
                  </c:pt>
                </c:numCache>
              </c:numRef>
            </c:plus>
            <c:minus>
              <c:numRef>
                <c:f>'muscle cry1'!$AG$34:$AL$34</c:f>
                <c:numCache>
                  <c:formatCode>General</c:formatCode>
                  <c:ptCount val="6"/>
                  <c:pt idx="0">
                    <c:v>0.15878243225798841</c:v>
                  </c:pt>
                  <c:pt idx="1">
                    <c:v>5.905097024936859E-2</c:v>
                  </c:pt>
                  <c:pt idx="2">
                    <c:v>0.10472888130793123</c:v>
                  </c:pt>
                  <c:pt idx="3">
                    <c:v>8.7605384620064161E-2</c:v>
                  </c:pt>
                  <c:pt idx="4">
                    <c:v>8.7829536720952839E-2</c:v>
                  </c:pt>
                  <c:pt idx="5">
                    <c:v>7.721890698316796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cry1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cry1'!$K$40:$Q$40</c:f>
              <c:numCache>
                <c:formatCode>0.00</c:formatCode>
                <c:ptCount val="7"/>
                <c:pt idx="0">
                  <c:v>1.5642784228936191</c:v>
                </c:pt>
                <c:pt idx="1">
                  <c:v>2.4104714764623107</c:v>
                </c:pt>
                <c:pt idx="2">
                  <c:v>1</c:v>
                </c:pt>
                <c:pt idx="3">
                  <c:v>2.1099641326108949</c:v>
                </c:pt>
                <c:pt idx="4">
                  <c:v>1.5961562807973944</c:v>
                </c:pt>
                <c:pt idx="5">
                  <c:v>1.8152162767838573</c:v>
                </c:pt>
                <c:pt idx="6">
                  <c:v>1.564278422893619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6B5-4DAE-B902-585C48A21956}"/>
            </c:ext>
          </c:extLst>
        </c:ser>
        <c:ser>
          <c:idx val="2"/>
          <c:order val="1"/>
          <c:tx>
            <c:strRef>
              <c:f>'muscle cry1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cry1'!$Z$34:$AE$34</c:f>
                <c:numCache>
                  <c:formatCode>General</c:formatCode>
                  <c:ptCount val="6"/>
                  <c:pt idx="0">
                    <c:v>6.6820232885134098E-2</c:v>
                  </c:pt>
                  <c:pt idx="1">
                    <c:v>5.8353517543129479E-2</c:v>
                  </c:pt>
                  <c:pt idx="2">
                    <c:v>9.2405461977370054E-2</c:v>
                  </c:pt>
                  <c:pt idx="3">
                    <c:v>7.3881201808248462E-2</c:v>
                  </c:pt>
                  <c:pt idx="4">
                    <c:v>0.15289978138025803</c:v>
                  </c:pt>
                  <c:pt idx="5">
                    <c:v>5.5617148765743252E-2</c:v>
                  </c:pt>
                </c:numCache>
              </c:numRef>
            </c:plus>
            <c:minus>
              <c:numRef>
                <c:f>'muscle cry1'!$Z$34:$AE$34</c:f>
                <c:numCache>
                  <c:formatCode>General</c:formatCode>
                  <c:ptCount val="6"/>
                  <c:pt idx="0">
                    <c:v>6.6820232885134098E-2</c:v>
                  </c:pt>
                  <c:pt idx="1">
                    <c:v>5.8353517543129479E-2</c:v>
                  </c:pt>
                  <c:pt idx="2">
                    <c:v>9.2405461977370054E-2</c:v>
                  </c:pt>
                  <c:pt idx="3">
                    <c:v>7.3881201808248462E-2</c:v>
                  </c:pt>
                  <c:pt idx="4">
                    <c:v>0.15289978138025803</c:v>
                  </c:pt>
                  <c:pt idx="5">
                    <c:v>5.561714876574325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cry1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cry1'!$K$39:$Q$39</c:f>
              <c:numCache>
                <c:formatCode>0.00</c:formatCode>
                <c:ptCount val="7"/>
                <c:pt idx="0">
                  <c:v>1.2741490774101922</c:v>
                </c:pt>
                <c:pt idx="1">
                  <c:v>1.2251499493854532</c:v>
                </c:pt>
                <c:pt idx="2">
                  <c:v>1</c:v>
                </c:pt>
                <c:pt idx="3">
                  <c:v>1.3854480699542078</c:v>
                </c:pt>
                <c:pt idx="4">
                  <c:v>2.7821976624345988</c:v>
                </c:pt>
                <c:pt idx="5">
                  <c:v>1.7380564367095004</c:v>
                </c:pt>
                <c:pt idx="6">
                  <c:v>1.274149077410192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6B5-4DAE-B902-585C48A21956}"/>
            </c:ext>
          </c:extLst>
        </c:ser>
        <c:ser>
          <c:idx val="1"/>
          <c:order val="2"/>
          <c:tx>
            <c:strRef>
              <c:f>'muscle cry1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cry1'!$S$34:$X$34</c:f>
                <c:numCache>
                  <c:formatCode>General</c:formatCode>
                  <c:ptCount val="6"/>
                  <c:pt idx="0">
                    <c:v>0.31596569989220685</c:v>
                  </c:pt>
                  <c:pt idx="1">
                    <c:v>0.22778096095338962</c:v>
                  </c:pt>
                  <c:pt idx="2">
                    <c:v>0.13554778369998802</c:v>
                  </c:pt>
                  <c:pt idx="3">
                    <c:v>8.47431546142529E-2</c:v>
                  </c:pt>
                  <c:pt idx="4">
                    <c:v>0.19004081956048638</c:v>
                  </c:pt>
                  <c:pt idx="5">
                    <c:v>0.32311147628989462</c:v>
                  </c:pt>
                </c:numCache>
              </c:numRef>
            </c:plus>
            <c:minus>
              <c:numRef>
                <c:f>'muscle cry1'!$S$34:$X$34</c:f>
                <c:numCache>
                  <c:formatCode>General</c:formatCode>
                  <c:ptCount val="6"/>
                  <c:pt idx="0">
                    <c:v>0.31596569989220685</c:v>
                  </c:pt>
                  <c:pt idx="1">
                    <c:v>0.22778096095338962</c:v>
                  </c:pt>
                  <c:pt idx="2">
                    <c:v>0.13554778369998802</c:v>
                  </c:pt>
                  <c:pt idx="3">
                    <c:v>8.47431546142529E-2</c:v>
                  </c:pt>
                  <c:pt idx="4">
                    <c:v>0.19004081956048638</c:v>
                  </c:pt>
                  <c:pt idx="5">
                    <c:v>0.323111476289894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cry1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cry1'!$K$38:$Q$38</c:f>
              <c:numCache>
                <c:formatCode>0.00</c:formatCode>
                <c:ptCount val="7"/>
                <c:pt idx="0">
                  <c:v>1.5860652562068116</c:v>
                </c:pt>
                <c:pt idx="1">
                  <c:v>3.522158911100675</c:v>
                </c:pt>
                <c:pt idx="2">
                  <c:v>1.4303608976691407</c:v>
                </c:pt>
                <c:pt idx="3">
                  <c:v>1</c:v>
                </c:pt>
                <c:pt idx="4">
                  <c:v>1.0237454011133003</c:v>
                </c:pt>
                <c:pt idx="5">
                  <c:v>1.865613529338862</c:v>
                </c:pt>
                <c:pt idx="6">
                  <c:v>1.586065256206811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06B5-4DAE-B902-585C48A21956}"/>
            </c:ext>
          </c:extLst>
        </c:ser>
        <c:ser>
          <c:idx val="0"/>
          <c:order val="3"/>
          <c:tx>
            <c:strRef>
              <c:f>'muscle cry1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cry1'!$L$34:$Q$34</c:f>
                <c:numCache>
                  <c:formatCode>General</c:formatCode>
                  <c:ptCount val="6"/>
                  <c:pt idx="0">
                    <c:v>7.378629969523276E-2</c:v>
                  </c:pt>
                  <c:pt idx="1">
                    <c:v>0.12054685045307557</c:v>
                  </c:pt>
                  <c:pt idx="2">
                    <c:v>0.24671888630086716</c:v>
                  </c:pt>
                  <c:pt idx="3">
                    <c:v>0.15866003159948644</c:v>
                  </c:pt>
                  <c:pt idx="4">
                    <c:v>0.27885432098988572</c:v>
                  </c:pt>
                  <c:pt idx="5">
                    <c:v>4.876748885835578E-2</c:v>
                  </c:pt>
                </c:numCache>
              </c:numRef>
            </c:plus>
            <c:minus>
              <c:numRef>
                <c:f>'muscle cry1'!$L$34:$Q$34</c:f>
                <c:numCache>
                  <c:formatCode>General</c:formatCode>
                  <c:ptCount val="6"/>
                  <c:pt idx="0">
                    <c:v>7.378629969523276E-2</c:v>
                  </c:pt>
                  <c:pt idx="1">
                    <c:v>0.12054685045307557</c:v>
                  </c:pt>
                  <c:pt idx="2">
                    <c:v>0.24671888630086716</c:v>
                  </c:pt>
                  <c:pt idx="3">
                    <c:v>0.15866003159948644</c:v>
                  </c:pt>
                  <c:pt idx="4">
                    <c:v>0.27885432098988572</c:v>
                  </c:pt>
                  <c:pt idx="5">
                    <c:v>4.87674888583557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cry1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cry1'!$K$37:$Q$37</c:f>
              <c:numCache>
                <c:formatCode>0.00</c:formatCode>
                <c:ptCount val="7"/>
                <c:pt idx="0">
                  <c:v>1.3058411814188275</c:v>
                </c:pt>
                <c:pt idx="1">
                  <c:v>1.0164760352207927</c:v>
                </c:pt>
                <c:pt idx="2">
                  <c:v>1</c:v>
                </c:pt>
                <c:pt idx="3">
                  <c:v>1.5217953122852446</c:v>
                </c:pt>
                <c:pt idx="4">
                  <c:v>2.4414828750521265</c:v>
                </c:pt>
                <c:pt idx="5">
                  <c:v>2.7809540195915443</c:v>
                </c:pt>
                <c:pt idx="6">
                  <c:v>1.30584118141882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06B5-4DAE-B902-585C48A219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.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musle bmal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le bmal'!$AF$34:$AL$34</c:f>
                <c:numCache>
                  <c:formatCode>General</c:formatCode>
                  <c:ptCount val="7"/>
                  <c:pt idx="0">
                    <c:v>8.4910456001406467E-2</c:v>
                  </c:pt>
                  <c:pt idx="1">
                    <c:v>0.11780740153586916</c:v>
                  </c:pt>
                  <c:pt idx="2">
                    <c:v>4.0798465356004586E-2</c:v>
                  </c:pt>
                  <c:pt idx="3">
                    <c:v>5.0995609866031404E-2</c:v>
                  </c:pt>
                  <c:pt idx="4">
                    <c:v>0.17306760673552038</c:v>
                  </c:pt>
                  <c:pt idx="5">
                    <c:v>0.18613063281596182</c:v>
                  </c:pt>
                  <c:pt idx="6">
                    <c:v>8.4910456001406467E-2</c:v>
                  </c:pt>
                </c:numCache>
              </c:numRef>
            </c:plus>
            <c:minus>
              <c:numRef>
                <c:f>'musle bmal'!$AF$34:$AL$34</c:f>
                <c:numCache>
                  <c:formatCode>General</c:formatCode>
                  <c:ptCount val="7"/>
                  <c:pt idx="0">
                    <c:v>8.4910456001406467E-2</c:v>
                  </c:pt>
                  <c:pt idx="1">
                    <c:v>0.11780740153586916</c:v>
                  </c:pt>
                  <c:pt idx="2">
                    <c:v>4.0798465356004586E-2</c:v>
                  </c:pt>
                  <c:pt idx="3">
                    <c:v>5.0995609866031404E-2</c:v>
                  </c:pt>
                  <c:pt idx="4">
                    <c:v>0.17306760673552038</c:v>
                  </c:pt>
                  <c:pt idx="5">
                    <c:v>0.18613063281596182</c:v>
                  </c:pt>
                  <c:pt idx="6">
                    <c:v>8.491045600140646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le bmal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le bmal'!$K$40:$Q$40</c:f>
              <c:numCache>
                <c:formatCode>0.00</c:formatCode>
                <c:ptCount val="7"/>
                <c:pt idx="0">
                  <c:v>1.4089994770221022</c:v>
                </c:pt>
                <c:pt idx="1">
                  <c:v>1.9760160291361555</c:v>
                </c:pt>
                <c:pt idx="2">
                  <c:v>1</c:v>
                </c:pt>
                <c:pt idx="3">
                  <c:v>1.8233612082507991</c:v>
                </c:pt>
                <c:pt idx="4">
                  <c:v>1.34567499425547</c:v>
                </c:pt>
                <c:pt idx="5">
                  <c:v>1.7994059520004098</c:v>
                </c:pt>
                <c:pt idx="6">
                  <c:v>1.408999477022102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BAE-42F3-A4D4-6A9B12406452}"/>
            </c:ext>
          </c:extLst>
        </c:ser>
        <c:ser>
          <c:idx val="2"/>
          <c:order val="1"/>
          <c:tx>
            <c:strRef>
              <c:f>'musle bmal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le bmal'!$Y$34:$AE$34</c:f>
                <c:numCache>
                  <c:formatCode>General</c:formatCode>
                  <c:ptCount val="7"/>
                  <c:pt idx="0">
                    <c:v>0.12165258721617231</c:v>
                  </c:pt>
                  <c:pt idx="1">
                    <c:v>0.23807023288533297</c:v>
                  </c:pt>
                  <c:pt idx="2">
                    <c:v>0.30164663515879681</c:v>
                  </c:pt>
                  <c:pt idx="3">
                    <c:v>0.27773351499468979</c:v>
                  </c:pt>
                  <c:pt idx="4">
                    <c:v>0.12835588498905653</c:v>
                  </c:pt>
                  <c:pt idx="5">
                    <c:v>0.15460112266428269</c:v>
                  </c:pt>
                  <c:pt idx="6">
                    <c:v>0.12165258721617231</c:v>
                  </c:pt>
                </c:numCache>
              </c:numRef>
            </c:plus>
            <c:minus>
              <c:numRef>
                <c:f>'musle bmal'!$Y$34:$AE$34</c:f>
                <c:numCache>
                  <c:formatCode>General</c:formatCode>
                  <c:ptCount val="7"/>
                  <c:pt idx="0">
                    <c:v>0.12165258721617231</c:v>
                  </c:pt>
                  <c:pt idx="1">
                    <c:v>0.23807023288533297</c:v>
                  </c:pt>
                  <c:pt idx="2">
                    <c:v>0.30164663515879681</c:v>
                  </c:pt>
                  <c:pt idx="3">
                    <c:v>0.27773351499468979</c:v>
                  </c:pt>
                  <c:pt idx="4">
                    <c:v>0.12835588498905653</c:v>
                  </c:pt>
                  <c:pt idx="5">
                    <c:v>0.15460112266428269</c:v>
                  </c:pt>
                  <c:pt idx="6">
                    <c:v>0.121652587216172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le bmal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le bmal'!$K$39:$Q$39</c:f>
              <c:numCache>
                <c:formatCode>0.00</c:formatCode>
                <c:ptCount val="7"/>
                <c:pt idx="0">
                  <c:v>1</c:v>
                </c:pt>
                <c:pt idx="1">
                  <c:v>2.8976408094376338</c:v>
                </c:pt>
                <c:pt idx="2">
                  <c:v>1.9488860902072553</c:v>
                </c:pt>
                <c:pt idx="3">
                  <c:v>1.7246822864186624</c:v>
                </c:pt>
                <c:pt idx="4">
                  <c:v>1.4362524395542278</c:v>
                </c:pt>
                <c:pt idx="5">
                  <c:v>1.4873903577053416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BAE-42F3-A4D4-6A9B12406452}"/>
            </c:ext>
          </c:extLst>
        </c:ser>
        <c:ser>
          <c:idx val="1"/>
          <c:order val="2"/>
          <c:tx>
            <c:strRef>
              <c:f>'musle bmal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le bmal'!$R$34:$X$34</c:f>
                <c:numCache>
                  <c:formatCode>General</c:formatCode>
                  <c:ptCount val="7"/>
                  <c:pt idx="0">
                    <c:v>0.22916776439555075</c:v>
                  </c:pt>
                  <c:pt idx="1">
                    <c:v>0.24428648677487641</c:v>
                  </c:pt>
                  <c:pt idx="2">
                    <c:v>0.31981196457964978</c:v>
                  </c:pt>
                  <c:pt idx="3">
                    <c:v>0.24616717005138739</c:v>
                  </c:pt>
                  <c:pt idx="4">
                    <c:v>0.12892862594891111</c:v>
                  </c:pt>
                  <c:pt idx="5">
                    <c:v>0.12385175137526244</c:v>
                  </c:pt>
                  <c:pt idx="6">
                    <c:v>0.22916776439555075</c:v>
                  </c:pt>
                </c:numCache>
              </c:numRef>
            </c:plus>
            <c:minus>
              <c:numRef>
                <c:f>'musle bmal'!$R$34:$X$34</c:f>
                <c:numCache>
                  <c:formatCode>General</c:formatCode>
                  <c:ptCount val="7"/>
                  <c:pt idx="0">
                    <c:v>0.22916776439555075</c:v>
                  </c:pt>
                  <c:pt idx="1">
                    <c:v>0.24428648677487641</c:v>
                  </c:pt>
                  <c:pt idx="2">
                    <c:v>0.31981196457964978</c:v>
                  </c:pt>
                  <c:pt idx="3">
                    <c:v>0.24616717005138739</c:v>
                  </c:pt>
                  <c:pt idx="4">
                    <c:v>0.12892862594891111</c:v>
                  </c:pt>
                  <c:pt idx="5">
                    <c:v>0.12385175137526244</c:v>
                  </c:pt>
                  <c:pt idx="6">
                    <c:v>0.229167764395550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le bmal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le bmal'!$K$38:$Q$38</c:f>
              <c:numCache>
                <c:formatCode>0.00</c:formatCode>
                <c:ptCount val="7"/>
                <c:pt idx="0">
                  <c:v>1.3374212983547022</c:v>
                </c:pt>
                <c:pt idx="1">
                  <c:v>4.8703075688893298</c:v>
                </c:pt>
                <c:pt idx="2">
                  <c:v>3.1972371324310642</c:v>
                </c:pt>
                <c:pt idx="3">
                  <c:v>1.583358384728822</c:v>
                </c:pt>
                <c:pt idx="4">
                  <c:v>1</c:v>
                </c:pt>
                <c:pt idx="5">
                  <c:v>1.2997025070756472</c:v>
                </c:pt>
                <c:pt idx="6">
                  <c:v>1.337421298354702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5BAE-42F3-A4D4-6A9B12406452}"/>
            </c:ext>
          </c:extLst>
        </c:ser>
        <c:ser>
          <c:idx val="0"/>
          <c:order val="3"/>
          <c:tx>
            <c:strRef>
              <c:f>'muscle clock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le bmal'!$K$34:$Q$34</c:f>
                <c:numCache>
                  <c:formatCode>General</c:formatCode>
                  <c:ptCount val="7"/>
                  <c:pt idx="0">
                    <c:v>0.14633714740078799</c:v>
                  </c:pt>
                  <c:pt idx="1">
                    <c:v>0.17907735799093477</c:v>
                  </c:pt>
                  <c:pt idx="2">
                    <c:v>0.14371429472216579</c:v>
                  </c:pt>
                  <c:pt idx="3">
                    <c:v>0.35931664930863066</c:v>
                  </c:pt>
                  <c:pt idx="4">
                    <c:v>0.11669352608202559</c:v>
                  </c:pt>
                  <c:pt idx="5">
                    <c:v>0.29653241246404827</c:v>
                  </c:pt>
                  <c:pt idx="6">
                    <c:v>0.14633714740078799</c:v>
                  </c:pt>
                </c:numCache>
              </c:numRef>
            </c:plus>
            <c:minus>
              <c:numRef>
                <c:f>'musle bmal'!$K$34:$Q$34</c:f>
                <c:numCache>
                  <c:formatCode>General</c:formatCode>
                  <c:ptCount val="7"/>
                  <c:pt idx="0">
                    <c:v>0.14633714740078799</c:v>
                  </c:pt>
                  <c:pt idx="1">
                    <c:v>0.17907735799093477</c:v>
                  </c:pt>
                  <c:pt idx="2">
                    <c:v>0.14371429472216579</c:v>
                  </c:pt>
                  <c:pt idx="3">
                    <c:v>0.35931664930863066</c:v>
                  </c:pt>
                  <c:pt idx="4">
                    <c:v>0.11669352608202559</c:v>
                  </c:pt>
                  <c:pt idx="5">
                    <c:v>0.29653241246404827</c:v>
                  </c:pt>
                  <c:pt idx="6">
                    <c:v>0.146337147400787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clock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clock'!$K$37:$Q$37</c:f>
              <c:numCache>
                <c:formatCode>0.00</c:formatCode>
                <c:ptCount val="7"/>
                <c:pt idx="0">
                  <c:v>1</c:v>
                </c:pt>
                <c:pt idx="1">
                  <c:v>1.4770842129840065</c:v>
                </c:pt>
                <c:pt idx="2">
                  <c:v>1.1140318307971329</c:v>
                </c:pt>
                <c:pt idx="3">
                  <c:v>1.9720202096697363</c:v>
                </c:pt>
                <c:pt idx="4">
                  <c:v>1.2269752239640572</c:v>
                </c:pt>
                <c:pt idx="5">
                  <c:v>2.2702358081023823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5BAE-42F3-A4D4-6A9B124064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muscle clock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clock'!$AF$34:$AL$34</c:f>
                <c:numCache>
                  <c:formatCode>General</c:formatCode>
                  <c:ptCount val="7"/>
                  <c:pt idx="0">
                    <c:v>8.4910456001406467E-2</c:v>
                  </c:pt>
                  <c:pt idx="1">
                    <c:v>0.11780740153586916</c:v>
                  </c:pt>
                  <c:pt idx="2">
                    <c:v>4.0798465356004586E-2</c:v>
                  </c:pt>
                  <c:pt idx="3">
                    <c:v>5.0995609866031404E-2</c:v>
                  </c:pt>
                  <c:pt idx="4">
                    <c:v>0.12980070505164029</c:v>
                  </c:pt>
                  <c:pt idx="5">
                    <c:v>9.3065316407980908E-2</c:v>
                  </c:pt>
                  <c:pt idx="6">
                    <c:v>8.4910456001406467E-2</c:v>
                  </c:pt>
                </c:numCache>
              </c:numRef>
            </c:plus>
            <c:minus>
              <c:numRef>
                <c:f>'muscle clock'!$AF$34:$AL$34</c:f>
                <c:numCache>
                  <c:formatCode>General</c:formatCode>
                  <c:ptCount val="7"/>
                  <c:pt idx="0">
                    <c:v>8.4910456001406467E-2</c:v>
                  </c:pt>
                  <c:pt idx="1">
                    <c:v>0.11780740153586916</c:v>
                  </c:pt>
                  <c:pt idx="2">
                    <c:v>4.0798465356004586E-2</c:v>
                  </c:pt>
                  <c:pt idx="3">
                    <c:v>5.0995609866031404E-2</c:v>
                  </c:pt>
                  <c:pt idx="4">
                    <c:v>0.12980070505164029</c:v>
                  </c:pt>
                  <c:pt idx="5">
                    <c:v>9.3065316407980908E-2</c:v>
                  </c:pt>
                  <c:pt idx="6">
                    <c:v>8.491045600140646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clock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clock'!$K$40:$Q$40</c:f>
              <c:numCache>
                <c:formatCode>0.00</c:formatCode>
                <c:ptCount val="7"/>
                <c:pt idx="0">
                  <c:v>1.4089994770221022</c:v>
                </c:pt>
                <c:pt idx="1">
                  <c:v>1.9760160291361555</c:v>
                </c:pt>
                <c:pt idx="2">
                  <c:v>1</c:v>
                </c:pt>
                <c:pt idx="3">
                  <c:v>1.8233612082507991</c:v>
                </c:pt>
                <c:pt idx="4">
                  <c:v>1.34567499425547</c:v>
                </c:pt>
                <c:pt idx="5">
                  <c:v>1.7994059520004098</c:v>
                </c:pt>
                <c:pt idx="6">
                  <c:v>1.408999477022102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E38-49B6-8C38-1C8B9C09649C}"/>
            </c:ext>
          </c:extLst>
        </c:ser>
        <c:ser>
          <c:idx val="2"/>
          <c:order val="1"/>
          <c:tx>
            <c:strRef>
              <c:f>'muscle clock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clock'!$Y$34:$AE$34</c:f>
                <c:numCache>
                  <c:formatCode>General</c:formatCode>
                  <c:ptCount val="7"/>
                  <c:pt idx="0">
                    <c:v>1.8207713165457377E-2</c:v>
                  </c:pt>
                  <c:pt idx="1">
                    <c:v>0.16183826073830834</c:v>
                  </c:pt>
                  <c:pt idx="2">
                    <c:v>0.16779721295041092</c:v>
                  </c:pt>
                  <c:pt idx="3">
                    <c:v>0.14623275758611745</c:v>
                  </c:pt>
                  <c:pt idx="4">
                    <c:v>5.5993019193745726E-2</c:v>
                  </c:pt>
                  <c:pt idx="5">
                    <c:v>7.5130427086305865E-2</c:v>
                  </c:pt>
                  <c:pt idx="6">
                    <c:v>1.8207713165457377E-2</c:v>
                  </c:pt>
                </c:numCache>
              </c:numRef>
            </c:plus>
            <c:minus>
              <c:numRef>
                <c:f>'muscle clock'!$Y$34:$AE$34</c:f>
                <c:numCache>
                  <c:formatCode>General</c:formatCode>
                  <c:ptCount val="7"/>
                  <c:pt idx="0">
                    <c:v>1.8207713165457377E-2</c:v>
                  </c:pt>
                  <c:pt idx="1">
                    <c:v>0.16183826073830834</c:v>
                  </c:pt>
                  <c:pt idx="2">
                    <c:v>0.16779721295041092</c:v>
                  </c:pt>
                  <c:pt idx="3">
                    <c:v>0.14623275758611745</c:v>
                  </c:pt>
                  <c:pt idx="4">
                    <c:v>5.5993019193745726E-2</c:v>
                  </c:pt>
                  <c:pt idx="5">
                    <c:v>7.5130427086305865E-2</c:v>
                  </c:pt>
                  <c:pt idx="6">
                    <c:v>1.820771316545737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clock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clock'!$K$39:$Q$39</c:f>
              <c:numCache>
                <c:formatCode>0.00</c:formatCode>
                <c:ptCount val="7"/>
                <c:pt idx="0">
                  <c:v>1</c:v>
                </c:pt>
                <c:pt idx="1">
                  <c:v>2.3532594317631457</c:v>
                </c:pt>
                <c:pt idx="2">
                  <c:v>2.2224594628595766</c:v>
                </c:pt>
                <c:pt idx="3">
                  <c:v>1.5197654399750313</c:v>
                </c:pt>
                <c:pt idx="4">
                  <c:v>1.1404779452930351</c:v>
                </c:pt>
                <c:pt idx="5">
                  <c:v>1.180650427725966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E38-49B6-8C38-1C8B9C09649C}"/>
            </c:ext>
          </c:extLst>
        </c:ser>
        <c:ser>
          <c:idx val="1"/>
          <c:order val="2"/>
          <c:tx>
            <c:strRef>
              <c:f>'muscle clock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clock'!$R$34:$X$34</c:f>
                <c:numCache>
                  <c:formatCode>General</c:formatCode>
                  <c:ptCount val="7"/>
                  <c:pt idx="0">
                    <c:v>0.41607948766225233</c:v>
                  </c:pt>
                  <c:pt idx="1">
                    <c:v>0.24070995544648602</c:v>
                  </c:pt>
                  <c:pt idx="2">
                    <c:v>0.33346919635894789</c:v>
                  </c:pt>
                  <c:pt idx="3">
                    <c:v>5.2804121201271967E-2</c:v>
                  </c:pt>
                  <c:pt idx="4">
                    <c:v>0.25002117421369779</c:v>
                  </c:pt>
                  <c:pt idx="5">
                    <c:v>0.32508547775604285</c:v>
                  </c:pt>
                  <c:pt idx="6">
                    <c:v>0.41607948766225233</c:v>
                  </c:pt>
                </c:numCache>
              </c:numRef>
            </c:plus>
            <c:minus>
              <c:numRef>
                <c:f>'muscle clock'!$R$34:$X$34</c:f>
                <c:numCache>
                  <c:formatCode>General</c:formatCode>
                  <c:ptCount val="7"/>
                  <c:pt idx="0">
                    <c:v>0.41607948766225233</c:v>
                  </c:pt>
                  <c:pt idx="1">
                    <c:v>0.24070995544648602</c:v>
                  </c:pt>
                  <c:pt idx="2">
                    <c:v>0.33346919635894789</c:v>
                  </c:pt>
                  <c:pt idx="3">
                    <c:v>5.2804121201271967E-2</c:v>
                  </c:pt>
                  <c:pt idx="4">
                    <c:v>0.25002117421369779</c:v>
                  </c:pt>
                  <c:pt idx="5">
                    <c:v>0.32508547775604285</c:v>
                  </c:pt>
                  <c:pt idx="6">
                    <c:v>0.416079487662252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clock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clock'!$K$38:$Q$38</c:f>
              <c:numCache>
                <c:formatCode>0.00</c:formatCode>
                <c:ptCount val="7"/>
                <c:pt idx="0">
                  <c:v>1.6844478800448481</c:v>
                </c:pt>
                <c:pt idx="1">
                  <c:v>2.9861594963052078</c:v>
                </c:pt>
                <c:pt idx="2">
                  <c:v>1.4520803474734838</c:v>
                </c:pt>
                <c:pt idx="3">
                  <c:v>1</c:v>
                </c:pt>
                <c:pt idx="4">
                  <c:v>1.3727912406287439</c:v>
                </c:pt>
                <c:pt idx="5">
                  <c:v>1.9842212606874474</c:v>
                </c:pt>
                <c:pt idx="6">
                  <c:v>1.684447880044848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DE38-49B6-8C38-1C8B9C09649C}"/>
            </c:ext>
          </c:extLst>
        </c:ser>
        <c:ser>
          <c:idx val="0"/>
          <c:order val="3"/>
          <c:tx>
            <c:strRef>
              <c:f>'muscle clock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clock'!$K$34:$Q$34</c:f>
                <c:numCache>
                  <c:formatCode>General</c:formatCode>
                  <c:ptCount val="7"/>
                  <c:pt idx="0">
                    <c:v>0.21950572110118197</c:v>
                  </c:pt>
                  <c:pt idx="1">
                    <c:v>0.17907735799093477</c:v>
                  </c:pt>
                  <c:pt idx="2">
                    <c:v>0.14371429472216579</c:v>
                  </c:pt>
                  <c:pt idx="3">
                    <c:v>0.23954443287242044</c:v>
                  </c:pt>
                  <c:pt idx="4">
                    <c:v>0.11669352608202559</c:v>
                  </c:pt>
                  <c:pt idx="5">
                    <c:v>0.29653241246404827</c:v>
                  </c:pt>
                  <c:pt idx="6">
                    <c:v>0.21950572110118197</c:v>
                  </c:pt>
                </c:numCache>
              </c:numRef>
            </c:plus>
            <c:minus>
              <c:numRef>
                <c:f>'muscle clock'!$K$34:$Q$34</c:f>
                <c:numCache>
                  <c:formatCode>General</c:formatCode>
                  <c:ptCount val="7"/>
                  <c:pt idx="0">
                    <c:v>0.21950572110118197</c:v>
                  </c:pt>
                  <c:pt idx="1">
                    <c:v>0.17907735799093477</c:v>
                  </c:pt>
                  <c:pt idx="2">
                    <c:v>0.14371429472216579</c:v>
                  </c:pt>
                  <c:pt idx="3">
                    <c:v>0.23954443287242044</c:v>
                  </c:pt>
                  <c:pt idx="4">
                    <c:v>0.11669352608202559</c:v>
                  </c:pt>
                  <c:pt idx="5">
                    <c:v>0.29653241246404827</c:v>
                  </c:pt>
                  <c:pt idx="6">
                    <c:v>0.219505721101181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clock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clock'!$K$37:$Q$37</c:f>
              <c:numCache>
                <c:formatCode>0.00</c:formatCode>
                <c:ptCount val="7"/>
                <c:pt idx="0">
                  <c:v>1</c:v>
                </c:pt>
                <c:pt idx="1">
                  <c:v>1.4770842129840065</c:v>
                </c:pt>
                <c:pt idx="2">
                  <c:v>1.1140318307971329</c:v>
                </c:pt>
                <c:pt idx="3">
                  <c:v>1.9720202096697363</c:v>
                </c:pt>
                <c:pt idx="4">
                  <c:v>1.2269752239640572</c:v>
                </c:pt>
                <c:pt idx="5">
                  <c:v>2.2702358081023823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DE38-49B6-8C38-1C8B9C0964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  <c:min val="0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muscle myogenin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myogenin'!$AF$34:$AL$34</c:f>
                <c:numCache>
                  <c:formatCode>General</c:formatCode>
                  <c:ptCount val="7"/>
                  <c:pt idx="0">
                    <c:v>0.10064515747766739</c:v>
                  </c:pt>
                  <c:pt idx="1">
                    <c:v>0.13782142116537391</c:v>
                  </c:pt>
                  <c:pt idx="2">
                    <c:v>6.1253554479515922E-2</c:v>
                  </c:pt>
                  <c:pt idx="3">
                    <c:v>0.10728451501620703</c:v>
                  </c:pt>
                  <c:pt idx="4">
                    <c:v>0.12818295529245424</c:v>
                  </c:pt>
                  <c:pt idx="5">
                    <c:v>0.14137488090790817</c:v>
                  </c:pt>
                  <c:pt idx="6">
                    <c:v>0.10064515747766739</c:v>
                  </c:pt>
                </c:numCache>
              </c:numRef>
            </c:plus>
            <c:minus>
              <c:numRef>
                <c:f>'muscle myogenin'!$AF$34:$AL$34</c:f>
                <c:numCache>
                  <c:formatCode>General</c:formatCode>
                  <c:ptCount val="7"/>
                  <c:pt idx="0">
                    <c:v>0.10064515747766739</c:v>
                  </c:pt>
                  <c:pt idx="1">
                    <c:v>0.13782142116537391</c:v>
                  </c:pt>
                  <c:pt idx="2">
                    <c:v>6.1253554479515922E-2</c:v>
                  </c:pt>
                  <c:pt idx="3">
                    <c:v>0.10728451501620703</c:v>
                  </c:pt>
                  <c:pt idx="4">
                    <c:v>0.12818295529245424</c:v>
                  </c:pt>
                  <c:pt idx="5">
                    <c:v>0.14137488090790817</c:v>
                  </c:pt>
                  <c:pt idx="6">
                    <c:v>0.100645157477667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myogenin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myogenin'!$K$40:$Q$40</c:f>
              <c:numCache>
                <c:formatCode>0.00</c:formatCode>
                <c:ptCount val="7"/>
                <c:pt idx="0">
                  <c:v>1.1827502245397588</c:v>
                </c:pt>
                <c:pt idx="1">
                  <c:v>1.7230522259677707</c:v>
                </c:pt>
                <c:pt idx="2">
                  <c:v>1</c:v>
                </c:pt>
                <c:pt idx="3">
                  <c:v>1.3208882080124402</c:v>
                </c:pt>
                <c:pt idx="4">
                  <c:v>1.7325655658274053</c:v>
                </c:pt>
                <c:pt idx="5">
                  <c:v>1.9327386369515371</c:v>
                </c:pt>
                <c:pt idx="6">
                  <c:v>1.182750224539758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323-4175-8ED2-C9A79417E7F8}"/>
            </c:ext>
          </c:extLst>
        </c:ser>
        <c:ser>
          <c:idx val="2"/>
          <c:order val="1"/>
          <c:tx>
            <c:strRef>
              <c:f>'muscle myogenin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myogenin'!$Y$34:$AE$34</c:f>
                <c:numCache>
                  <c:formatCode>General</c:formatCode>
                  <c:ptCount val="7"/>
                  <c:pt idx="0">
                    <c:v>5.1252236526858869E-2</c:v>
                  </c:pt>
                  <c:pt idx="1">
                    <c:v>0.12274904159352538</c:v>
                  </c:pt>
                  <c:pt idx="2">
                    <c:v>0.15738530076924914</c:v>
                  </c:pt>
                  <c:pt idx="3">
                    <c:v>0.15866897628419147</c:v>
                  </c:pt>
                  <c:pt idx="4">
                    <c:v>0.14599856757288096</c:v>
                  </c:pt>
                  <c:pt idx="5">
                    <c:v>0.19745245034787146</c:v>
                  </c:pt>
                  <c:pt idx="6">
                    <c:v>5.1252236526858869E-2</c:v>
                  </c:pt>
                </c:numCache>
              </c:numRef>
            </c:plus>
            <c:minus>
              <c:numRef>
                <c:f>'muscle myogenin'!$Y$34:$AE$34</c:f>
                <c:numCache>
                  <c:formatCode>General</c:formatCode>
                  <c:ptCount val="7"/>
                  <c:pt idx="0">
                    <c:v>5.1252236526858869E-2</c:v>
                  </c:pt>
                  <c:pt idx="1">
                    <c:v>0.12274904159352538</c:v>
                  </c:pt>
                  <c:pt idx="2">
                    <c:v>0.15738530076924914</c:v>
                  </c:pt>
                  <c:pt idx="3">
                    <c:v>0.15866897628419147</c:v>
                  </c:pt>
                  <c:pt idx="4">
                    <c:v>0.14599856757288096</c:v>
                  </c:pt>
                  <c:pt idx="5">
                    <c:v>0.19745245034787146</c:v>
                  </c:pt>
                  <c:pt idx="6">
                    <c:v>5.125223652685886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myogenin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myogenin'!$K$39:$Q$39</c:f>
              <c:numCache>
                <c:formatCode>0.00</c:formatCode>
                <c:ptCount val="7"/>
                <c:pt idx="0">
                  <c:v>1</c:v>
                </c:pt>
                <c:pt idx="1">
                  <c:v>1.491555053684871</c:v>
                </c:pt>
                <c:pt idx="2">
                  <c:v>1.9856314113545266</c:v>
                </c:pt>
                <c:pt idx="3">
                  <c:v>2.4752750794834202</c:v>
                </c:pt>
                <c:pt idx="4">
                  <c:v>1.307448930003944</c:v>
                </c:pt>
                <c:pt idx="5">
                  <c:v>1.5139551575953623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323-4175-8ED2-C9A79417E7F8}"/>
            </c:ext>
          </c:extLst>
        </c:ser>
        <c:ser>
          <c:idx val="1"/>
          <c:order val="2"/>
          <c:tx>
            <c:strRef>
              <c:f>'muscle myogenin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myogenin'!$R$34:$X$34</c:f>
                <c:numCache>
                  <c:formatCode>General</c:formatCode>
                  <c:ptCount val="7"/>
                  <c:pt idx="0">
                    <c:v>0.18552774946471029</c:v>
                  </c:pt>
                  <c:pt idx="1">
                    <c:v>0.24880040180856081</c:v>
                  </c:pt>
                  <c:pt idx="2">
                    <c:v>8.0437569324626437E-2</c:v>
                  </c:pt>
                  <c:pt idx="3">
                    <c:v>0.16608412208512086</c:v>
                  </c:pt>
                  <c:pt idx="4">
                    <c:v>0.13048501124073394</c:v>
                  </c:pt>
                  <c:pt idx="5">
                    <c:v>0.20863918894660186</c:v>
                  </c:pt>
                  <c:pt idx="6">
                    <c:v>0.18552774946471029</c:v>
                  </c:pt>
                </c:numCache>
              </c:numRef>
            </c:plus>
            <c:minus>
              <c:numRef>
                <c:f>'muscle myogenin'!$R$34:$X$34</c:f>
                <c:numCache>
                  <c:formatCode>General</c:formatCode>
                  <c:ptCount val="7"/>
                  <c:pt idx="0">
                    <c:v>0.18552774946471029</c:v>
                  </c:pt>
                  <c:pt idx="1">
                    <c:v>0.24880040180856081</c:v>
                  </c:pt>
                  <c:pt idx="2">
                    <c:v>8.0437569324626437E-2</c:v>
                  </c:pt>
                  <c:pt idx="3">
                    <c:v>0.16608412208512086</c:v>
                  </c:pt>
                  <c:pt idx="4">
                    <c:v>0.13048501124073394</c:v>
                  </c:pt>
                  <c:pt idx="5">
                    <c:v>0.20863918894660186</c:v>
                  </c:pt>
                  <c:pt idx="6">
                    <c:v>0.185527749464710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myogenin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myogenin'!$K$38:$Q$38</c:f>
              <c:numCache>
                <c:formatCode>0.00</c:formatCode>
                <c:ptCount val="7"/>
                <c:pt idx="0">
                  <c:v>1.4935925824061227</c:v>
                </c:pt>
                <c:pt idx="1">
                  <c:v>2.3344098002768652</c:v>
                </c:pt>
                <c:pt idx="2">
                  <c:v>1</c:v>
                </c:pt>
                <c:pt idx="3">
                  <c:v>1.3201291054688677</c:v>
                </c:pt>
                <c:pt idx="4">
                  <c:v>1.4837763541285884</c:v>
                </c:pt>
                <c:pt idx="5">
                  <c:v>2.1997323979805246</c:v>
                </c:pt>
                <c:pt idx="6">
                  <c:v>1.493592582406122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7323-4175-8ED2-C9A79417E7F8}"/>
            </c:ext>
          </c:extLst>
        </c:ser>
        <c:ser>
          <c:idx val="0"/>
          <c:order val="3"/>
          <c:tx>
            <c:strRef>
              <c:f>'muscle myogenin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myogenin'!$K$34:$Q$34</c:f>
                <c:numCache>
                  <c:formatCode>General</c:formatCode>
                  <c:ptCount val="7"/>
                  <c:pt idx="0">
                    <c:v>0.150766540282286</c:v>
                  </c:pt>
                  <c:pt idx="1">
                    <c:v>0.16040238477411559</c:v>
                  </c:pt>
                  <c:pt idx="2">
                    <c:v>0.15408100742491262</c:v>
                  </c:pt>
                  <c:pt idx="3">
                    <c:v>0.20066633450961557</c:v>
                  </c:pt>
                  <c:pt idx="4">
                    <c:v>0.10847282722920919</c:v>
                  </c:pt>
                  <c:pt idx="5">
                    <c:v>0.16540127689358977</c:v>
                  </c:pt>
                  <c:pt idx="6">
                    <c:v>0.150766540282286</c:v>
                  </c:pt>
                </c:numCache>
              </c:numRef>
            </c:plus>
            <c:minus>
              <c:numRef>
                <c:f>'muscle myogenin'!$K$34:$Q$34</c:f>
                <c:numCache>
                  <c:formatCode>General</c:formatCode>
                  <c:ptCount val="7"/>
                  <c:pt idx="0">
                    <c:v>0.150766540282286</c:v>
                  </c:pt>
                  <c:pt idx="1">
                    <c:v>0.16040238477411559</c:v>
                  </c:pt>
                  <c:pt idx="2">
                    <c:v>0.15408100742491262</c:v>
                  </c:pt>
                  <c:pt idx="3">
                    <c:v>0.20066633450961557</c:v>
                  </c:pt>
                  <c:pt idx="4">
                    <c:v>0.10847282722920919</c:v>
                  </c:pt>
                  <c:pt idx="5">
                    <c:v>0.16540127689358977</c:v>
                  </c:pt>
                  <c:pt idx="6">
                    <c:v>0.1507665402822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myogenin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myogenin'!$K$37:$Q$37</c:f>
              <c:numCache>
                <c:formatCode>0.00</c:formatCode>
                <c:ptCount val="7"/>
                <c:pt idx="0">
                  <c:v>1</c:v>
                </c:pt>
                <c:pt idx="1">
                  <c:v>1.8486398400730608</c:v>
                </c:pt>
                <c:pt idx="2">
                  <c:v>1.0851399122189596</c:v>
                </c:pt>
                <c:pt idx="3">
                  <c:v>2.9145946306560839</c:v>
                </c:pt>
                <c:pt idx="4">
                  <c:v>1.0348484140608569</c:v>
                </c:pt>
                <c:pt idx="5">
                  <c:v>1.9510434380768606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7323-4175-8ED2-C9A79417E7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.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fat reverb  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reverb  '!$AF$34:$AL$34</c:f>
                <c:numCache>
                  <c:formatCode>General</c:formatCode>
                  <c:ptCount val="7"/>
                  <c:pt idx="0">
                    <c:v>0.12957655695603454</c:v>
                  </c:pt>
                  <c:pt idx="1">
                    <c:v>5.8441502069319973E-2</c:v>
                  </c:pt>
                  <c:pt idx="2">
                    <c:v>0.10986669344410734</c:v>
                  </c:pt>
                  <c:pt idx="3">
                    <c:v>0.18835832451971712</c:v>
                  </c:pt>
                  <c:pt idx="4">
                    <c:v>0.17272439350850355</c:v>
                  </c:pt>
                  <c:pt idx="5">
                    <c:v>3.9397167985776603E-2</c:v>
                  </c:pt>
                  <c:pt idx="6">
                    <c:v>0.12957655695603454</c:v>
                  </c:pt>
                </c:numCache>
              </c:numRef>
            </c:plus>
            <c:minus>
              <c:numRef>
                <c:f>'fat reverb  '!$AF$34:$AL$34</c:f>
                <c:numCache>
                  <c:formatCode>General</c:formatCode>
                  <c:ptCount val="7"/>
                  <c:pt idx="0">
                    <c:v>0.12957655695603454</c:v>
                  </c:pt>
                  <c:pt idx="1">
                    <c:v>5.8441502069319973E-2</c:v>
                  </c:pt>
                  <c:pt idx="2">
                    <c:v>0.10986669344410734</c:v>
                  </c:pt>
                  <c:pt idx="3">
                    <c:v>0.18835832451971712</c:v>
                  </c:pt>
                  <c:pt idx="4">
                    <c:v>0.17272439350850355</c:v>
                  </c:pt>
                  <c:pt idx="5">
                    <c:v>3.9397167985776603E-2</c:v>
                  </c:pt>
                  <c:pt idx="6">
                    <c:v>0.129576556956034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reverb 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reverb  '!$K$40:$Q$40</c:f>
              <c:numCache>
                <c:formatCode>0.00</c:formatCode>
                <c:ptCount val="7"/>
                <c:pt idx="0">
                  <c:v>1.4404770536940175</c:v>
                </c:pt>
                <c:pt idx="1">
                  <c:v>1.0187720758468775</c:v>
                </c:pt>
                <c:pt idx="2">
                  <c:v>1.1530711416792874</c:v>
                </c:pt>
                <c:pt idx="3">
                  <c:v>1</c:v>
                </c:pt>
                <c:pt idx="4">
                  <c:v>1.0441577595379803</c:v>
                </c:pt>
                <c:pt idx="5">
                  <c:v>1.0760466501868804</c:v>
                </c:pt>
                <c:pt idx="6">
                  <c:v>1.44047705369401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3850-4049-A5EF-34EC1A13A857}"/>
            </c:ext>
          </c:extLst>
        </c:ser>
        <c:ser>
          <c:idx val="2"/>
          <c:order val="1"/>
          <c:tx>
            <c:strRef>
              <c:f>'fat reverb  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reverb  '!$Y$34:$AE$34</c:f>
                <c:numCache>
                  <c:formatCode>General</c:formatCode>
                  <c:ptCount val="7"/>
                  <c:pt idx="0">
                    <c:v>0.16330284924856311</c:v>
                  </c:pt>
                  <c:pt idx="1">
                    <c:v>6.6441171645499938E-2</c:v>
                  </c:pt>
                  <c:pt idx="2">
                    <c:v>9.687299728797634E-2</c:v>
                  </c:pt>
                  <c:pt idx="3">
                    <c:v>0.13360147350234372</c:v>
                  </c:pt>
                  <c:pt idx="4">
                    <c:v>0.21286811726915023</c:v>
                  </c:pt>
                  <c:pt idx="5">
                    <c:v>0.13575967787566051</c:v>
                  </c:pt>
                  <c:pt idx="6">
                    <c:v>0.16330284924856311</c:v>
                  </c:pt>
                </c:numCache>
              </c:numRef>
            </c:plus>
            <c:minus>
              <c:numRef>
                <c:f>'fat reverb  '!$Y$34:$AE$34</c:f>
                <c:numCache>
                  <c:formatCode>General</c:formatCode>
                  <c:ptCount val="7"/>
                  <c:pt idx="0">
                    <c:v>0.16330284924856311</c:v>
                  </c:pt>
                  <c:pt idx="1">
                    <c:v>6.6441171645499938E-2</c:v>
                  </c:pt>
                  <c:pt idx="2">
                    <c:v>9.687299728797634E-2</c:v>
                  </c:pt>
                  <c:pt idx="3">
                    <c:v>0.13360147350234372</c:v>
                  </c:pt>
                  <c:pt idx="4">
                    <c:v>0.21286811726915023</c:v>
                  </c:pt>
                  <c:pt idx="5">
                    <c:v>0.13575967787566051</c:v>
                  </c:pt>
                  <c:pt idx="6">
                    <c:v>0.163302849248563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reverb 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reverb  '!$K$39:$Q$39</c:f>
              <c:numCache>
                <c:formatCode>0.00</c:formatCode>
                <c:ptCount val="7"/>
                <c:pt idx="0">
                  <c:v>2.0344928136357248</c:v>
                </c:pt>
                <c:pt idx="1">
                  <c:v>1.4472747505041368</c:v>
                </c:pt>
                <c:pt idx="2">
                  <c:v>1.7581530675015824</c:v>
                </c:pt>
                <c:pt idx="3">
                  <c:v>1.6822057186479933</c:v>
                </c:pt>
                <c:pt idx="4">
                  <c:v>2.207283956813038</c:v>
                </c:pt>
                <c:pt idx="5">
                  <c:v>1</c:v>
                </c:pt>
                <c:pt idx="6">
                  <c:v>2.034492813635724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3850-4049-A5EF-34EC1A13A857}"/>
            </c:ext>
          </c:extLst>
        </c:ser>
        <c:ser>
          <c:idx val="1"/>
          <c:order val="2"/>
          <c:tx>
            <c:strRef>
              <c:f>'fat reverb  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reverb  '!$R$34:$X$34</c:f>
                <c:numCache>
                  <c:formatCode>General</c:formatCode>
                  <c:ptCount val="7"/>
                  <c:pt idx="0">
                    <c:v>0.12620960034318898</c:v>
                  </c:pt>
                  <c:pt idx="1">
                    <c:v>3.3843587593473522E-2</c:v>
                  </c:pt>
                  <c:pt idx="2">
                    <c:v>0.10820054155626975</c:v>
                  </c:pt>
                  <c:pt idx="3">
                    <c:v>0.15529896486347677</c:v>
                  </c:pt>
                  <c:pt idx="4">
                    <c:v>0.13038821741531445</c:v>
                  </c:pt>
                  <c:pt idx="5">
                    <c:v>0.2415816228740279</c:v>
                  </c:pt>
                  <c:pt idx="6">
                    <c:v>0.12620960034318898</c:v>
                  </c:pt>
                </c:numCache>
              </c:numRef>
            </c:plus>
            <c:minus>
              <c:numRef>
                <c:f>'fat reverb  '!$R$34:$X$34</c:f>
                <c:numCache>
                  <c:formatCode>General</c:formatCode>
                  <c:ptCount val="7"/>
                  <c:pt idx="0">
                    <c:v>0.12620960034318898</c:v>
                  </c:pt>
                  <c:pt idx="1">
                    <c:v>3.3843587593473522E-2</c:v>
                  </c:pt>
                  <c:pt idx="2">
                    <c:v>0.10820054155626975</c:v>
                  </c:pt>
                  <c:pt idx="3">
                    <c:v>0.15529896486347677</c:v>
                  </c:pt>
                  <c:pt idx="4">
                    <c:v>0.13038821741531445</c:v>
                  </c:pt>
                  <c:pt idx="5">
                    <c:v>0.2415816228740279</c:v>
                  </c:pt>
                  <c:pt idx="6">
                    <c:v>0.126209600343188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reverb 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reverb  '!$K$38:$Q$38</c:f>
              <c:numCache>
                <c:formatCode>0.00</c:formatCode>
                <c:ptCount val="7"/>
                <c:pt idx="0">
                  <c:v>1</c:v>
                </c:pt>
                <c:pt idx="1">
                  <c:v>1.6283213285907714</c:v>
                </c:pt>
                <c:pt idx="2">
                  <c:v>1.2250174085197436</c:v>
                </c:pt>
                <c:pt idx="3">
                  <c:v>1.3911294813217177</c:v>
                </c:pt>
                <c:pt idx="4">
                  <c:v>1.0909155104467683</c:v>
                </c:pt>
                <c:pt idx="5">
                  <c:v>1.0354666997579864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3850-4049-A5EF-34EC1A13A857}"/>
            </c:ext>
          </c:extLst>
        </c:ser>
        <c:ser>
          <c:idx val="0"/>
          <c:order val="3"/>
          <c:tx>
            <c:strRef>
              <c:f>'fat reverb  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reverb  '!$K$34:$Q$34</c:f>
                <c:numCache>
                  <c:formatCode>General</c:formatCode>
                  <c:ptCount val="7"/>
                  <c:pt idx="0">
                    <c:v>0.36882765938795742</c:v>
                  </c:pt>
                  <c:pt idx="1">
                    <c:v>0.67912138381221487</c:v>
                  </c:pt>
                  <c:pt idx="2">
                    <c:v>0.35973451754998093</c:v>
                  </c:pt>
                  <c:pt idx="3">
                    <c:v>0.57879158003248399</c:v>
                  </c:pt>
                  <c:pt idx="4">
                    <c:v>0.36720726700466988</c:v>
                  </c:pt>
                  <c:pt idx="5">
                    <c:v>0.37215188498299578</c:v>
                  </c:pt>
                  <c:pt idx="6">
                    <c:v>0.36882765938795742</c:v>
                  </c:pt>
                </c:numCache>
              </c:numRef>
            </c:plus>
            <c:minus>
              <c:numRef>
                <c:f>'fat reverb  '!$K$34:$Q$34</c:f>
                <c:numCache>
                  <c:formatCode>General</c:formatCode>
                  <c:ptCount val="7"/>
                  <c:pt idx="0">
                    <c:v>0.36882765938795742</c:v>
                  </c:pt>
                  <c:pt idx="1">
                    <c:v>0.67912138381221487</c:v>
                  </c:pt>
                  <c:pt idx="2">
                    <c:v>0.35973451754998093</c:v>
                  </c:pt>
                  <c:pt idx="3">
                    <c:v>0.57879158003248399</c:v>
                  </c:pt>
                  <c:pt idx="4">
                    <c:v>0.36720726700466988</c:v>
                  </c:pt>
                  <c:pt idx="5">
                    <c:v>0.37215188498299578</c:v>
                  </c:pt>
                  <c:pt idx="6">
                    <c:v>0.368827659387957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reverb 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reverb  '!$K$37:$Q$37</c:f>
              <c:numCache>
                <c:formatCode>0.00</c:formatCode>
                <c:ptCount val="7"/>
                <c:pt idx="0">
                  <c:v>1</c:v>
                </c:pt>
                <c:pt idx="1">
                  <c:v>3.6949245033805345</c:v>
                </c:pt>
                <c:pt idx="2">
                  <c:v>2.3349849788874795</c:v>
                </c:pt>
                <c:pt idx="3">
                  <c:v>3.2983929883597951</c:v>
                </c:pt>
                <c:pt idx="4">
                  <c:v>2.8665126337380848</c:v>
                </c:pt>
                <c:pt idx="5">
                  <c:v>1.6080693498241843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3850-4049-A5EF-34EC1A13A8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fat  ror  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 ror  '!$AF$34:$AL$34</c:f>
                <c:numCache>
                  <c:formatCode>General</c:formatCode>
                  <c:ptCount val="7"/>
                  <c:pt idx="0">
                    <c:v>3.9587353569148116E-2</c:v>
                  </c:pt>
                  <c:pt idx="1">
                    <c:v>5.6672096638253601E-2</c:v>
                  </c:pt>
                  <c:pt idx="2">
                    <c:v>0.24792191929626758</c:v>
                  </c:pt>
                  <c:pt idx="3">
                    <c:v>0.36313876514540522</c:v>
                  </c:pt>
                  <c:pt idx="4">
                    <c:v>6.5252313869701442E-2</c:v>
                  </c:pt>
                  <c:pt idx="5">
                    <c:v>0.12431779258202322</c:v>
                  </c:pt>
                  <c:pt idx="6">
                    <c:v>3.9587353569148116E-2</c:v>
                  </c:pt>
                </c:numCache>
              </c:numRef>
            </c:plus>
            <c:minus>
              <c:numRef>
                <c:f>'fat  ror  '!$AF$34:$AL$34</c:f>
                <c:numCache>
                  <c:formatCode>General</c:formatCode>
                  <c:ptCount val="7"/>
                  <c:pt idx="0">
                    <c:v>3.9587353569148116E-2</c:v>
                  </c:pt>
                  <c:pt idx="1">
                    <c:v>5.6672096638253601E-2</c:v>
                  </c:pt>
                  <c:pt idx="2">
                    <c:v>0.24792191929626758</c:v>
                  </c:pt>
                  <c:pt idx="3">
                    <c:v>0.36313876514540522</c:v>
                  </c:pt>
                  <c:pt idx="4">
                    <c:v>6.5252313869701442E-2</c:v>
                  </c:pt>
                  <c:pt idx="5">
                    <c:v>0.12431779258202322</c:v>
                  </c:pt>
                  <c:pt idx="6">
                    <c:v>3.958735356914811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 ror 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 ror  '!$K$40:$Q$40</c:f>
              <c:numCache>
                <c:formatCode>0.00</c:formatCode>
                <c:ptCount val="7"/>
                <c:pt idx="0">
                  <c:v>1.5097218085521291</c:v>
                </c:pt>
                <c:pt idx="1">
                  <c:v>1.2344769439090713</c:v>
                </c:pt>
                <c:pt idx="2">
                  <c:v>1</c:v>
                </c:pt>
                <c:pt idx="3">
                  <c:v>1.882739370943163</c:v>
                </c:pt>
                <c:pt idx="4">
                  <c:v>1.4545614117893846</c:v>
                </c:pt>
                <c:pt idx="5">
                  <c:v>1.0227061139632194</c:v>
                </c:pt>
                <c:pt idx="6">
                  <c:v>1.509721808552129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78D-4502-BBE2-CC17CF569147}"/>
            </c:ext>
          </c:extLst>
        </c:ser>
        <c:ser>
          <c:idx val="2"/>
          <c:order val="1"/>
          <c:tx>
            <c:strRef>
              <c:f>'fat  ror  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 ror  '!$Y$34:$AE$34</c:f>
                <c:numCache>
                  <c:formatCode>General</c:formatCode>
                  <c:ptCount val="7"/>
                  <c:pt idx="0">
                    <c:v>0.10830589974897036</c:v>
                  </c:pt>
                  <c:pt idx="1">
                    <c:v>6.2756893545507536E-2</c:v>
                  </c:pt>
                  <c:pt idx="2">
                    <c:v>2.2672463568876089E-2</c:v>
                  </c:pt>
                  <c:pt idx="3">
                    <c:v>8.2724102378385136E-2</c:v>
                  </c:pt>
                  <c:pt idx="4">
                    <c:v>0.25385533584959896</c:v>
                  </c:pt>
                  <c:pt idx="5">
                    <c:v>4.2697456341608882E-2</c:v>
                  </c:pt>
                  <c:pt idx="6">
                    <c:v>0.10830589974897036</c:v>
                  </c:pt>
                </c:numCache>
              </c:numRef>
            </c:plus>
            <c:minus>
              <c:numRef>
                <c:f>'fat  ror  '!$Y$34:$AE$34</c:f>
                <c:numCache>
                  <c:formatCode>General</c:formatCode>
                  <c:ptCount val="7"/>
                  <c:pt idx="0">
                    <c:v>0.10830589974897036</c:v>
                  </c:pt>
                  <c:pt idx="1">
                    <c:v>6.2756893545507536E-2</c:v>
                  </c:pt>
                  <c:pt idx="2">
                    <c:v>2.2672463568876089E-2</c:v>
                  </c:pt>
                  <c:pt idx="3">
                    <c:v>8.2724102378385136E-2</c:v>
                  </c:pt>
                  <c:pt idx="4">
                    <c:v>0.25385533584959896</c:v>
                  </c:pt>
                  <c:pt idx="5">
                    <c:v>4.2697456341608882E-2</c:v>
                  </c:pt>
                  <c:pt idx="6">
                    <c:v>0.108305899748970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 ror 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 ror  '!$K$39:$Q$39</c:f>
              <c:numCache>
                <c:formatCode>0.00</c:formatCode>
                <c:ptCount val="7"/>
                <c:pt idx="0">
                  <c:v>1</c:v>
                </c:pt>
                <c:pt idx="1">
                  <c:v>1.4412326841008225</c:v>
                </c:pt>
                <c:pt idx="2">
                  <c:v>1.0523735772772471</c:v>
                </c:pt>
                <c:pt idx="3">
                  <c:v>1.3674551973002451</c:v>
                </c:pt>
                <c:pt idx="4">
                  <c:v>1.485538233970191</c:v>
                </c:pt>
                <c:pt idx="5">
                  <c:v>1.1661867392213565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F78D-4502-BBE2-CC17CF569147}"/>
            </c:ext>
          </c:extLst>
        </c:ser>
        <c:ser>
          <c:idx val="1"/>
          <c:order val="2"/>
          <c:tx>
            <c:strRef>
              <c:f>'fat  ror  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 ror  '!$R$34:$X$34</c:f>
                <c:numCache>
                  <c:formatCode>General</c:formatCode>
                  <c:ptCount val="7"/>
                  <c:pt idx="0">
                    <c:v>0.70760063076356394</c:v>
                  </c:pt>
                  <c:pt idx="1">
                    <c:v>7.5988893799287888E-2</c:v>
                  </c:pt>
                  <c:pt idx="2">
                    <c:v>1.1287503139921315</c:v>
                  </c:pt>
                  <c:pt idx="3">
                    <c:v>0.23396822749153473</c:v>
                  </c:pt>
                  <c:pt idx="4">
                    <c:v>0.41445014296403804</c:v>
                  </c:pt>
                  <c:pt idx="5">
                    <c:v>0.47075617593442765</c:v>
                  </c:pt>
                  <c:pt idx="6">
                    <c:v>0.70760063076356394</c:v>
                  </c:pt>
                </c:numCache>
              </c:numRef>
            </c:plus>
            <c:minus>
              <c:numRef>
                <c:f>'fat  ror  '!$R$34:$X$34</c:f>
                <c:numCache>
                  <c:formatCode>General</c:formatCode>
                  <c:ptCount val="7"/>
                  <c:pt idx="0">
                    <c:v>0.70760063076356394</c:v>
                  </c:pt>
                  <c:pt idx="1">
                    <c:v>7.5988893799287888E-2</c:v>
                  </c:pt>
                  <c:pt idx="2">
                    <c:v>1.1287503139921315</c:v>
                  </c:pt>
                  <c:pt idx="3">
                    <c:v>0.23396822749153473</c:v>
                  </c:pt>
                  <c:pt idx="4">
                    <c:v>0.41445014296403804</c:v>
                  </c:pt>
                  <c:pt idx="5">
                    <c:v>0.47075617593442765</c:v>
                  </c:pt>
                  <c:pt idx="6">
                    <c:v>0.707600630763563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 ror 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 ror  '!$K$38:$Q$38</c:f>
              <c:numCache>
                <c:formatCode>0.00</c:formatCode>
                <c:ptCount val="7"/>
                <c:pt idx="0">
                  <c:v>4.9027346494679387</c:v>
                </c:pt>
                <c:pt idx="1">
                  <c:v>1</c:v>
                </c:pt>
                <c:pt idx="2">
                  <c:v>5.0680931614491103</c:v>
                </c:pt>
                <c:pt idx="3">
                  <c:v>2.4370933134673116</c:v>
                </c:pt>
                <c:pt idx="4">
                  <c:v>3.1076988250479327</c:v>
                </c:pt>
                <c:pt idx="5">
                  <c:v>4.4728649545284824</c:v>
                </c:pt>
                <c:pt idx="6">
                  <c:v>4.902734649467938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F78D-4502-BBE2-CC17CF569147}"/>
            </c:ext>
          </c:extLst>
        </c:ser>
        <c:ser>
          <c:idx val="0"/>
          <c:order val="3"/>
          <c:tx>
            <c:strRef>
              <c:f>'fat  ror  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 ror  '!$K$34:$Q$34</c:f>
                <c:numCache>
                  <c:formatCode>General</c:formatCode>
                  <c:ptCount val="7"/>
                  <c:pt idx="0">
                    <c:v>0.24438507882010468</c:v>
                  </c:pt>
                  <c:pt idx="1">
                    <c:v>3.2897973395091436E-2</c:v>
                  </c:pt>
                  <c:pt idx="2">
                    <c:v>0.15238236168108166</c:v>
                  </c:pt>
                  <c:pt idx="3">
                    <c:v>6.4964423145533856E-2</c:v>
                  </c:pt>
                  <c:pt idx="4">
                    <c:v>0.29722165820104379</c:v>
                  </c:pt>
                  <c:pt idx="5">
                    <c:v>0.22764496457709119</c:v>
                  </c:pt>
                  <c:pt idx="6">
                    <c:v>0.24438507882010468</c:v>
                  </c:pt>
                </c:numCache>
              </c:numRef>
            </c:plus>
            <c:minus>
              <c:numRef>
                <c:f>'fat  ror  '!$K$34:$Q$34</c:f>
                <c:numCache>
                  <c:formatCode>General</c:formatCode>
                  <c:ptCount val="7"/>
                  <c:pt idx="0">
                    <c:v>0.24438507882010468</c:v>
                  </c:pt>
                  <c:pt idx="1">
                    <c:v>3.2897973395091436E-2</c:v>
                  </c:pt>
                  <c:pt idx="2">
                    <c:v>0.15238236168108166</c:v>
                  </c:pt>
                  <c:pt idx="3">
                    <c:v>6.4964423145533856E-2</c:v>
                  </c:pt>
                  <c:pt idx="4">
                    <c:v>0.29722165820104379</c:v>
                  </c:pt>
                  <c:pt idx="5">
                    <c:v>0.22764496457709119</c:v>
                  </c:pt>
                  <c:pt idx="6">
                    <c:v>0.244385078820104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 ror 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 ror  '!$K$37:$Q$37</c:f>
              <c:numCache>
                <c:formatCode>0.00</c:formatCode>
                <c:ptCount val="7"/>
                <c:pt idx="0">
                  <c:v>1</c:v>
                </c:pt>
                <c:pt idx="1">
                  <c:v>1.3762328433656128</c:v>
                </c:pt>
                <c:pt idx="2">
                  <c:v>1.306281986800917</c:v>
                </c:pt>
                <c:pt idx="3">
                  <c:v>1.0079869283553275</c:v>
                </c:pt>
                <c:pt idx="4">
                  <c:v>2.3925161886165887</c:v>
                </c:pt>
                <c:pt idx="5">
                  <c:v>1.699666518000855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F78D-4502-BBE2-CC17CF5691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fat per1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per1'!$AG$34:$AL$34</c:f>
                <c:numCache>
                  <c:formatCode>General</c:formatCode>
                  <c:ptCount val="6"/>
                  <c:pt idx="0">
                    <c:v>6.709601418113241E-2</c:v>
                  </c:pt>
                  <c:pt idx="1">
                    <c:v>8.9382082984545752E-2</c:v>
                  </c:pt>
                  <c:pt idx="2">
                    <c:v>8.4634279319483266E-2</c:v>
                  </c:pt>
                  <c:pt idx="3">
                    <c:v>3.0651577379555147E-2</c:v>
                  </c:pt>
                  <c:pt idx="4">
                    <c:v>5.8225732363089144E-2</c:v>
                  </c:pt>
                  <c:pt idx="5">
                    <c:v>0.14332934096219382</c:v>
                  </c:pt>
                </c:numCache>
              </c:numRef>
            </c:plus>
            <c:minus>
              <c:numRef>
                <c:f>'fat per1'!$AG$34:$AL$34</c:f>
                <c:numCache>
                  <c:formatCode>General</c:formatCode>
                  <c:ptCount val="6"/>
                  <c:pt idx="0">
                    <c:v>6.709601418113241E-2</c:v>
                  </c:pt>
                  <c:pt idx="1">
                    <c:v>8.9382082984545752E-2</c:v>
                  </c:pt>
                  <c:pt idx="2">
                    <c:v>8.4634279319483266E-2</c:v>
                  </c:pt>
                  <c:pt idx="3">
                    <c:v>3.0651577379555147E-2</c:v>
                  </c:pt>
                  <c:pt idx="4">
                    <c:v>5.8225732363089144E-2</c:v>
                  </c:pt>
                  <c:pt idx="5">
                    <c:v>0.143329340962193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per1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per1'!$K$40:$Q$40</c:f>
              <c:numCache>
                <c:formatCode>0.00</c:formatCode>
                <c:ptCount val="7"/>
                <c:pt idx="0">
                  <c:v>3.705087589822448</c:v>
                </c:pt>
                <c:pt idx="1">
                  <c:v>1.3905249265077995</c:v>
                </c:pt>
                <c:pt idx="2">
                  <c:v>1.939062647121671</c:v>
                </c:pt>
                <c:pt idx="3">
                  <c:v>1.4411119589888999</c:v>
                </c:pt>
                <c:pt idx="4">
                  <c:v>1</c:v>
                </c:pt>
                <c:pt idx="5">
                  <c:v>1.8894222794668296</c:v>
                </c:pt>
                <c:pt idx="6">
                  <c:v>3.70508758982244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AA4-4FE3-9852-DD53AB48C747}"/>
            </c:ext>
          </c:extLst>
        </c:ser>
        <c:ser>
          <c:idx val="2"/>
          <c:order val="1"/>
          <c:tx>
            <c:strRef>
              <c:f>'fat per1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per1'!$Z$34:$AE$34</c:f>
                <c:numCache>
                  <c:formatCode>General</c:formatCode>
                  <c:ptCount val="6"/>
                  <c:pt idx="0">
                    <c:v>0.17669586809195359</c:v>
                  </c:pt>
                  <c:pt idx="1">
                    <c:v>4.7277083871653157E-2</c:v>
                  </c:pt>
                  <c:pt idx="2">
                    <c:v>7.4099380269717047E-2</c:v>
                  </c:pt>
                  <c:pt idx="3">
                    <c:v>0.10805502266242419</c:v>
                  </c:pt>
                  <c:pt idx="4">
                    <c:v>0.11746454470044837</c:v>
                  </c:pt>
                  <c:pt idx="5">
                    <c:v>3.300156305850014E-2</c:v>
                  </c:pt>
                </c:numCache>
              </c:numRef>
            </c:plus>
            <c:minus>
              <c:numRef>
                <c:f>'fat per1'!$Z$34:$AE$34</c:f>
                <c:numCache>
                  <c:formatCode>General</c:formatCode>
                  <c:ptCount val="6"/>
                  <c:pt idx="0">
                    <c:v>0.17669586809195359</c:v>
                  </c:pt>
                  <c:pt idx="1">
                    <c:v>4.7277083871653157E-2</c:v>
                  </c:pt>
                  <c:pt idx="2">
                    <c:v>7.4099380269717047E-2</c:v>
                  </c:pt>
                  <c:pt idx="3">
                    <c:v>0.10805502266242419</c:v>
                  </c:pt>
                  <c:pt idx="4">
                    <c:v>0.11746454470044837</c:v>
                  </c:pt>
                  <c:pt idx="5">
                    <c:v>3.30015630585001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per1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per1'!$K$39:$Q$39</c:f>
              <c:numCache>
                <c:formatCode>0.00</c:formatCode>
                <c:ptCount val="7"/>
                <c:pt idx="0">
                  <c:v>1.3661901726386143</c:v>
                </c:pt>
                <c:pt idx="1">
                  <c:v>1.412096249407603</c:v>
                </c:pt>
                <c:pt idx="2">
                  <c:v>1.4747928957311625</c:v>
                </c:pt>
                <c:pt idx="3">
                  <c:v>1</c:v>
                </c:pt>
                <c:pt idx="4">
                  <c:v>2.5161327470768451</c:v>
                </c:pt>
                <c:pt idx="5">
                  <c:v>2.1305721681263914</c:v>
                </c:pt>
                <c:pt idx="6">
                  <c:v>1.366190172638614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AA4-4FE3-9852-DD53AB48C747}"/>
            </c:ext>
          </c:extLst>
        </c:ser>
        <c:ser>
          <c:idx val="1"/>
          <c:order val="2"/>
          <c:tx>
            <c:strRef>
              <c:f>'fat per1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per1'!$S$34:$X$34</c:f>
                <c:numCache>
                  <c:formatCode>General</c:formatCode>
                  <c:ptCount val="6"/>
                  <c:pt idx="0">
                    <c:v>0.32348285835609397</c:v>
                  </c:pt>
                  <c:pt idx="1">
                    <c:v>0.21479013655629453</c:v>
                  </c:pt>
                  <c:pt idx="2">
                    <c:v>0.14171300046442284</c:v>
                  </c:pt>
                  <c:pt idx="3">
                    <c:v>0.12709390993566957</c:v>
                  </c:pt>
                  <c:pt idx="4">
                    <c:v>6.7328296041739705E-2</c:v>
                  </c:pt>
                  <c:pt idx="5">
                    <c:v>6.8065747793059114E-2</c:v>
                  </c:pt>
                </c:numCache>
              </c:numRef>
            </c:plus>
            <c:minus>
              <c:numRef>
                <c:f>'fat per1'!$S$34:$X$34</c:f>
                <c:numCache>
                  <c:formatCode>General</c:formatCode>
                  <c:ptCount val="6"/>
                  <c:pt idx="0">
                    <c:v>0.32348285835609397</c:v>
                  </c:pt>
                  <c:pt idx="1">
                    <c:v>0.21479013655629453</c:v>
                  </c:pt>
                  <c:pt idx="2">
                    <c:v>0.14171300046442284</c:v>
                  </c:pt>
                  <c:pt idx="3">
                    <c:v>0.12709390993566957</c:v>
                  </c:pt>
                  <c:pt idx="4">
                    <c:v>6.7328296041739705E-2</c:v>
                  </c:pt>
                  <c:pt idx="5">
                    <c:v>6.806574779305911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per1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per1'!$K$38:$Q$38</c:f>
              <c:numCache>
                <c:formatCode>0.00</c:formatCode>
                <c:ptCount val="7"/>
                <c:pt idx="0">
                  <c:v>1.0467338774351427</c:v>
                </c:pt>
                <c:pt idx="1">
                  <c:v>2.2607771781681141</c:v>
                </c:pt>
                <c:pt idx="2">
                  <c:v>1.7610546319980371</c:v>
                </c:pt>
                <c:pt idx="3">
                  <c:v>1.6751733287089889</c:v>
                </c:pt>
                <c:pt idx="4">
                  <c:v>1.2917935110673755</c:v>
                </c:pt>
                <c:pt idx="5">
                  <c:v>1</c:v>
                </c:pt>
                <c:pt idx="6">
                  <c:v>1.046733877435142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CAA4-4FE3-9852-DD53AB48C747}"/>
            </c:ext>
          </c:extLst>
        </c:ser>
        <c:ser>
          <c:idx val="0"/>
          <c:order val="3"/>
          <c:tx>
            <c:strRef>
              <c:f>'fat per1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per1'!$L$34:$Q$34</c:f>
                <c:numCache>
                  <c:formatCode>General</c:formatCode>
                  <c:ptCount val="6"/>
                  <c:pt idx="0">
                    <c:v>0.31183691595018143</c:v>
                  </c:pt>
                  <c:pt idx="1">
                    <c:v>0.157827296065917</c:v>
                  </c:pt>
                  <c:pt idx="2">
                    <c:v>7.7171969899128917E-2</c:v>
                  </c:pt>
                  <c:pt idx="3">
                    <c:v>0.1804078189807562</c:v>
                  </c:pt>
                  <c:pt idx="4">
                    <c:v>0.15826368262730384</c:v>
                  </c:pt>
                  <c:pt idx="5">
                    <c:v>7.1553916746255497E-2</c:v>
                  </c:pt>
                </c:numCache>
              </c:numRef>
            </c:plus>
            <c:minus>
              <c:numRef>
                <c:f>'fat per1'!$L$34:$Q$34</c:f>
                <c:numCache>
                  <c:formatCode>General</c:formatCode>
                  <c:ptCount val="6"/>
                  <c:pt idx="0">
                    <c:v>0.31183691595018143</c:v>
                  </c:pt>
                  <c:pt idx="1">
                    <c:v>0.157827296065917</c:v>
                  </c:pt>
                  <c:pt idx="2">
                    <c:v>7.7171969899128917E-2</c:v>
                  </c:pt>
                  <c:pt idx="3">
                    <c:v>0.1804078189807562</c:v>
                  </c:pt>
                  <c:pt idx="4">
                    <c:v>0.15826368262730384</c:v>
                  </c:pt>
                  <c:pt idx="5">
                    <c:v>7.15539167462554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per1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per1'!$K$37:$Q$37</c:f>
              <c:numCache>
                <c:formatCode>0.00</c:formatCode>
                <c:ptCount val="7"/>
                <c:pt idx="0">
                  <c:v>1</c:v>
                </c:pt>
                <c:pt idx="1">
                  <c:v>2.1262191719269463</c:v>
                </c:pt>
                <c:pt idx="2">
                  <c:v>1.2971751270031355</c:v>
                </c:pt>
                <c:pt idx="3">
                  <c:v>1.0186919962777055</c:v>
                </c:pt>
                <c:pt idx="4">
                  <c:v>2.8789679215368102</c:v>
                </c:pt>
                <c:pt idx="5">
                  <c:v>1.902489499721592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CAA4-4FE3-9852-DD53AB48C7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.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fat cry1  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cry1  '!$AG$34:$AL$34</c:f>
                <c:numCache>
                  <c:formatCode>General</c:formatCode>
                  <c:ptCount val="6"/>
                  <c:pt idx="0">
                    <c:v>3.0651577379555147E-2</c:v>
                  </c:pt>
                  <c:pt idx="1">
                    <c:v>6.709601418113241E-2</c:v>
                  </c:pt>
                  <c:pt idx="2">
                    <c:v>8.9382082984545752E-2</c:v>
                  </c:pt>
                  <c:pt idx="3">
                    <c:v>0.14332934096219382</c:v>
                  </c:pt>
                  <c:pt idx="4">
                    <c:v>8.4634279319483266E-2</c:v>
                  </c:pt>
                  <c:pt idx="5">
                    <c:v>5.8225732363089144E-2</c:v>
                  </c:pt>
                </c:numCache>
              </c:numRef>
            </c:plus>
            <c:minus>
              <c:numRef>
                <c:f>'fat cry1  '!$AG$34:$AL$34</c:f>
                <c:numCache>
                  <c:formatCode>General</c:formatCode>
                  <c:ptCount val="6"/>
                  <c:pt idx="0">
                    <c:v>3.0651577379555147E-2</c:v>
                  </c:pt>
                  <c:pt idx="1">
                    <c:v>6.709601418113241E-2</c:v>
                  </c:pt>
                  <c:pt idx="2">
                    <c:v>8.9382082984545752E-2</c:v>
                  </c:pt>
                  <c:pt idx="3">
                    <c:v>0.14332934096219382</c:v>
                  </c:pt>
                  <c:pt idx="4">
                    <c:v>8.4634279319483266E-2</c:v>
                  </c:pt>
                  <c:pt idx="5">
                    <c:v>5.822573236308914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cry1 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cry1  '!$K$40:$Q$40</c:f>
              <c:numCache>
                <c:formatCode>0.00</c:formatCode>
                <c:ptCount val="7"/>
                <c:pt idx="0">
                  <c:v>1.8894222794668296</c:v>
                </c:pt>
                <c:pt idx="1">
                  <c:v>1</c:v>
                </c:pt>
                <c:pt idx="2">
                  <c:v>1.3905249265077995</c:v>
                </c:pt>
                <c:pt idx="3">
                  <c:v>1.939062647121671</c:v>
                </c:pt>
                <c:pt idx="4">
                  <c:v>3.705087589822448</c:v>
                </c:pt>
                <c:pt idx="5">
                  <c:v>1.4411119589888999</c:v>
                </c:pt>
                <c:pt idx="6">
                  <c:v>1.88942227946682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C39-411F-9629-264B0AFBF872}"/>
            </c:ext>
          </c:extLst>
        </c:ser>
        <c:ser>
          <c:idx val="2"/>
          <c:order val="1"/>
          <c:tx>
            <c:strRef>
              <c:f>'fat cry1  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cry1  '!$Z$34:$AE$34</c:f>
                <c:numCache>
                  <c:formatCode>General</c:formatCode>
                  <c:ptCount val="6"/>
                  <c:pt idx="0">
                    <c:v>0.15297940177284466</c:v>
                  </c:pt>
                  <c:pt idx="1">
                    <c:v>0.11870770443545087</c:v>
                  </c:pt>
                  <c:pt idx="2">
                    <c:v>0.18782262594116106</c:v>
                  </c:pt>
                  <c:pt idx="3">
                    <c:v>1.812723243797534E-2</c:v>
                  </c:pt>
                  <c:pt idx="4">
                    <c:v>6.9093766122570469E-2</c:v>
                  </c:pt>
                  <c:pt idx="5">
                    <c:v>3.7623714367486058E-2</c:v>
                  </c:pt>
                </c:numCache>
              </c:numRef>
            </c:plus>
            <c:minus>
              <c:numRef>
                <c:f>'fat cry1  '!$Z$34:$AE$34</c:f>
                <c:numCache>
                  <c:formatCode>General</c:formatCode>
                  <c:ptCount val="6"/>
                  <c:pt idx="0">
                    <c:v>0.15297940177284466</c:v>
                  </c:pt>
                  <c:pt idx="1">
                    <c:v>0.11870770443545087</c:v>
                  </c:pt>
                  <c:pt idx="2">
                    <c:v>0.18782262594116106</c:v>
                  </c:pt>
                  <c:pt idx="3">
                    <c:v>1.812723243797534E-2</c:v>
                  </c:pt>
                  <c:pt idx="4">
                    <c:v>6.9093766122570469E-2</c:v>
                  </c:pt>
                  <c:pt idx="5">
                    <c:v>3.762371436748605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cry1 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cry1  '!$K$39:$Q$39</c:f>
              <c:numCache>
                <c:formatCode>0.00</c:formatCode>
                <c:ptCount val="7"/>
                <c:pt idx="0">
                  <c:v>1</c:v>
                </c:pt>
                <c:pt idx="1">
                  <c:v>2.8017850103891826</c:v>
                </c:pt>
                <c:pt idx="2">
                  <c:v>1.8135299959107452</c:v>
                </c:pt>
                <c:pt idx="3">
                  <c:v>2.8531706870721889</c:v>
                </c:pt>
                <c:pt idx="4">
                  <c:v>1.427447242823938</c:v>
                </c:pt>
                <c:pt idx="5">
                  <c:v>1.3644950048754356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C39-411F-9629-264B0AFBF872}"/>
            </c:ext>
          </c:extLst>
        </c:ser>
        <c:ser>
          <c:idx val="1"/>
          <c:order val="2"/>
          <c:tx>
            <c:strRef>
              <c:f>'fat cry1  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cry1  '!$S$34:$X$34</c:f>
                <c:numCache>
                  <c:formatCode>General</c:formatCode>
                  <c:ptCount val="6"/>
                  <c:pt idx="0">
                    <c:v>7.5404843734877783E-2</c:v>
                  </c:pt>
                  <c:pt idx="1">
                    <c:v>0.29316360171611455</c:v>
                  </c:pt>
                  <c:pt idx="2">
                    <c:v>8.6149901739098964E-2</c:v>
                  </c:pt>
                  <c:pt idx="3">
                    <c:v>0.52130798526504873</c:v>
                  </c:pt>
                  <c:pt idx="4">
                    <c:v>0.1625074285537538</c:v>
                  </c:pt>
                  <c:pt idx="5">
                    <c:v>8.5470753593857848E-2</c:v>
                  </c:pt>
                </c:numCache>
              </c:numRef>
            </c:plus>
            <c:minus>
              <c:numRef>
                <c:f>'fat cry1  '!$S$34:$X$34</c:f>
                <c:numCache>
                  <c:formatCode>General</c:formatCode>
                  <c:ptCount val="6"/>
                  <c:pt idx="0">
                    <c:v>7.5404843734877783E-2</c:v>
                  </c:pt>
                  <c:pt idx="1">
                    <c:v>0.29316360171611455</c:v>
                  </c:pt>
                  <c:pt idx="2">
                    <c:v>8.6149901739098964E-2</c:v>
                  </c:pt>
                  <c:pt idx="3">
                    <c:v>0.52130798526504873</c:v>
                  </c:pt>
                  <c:pt idx="4">
                    <c:v>0.1625074285537538</c:v>
                  </c:pt>
                  <c:pt idx="5">
                    <c:v>8.547075359385784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cry1 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cry1  '!$K$38:$Q$38</c:f>
              <c:numCache>
                <c:formatCode>0.00</c:formatCode>
                <c:ptCount val="7"/>
                <c:pt idx="0">
                  <c:v>1.617890212682692</c:v>
                </c:pt>
                <c:pt idx="1">
                  <c:v>1</c:v>
                </c:pt>
                <c:pt idx="2">
                  <c:v>1.7516574724384064</c:v>
                </c:pt>
                <c:pt idx="3">
                  <c:v>1.4658486725368405</c:v>
                </c:pt>
                <c:pt idx="4">
                  <c:v>3.6126234502927956</c:v>
                </c:pt>
                <c:pt idx="5">
                  <c:v>2.0291552989161139</c:v>
                </c:pt>
                <c:pt idx="6">
                  <c:v>1.61789021268269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CC39-411F-9629-264B0AFBF872}"/>
            </c:ext>
          </c:extLst>
        </c:ser>
        <c:ser>
          <c:idx val="0"/>
          <c:order val="3"/>
          <c:tx>
            <c:strRef>
              <c:f>'fat cry1  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cry1  '!$L$34:$Q$34</c:f>
                <c:numCache>
                  <c:formatCode>General</c:formatCode>
                  <c:ptCount val="6"/>
                  <c:pt idx="0">
                    <c:v>0.25044349705497027</c:v>
                  </c:pt>
                  <c:pt idx="1">
                    <c:v>0.16154491091733467</c:v>
                  </c:pt>
                  <c:pt idx="2">
                    <c:v>6.1199274506568049E-2</c:v>
                  </c:pt>
                  <c:pt idx="3">
                    <c:v>3.6685097940867627E-2</c:v>
                  </c:pt>
                  <c:pt idx="4">
                    <c:v>8.2314106342264534E-2</c:v>
                  </c:pt>
                  <c:pt idx="5">
                    <c:v>0.23155352652939196</c:v>
                  </c:pt>
                </c:numCache>
              </c:numRef>
            </c:plus>
            <c:minus>
              <c:numRef>
                <c:f>'fat cry1  '!$L$34:$Q$34</c:f>
                <c:numCache>
                  <c:formatCode>General</c:formatCode>
                  <c:ptCount val="6"/>
                  <c:pt idx="0">
                    <c:v>0.25044349705497027</c:v>
                  </c:pt>
                  <c:pt idx="1">
                    <c:v>0.16154491091733467</c:v>
                  </c:pt>
                  <c:pt idx="2">
                    <c:v>6.1199274506568049E-2</c:v>
                  </c:pt>
                  <c:pt idx="3">
                    <c:v>3.6685097940867627E-2</c:v>
                  </c:pt>
                  <c:pt idx="4">
                    <c:v>8.2314106342264534E-2</c:v>
                  </c:pt>
                  <c:pt idx="5">
                    <c:v>0.231553526529391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cry1 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cry1  '!$K$37:$Q$37</c:f>
              <c:numCache>
                <c:formatCode>0.00</c:formatCode>
                <c:ptCount val="7"/>
                <c:pt idx="0">
                  <c:v>2.4899573743218819</c:v>
                </c:pt>
                <c:pt idx="1">
                  <c:v>2.2633372818594655</c:v>
                </c:pt>
                <c:pt idx="2">
                  <c:v>1.206719296322099</c:v>
                </c:pt>
                <c:pt idx="3">
                  <c:v>1</c:v>
                </c:pt>
                <c:pt idx="4">
                  <c:v>1.0915217186376627</c:v>
                </c:pt>
                <c:pt idx="5">
                  <c:v>1.1700898645010041</c:v>
                </c:pt>
                <c:pt idx="6">
                  <c:v>2.489957374321881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CC39-411F-9629-264B0AFBF8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fat bmal 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bmal '!$AF$34:$AL$34</c:f>
                <c:numCache>
                  <c:formatCode>General</c:formatCode>
                  <c:ptCount val="7"/>
                  <c:pt idx="0">
                    <c:v>9.4454928218009493E-2</c:v>
                  </c:pt>
                  <c:pt idx="1">
                    <c:v>9.317085659958034E-2</c:v>
                  </c:pt>
                  <c:pt idx="2">
                    <c:v>0.15996445720586183</c:v>
                  </c:pt>
                  <c:pt idx="3">
                    <c:v>0.39968199958947603</c:v>
                  </c:pt>
                  <c:pt idx="4">
                    <c:v>0.15623347925114034</c:v>
                  </c:pt>
                  <c:pt idx="5">
                    <c:v>4.327734514789229E-2</c:v>
                  </c:pt>
                  <c:pt idx="6">
                    <c:v>9.4454928218009493E-2</c:v>
                  </c:pt>
                </c:numCache>
              </c:numRef>
            </c:plus>
            <c:minus>
              <c:numRef>
                <c:f>'fat bmal '!$AF$34:$AL$34</c:f>
                <c:numCache>
                  <c:formatCode>General</c:formatCode>
                  <c:ptCount val="7"/>
                  <c:pt idx="0">
                    <c:v>9.4454928218009493E-2</c:v>
                  </c:pt>
                  <c:pt idx="1">
                    <c:v>9.317085659958034E-2</c:v>
                  </c:pt>
                  <c:pt idx="2">
                    <c:v>0.15996445720586183</c:v>
                  </c:pt>
                  <c:pt idx="3">
                    <c:v>0.39968199958947603</c:v>
                  </c:pt>
                  <c:pt idx="4">
                    <c:v>0.15623347925114034</c:v>
                  </c:pt>
                  <c:pt idx="5">
                    <c:v>4.327734514789229E-2</c:v>
                  </c:pt>
                  <c:pt idx="6">
                    <c:v>9.44549282180094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bmal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bmal '!$K$40:$Q$40</c:f>
              <c:numCache>
                <c:formatCode>0.00</c:formatCode>
                <c:ptCount val="7"/>
                <c:pt idx="0">
                  <c:v>1</c:v>
                </c:pt>
                <c:pt idx="1">
                  <c:v>1.0429516711759501</c:v>
                </c:pt>
                <c:pt idx="2">
                  <c:v>1.1296614212276483</c:v>
                </c:pt>
                <c:pt idx="3">
                  <c:v>1.6286956233685541</c:v>
                </c:pt>
                <c:pt idx="4">
                  <c:v>1.1297173485315239</c:v>
                </c:pt>
                <c:pt idx="5">
                  <c:v>1.305401106996658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37F-450F-A36C-89203820D74F}"/>
            </c:ext>
          </c:extLst>
        </c:ser>
        <c:ser>
          <c:idx val="2"/>
          <c:order val="1"/>
          <c:tx>
            <c:strRef>
              <c:f>'fat bmal 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bmal '!$Y$34:$AE$34</c:f>
                <c:numCache>
                  <c:formatCode>General</c:formatCode>
                  <c:ptCount val="7"/>
                  <c:pt idx="0">
                    <c:v>8.2619062889559364E-2</c:v>
                  </c:pt>
                  <c:pt idx="1">
                    <c:v>0.38320075912363949</c:v>
                  </c:pt>
                  <c:pt idx="2">
                    <c:v>0.22969291345364218</c:v>
                  </c:pt>
                  <c:pt idx="3">
                    <c:v>7.7654906498426712E-2</c:v>
                  </c:pt>
                  <c:pt idx="4">
                    <c:v>0.15373372077226322</c:v>
                  </c:pt>
                  <c:pt idx="5">
                    <c:v>0.31291974958530727</c:v>
                  </c:pt>
                  <c:pt idx="6">
                    <c:v>8.2619062889559364E-2</c:v>
                  </c:pt>
                </c:numCache>
              </c:numRef>
            </c:plus>
            <c:minus>
              <c:numRef>
                <c:f>'fat bmal '!$Y$34:$AE$34</c:f>
                <c:numCache>
                  <c:formatCode>General</c:formatCode>
                  <c:ptCount val="7"/>
                  <c:pt idx="0">
                    <c:v>8.2619062889559364E-2</c:v>
                  </c:pt>
                  <c:pt idx="1">
                    <c:v>0.38320075912363949</c:v>
                  </c:pt>
                  <c:pt idx="2">
                    <c:v>0.22969291345364218</c:v>
                  </c:pt>
                  <c:pt idx="3">
                    <c:v>7.7654906498426712E-2</c:v>
                  </c:pt>
                  <c:pt idx="4">
                    <c:v>0.15373372077226322</c:v>
                  </c:pt>
                  <c:pt idx="5">
                    <c:v>0.31291974958530727</c:v>
                  </c:pt>
                  <c:pt idx="6">
                    <c:v>8.261906288955936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bmal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bmal '!$K$39:$Q$39</c:f>
              <c:numCache>
                <c:formatCode>0.00</c:formatCode>
                <c:ptCount val="7"/>
                <c:pt idx="0">
                  <c:v>1.2358821372738131</c:v>
                </c:pt>
                <c:pt idx="1">
                  <c:v>2.5358936882975898</c:v>
                </c:pt>
                <c:pt idx="2">
                  <c:v>2.0481628698672338</c:v>
                </c:pt>
                <c:pt idx="3">
                  <c:v>1.4718892021713221</c:v>
                </c:pt>
                <c:pt idx="4">
                  <c:v>1</c:v>
                </c:pt>
                <c:pt idx="5">
                  <c:v>1.5110751740448429</c:v>
                </c:pt>
                <c:pt idx="6">
                  <c:v>1.235882137273813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37F-450F-A36C-89203820D74F}"/>
            </c:ext>
          </c:extLst>
        </c:ser>
        <c:ser>
          <c:idx val="1"/>
          <c:order val="2"/>
          <c:tx>
            <c:strRef>
              <c:f>'fat bmal 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bmal '!$R$34:$X$34</c:f>
                <c:numCache>
                  <c:formatCode>General</c:formatCode>
                  <c:ptCount val="7"/>
                  <c:pt idx="0">
                    <c:v>0.11099565114459368</c:v>
                  </c:pt>
                  <c:pt idx="1">
                    <c:v>0.13439043257492825</c:v>
                  </c:pt>
                  <c:pt idx="2">
                    <c:v>4.8396929585754471E-2</c:v>
                  </c:pt>
                  <c:pt idx="3">
                    <c:v>0.21531344659477977</c:v>
                  </c:pt>
                  <c:pt idx="4">
                    <c:v>0.40786710472389343</c:v>
                  </c:pt>
                  <c:pt idx="5">
                    <c:v>0.17299794371988889</c:v>
                  </c:pt>
                  <c:pt idx="6">
                    <c:v>0.11099565114459368</c:v>
                  </c:pt>
                </c:numCache>
              </c:numRef>
            </c:plus>
            <c:minus>
              <c:numRef>
                <c:f>'fat bmal '!$R$34:$X$34</c:f>
                <c:numCache>
                  <c:formatCode>General</c:formatCode>
                  <c:ptCount val="7"/>
                  <c:pt idx="0">
                    <c:v>0.11099565114459368</c:v>
                  </c:pt>
                  <c:pt idx="1">
                    <c:v>0.13439043257492825</c:v>
                  </c:pt>
                  <c:pt idx="2">
                    <c:v>4.8396929585754471E-2</c:v>
                  </c:pt>
                  <c:pt idx="3">
                    <c:v>0.21531344659477977</c:v>
                  </c:pt>
                  <c:pt idx="4">
                    <c:v>0.40786710472389343</c:v>
                  </c:pt>
                  <c:pt idx="5">
                    <c:v>0.17299794371988889</c:v>
                  </c:pt>
                  <c:pt idx="6">
                    <c:v>0.110995651144593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bmal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bmal '!$K$38:$Q$38</c:f>
              <c:numCache>
                <c:formatCode>0.00</c:formatCode>
                <c:ptCount val="7"/>
                <c:pt idx="0">
                  <c:v>1.2801595042401457</c:v>
                </c:pt>
                <c:pt idx="1">
                  <c:v>2.9608384797699294</c:v>
                </c:pt>
                <c:pt idx="2">
                  <c:v>1</c:v>
                </c:pt>
                <c:pt idx="3">
                  <c:v>1.5500848546260262</c:v>
                </c:pt>
                <c:pt idx="4">
                  <c:v>3.7385685226147762</c:v>
                </c:pt>
                <c:pt idx="5">
                  <c:v>1.0288758163190002</c:v>
                </c:pt>
                <c:pt idx="6">
                  <c:v>1.280159504240145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437F-450F-A36C-89203820D74F}"/>
            </c:ext>
          </c:extLst>
        </c:ser>
        <c:ser>
          <c:idx val="0"/>
          <c:order val="3"/>
          <c:tx>
            <c:strRef>
              <c:f>'fat bmal 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bmal '!$K$34:$Q$34</c:f>
                <c:numCache>
                  <c:formatCode>General</c:formatCode>
                  <c:ptCount val="7"/>
                  <c:pt idx="0">
                    <c:v>8.4456697969704439E-2</c:v>
                  </c:pt>
                  <c:pt idx="1">
                    <c:v>0.16032960575967695</c:v>
                  </c:pt>
                  <c:pt idx="2">
                    <c:v>0.47927889894654258</c:v>
                  </c:pt>
                  <c:pt idx="3">
                    <c:v>7.1558345329943207E-2</c:v>
                  </c:pt>
                  <c:pt idx="4">
                    <c:v>0.12102876595378687</c:v>
                  </c:pt>
                  <c:pt idx="5">
                    <c:v>0.24644844158530149</c:v>
                  </c:pt>
                  <c:pt idx="6">
                    <c:v>8.4456697969704439E-2</c:v>
                  </c:pt>
                </c:numCache>
              </c:numRef>
            </c:plus>
            <c:minus>
              <c:numRef>
                <c:f>'fat bmal '!$K$34:$Q$34</c:f>
                <c:numCache>
                  <c:formatCode>General</c:formatCode>
                  <c:ptCount val="7"/>
                  <c:pt idx="0">
                    <c:v>8.4456697969704439E-2</c:v>
                  </c:pt>
                  <c:pt idx="1">
                    <c:v>0.16032960575967695</c:v>
                  </c:pt>
                  <c:pt idx="2">
                    <c:v>0.47927889894654258</c:v>
                  </c:pt>
                  <c:pt idx="3">
                    <c:v>7.1558345329943207E-2</c:v>
                  </c:pt>
                  <c:pt idx="4">
                    <c:v>0.12102876595378687</c:v>
                  </c:pt>
                  <c:pt idx="5">
                    <c:v>0.24644844158530149</c:v>
                  </c:pt>
                  <c:pt idx="6">
                    <c:v>8.445669796970443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clock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bmal '!$K$37:$Q$37</c:f>
              <c:numCache>
                <c:formatCode>0.00</c:formatCode>
                <c:ptCount val="7"/>
                <c:pt idx="0">
                  <c:v>1</c:v>
                </c:pt>
                <c:pt idx="1">
                  <c:v>1.4117459854659191</c:v>
                </c:pt>
                <c:pt idx="2">
                  <c:v>1.7064244783447744</c:v>
                </c:pt>
                <c:pt idx="3">
                  <c:v>1.0711060179410838</c:v>
                </c:pt>
                <c:pt idx="4">
                  <c:v>1.2302941395360685</c:v>
                </c:pt>
                <c:pt idx="5">
                  <c:v>2.0749217466733478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437F-450F-A36C-89203820D7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fat clock 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clock '!$AF$34:$AL$34</c:f>
                <c:numCache>
                  <c:formatCode>General</c:formatCode>
                  <c:ptCount val="7"/>
                  <c:pt idx="0">
                    <c:v>0.21456903003241407</c:v>
                  </c:pt>
                  <c:pt idx="1">
                    <c:v>8.5455303528302828E-2</c:v>
                  </c:pt>
                  <c:pt idx="2">
                    <c:v>0.28274976181581635</c:v>
                  </c:pt>
                  <c:pt idx="3">
                    <c:v>0.10064515747766739</c:v>
                  </c:pt>
                  <c:pt idx="4">
                    <c:v>6.8910710582686954E-2</c:v>
                  </c:pt>
                  <c:pt idx="5">
                    <c:v>3.0626777239757961E-2</c:v>
                  </c:pt>
                  <c:pt idx="6">
                    <c:v>0.21456903003241407</c:v>
                  </c:pt>
                </c:numCache>
              </c:numRef>
            </c:plus>
            <c:minus>
              <c:numRef>
                <c:f>'fat clock '!$AF$34:$AL$34</c:f>
                <c:numCache>
                  <c:formatCode>General</c:formatCode>
                  <c:ptCount val="7"/>
                  <c:pt idx="0">
                    <c:v>0.21456903003241407</c:v>
                  </c:pt>
                  <c:pt idx="1">
                    <c:v>8.5455303528302828E-2</c:v>
                  </c:pt>
                  <c:pt idx="2">
                    <c:v>0.28274976181581635</c:v>
                  </c:pt>
                  <c:pt idx="3">
                    <c:v>0.10064515747766739</c:v>
                  </c:pt>
                  <c:pt idx="4">
                    <c:v>6.8910710582686954E-2</c:v>
                  </c:pt>
                  <c:pt idx="5">
                    <c:v>3.0626777239757961E-2</c:v>
                  </c:pt>
                  <c:pt idx="6">
                    <c:v>0.214569030032414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clock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clock '!$K$40:$Q$40</c:f>
              <c:numCache>
                <c:formatCode>0.00</c:formatCode>
                <c:ptCount val="7"/>
                <c:pt idx="0">
                  <c:v>1.3208882080124402</c:v>
                </c:pt>
                <c:pt idx="1">
                  <c:v>1.7325655658274053</c:v>
                </c:pt>
                <c:pt idx="2">
                  <c:v>1.9327386369515371</c:v>
                </c:pt>
                <c:pt idx="3">
                  <c:v>1.1827502245397588</c:v>
                </c:pt>
                <c:pt idx="4">
                  <c:v>1.7230522259677707</c:v>
                </c:pt>
                <c:pt idx="5">
                  <c:v>1</c:v>
                </c:pt>
                <c:pt idx="6">
                  <c:v>1.32088820801244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E0D-45D3-8959-74A16F88A8B3}"/>
            </c:ext>
          </c:extLst>
        </c:ser>
        <c:ser>
          <c:idx val="2"/>
          <c:order val="1"/>
          <c:tx>
            <c:strRef>
              <c:f>'fat clock 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clock '!$Y$34:$AE$34</c:f>
                <c:numCache>
                  <c:formatCode>General</c:formatCode>
                  <c:ptCount val="7"/>
                  <c:pt idx="0">
                    <c:v>5.3993212931614694E-2</c:v>
                  </c:pt>
                  <c:pt idx="1">
                    <c:v>0.1396502418582373</c:v>
                  </c:pt>
                  <c:pt idx="2">
                    <c:v>2.5626118263429459E-2</c:v>
                  </c:pt>
                  <c:pt idx="3">
                    <c:v>3.4214035376171778E-2</c:v>
                  </c:pt>
                  <c:pt idx="4">
                    <c:v>0.24549808318705069</c:v>
                  </c:pt>
                  <c:pt idx="5">
                    <c:v>0.12438432553922758</c:v>
                  </c:pt>
                  <c:pt idx="6">
                    <c:v>5.3993212931614694E-2</c:v>
                  </c:pt>
                </c:numCache>
              </c:numRef>
            </c:plus>
            <c:minus>
              <c:numRef>
                <c:f>'fat clock '!$Y$34:$AE$34</c:f>
                <c:numCache>
                  <c:formatCode>General</c:formatCode>
                  <c:ptCount val="7"/>
                  <c:pt idx="0">
                    <c:v>5.3993212931614694E-2</c:v>
                  </c:pt>
                  <c:pt idx="1">
                    <c:v>0.1396502418582373</c:v>
                  </c:pt>
                  <c:pt idx="2">
                    <c:v>2.5626118263429459E-2</c:v>
                  </c:pt>
                  <c:pt idx="3">
                    <c:v>3.4214035376171778E-2</c:v>
                  </c:pt>
                  <c:pt idx="4">
                    <c:v>0.24549808318705069</c:v>
                  </c:pt>
                  <c:pt idx="5">
                    <c:v>0.12438432553922758</c:v>
                  </c:pt>
                  <c:pt idx="6">
                    <c:v>5.399321293161469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clock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clock '!$K$39:$Q$39</c:f>
              <c:numCache>
                <c:formatCode>0.00</c:formatCode>
                <c:ptCount val="7"/>
                <c:pt idx="0">
                  <c:v>1.0161248746345914</c:v>
                </c:pt>
                <c:pt idx="1">
                  <c:v>1.5018782377240467</c:v>
                </c:pt>
                <c:pt idx="2">
                  <c:v>1</c:v>
                </c:pt>
                <c:pt idx="3">
                  <c:v>1.2483852017116928</c:v>
                </c:pt>
                <c:pt idx="4">
                  <c:v>1.4915550536848712</c:v>
                </c:pt>
                <c:pt idx="5">
                  <c:v>1.5023468506397335</c:v>
                </c:pt>
                <c:pt idx="6">
                  <c:v>1.016124874634591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E0D-45D3-8959-74A16F88A8B3}"/>
            </c:ext>
          </c:extLst>
        </c:ser>
        <c:ser>
          <c:idx val="1"/>
          <c:order val="2"/>
          <c:tx>
            <c:strRef>
              <c:f>'fat clock 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clock '!$R$34:$X$34</c:f>
                <c:numCache>
                  <c:formatCode>General</c:formatCode>
                  <c:ptCount val="7"/>
                  <c:pt idx="0">
                    <c:v>0.37105549892942058</c:v>
                  </c:pt>
                  <c:pt idx="1">
                    <c:v>5.3625046216417623E-2</c:v>
                  </c:pt>
                  <c:pt idx="2">
                    <c:v>0.26097002248146789</c:v>
                  </c:pt>
                  <c:pt idx="3">
                    <c:v>0.49760080361712161</c:v>
                  </c:pt>
                  <c:pt idx="4">
                    <c:v>0.41727837789320371</c:v>
                  </c:pt>
                  <c:pt idx="5">
                    <c:v>0.33216824417024171</c:v>
                  </c:pt>
                  <c:pt idx="6">
                    <c:v>0.37105549892942058</c:v>
                  </c:pt>
                </c:numCache>
              </c:numRef>
            </c:plus>
            <c:minus>
              <c:numRef>
                <c:f>'fat clock '!$R$34:$X$34</c:f>
                <c:numCache>
                  <c:formatCode>General</c:formatCode>
                  <c:ptCount val="7"/>
                  <c:pt idx="0">
                    <c:v>0.37105549892942058</c:v>
                  </c:pt>
                  <c:pt idx="1">
                    <c:v>5.3625046216417623E-2</c:v>
                  </c:pt>
                  <c:pt idx="2">
                    <c:v>0.26097002248146789</c:v>
                  </c:pt>
                  <c:pt idx="3">
                    <c:v>0.49760080361712161</c:v>
                  </c:pt>
                  <c:pt idx="4">
                    <c:v>0.41727837789320371</c:v>
                  </c:pt>
                  <c:pt idx="5">
                    <c:v>0.33216824417024171</c:v>
                  </c:pt>
                  <c:pt idx="6">
                    <c:v>0.371055498929420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clock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clock '!$K$38:$Q$38</c:f>
              <c:numCache>
                <c:formatCode>0.00</c:formatCode>
                <c:ptCount val="7"/>
                <c:pt idx="0">
                  <c:v>1.4935925824061227</c:v>
                </c:pt>
                <c:pt idx="1">
                  <c:v>1</c:v>
                </c:pt>
                <c:pt idx="2">
                  <c:v>1.4837763541285884</c:v>
                </c:pt>
                <c:pt idx="3">
                  <c:v>2.3344098002768652</c:v>
                </c:pt>
                <c:pt idx="4">
                  <c:v>2.1997323979805246</c:v>
                </c:pt>
                <c:pt idx="5">
                  <c:v>1.3201291054688677</c:v>
                </c:pt>
                <c:pt idx="6">
                  <c:v>1.493592582406122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CE0D-45D3-8959-74A16F88A8B3}"/>
            </c:ext>
          </c:extLst>
        </c:ser>
        <c:ser>
          <c:idx val="0"/>
          <c:order val="3"/>
          <c:tx>
            <c:strRef>
              <c:f>'fat clock 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at clock '!$K$34:$Q$34</c:f>
                <c:numCache>
                  <c:formatCode>General</c:formatCode>
                  <c:ptCount val="7"/>
                  <c:pt idx="0">
                    <c:v>0.150766540282286</c:v>
                  </c:pt>
                  <c:pt idx="1">
                    <c:v>0.30816201484982531</c:v>
                  </c:pt>
                  <c:pt idx="2">
                    <c:v>0.22725383197939739</c:v>
                  </c:pt>
                  <c:pt idx="3">
                    <c:v>3.6157609076403065E-2</c:v>
                  </c:pt>
                  <c:pt idx="4">
                    <c:v>0.21452325448804682</c:v>
                  </c:pt>
                  <c:pt idx="5">
                    <c:v>0.16540127689359058</c:v>
                  </c:pt>
                  <c:pt idx="6">
                    <c:v>0.150766540282286</c:v>
                  </c:pt>
                </c:numCache>
              </c:numRef>
            </c:plus>
            <c:minus>
              <c:numRef>
                <c:f>'fat clock '!$K$34:$Q$34</c:f>
                <c:numCache>
                  <c:formatCode>General</c:formatCode>
                  <c:ptCount val="7"/>
                  <c:pt idx="0">
                    <c:v>0.150766540282286</c:v>
                  </c:pt>
                  <c:pt idx="1">
                    <c:v>0.30816201484982531</c:v>
                  </c:pt>
                  <c:pt idx="2">
                    <c:v>0.22725383197939739</c:v>
                  </c:pt>
                  <c:pt idx="3">
                    <c:v>3.6157609076403065E-2</c:v>
                  </c:pt>
                  <c:pt idx="4">
                    <c:v>0.21452325448804682</c:v>
                  </c:pt>
                  <c:pt idx="5">
                    <c:v>0.16540127689359058</c:v>
                  </c:pt>
                  <c:pt idx="6">
                    <c:v>0.1507665402822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fat clock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fat clock '!$K$37:$Q$37</c:f>
              <c:numCache>
                <c:formatCode>0.00</c:formatCode>
                <c:ptCount val="7"/>
                <c:pt idx="0">
                  <c:v>1</c:v>
                </c:pt>
                <c:pt idx="1">
                  <c:v>1.0851399122189593</c:v>
                </c:pt>
                <c:pt idx="2">
                  <c:v>1.4535382240963568</c:v>
                </c:pt>
                <c:pt idx="3">
                  <c:v>1.0348484140608569</c:v>
                </c:pt>
                <c:pt idx="4">
                  <c:v>1.9376859238923043</c:v>
                </c:pt>
                <c:pt idx="5">
                  <c:v>1.9510434380768602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CE0D-45D3-8959-74A16F88A8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  <c:min val="0"/>
        </c:scaling>
        <c:delete val="0"/>
        <c:axPos val="l"/>
        <c:numFmt formatCode="0.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liver cry1 '!$R$40</c:f>
              <c:strCache>
                <c:ptCount val="1"/>
                <c:pt idx="0">
                  <c:v>Chow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cry1 '!$AG$34:$AL$34</c:f>
                <c:numCache>
                  <c:formatCode>General</c:formatCode>
                  <c:ptCount val="6"/>
                  <c:pt idx="0">
                    <c:v>3.4372081511980852E-2</c:v>
                  </c:pt>
                  <c:pt idx="1">
                    <c:v>6.4743248529404773E-2</c:v>
                  </c:pt>
                  <c:pt idx="2">
                    <c:v>3.4250746277834171E-2</c:v>
                  </c:pt>
                  <c:pt idx="3">
                    <c:v>8.8797105753631714E-2</c:v>
                  </c:pt>
                  <c:pt idx="4">
                    <c:v>8.3939858049459845E-2</c:v>
                  </c:pt>
                  <c:pt idx="5">
                    <c:v>4.7922079724622792E-2</c:v>
                  </c:pt>
                </c:numCache>
              </c:numRef>
            </c:plus>
            <c:minus>
              <c:numRef>
                <c:f>'liver cry1 '!$AG$34:$AL$34</c:f>
                <c:numCache>
                  <c:formatCode>General</c:formatCode>
                  <c:ptCount val="6"/>
                  <c:pt idx="0">
                    <c:v>3.4372081511980852E-2</c:v>
                  </c:pt>
                  <c:pt idx="1">
                    <c:v>6.4743248529404773E-2</c:v>
                  </c:pt>
                  <c:pt idx="2">
                    <c:v>3.4250746277834171E-2</c:v>
                  </c:pt>
                  <c:pt idx="3">
                    <c:v>8.8797105753631714E-2</c:v>
                  </c:pt>
                  <c:pt idx="4">
                    <c:v>8.3939858049459845E-2</c:v>
                  </c:pt>
                  <c:pt idx="5">
                    <c:v>4.792207972462279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cry1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cry1 '!$K$40:$Q$40</c:f>
              <c:numCache>
                <c:formatCode>0.00</c:formatCode>
                <c:ptCount val="7"/>
                <c:pt idx="0">
                  <c:v>1.580860841176785</c:v>
                </c:pt>
                <c:pt idx="1">
                  <c:v>1</c:v>
                </c:pt>
                <c:pt idx="2">
                  <c:v>1.3314543343405314</c:v>
                </c:pt>
                <c:pt idx="3">
                  <c:v>1.0772125503509522</c:v>
                </c:pt>
                <c:pt idx="4">
                  <c:v>2.9451441009140535</c:v>
                </c:pt>
                <c:pt idx="5">
                  <c:v>1.9836348077726478</c:v>
                </c:pt>
                <c:pt idx="6">
                  <c:v>1.5808608411767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D87-4BA1-9D76-76DA12939387}"/>
            </c:ext>
          </c:extLst>
        </c:ser>
        <c:ser>
          <c:idx val="2"/>
          <c:order val="1"/>
          <c:tx>
            <c:strRef>
              <c:f>'liver cry1 '!$R$39</c:f>
              <c:strCache>
                <c:ptCount val="1"/>
                <c:pt idx="0">
                  <c:v>Chow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cry1 '!$Z$34:$AE$34</c:f>
                <c:numCache>
                  <c:formatCode>General</c:formatCode>
                  <c:ptCount val="6"/>
                  <c:pt idx="0">
                    <c:v>0.16936657601586816</c:v>
                  </c:pt>
                  <c:pt idx="1">
                    <c:v>0.13680627072790486</c:v>
                  </c:pt>
                  <c:pt idx="2">
                    <c:v>7.4196962978400963E-2</c:v>
                  </c:pt>
                  <c:pt idx="3">
                    <c:v>2.1279306974529302E-2</c:v>
                  </c:pt>
                  <c:pt idx="4">
                    <c:v>6.3961881041293009E-2</c:v>
                  </c:pt>
                  <c:pt idx="5">
                    <c:v>2.3091248362951022E-2</c:v>
                  </c:pt>
                </c:numCache>
              </c:numRef>
            </c:plus>
            <c:minus>
              <c:numRef>
                <c:f>'liver cry1 '!$Z$34:$AE$34</c:f>
                <c:numCache>
                  <c:formatCode>General</c:formatCode>
                  <c:ptCount val="6"/>
                  <c:pt idx="0">
                    <c:v>0.16936657601586816</c:v>
                  </c:pt>
                  <c:pt idx="1">
                    <c:v>0.13680627072790486</c:v>
                  </c:pt>
                  <c:pt idx="2">
                    <c:v>7.4196962978400963E-2</c:v>
                  </c:pt>
                  <c:pt idx="3">
                    <c:v>2.1279306974529302E-2</c:v>
                  </c:pt>
                  <c:pt idx="4">
                    <c:v>6.3961881041293009E-2</c:v>
                  </c:pt>
                  <c:pt idx="5">
                    <c:v>2.309124836295102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cry1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cry1 '!$K$39:$Q$39</c:f>
              <c:numCache>
                <c:formatCode>0.00</c:formatCode>
                <c:ptCount val="7"/>
                <c:pt idx="0">
                  <c:v>1</c:v>
                </c:pt>
                <c:pt idx="1">
                  <c:v>2.3673593818665255</c:v>
                </c:pt>
                <c:pt idx="2">
                  <c:v>1.9784801333237487</c:v>
                </c:pt>
                <c:pt idx="3">
                  <c:v>1.7541477923026456</c:v>
                </c:pt>
                <c:pt idx="4">
                  <c:v>1.092621406841974</c:v>
                </c:pt>
                <c:pt idx="5">
                  <c:v>1.3485863265490321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D87-4BA1-9D76-76DA12939387}"/>
            </c:ext>
          </c:extLst>
        </c:ser>
        <c:ser>
          <c:idx val="1"/>
          <c:order val="2"/>
          <c:tx>
            <c:strRef>
              <c:f>'liver cry1 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cry1 '!$S$34:$X$34</c:f>
                <c:numCache>
                  <c:formatCode>General</c:formatCode>
                  <c:ptCount val="6"/>
                  <c:pt idx="0">
                    <c:v>0.14205385506831714</c:v>
                  </c:pt>
                  <c:pt idx="1">
                    <c:v>0.11956840033898845</c:v>
                  </c:pt>
                  <c:pt idx="2">
                    <c:v>0.15570690999317097</c:v>
                  </c:pt>
                  <c:pt idx="3">
                    <c:v>0.16887511184172613</c:v>
                  </c:pt>
                  <c:pt idx="4">
                    <c:v>0.27713189801520793</c:v>
                  </c:pt>
                  <c:pt idx="5">
                    <c:v>3.5851815050303271E-2</c:v>
                  </c:pt>
                </c:numCache>
              </c:numRef>
            </c:plus>
            <c:minus>
              <c:numRef>
                <c:f>'liver cry1 '!$S$34:$X$34</c:f>
                <c:numCache>
                  <c:formatCode>General</c:formatCode>
                  <c:ptCount val="6"/>
                  <c:pt idx="0">
                    <c:v>0.14205385506831714</c:v>
                  </c:pt>
                  <c:pt idx="1">
                    <c:v>0.11956840033898845</c:v>
                  </c:pt>
                  <c:pt idx="2">
                    <c:v>0.15570690999317097</c:v>
                  </c:pt>
                  <c:pt idx="3">
                    <c:v>0.16887511184172613</c:v>
                  </c:pt>
                  <c:pt idx="4">
                    <c:v>0.27713189801520793</c:v>
                  </c:pt>
                  <c:pt idx="5">
                    <c:v>3.585181505030327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cry1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cry1 '!$K$38:$Q$38</c:f>
              <c:numCache>
                <c:formatCode>0.00</c:formatCode>
                <c:ptCount val="7"/>
                <c:pt idx="0">
                  <c:v>1</c:v>
                </c:pt>
                <c:pt idx="1">
                  <c:v>1.9841301714882569</c:v>
                </c:pt>
                <c:pt idx="2">
                  <c:v>1.6641604998657249</c:v>
                </c:pt>
                <c:pt idx="3">
                  <c:v>1.0983975915646242</c:v>
                </c:pt>
                <c:pt idx="4">
                  <c:v>1.5300868086287363</c:v>
                </c:pt>
                <c:pt idx="5">
                  <c:v>2.4985542352131871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ED87-4BA1-9D76-76DA12939387}"/>
            </c:ext>
          </c:extLst>
        </c:ser>
        <c:ser>
          <c:idx val="0"/>
          <c:order val="3"/>
          <c:tx>
            <c:strRef>
              <c:f>'liver cry1 '!$R$37</c:f>
              <c:strCache>
                <c:ptCount val="1"/>
                <c:pt idx="0">
                  <c:v>HF-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cry1 '!$L$34:$Q$34</c:f>
                <c:numCache>
                  <c:formatCode>General</c:formatCode>
                  <c:ptCount val="6"/>
                  <c:pt idx="0">
                    <c:v>0.53008760427586077</c:v>
                  </c:pt>
                  <c:pt idx="1">
                    <c:v>0.14183125161495894</c:v>
                  </c:pt>
                  <c:pt idx="2">
                    <c:v>0.1111490704045756</c:v>
                  </c:pt>
                  <c:pt idx="3">
                    <c:v>0.17802134573781347</c:v>
                  </c:pt>
                  <c:pt idx="4">
                    <c:v>0.17619681705067272</c:v>
                  </c:pt>
                  <c:pt idx="5">
                    <c:v>0.10246588221445156</c:v>
                  </c:pt>
                </c:numCache>
              </c:numRef>
            </c:plus>
            <c:minus>
              <c:numRef>
                <c:f>'liver cry1 '!$L$34:$Q$34</c:f>
                <c:numCache>
                  <c:formatCode>General</c:formatCode>
                  <c:ptCount val="6"/>
                  <c:pt idx="0">
                    <c:v>0.53008760427586077</c:v>
                  </c:pt>
                  <c:pt idx="1">
                    <c:v>0.14183125161495894</c:v>
                  </c:pt>
                  <c:pt idx="2">
                    <c:v>0.1111490704045756</c:v>
                  </c:pt>
                  <c:pt idx="3">
                    <c:v>0.17802134573781347</c:v>
                  </c:pt>
                  <c:pt idx="4">
                    <c:v>0.17619681705067272</c:v>
                  </c:pt>
                  <c:pt idx="5">
                    <c:v>0.102465882214451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cry1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cry1 '!$K$37:$Q$37</c:f>
              <c:numCache>
                <c:formatCode>0.00</c:formatCode>
                <c:ptCount val="7"/>
                <c:pt idx="0">
                  <c:v>1.51779390387157</c:v>
                </c:pt>
                <c:pt idx="1">
                  <c:v>1.4120962494076033</c:v>
                </c:pt>
                <c:pt idx="2">
                  <c:v>1.4747928957311625</c:v>
                </c:pt>
                <c:pt idx="3">
                  <c:v>1</c:v>
                </c:pt>
                <c:pt idx="4">
                  <c:v>2.3914602516752046</c:v>
                </c:pt>
                <c:pt idx="5">
                  <c:v>2.1305721681263914</c:v>
                </c:pt>
                <c:pt idx="6">
                  <c:v>1.5177939038715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ED87-4BA1-9D76-76DA129393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.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liver bmal '!$R$40</c:f>
              <c:strCache>
                <c:ptCount val="1"/>
                <c:pt idx="0">
                  <c:v>Chow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bmal '!$AF$34:$AL$34</c:f>
                <c:numCache>
                  <c:formatCode>General</c:formatCode>
                  <c:ptCount val="7"/>
                  <c:pt idx="0">
                    <c:v>3.071904497908548E-2</c:v>
                  </c:pt>
                  <c:pt idx="1">
                    <c:v>0.4375097260434897</c:v>
                  </c:pt>
                  <c:pt idx="2">
                    <c:v>0.31112687207610124</c:v>
                  </c:pt>
                  <c:pt idx="3">
                    <c:v>5.8965915374830459E-2</c:v>
                  </c:pt>
                  <c:pt idx="4">
                    <c:v>6.037743792235728E-2</c:v>
                  </c:pt>
                  <c:pt idx="5">
                    <c:v>0.20129620659151251</c:v>
                  </c:pt>
                  <c:pt idx="6">
                    <c:v>3.071904497908548E-2</c:v>
                  </c:pt>
                </c:numCache>
              </c:numRef>
            </c:plus>
            <c:minus>
              <c:numRef>
                <c:f>'liver bmal '!$AF$34:$AL$34</c:f>
                <c:numCache>
                  <c:formatCode>General</c:formatCode>
                  <c:ptCount val="7"/>
                  <c:pt idx="0">
                    <c:v>3.071904497908548E-2</c:v>
                  </c:pt>
                  <c:pt idx="1">
                    <c:v>0.4375097260434897</c:v>
                  </c:pt>
                  <c:pt idx="2">
                    <c:v>0.31112687207610124</c:v>
                  </c:pt>
                  <c:pt idx="3">
                    <c:v>5.8965915374830459E-2</c:v>
                  </c:pt>
                  <c:pt idx="4">
                    <c:v>6.037743792235728E-2</c:v>
                  </c:pt>
                  <c:pt idx="5">
                    <c:v>0.20129620659151251</c:v>
                  </c:pt>
                  <c:pt idx="6">
                    <c:v>3.07190449790854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bmal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bmal '!$K$40:$Q$40</c:f>
              <c:numCache>
                <c:formatCode>0.00</c:formatCode>
                <c:ptCount val="7"/>
                <c:pt idx="0">
                  <c:v>1</c:v>
                </c:pt>
                <c:pt idx="1">
                  <c:v>2.830456199733689</c:v>
                </c:pt>
                <c:pt idx="2">
                  <c:v>2.2509168730543241</c:v>
                </c:pt>
                <c:pt idx="3">
                  <c:v>1.1427502513958081</c:v>
                </c:pt>
                <c:pt idx="4">
                  <c:v>1.240747768183327</c:v>
                </c:pt>
                <c:pt idx="5">
                  <c:v>1.5409445121478973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7F6-410A-9E72-99483D6A1302}"/>
            </c:ext>
          </c:extLst>
        </c:ser>
        <c:ser>
          <c:idx val="2"/>
          <c:order val="1"/>
          <c:tx>
            <c:strRef>
              <c:f>'liver bmal '!$R$39</c:f>
              <c:strCache>
                <c:ptCount val="1"/>
                <c:pt idx="0">
                  <c:v>Chow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bmal '!$Y$34:$AE$34</c:f>
                <c:numCache>
                  <c:formatCode>General</c:formatCode>
                  <c:ptCount val="7"/>
                  <c:pt idx="0">
                    <c:v>0.15691200240458311</c:v>
                  </c:pt>
                  <c:pt idx="1">
                    <c:v>0.14745252982234006</c:v>
                  </c:pt>
                  <c:pt idx="2">
                    <c:v>7.8082319248164958E-2</c:v>
                  </c:pt>
                  <c:pt idx="3">
                    <c:v>0.2084523022459491</c:v>
                  </c:pt>
                  <c:pt idx="4">
                    <c:v>0.20405164079176338</c:v>
                  </c:pt>
                  <c:pt idx="5">
                    <c:v>0.25884969332575652</c:v>
                  </c:pt>
                  <c:pt idx="6">
                    <c:v>0.15691200240458311</c:v>
                  </c:pt>
                </c:numCache>
              </c:numRef>
            </c:plus>
            <c:minus>
              <c:numRef>
                <c:f>'liver bmal '!$Y$34:$AE$34</c:f>
                <c:numCache>
                  <c:formatCode>General</c:formatCode>
                  <c:ptCount val="7"/>
                  <c:pt idx="0">
                    <c:v>0.15691200240458311</c:v>
                  </c:pt>
                  <c:pt idx="1">
                    <c:v>0.14745252982234006</c:v>
                  </c:pt>
                  <c:pt idx="2">
                    <c:v>7.8082319248164958E-2</c:v>
                  </c:pt>
                  <c:pt idx="3">
                    <c:v>0.2084523022459491</c:v>
                  </c:pt>
                  <c:pt idx="4">
                    <c:v>0.20405164079176338</c:v>
                  </c:pt>
                  <c:pt idx="5">
                    <c:v>0.25884969332575652</c:v>
                  </c:pt>
                  <c:pt idx="6">
                    <c:v>0.156912002404583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bmal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bmal '!$K$39:$Q$39</c:f>
              <c:numCache>
                <c:formatCode>0.00</c:formatCode>
                <c:ptCount val="7"/>
                <c:pt idx="0">
                  <c:v>1.2774541449877121</c:v>
                </c:pt>
                <c:pt idx="1">
                  <c:v>1.2847587736419295</c:v>
                </c:pt>
                <c:pt idx="2">
                  <c:v>1.2608976124270896</c:v>
                </c:pt>
                <c:pt idx="3">
                  <c:v>1.2274294031146449</c:v>
                </c:pt>
                <c:pt idx="4">
                  <c:v>1</c:v>
                </c:pt>
                <c:pt idx="5">
                  <c:v>1.6324752310089103</c:v>
                </c:pt>
                <c:pt idx="6">
                  <c:v>1.277454144987712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7F6-410A-9E72-99483D6A1302}"/>
            </c:ext>
          </c:extLst>
        </c:ser>
        <c:ser>
          <c:idx val="1"/>
          <c:order val="2"/>
          <c:tx>
            <c:strRef>
              <c:f>'liver bmal 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bmal '!$R$34:$X$34</c:f>
                <c:numCache>
                  <c:formatCode>General</c:formatCode>
                  <c:ptCount val="7"/>
                  <c:pt idx="0">
                    <c:v>0.13263078338815018</c:v>
                  </c:pt>
                  <c:pt idx="1">
                    <c:v>5.6282780067209506E-2</c:v>
                  </c:pt>
                  <c:pt idx="2">
                    <c:v>0.20372080494692504</c:v>
                  </c:pt>
                  <c:pt idx="3">
                    <c:v>0.24902944352020381</c:v>
                  </c:pt>
                  <c:pt idx="4">
                    <c:v>0.26656660312089503</c:v>
                  </c:pt>
                  <c:pt idx="5">
                    <c:v>0.28656841029446123</c:v>
                  </c:pt>
                  <c:pt idx="6">
                    <c:v>0.13263078338815018</c:v>
                  </c:pt>
                </c:numCache>
              </c:numRef>
            </c:plus>
            <c:minus>
              <c:numRef>
                <c:f>'liver bmal '!$R$34:$X$34</c:f>
                <c:numCache>
                  <c:formatCode>General</c:formatCode>
                  <c:ptCount val="7"/>
                  <c:pt idx="0">
                    <c:v>0.13263078338815018</c:v>
                  </c:pt>
                  <c:pt idx="1">
                    <c:v>5.6282780067209506E-2</c:v>
                  </c:pt>
                  <c:pt idx="2">
                    <c:v>0.20372080494692504</c:v>
                  </c:pt>
                  <c:pt idx="3">
                    <c:v>0.24902944352020381</c:v>
                  </c:pt>
                  <c:pt idx="4">
                    <c:v>0.26656660312089503</c:v>
                  </c:pt>
                  <c:pt idx="5">
                    <c:v>0.28656841029446123</c:v>
                  </c:pt>
                  <c:pt idx="6">
                    <c:v>0.132630783388150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bmal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bmal '!$K$38:$Q$38</c:f>
              <c:numCache>
                <c:formatCode>0.00</c:formatCode>
                <c:ptCount val="7"/>
                <c:pt idx="0">
                  <c:v>1</c:v>
                </c:pt>
                <c:pt idx="1">
                  <c:v>2.3259346661417077</c:v>
                </c:pt>
                <c:pt idx="2">
                  <c:v>3.7747356716538283</c:v>
                </c:pt>
                <c:pt idx="3">
                  <c:v>1.6687139814522873</c:v>
                </c:pt>
                <c:pt idx="4">
                  <c:v>1.4618363631445668</c:v>
                </c:pt>
                <c:pt idx="5">
                  <c:v>1.7771933169943872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27F6-410A-9E72-99483D6A1302}"/>
            </c:ext>
          </c:extLst>
        </c:ser>
        <c:ser>
          <c:idx val="0"/>
          <c:order val="3"/>
          <c:tx>
            <c:strRef>
              <c:f>'muscle clock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bmal '!$K$34:$Q$34</c:f>
                <c:numCache>
                  <c:formatCode>General</c:formatCode>
                  <c:ptCount val="7"/>
                  <c:pt idx="0">
                    <c:v>0.1461914523995903</c:v>
                  </c:pt>
                  <c:pt idx="1">
                    <c:v>0.57128489599781107</c:v>
                  </c:pt>
                  <c:pt idx="2">
                    <c:v>0.17801561079311343</c:v>
                  </c:pt>
                  <c:pt idx="3">
                    <c:v>0.12862424996365035</c:v>
                  </c:pt>
                  <c:pt idx="4">
                    <c:v>0.19585120710903042</c:v>
                  </c:pt>
                  <c:pt idx="5">
                    <c:v>0.14874979181092923</c:v>
                  </c:pt>
                  <c:pt idx="6">
                    <c:v>0.1461914523995903</c:v>
                  </c:pt>
                </c:numCache>
              </c:numRef>
            </c:plus>
            <c:minus>
              <c:numRef>
                <c:f>'liver bmal '!$K$34:$Q$34</c:f>
                <c:numCache>
                  <c:formatCode>General</c:formatCode>
                  <c:ptCount val="7"/>
                  <c:pt idx="0">
                    <c:v>0.1461914523995903</c:v>
                  </c:pt>
                  <c:pt idx="1">
                    <c:v>0.57128489599781107</c:v>
                  </c:pt>
                  <c:pt idx="2">
                    <c:v>0.17801561079311343</c:v>
                  </c:pt>
                  <c:pt idx="3">
                    <c:v>0.12862424996365035</c:v>
                  </c:pt>
                  <c:pt idx="4">
                    <c:v>0.19585120710903042</c:v>
                  </c:pt>
                  <c:pt idx="5">
                    <c:v>0.14874979181092923</c:v>
                  </c:pt>
                  <c:pt idx="6">
                    <c:v>0.14619145239959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clock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clock'!$K$37:$Q$37</c:f>
              <c:numCache>
                <c:formatCode>0.00</c:formatCode>
                <c:ptCount val="7"/>
                <c:pt idx="0">
                  <c:v>1</c:v>
                </c:pt>
                <c:pt idx="1">
                  <c:v>1.4770842129840065</c:v>
                </c:pt>
                <c:pt idx="2">
                  <c:v>1.1140318307971329</c:v>
                </c:pt>
                <c:pt idx="3">
                  <c:v>1.9720202096697363</c:v>
                </c:pt>
                <c:pt idx="4">
                  <c:v>1.2269752239640572</c:v>
                </c:pt>
                <c:pt idx="5">
                  <c:v>2.2702358081023823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27F6-410A-9E72-99483D6A13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liver clock '!$R$40</c:f>
              <c:strCache>
                <c:ptCount val="1"/>
                <c:pt idx="0">
                  <c:v>Chow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clock '!$AF$34:$AL$34</c:f>
                <c:numCache>
                  <c:formatCode>General</c:formatCode>
                  <c:ptCount val="7"/>
                  <c:pt idx="0">
                    <c:v>0.23683319787783616</c:v>
                  </c:pt>
                  <c:pt idx="1">
                    <c:v>0.11282616158866664</c:v>
                  </c:pt>
                  <c:pt idx="2">
                    <c:v>0.22060355676726037</c:v>
                  </c:pt>
                  <c:pt idx="3">
                    <c:v>0.19723395687452408</c:v>
                  </c:pt>
                  <c:pt idx="4">
                    <c:v>0.48874786188100733</c:v>
                  </c:pt>
                  <c:pt idx="5">
                    <c:v>0.3918946290715869</c:v>
                  </c:pt>
                  <c:pt idx="6">
                    <c:v>0.23683319787783616</c:v>
                  </c:pt>
                </c:numCache>
              </c:numRef>
            </c:plus>
            <c:minus>
              <c:numRef>
                <c:f>'liver clock '!$AF$34:$AL$34</c:f>
                <c:numCache>
                  <c:formatCode>General</c:formatCode>
                  <c:ptCount val="7"/>
                  <c:pt idx="0">
                    <c:v>0.23683319787783616</c:v>
                  </c:pt>
                  <c:pt idx="1">
                    <c:v>0.11282616158866664</c:v>
                  </c:pt>
                  <c:pt idx="2">
                    <c:v>0.22060355676726037</c:v>
                  </c:pt>
                  <c:pt idx="3">
                    <c:v>0.19723395687452408</c:v>
                  </c:pt>
                  <c:pt idx="4">
                    <c:v>0.48874786188100733</c:v>
                  </c:pt>
                  <c:pt idx="5">
                    <c:v>0.3918946290715869</c:v>
                  </c:pt>
                  <c:pt idx="6">
                    <c:v>0.236833197877836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clock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clock '!$K$40:$Q$40</c:f>
              <c:numCache>
                <c:formatCode>0.00</c:formatCode>
                <c:ptCount val="7"/>
                <c:pt idx="0">
                  <c:v>1.8292076743850603</c:v>
                </c:pt>
                <c:pt idx="1">
                  <c:v>1</c:v>
                </c:pt>
                <c:pt idx="2">
                  <c:v>1.4016932479960151</c:v>
                </c:pt>
                <c:pt idx="3">
                  <c:v>1.3176638796354518</c:v>
                </c:pt>
                <c:pt idx="4">
                  <c:v>2.8545346213170841</c:v>
                </c:pt>
                <c:pt idx="5">
                  <c:v>4.8380161898285001</c:v>
                </c:pt>
                <c:pt idx="6">
                  <c:v>1.82920767438506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6E0-4E8C-A788-D02A65E43B7C}"/>
            </c:ext>
          </c:extLst>
        </c:ser>
        <c:ser>
          <c:idx val="2"/>
          <c:order val="1"/>
          <c:tx>
            <c:strRef>
              <c:f>'liver clock '!$R$39</c:f>
              <c:strCache>
                <c:ptCount val="1"/>
                <c:pt idx="0">
                  <c:v>Chow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clock '!$Y$34:$AE$34</c:f>
                <c:numCache>
                  <c:formatCode>General</c:formatCode>
                  <c:ptCount val="7"/>
                  <c:pt idx="0">
                    <c:v>9.0092994670836118E-2</c:v>
                  </c:pt>
                  <c:pt idx="1">
                    <c:v>0.22839823112550223</c:v>
                  </c:pt>
                  <c:pt idx="2">
                    <c:v>0.28621997986189973</c:v>
                  </c:pt>
                  <c:pt idx="3">
                    <c:v>0.10005983415429735</c:v>
                  </c:pt>
                  <c:pt idx="4">
                    <c:v>7.2399922700164154E-2</c:v>
                  </c:pt>
                  <c:pt idx="5">
                    <c:v>0.11161355958930731</c:v>
                  </c:pt>
                  <c:pt idx="6">
                    <c:v>9.0092994670836118E-2</c:v>
                  </c:pt>
                </c:numCache>
              </c:numRef>
            </c:plus>
            <c:minus>
              <c:numRef>
                <c:f>'liver clock '!$Y$34:$AE$34</c:f>
                <c:numCache>
                  <c:formatCode>General</c:formatCode>
                  <c:ptCount val="7"/>
                  <c:pt idx="0">
                    <c:v>9.0092994670836118E-2</c:v>
                  </c:pt>
                  <c:pt idx="1">
                    <c:v>0.22839823112550223</c:v>
                  </c:pt>
                  <c:pt idx="2">
                    <c:v>0.28621997986189973</c:v>
                  </c:pt>
                  <c:pt idx="3">
                    <c:v>0.10005983415429735</c:v>
                  </c:pt>
                  <c:pt idx="4">
                    <c:v>7.2399922700164154E-2</c:v>
                  </c:pt>
                  <c:pt idx="5">
                    <c:v>0.11161355958930731</c:v>
                  </c:pt>
                  <c:pt idx="6">
                    <c:v>9.009299467083611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clock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clock '!$K$39:$Q$39</c:f>
              <c:numCache>
                <c:formatCode>0.00</c:formatCode>
                <c:ptCount val="7"/>
                <c:pt idx="0">
                  <c:v>1</c:v>
                </c:pt>
                <c:pt idx="1">
                  <c:v>2.2071447160026385</c:v>
                </c:pt>
                <c:pt idx="2">
                  <c:v>3.0382454193862225</c:v>
                </c:pt>
                <c:pt idx="3">
                  <c:v>1.282312138686601</c:v>
                </c:pt>
                <c:pt idx="4">
                  <c:v>1.0186588245774817</c:v>
                </c:pt>
                <c:pt idx="5">
                  <c:v>1.0183422255427503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6E0-4E8C-A788-D02A65E43B7C}"/>
            </c:ext>
          </c:extLst>
        </c:ser>
        <c:ser>
          <c:idx val="1"/>
          <c:order val="2"/>
          <c:tx>
            <c:strRef>
              <c:f>'liver clock 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clock '!$R$34:$X$34</c:f>
                <c:numCache>
                  <c:formatCode>General</c:formatCode>
                  <c:ptCount val="7"/>
                  <c:pt idx="0">
                    <c:v>0.14552307112605892</c:v>
                  </c:pt>
                  <c:pt idx="1">
                    <c:v>5.7173842155809652E-2</c:v>
                  </c:pt>
                  <c:pt idx="2">
                    <c:v>0.12818491085790057</c:v>
                  </c:pt>
                  <c:pt idx="3">
                    <c:v>0.39284732112477716</c:v>
                  </c:pt>
                  <c:pt idx="4">
                    <c:v>0.19046460121667702</c:v>
                  </c:pt>
                  <c:pt idx="5">
                    <c:v>0.1586410062745662</c:v>
                  </c:pt>
                  <c:pt idx="6">
                    <c:v>0.14552307112605892</c:v>
                  </c:pt>
                </c:numCache>
              </c:numRef>
            </c:plus>
            <c:minus>
              <c:numRef>
                <c:f>'liver clock '!$R$34:$X$34</c:f>
                <c:numCache>
                  <c:formatCode>General</c:formatCode>
                  <c:ptCount val="7"/>
                  <c:pt idx="0">
                    <c:v>0.14552307112605892</c:v>
                  </c:pt>
                  <c:pt idx="1">
                    <c:v>5.7173842155809652E-2</c:v>
                  </c:pt>
                  <c:pt idx="2">
                    <c:v>0.12818491085790057</c:v>
                  </c:pt>
                  <c:pt idx="3">
                    <c:v>0.39284732112477716</c:v>
                  </c:pt>
                  <c:pt idx="4">
                    <c:v>0.19046460121667702</c:v>
                  </c:pt>
                  <c:pt idx="5">
                    <c:v>0.1586410062745662</c:v>
                  </c:pt>
                  <c:pt idx="6">
                    <c:v>0.145523071126058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clock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clock '!$K$38:$Q$38</c:f>
              <c:numCache>
                <c:formatCode>0.00</c:formatCode>
                <c:ptCount val="7"/>
                <c:pt idx="0">
                  <c:v>1</c:v>
                </c:pt>
                <c:pt idx="1">
                  <c:v>1.2096065327989969</c:v>
                </c:pt>
                <c:pt idx="2">
                  <c:v>1.3498548685986311</c:v>
                </c:pt>
                <c:pt idx="3">
                  <c:v>1.4761431744386879</c:v>
                </c:pt>
                <c:pt idx="4">
                  <c:v>1.1200745561328525</c:v>
                </c:pt>
                <c:pt idx="5">
                  <c:v>2.0590799475973594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76E0-4E8C-A788-D02A65E43B7C}"/>
            </c:ext>
          </c:extLst>
        </c:ser>
        <c:ser>
          <c:idx val="0"/>
          <c:order val="3"/>
          <c:tx>
            <c:strRef>
              <c:f>'liver clock '!$R$37</c:f>
              <c:strCache>
                <c:ptCount val="1"/>
                <c:pt idx="0">
                  <c:v>HF-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clock '!$K$34:$Q$34</c:f>
                <c:numCache>
                  <c:formatCode>General</c:formatCode>
                  <c:ptCount val="7"/>
                  <c:pt idx="0">
                    <c:v>8.177440176929561E-2</c:v>
                  </c:pt>
                  <c:pt idx="1">
                    <c:v>0.33908931533398906</c:v>
                  </c:pt>
                  <c:pt idx="2">
                    <c:v>0.27509659360990524</c:v>
                  </c:pt>
                  <c:pt idx="3">
                    <c:v>5.029231214330384E-2</c:v>
                  </c:pt>
                  <c:pt idx="4">
                    <c:v>0.2277171485834549</c:v>
                  </c:pt>
                  <c:pt idx="5">
                    <c:v>0.27026228532645691</c:v>
                  </c:pt>
                  <c:pt idx="6">
                    <c:v>8.177440176929561E-2</c:v>
                  </c:pt>
                </c:numCache>
              </c:numRef>
            </c:plus>
            <c:minus>
              <c:numRef>
                <c:f>'liver clock '!$K$34:$Q$34</c:f>
                <c:numCache>
                  <c:formatCode>General</c:formatCode>
                  <c:ptCount val="7"/>
                  <c:pt idx="0">
                    <c:v>8.177440176929561E-2</c:v>
                  </c:pt>
                  <c:pt idx="1">
                    <c:v>0.33908931533398906</c:v>
                  </c:pt>
                  <c:pt idx="2">
                    <c:v>0.27509659360990524</c:v>
                  </c:pt>
                  <c:pt idx="3">
                    <c:v>5.029231214330384E-2</c:v>
                  </c:pt>
                  <c:pt idx="4">
                    <c:v>0.2277171485834549</c:v>
                  </c:pt>
                  <c:pt idx="5">
                    <c:v>0.27026228532645691</c:v>
                  </c:pt>
                  <c:pt idx="6">
                    <c:v>8.17744017692956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clock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clock '!$K$37:$Q$37</c:f>
              <c:numCache>
                <c:formatCode>0.00</c:formatCode>
                <c:ptCount val="7"/>
                <c:pt idx="0">
                  <c:v>1.1366426138228218</c:v>
                </c:pt>
                <c:pt idx="1">
                  <c:v>1.7859575200131332</c:v>
                </c:pt>
                <c:pt idx="2">
                  <c:v>1.697996665825932</c:v>
                </c:pt>
                <c:pt idx="3">
                  <c:v>1</c:v>
                </c:pt>
                <c:pt idx="4">
                  <c:v>1.384632380998907</c:v>
                </c:pt>
                <c:pt idx="5">
                  <c:v>1.710898496008576</c:v>
                </c:pt>
                <c:pt idx="6">
                  <c:v>1.136642613822821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76E0-4E8C-A788-D02A65E43B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liver ror 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ror '!$AF$34:$AL$34</c:f>
                <c:numCache>
                  <c:formatCode>General</c:formatCode>
                  <c:ptCount val="7"/>
                  <c:pt idx="0">
                    <c:v>0.10085110941112375</c:v>
                  </c:pt>
                  <c:pt idx="1">
                    <c:v>0.13518136610476206</c:v>
                  </c:pt>
                  <c:pt idx="2">
                    <c:v>2.1265435898298407E-2</c:v>
                  </c:pt>
                  <c:pt idx="3">
                    <c:v>0.18835832451971718</c:v>
                  </c:pt>
                  <c:pt idx="4">
                    <c:v>0.13785087825837911</c:v>
                  </c:pt>
                  <c:pt idx="5">
                    <c:v>0.12133972732609122</c:v>
                  </c:pt>
                  <c:pt idx="6">
                    <c:v>0.10085110941112375</c:v>
                  </c:pt>
                </c:numCache>
              </c:numRef>
            </c:plus>
            <c:minus>
              <c:numRef>
                <c:f>'liver ror '!$AF$34:$AL$34</c:f>
                <c:numCache>
                  <c:formatCode>General</c:formatCode>
                  <c:ptCount val="7"/>
                  <c:pt idx="0">
                    <c:v>0.10085110941112375</c:v>
                  </c:pt>
                  <c:pt idx="1">
                    <c:v>0.13518136610476206</c:v>
                  </c:pt>
                  <c:pt idx="2">
                    <c:v>2.1265435898298407E-2</c:v>
                  </c:pt>
                  <c:pt idx="3">
                    <c:v>0.18835832451971718</c:v>
                  </c:pt>
                  <c:pt idx="4">
                    <c:v>0.13785087825837911</c:v>
                  </c:pt>
                  <c:pt idx="5">
                    <c:v>0.12133972732609122</c:v>
                  </c:pt>
                  <c:pt idx="6">
                    <c:v>0.100851109411123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ror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ror '!$K$40:$Q$40</c:f>
              <c:numCache>
                <c:formatCode>0.00</c:formatCode>
                <c:ptCount val="7"/>
                <c:pt idx="0">
                  <c:v>1.1715625268876586</c:v>
                </c:pt>
                <c:pt idx="1">
                  <c:v>1.3055692814856104</c:v>
                </c:pt>
                <c:pt idx="2">
                  <c:v>1.0345700149756554</c:v>
                </c:pt>
                <c:pt idx="3">
                  <c:v>1</c:v>
                </c:pt>
                <c:pt idx="4">
                  <c:v>1.0701612465891821</c:v>
                </c:pt>
                <c:pt idx="5">
                  <c:v>1.2607797723027216</c:v>
                </c:pt>
                <c:pt idx="6">
                  <c:v>1.171562526887658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857-450D-8609-AB81AB6E43FA}"/>
            </c:ext>
          </c:extLst>
        </c:ser>
        <c:ser>
          <c:idx val="2"/>
          <c:order val="1"/>
          <c:tx>
            <c:strRef>
              <c:f>'liver ror 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ror '!$Y$34:$AE$34</c:f>
                <c:numCache>
                  <c:formatCode>General</c:formatCode>
                  <c:ptCount val="7"/>
                  <c:pt idx="0">
                    <c:v>0.17954849114899435</c:v>
                  </c:pt>
                  <c:pt idx="1">
                    <c:v>5.7516118552942953E-2</c:v>
                  </c:pt>
                  <c:pt idx="2">
                    <c:v>0.13507702691525034</c:v>
                  </c:pt>
                  <c:pt idx="3">
                    <c:v>5.873054634274303E-2</c:v>
                  </c:pt>
                  <c:pt idx="4">
                    <c:v>0.10579650365302366</c:v>
                  </c:pt>
                  <c:pt idx="5">
                    <c:v>0.10129662473397723</c:v>
                  </c:pt>
                  <c:pt idx="6">
                    <c:v>0.17954849114899435</c:v>
                  </c:pt>
                </c:numCache>
              </c:numRef>
            </c:plus>
            <c:minus>
              <c:numRef>
                <c:f>'liver ror '!$Y$34:$AE$34</c:f>
                <c:numCache>
                  <c:formatCode>General</c:formatCode>
                  <c:ptCount val="7"/>
                  <c:pt idx="0">
                    <c:v>0.17954849114899435</c:v>
                  </c:pt>
                  <c:pt idx="1">
                    <c:v>5.7516118552942953E-2</c:v>
                  </c:pt>
                  <c:pt idx="2">
                    <c:v>0.13507702691525034</c:v>
                  </c:pt>
                  <c:pt idx="3">
                    <c:v>5.873054634274303E-2</c:v>
                  </c:pt>
                  <c:pt idx="4">
                    <c:v>0.10579650365302366</c:v>
                  </c:pt>
                  <c:pt idx="5">
                    <c:v>0.10129662473397723</c:v>
                  </c:pt>
                  <c:pt idx="6">
                    <c:v>0.179548491148994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ror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ror '!$K$39:$Q$39</c:f>
              <c:numCache>
                <c:formatCode>0.00</c:formatCode>
                <c:ptCount val="7"/>
                <c:pt idx="0">
                  <c:v>1.4915710928409767</c:v>
                </c:pt>
                <c:pt idx="1">
                  <c:v>1.2780369273396384</c:v>
                </c:pt>
                <c:pt idx="2">
                  <c:v>1.1184307746395892</c:v>
                </c:pt>
                <c:pt idx="3">
                  <c:v>1.2113084845167168</c:v>
                </c:pt>
                <c:pt idx="4">
                  <c:v>1.1591342978347956</c:v>
                </c:pt>
                <c:pt idx="5">
                  <c:v>1</c:v>
                </c:pt>
                <c:pt idx="6">
                  <c:v>1.491571092840976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F857-450D-8609-AB81AB6E43FA}"/>
            </c:ext>
          </c:extLst>
        </c:ser>
        <c:ser>
          <c:idx val="1"/>
          <c:order val="2"/>
          <c:tx>
            <c:strRef>
              <c:f>'liver ror 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ror '!$R$34:$X$34</c:f>
                <c:numCache>
                  <c:formatCode>General</c:formatCode>
                  <c:ptCount val="7"/>
                  <c:pt idx="0">
                    <c:v>0.57173395671212479</c:v>
                  </c:pt>
                  <c:pt idx="1">
                    <c:v>6.0971403516481629E-2</c:v>
                  </c:pt>
                  <c:pt idx="2">
                    <c:v>0.88325614936648578</c:v>
                  </c:pt>
                  <c:pt idx="3">
                    <c:v>0.67747329373815046</c:v>
                  </c:pt>
                  <c:pt idx="4">
                    <c:v>0.89036386051346461</c:v>
                  </c:pt>
                  <c:pt idx="5">
                    <c:v>0.12456485370955196</c:v>
                  </c:pt>
                  <c:pt idx="6">
                    <c:v>0.57173395671212479</c:v>
                  </c:pt>
                </c:numCache>
              </c:numRef>
            </c:plus>
            <c:minus>
              <c:numRef>
                <c:f>'liver ror '!$R$34:$X$34</c:f>
                <c:numCache>
                  <c:formatCode>General</c:formatCode>
                  <c:ptCount val="7"/>
                  <c:pt idx="0">
                    <c:v>0.57173395671212479</c:v>
                  </c:pt>
                  <c:pt idx="1">
                    <c:v>6.0971403516481629E-2</c:v>
                  </c:pt>
                  <c:pt idx="2">
                    <c:v>0.88325614936648578</c:v>
                  </c:pt>
                  <c:pt idx="3">
                    <c:v>0.67747329373815046</c:v>
                  </c:pt>
                  <c:pt idx="4">
                    <c:v>0.89036386051346461</c:v>
                  </c:pt>
                  <c:pt idx="5">
                    <c:v>0.12456485370955196</c:v>
                  </c:pt>
                  <c:pt idx="6">
                    <c:v>0.571733956712124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ror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ror '!$K$38:$Q$38</c:f>
              <c:numCache>
                <c:formatCode>0.00</c:formatCode>
                <c:ptCount val="7"/>
                <c:pt idx="0">
                  <c:v>2.8541841477276777</c:v>
                </c:pt>
                <c:pt idx="1">
                  <c:v>1</c:v>
                </c:pt>
                <c:pt idx="2">
                  <c:v>4.9198988469607823</c:v>
                </c:pt>
                <c:pt idx="3">
                  <c:v>3.2636579155907581</c:v>
                </c:pt>
                <c:pt idx="4">
                  <c:v>3.4764182420502494</c:v>
                </c:pt>
                <c:pt idx="5">
                  <c:v>6.6257099762342531</c:v>
                </c:pt>
                <c:pt idx="6">
                  <c:v>2.854184147727677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F857-450D-8609-AB81AB6E43FA}"/>
            </c:ext>
          </c:extLst>
        </c:ser>
        <c:ser>
          <c:idx val="0"/>
          <c:order val="3"/>
          <c:tx>
            <c:strRef>
              <c:f>'liver ror 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ror '!$K$34:$Q$34</c:f>
                <c:numCache>
                  <c:formatCode>General</c:formatCode>
                  <c:ptCount val="7"/>
                  <c:pt idx="0">
                    <c:v>0.20129640478225688</c:v>
                  </c:pt>
                  <c:pt idx="1">
                    <c:v>0.16584101096267062</c:v>
                  </c:pt>
                  <c:pt idx="2">
                    <c:v>0.11568268353323796</c:v>
                  </c:pt>
                  <c:pt idx="3">
                    <c:v>0.11962051142151132</c:v>
                  </c:pt>
                  <c:pt idx="4">
                    <c:v>7.8024346878137807E-2</c:v>
                  </c:pt>
                  <c:pt idx="5">
                    <c:v>0.25523369704088888</c:v>
                  </c:pt>
                  <c:pt idx="6">
                    <c:v>0.20129640478225688</c:v>
                  </c:pt>
                </c:numCache>
              </c:numRef>
            </c:plus>
            <c:minus>
              <c:numRef>
                <c:f>'liver ror '!$K$34:$Q$34</c:f>
                <c:numCache>
                  <c:formatCode>General</c:formatCode>
                  <c:ptCount val="7"/>
                  <c:pt idx="0">
                    <c:v>0.20129640478225688</c:v>
                  </c:pt>
                  <c:pt idx="1">
                    <c:v>0.16584101096267062</c:v>
                  </c:pt>
                  <c:pt idx="2">
                    <c:v>0.11568268353323796</c:v>
                  </c:pt>
                  <c:pt idx="3">
                    <c:v>0.11962051142151132</c:v>
                  </c:pt>
                  <c:pt idx="4">
                    <c:v>7.8024346878137807E-2</c:v>
                  </c:pt>
                  <c:pt idx="5">
                    <c:v>0.25523369704088888</c:v>
                  </c:pt>
                  <c:pt idx="6">
                    <c:v>0.201296404782256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ror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ror '!$K$37:$Q$37</c:f>
              <c:numCache>
                <c:formatCode>0.00</c:formatCode>
                <c:ptCount val="7"/>
                <c:pt idx="0">
                  <c:v>1</c:v>
                </c:pt>
                <c:pt idx="1">
                  <c:v>2.6414498645562525</c:v>
                </c:pt>
                <c:pt idx="2">
                  <c:v>1.6243142787816045</c:v>
                </c:pt>
                <c:pt idx="3">
                  <c:v>1.3011306846917452</c:v>
                </c:pt>
                <c:pt idx="4">
                  <c:v>1.8427891933462015</c:v>
                </c:pt>
                <c:pt idx="5">
                  <c:v>2.392761182296181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F857-450D-8609-AB81AB6E43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liver reverb 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reverb '!$AF$34:$AL$34</c:f>
                <c:numCache>
                  <c:formatCode>General</c:formatCode>
                  <c:ptCount val="7"/>
                  <c:pt idx="0">
                    <c:v>0.10085110941112375</c:v>
                  </c:pt>
                  <c:pt idx="1">
                    <c:v>7.828649061168258E-2</c:v>
                  </c:pt>
                  <c:pt idx="2">
                    <c:v>4.5876506217096269E-2</c:v>
                  </c:pt>
                  <c:pt idx="3">
                    <c:v>0.18835832451971718</c:v>
                  </c:pt>
                  <c:pt idx="4">
                    <c:v>0.20677631738756866</c:v>
                  </c:pt>
                  <c:pt idx="5">
                    <c:v>0.12133972732609122</c:v>
                  </c:pt>
                  <c:pt idx="6">
                    <c:v>0.10085110941112375</c:v>
                  </c:pt>
                </c:numCache>
              </c:numRef>
            </c:plus>
            <c:minus>
              <c:numRef>
                <c:f>'liver reverb '!$AF$34:$AL$34</c:f>
                <c:numCache>
                  <c:formatCode>General</c:formatCode>
                  <c:ptCount val="7"/>
                  <c:pt idx="0">
                    <c:v>0.10085110941112375</c:v>
                  </c:pt>
                  <c:pt idx="1">
                    <c:v>7.828649061168258E-2</c:v>
                  </c:pt>
                  <c:pt idx="2">
                    <c:v>4.5876506217096269E-2</c:v>
                  </c:pt>
                  <c:pt idx="3">
                    <c:v>0.18835832451971718</c:v>
                  </c:pt>
                  <c:pt idx="4">
                    <c:v>0.20677631738756866</c:v>
                  </c:pt>
                  <c:pt idx="5">
                    <c:v>0.12133972732609122</c:v>
                  </c:pt>
                  <c:pt idx="6">
                    <c:v>0.100851109411123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reverb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reverb '!$K$40:$Q$40</c:f>
              <c:numCache>
                <c:formatCode>0.00</c:formatCode>
                <c:ptCount val="7"/>
                <c:pt idx="0">
                  <c:v>1.1715625268876586</c:v>
                </c:pt>
                <c:pt idx="1">
                  <c:v>1.1350536776351046</c:v>
                </c:pt>
                <c:pt idx="2">
                  <c:v>1.0868995476344887</c:v>
                </c:pt>
                <c:pt idx="3">
                  <c:v>1</c:v>
                </c:pt>
                <c:pt idx="4">
                  <c:v>1.0701612465891821</c:v>
                </c:pt>
                <c:pt idx="5">
                  <c:v>1.2607797723027216</c:v>
                </c:pt>
                <c:pt idx="6">
                  <c:v>1.171562526887658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3D43-4A14-8446-2A6AB4883F2F}"/>
            </c:ext>
          </c:extLst>
        </c:ser>
        <c:ser>
          <c:idx val="2"/>
          <c:order val="1"/>
          <c:tx>
            <c:strRef>
              <c:f>'liver reverb 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reverb '!$Y$34:$AE$34</c:f>
                <c:numCache>
                  <c:formatCode>General</c:formatCode>
                  <c:ptCount val="7"/>
                  <c:pt idx="0">
                    <c:v>8.977424557449741E-2</c:v>
                  </c:pt>
                  <c:pt idx="1">
                    <c:v>8.627417782941442E-2</c:v>
                  </c:pt>
                  <c:pt idx="2">
                    <c:v>0.20332425541413834</c:v>
                  </c:pt>
                  <c:pt idx="3">
                    <c:v>9.3391333563846116E-2</c:v>
                  </c:pt>
                  <c:pt idx="4">
                    <c:v>6.7561228477489826E-2</c:v>
                  </c:pt>
                  <c:pt idx="5">
                    <c:v>0.10129662473397745</c:v>
                  </c:pt>
                  <c:pt idx="6">
                    <c:v>8.977424557449741E-2</c:v>
                  </c:pt>
                </c:numCache>
              </c:numRef>
            </c:plus>
            <c:minus>
              <c:numRef>
                <c:f>'liver reverb '!$Y$34:$AE$34</c:f>
                <c:numCache>
                  <c:formatCode>General</c:formatCode>
                  <c:ptCount val="7"/>
                  <c:pt idx="0">
                    <c:v>8.977424557449741E-2</c:v>
                  </c:pt>
                  <c:pt idx="1">
                    <c:v>8.627417782941442E-2</c:v>
                  </c:pt>
                  <c:pt idx="2">
                    <c:v>0.20332425541413834</c:v>
                  </c:pt>
                  <c:pt idx="3">
                    <c:v>9.3391333563846116E-2</c:v>
                  </c:pt>
                  <c:pt idx="4">
                    <c:v>6.7561228477489826E-2</c:v>
                  </c:pt>
                  <c:pt idx="5">
                    <c:v>0.10129662473397745</c:v>
                  </c:pt>
                  <c:pt idx="6">
                    <c:v>8.97742455744974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reverb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reverb '!$K$39:$Q$39</c:f>
              <c:numCache>
                <c:formatCode>0.00</c:formatCode>
                <c:ptCount val="7"/>
                <c:pt idx="0">
                  <c:v>1.4915710928409764</c:v>
                </c:pt>
                <c:pt idx="1">
                  <c:v>1.2780369273396381</c:v>
                </c:pt>
                <c:pt idx="2">
                  <c:v>1.683514285730686</c:v>
                </c:pt>
                <c:pt idx="3">
                  <c:v>1.0885445555008513</c:v>
                </c:pt>
                <c:pt idx="4">
                  <c:v>1.2446574981206184</c:v>
                </c:pt>
                <c:pt idx="5">
                  <c:v>1</c:v>
                </c:pt>
                <c:pt idx="6">
                  <c:v>1.491571092840976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3D43-4A14-8446-2A6AB4883F2F}"/>
            </c:ext>
          </c:extLst>
        </c:ser>
        <c:ser>
          <c:idx val="1"/>
          <c:order val="2"/>
          <c:tx>
            <c:strRef>
              <c:f>'liver reverb 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reverb '!$R$34:$X$34</c:f>
                <c:numCache>
                  <c:formatCode>General</c:formatCode>
                  <c:ptCount val="7"/>
                  <c:pt idx="0">
                    <c:v>0.3688276593879572</c:v>
                  </c:pt>
                  <c:pt idx="1">
                    <c:v>8.6955531458042468E-2</c:v>
                  </c:pt>
                  <c:pt idx="2">
                    <c:v>0.19016759284659668</c:v>
                  </c:pt>
                  <c:pt idx="3">
                    <c:v>0.16004173669992108</c:v>
                  </c:pt>
                  <c:pt idx="4">
                    <c:v>0.20746332994986091</c:v>
                  </c:pt>
                  <c:pt idx="5">
                    <c:v>0.2529418171595873</c:v>
                  </c:pt>
                  <c:pt idx="6">
                    <c:v>0.3688276593879572</c:v>
                  </c:pt>
                </c:numCache>
              </c:numRef>
            </c:plus>
            <c:minus>
              <c:numRef>
                <c:f>'liver reverb '!$R$34:$X$34</c:f>
                <c:numCache>
                  <c:formatCode>General</c:formatCode>
                  <c:ptCount val="7"/>
                  <c:pt idx="0">
                    <c:v>0.3688276593879572</c:v>
                  </c:pt>
                  <c:pt idx="1">
                    <c:v>8.6955531458042468E-2</c:v>
                  </c:pt>
                  <c:pt idx="2">
                    <c:v>0.19016759284659668</c:v>
                  </c:pt>
                  <c:pt idx="3">
                    <c:v>0.16004173669992108</c:v>
                  </c:pt>
                  <c:pt idx="4">
                    <c:v>0.20746332994986091</c:v>
                  </c:pt>
                  <c:pt idx="5">
                    <c:v>0.2529418171595873</c:v>
                  </c:pt>
                  <c:pt idx="6">
                    <c:v>0.36882765938795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reverb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reverb '!$K$38:$Q$38</c:f>
              <c:numCache>
                <c:formatCode>0.00</c:formatCode>
                <c:ptCount val="7"/>
                <c:pt idx="0">
                  <c:v>1</c:v>
                </c:pt>
                <c:pt idx="1">
                  <c:v>2.6247652157832149</c:v>
                </c:pt>
                <c:pt idx="2">
                  <c:v>2.7124505564587054</c:v>
                </c:pt>
                <c:pt idx="3">
                  <c:v>2.0861741823666553</c:v>
                </c:pt>
                <c:pt idx="4">
                  <c:v>2.3828927089983454</c:v>
                </c:pt>
                <c:pt idx="5">
                  <c:v>2.5256748160057212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3D43-4A14-8446-2A6AB4883F2F}"/>
            </c:ext>
          </c:extLst>
        </c:ser>
        <c:ser>
          <c:idx val="0"/>
          <c:order val="3"/>
          <c:tx>
            <c:strRef>
              <c:f>'liver reverb 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ver reverb '!$K$34:$Q$34</c:f>
                <c:numCache>
                  <c:formatCode>General</c:formatCode>
                  <c:ptCount val="7"/>
                  <c:pt idx="0">
                    <c:v>0.17417889933003092</c:v>
                  </c:pt>
                  <c:pt idx="1">
                    <c:v>0.24695884034214141</c:v>
                  </c:pt>
                  <c:pt idx="2">
                    <c:v>0.35973488141973914</c:v>
                  </c:pt>
                  <c:pt idx="3">
                    <c:v>0.18130073421011197</c:v>
                  </c:pt>
                  <c:pt idx="4">
                    <c:v>0.12011929312184866</c:v>
                  </c:pt>
                  <c:pt idx="5">
                    <c:v>0.10722589855926724</c:v>
                  </c:pt>
                  <c:pt idx="6">
                    <c:v>0.17417889933003092</c:v>
                  </c:pt>
                </c:numCache>
              </c:numRef>
            </c:plus>
            <c:minus>
              <c:numRef>
                <c:f>'liver reverb '!$K$34:$Q$34</c:f>
                <c:numCache>
                  <c:formatCode>General</c:formatCode>
                  <c:ptCount val="7"/>
                  <c:pt idx="0">
                    <c:v>0.17417889933003092</c:v>
                  </c:pt>
                  <c:pt idx="1">
                    <c:v>0.24695884034214141</c:v>
                  </c:pt>
                  <c:pt idx="2">
                    <c:v>0.35973488141973914</c:v>
                  </c:pt>
                  <c:pt idx="3">
                    <c:v>0.18130073421011197</c:v>
                  </c:pt>
                  <c:pt idx="4">
                    <c:v>0.12011929312184866</c:v>
                  </c:pt>
                  <c:pt idx="5">
                    <c:v>0.10722589855926724</c:v>
                  </c:pt>
                  <c:pt idx="6">
                    <c:v>0.174178899330030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liver reverb 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liver reverb '!$K$37:$Q$37</c:f>
              <c:numCache>
                <c:formatCode>0.00</c:formatCode>
                <c:ptCount val="7"/>
                <c:pt idx="0">
                  <c:v>1.0071845282777474</c:v>
                </c:pt>
                <c:pt idx="1">
                  <c:v>2.0836436625038934</c:v>
                </c:pt>
                <c:pt idx="2">
                  <c:v>2.2723139274868331</c:v>
                </c:pt>
                <c:pt idx="3">
                  <c:v>1.1434987697255261</c:v>
                </c:pt>
                <c:pt idx="4">
                  <c:v>1.1949287150115211</c:v>
                </c:pt>
                <c:pt idx="5">
                  <c:v>1</c:v>
                </c:pt>
                <c:pt idx="6">
                  <c:v>1.007184528277747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3D43-4A14-8446-2A6AB4883F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muscle reverb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reverb'!$AF$34:$AL$34</c:f>
                <c:numCache>
                  <c:formatCode>General</c:formatCode>
                  <c:ptCount val="7"/>
                  <c:pt idx="0">
                    <c:v>9.6689652287103911E-2</c:v>
                  </c:pt>
                  <c:pt idx="1">
                    <c:v>0.15170442653904598</c:v>
                  </c:pt>
                  <c:pt idx="2">
                    <c:v>6.2888455758850145E-2</c:v>
                  </c:pt>
                  <c:pt idx="3">
                    <c:v>0.11124834677549063</c:v>
                  </c:pt>
                  <c:pt idx="4">
                    <c:v>0.24219242649122291</c:v>
                  </c:pt>
                  <c:pt idx="5">
                    <c:v>4.0436189024216911E-2</c:v>
                  </c:pt>
                  <c:pt idx="6">
                    <c:v>9.6689652287103911E-2</c:v>
                  </c:pt>
                </c:numCache>
              </c:numRef>
            </c:plus>
            <c:minus>
              <c:numRef>
                <c:f>'muscle reverb'!$AF$34:$AL$34</c:f>
                <c:numCache>
                  <c:formatCode>General</c:formatCode>
                  <c:ptCount val="7"/>
                  <c:pt idx="0">
                    <c:v>9.6689652287103911E-2</c:v>
                  </c:pt>
                  <c:pt idx="1">
                    <c:v>0.15170442653904598</c:v>
                  </c:pt>
                  <c:pt idx="2">
                    <c:v>6.2888455758850145E-2</c:v>
                  </c:pt>
                  <c:pt idx="3">
                    <c:v>0.11124834677549063</c:v>
                  </c:pt>
                  <c:pt idx="4">
                    <c:v>0.24219242649122291</c:v>
                  </c:pt>
                  <c:pt idx="5">
                    <c:v>4.0436189024216911E-2</c:v>
                  </c:pt>
                  <c:pt idx="6">
                    <c:v>9.668965228710391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reverb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reverb'!$K$40:$Q$40</c:f>
              <c:numCache>
                <c:formatCode>0.00</c:formatCode>
                <c:ptCount val="7"/>
                <c:pt idx="0">
                  <c:v>1.6141606405126363</c:v>
                </c:pt>
                <c:pt idx="1">
                  <c:v>2.2638799197224753</c:v>
                </c:pt>
                <c:pt idx="2">
                  <c:v>1</c:v>
                </c:pt>
                <c:pt idx="3">
                  <c:v>1.8864056259533937</c:v>
                </c:pt>
                <c:pt idx="4">
                  <c:v>1.4662359695840923</c:v>
                </c:pt>
                <c:pt idx="5">
                  <c:v>1.5251648195515732</c:v>
                </c:pt>
                <c:pt idx="6">
                  <c:v>1.614160640512636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C54-491B-8529-7A55DC77E3A5}"/>
            </c:ext>
          </c:extLst>
        </c:ser>
        <c:ser>
          <c:idx val="2"/>
          <c:order val="1"/>
          <c:tx>
            <c:strRef>
              <c:f>'muscle reverb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reverb'!$Y$34:$AE$34</c:f>
                <c:numCache>
                  <c:formatCode>General</c:formatCode>
                  <c:ptCount val="7"/>
                  <c:pt idx="0">
                    <c:v>8.5347336705348956E-2</c:v>
                  </c:pt>
                  <c:pt idx="1">
                    <c:v>0.14688704635991329</c:v>
                  </c:pt>
                  <c:pt idx="2">
                    <c:v>0.17582391996921512</c:v>
                  </c:pt>
                  <c:pt idx="3">
                    <c:v>0.13996704929718196</c:v>
                  </c:pt>
                  <c:pt idx="4">
                    <c:v>7.8367686055807781E-2</c:v>
                  </c:pt>
                  <c:pt idx="5">
                    <c:v>8.7158779462533309E-2</c:v>
                  </c:pt>
                  <c:pt idx="6">
                    <c:v>8.5347336705348956E-2</c:v>
                  </c:pt>
                </c:numCache>
              </c:numRef>
            </c:plus>
            <c:minus>
              <c:numRef>
                <c:f>'muscle reverb'!$Y$34:$AE$34</c:f>
                <c:numCache>
                  <c:formatCode>General</c:formatCode>
                  <c:ptCount val="7"/>
                  <c:pt idx="0">
                    <c:v>8.5347336705348956E-2</c:v>
                  </c:pt>
                  <c:pt idx="1">
                    <c:v>0.14688704635991329</c:v>
                  </c:pt>
                  <c:pt idx="2">
                    <c:v>0.17582391996921512</c:v>
                  </c:pt>
                  <c:pt idx="3">
                    <c:v>0.13996704929718196</c:v>
                  </c:pt>
                  <c:pt idx="4">
                    <c:v>7.8367686055807781E-2</c:v>
                  </c:pt>
                  <c:pt idx="5">
                    <c:v>8.7158779462533309E-2</c:v>
                  </c:pt>
                  <c:pt idx="6">
                    <c:v>8.534733670534895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reverb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reverb'!$K$39:$Q$39</c:f>
              <c:numCache>
                <c:formatCode>0.00</c:formatCode>
                <c:ptCount val="7"/>
                <c:pt idx="0">
                  <c:v>1.3038098252644432</c:v>
                </c:pt>
                <c:pt idx="1">
                  <c:v>1.6340317360623231</c:v>
                </c:pt>
                <c:pt idx="2">
                  <c:v>1.391159455449601</c:v>
                </c:pt>
                <c:pt idx="3">
                  <c:v>1.4069420995581612</c:v>
                </c:pt>
                <c:pt idx="4">
                  <c:v>1.5038394735738407</c:v>
                </c:pt>
                <c:pt idx="5">
                  <c:v>1</c:v>
                </c:pt>
                <c:pt idx="6">
                  <c:v>1.303809825264443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C54-491B-8529-7A55DC77E3A5}"/>
            </c:ext>
          </c:extLst>
        </c:ser>
        <c:ser>
          <c:idx val="1"/>
          <c:order val="2"/>
          <c:tx>
            <c:strRef>
              <c:f>'muscle reverb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reverb'!$R$34:$X$34</c:f>
                <c:numCache>
                  <c:formatCode>General</c:formatCode>
                  <c:ptCount val="7"/>
                  <c:pt idx="0">
                    <c:v>0.2561480249548832</c:v>
                  </c:pt>
                  <c:pt idx="1">
                    <c:v>0.70683820117129814</c:v>
                  </c:pt>
                  <c:pt idx="2">
                    <c:v>0.83231327240864528</c:v>
                  </c:pt>
                  <c:pt idx="3">
                    <c:v>0.37959027364466674</c:v>
                  </c:pt>
                  <c:pt idx="4">
                    <c:v>0.76518790632602607</c:v>
                  </c:pt>
                  <c:pt idx="5">
                    <c:v>0.51969156522863713</c:v>
                  </c:pt>
                  <c:pt idx="6">
                    <c:v>0.2561480249548832</c:v>
                  </c:pt>
                </c:numCache>
              </c:numRef>
            </c:plus>
            <c:minus>
              <c:numRef>
                <c:f>'muscle reverb'!$R$34:$X$34</c:f>
                <c:numCache>
                  <c:formatCode>General</c:formatCode>
                  <c:ptCount val="7"/>
                  <c:pt idx="0">
                    <c:v>0.2561480249548832</c:v>
                  </c:pt>
                  <c:pt idx="1">
                    <c:v>0.70683820117129814</c:v>
                  </c:pt>
                  <c:pt idx="2">
                    <c:v>0.83231327240864528</c:v>
                  </c:pt>
                  <c:pt idx="3">
                    <c:v>0.37959027364466674</c:v>
                  </c:pt>
                  <c:pt idx="4">
                    <c:v>0.76518790632602607</c:v>
                  </c:pt>
                  <c:pt idx="5">
                    <c:v>0.51969156522863713</c:v>
                  </c:pt>
                  <c:pt idx="6">
                    <c:v>0.25614802495488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reverb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reverb'!$K$38:$Q$38</c:f>
              <c:numCache>
                <c:formatCode>0.00</c:formatCode>
                <c:ptCount val="7"/>
                <c:pt idx="0">
                  <c:v>1</c:v>
                </c:pt>
                <c:pt idx="1">
                  <c:v>9.0941750824650995</c:v>
                </c:pt>
                <c:pt idx="2">
                  <c:v>3.72276489704028</c:v>
                </c:pt>
                <c:pt idx="3">
                  <c:v>6.0521034928318986</c:v>
                </c:pt>
                <c:pt idx="4">
                  <c:v>4.1963243476499059</c:v>
                </c:pt>
                <c:pt idx="5">
                  <c:v>3.6888380771879805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CC54-491B-8529-7A55DC77E3A5}"/>
            </c:ext>
          </c:extLst>
        </c:ser>
        <c:ser>
          <c:idx val="0"/>
          <c:order val="3"/>
          <c:tx>
            <c:strRef>
              <c:f>'muscle reverb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reverb'!$K$34:$Q$34</c:f>
                <c:numCache>
                  <c:formatCode>General</c:formatCode>
                  <c:ptCount val="7"/>
                  <c:pt idx="0">
                    <c:v>0.12924487941451723</c:v>
                  </c:pt>
                  <c:pt idx="1">
                    <c:v>0.27811040200138892</c:v>
                  </c:pt>
                  <c:pt idx="2">
                    <c:v>0.34087372406116223</c:v>
                  </c:pt>
                  <c:pt idx="3">
                    <c:v>0.16961998221200095</c:v>
                  </c:pt>
                  <c:pt idx="4">
                    <c:v>0.16769946793959936</c:v>
                  </c:pt>
                  <c:pt idx="5">
                    <c:v>0.23650010534487556</c:v>
                  </c:pt>
                  <c:pt idx="6">
                    <c:v>0.12924487941451723</c:v>
                  </c:pt>
                </c:numCache>
              </c:numRef>
            </c:plus>
            <c:minus>
              <c:numRef>
                <c:f>'muscle reverb'!$K$34:$Q$34</c:f>
                <c:numCache>
                  <c:formatCode>General</c:formatCode>
                  <c:ptCount val="7"/>
                  <c:pt idx="0">
                    <c:v>0.12924487941451723</c:v>
                  </c:pt>
                  <c:pt idx="1">
                    <c:v>0.27811040200138892</c:v>
                  </c:pt>
                  <c:pt idx="2">
                    <c:v>0.34087372406116223</c:v>
                  </c:pt>
                  <c:pt idx="3">
                    <c:v>0.16961998221200095</c:v>
                  </c:pt>
                  <c:pt idx="4">
                    <c:v>0.16769946793959936</c:v>
                  </c:pt>
                  <c:pt idx="5">
                    <c:v>0.23650010534487556</c:v>
                  </c:pt>
                  <c:pt idx="6">
                    <c:v>0.129244879414517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reverb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reverb'!$K$37:$Q$37</c:f>
              <c:numCache>
                <c:formatCode>0.00</c:formatCode>
                <c:ptCount val="7"/>
                <c:pt idx="0">
                  <c:v>1</c:v>
                </c:pt>
                <c:pt idx="1">
                  <c:v>2.2954541498454204</c:v>
                </c:pt>
                <c:pt idx="2">
                  <c:v>1.7550829397019927</c:v>
                </c:pt>
                <c:pt idx="3">
                  <c:v>1.3358710310450301</c:v>
                </c:pt>
                <c:pt idx="4">
                  <c:v>1.4205508604710932</c:v>
                </c:pt>
                <c:pt idx="5">
                  <c:v>1.4860053490352065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CC54-491B-8529-7A55DC77E3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muscle ror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ror'!$AF$34:$AL$34</c:f>
                <c:numCache>
                  <c:formatCode>General</c:formatCode>
                  <c:ptCount val="7"/>
                  <c:pt idx="0">
                    <c:v>9.6689652287103911E-2</c:v>
                  </c:pt>
                  <c:pt idx="1">
                    <c:v>0.15170442653904598</c:v>
                  </c:pt>
                  <c:pt idx="2">
                    <c:v>6.2888455758850145E-2</c:v>
                  </c:pt>
                  <c:pt idx="3">
                    <c:v>0.11124834677549063</c:v>
                  </c:pt>
                  <c:pt idx="4">
                    <c:v>0.16146161766081527</c:v>
                  </c:pt>
                  <c:pt idx="5">
                    <c:v>4.0436189024216911E-2</c:v>
                  </c:pt>
                  <c:pt idx="6">
                    <c:v>9.6689652287103911E-2</c:v>
                  </c:pt>
                </c:numCache>
              </c:numRef>
            </c:plus>
            <c:minus>
              <c:numRef>
                <c:f>'muscle ror'!$AF$34:$AL$34</c:f>
                <c:numCache>
                  <c:formatCode>General</c:formatCode>
                  <c:ptCount val="7"/>
                  <c:pt idx="0">
                    <c:v>9.6689652287103911E-2</c:v>
                  </c:pt>
                  <c:pt idx="1">
                    <c:v>0.15170442653904598</c:v>
                  </c:pt>
                  <c:pt idx="2">
                    <c:v>6.2888455758850145E-2</c:v>
                  </c:pt>
                  <c:pt idx="3">
                    <c:v>0.11124834677549063</c:v>
                  </c:pt>
                  <c:pt idx="4">
                    <c:v>0.16146161766081527</c:v>
                  </c:pt>
                  <c:pt idx="5">
                    <c:v>4.0436189024216911E-2</c:v>
                  </c:pt>
                  <c:pt idx="6">
                    <c:v>9.668965228710391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ror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ror'!$K$40:$Q$40</c:f>
              <c:numCache>
                <c:formatCode>0.00</c:formatCode>
                <c:ptCount val="7"/>
                <c:pt idx="0">
                  <c:v>1.6141606405126363</c:v>
                </c:pt>
                <c:pt idx="1">
                  <c:v>2.2638799197224753</c:v>
                </c:pt>
                <c:pt idx="2">
                  <c:v>1</c:v>
                </c:pt>
                <c:pt idx="3">
                  <c:v>1.8864056259533937</c:v>
                </c:pt>
                <c:pt idx="4">
                  <c:v>1.4662359695840923</c:v>
                </c:pt>
                <c:pt idx="5">
                  <c:v>1.5251648195515732</c:v>
                </c:pt>
                <c:pt idx="6">
                  <c:v>1.614160640512636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B040-4573-82AA-9A8497DD943B}"/>
            </c:ext>
          </c:extLst>
        </c:ser>
        <c:ser>
          <c:idx val="2"/>
          <c:order val="1"/>
          <c:tx>
            <c:strRef>
              <c:f>'muscle ror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ror'!$Y$34:$AE$34</c:f>
                <c:numCache>
                  <c:formatCode>General</c:formatCode>
                  <c:ptCount val="7"/>
                  <c:pt idx="0">
                    <c:v>0.18469313560379014</c:v>
                  </c:pt>
                  <c:pt idx="1">
                    <c:v>0.10595538271042272</c:v>
                  </c:pt>
                  <c:pt idx="2">
                    <c:v>0.12638660455525683</c:v>
                  </c:pt>
                  <c:pt idx="3">
                    <c:v>0.11901392368437332</c:v>
                  </c:pt>
                  <c:pt idx="4">
                    <c:v>0.12337744000469496</c:v>
                  </c:pt>
                  <c:pt idx="5">
                    <c:v>9.430656477254562E-2</c:v>
                  </c:pt>
                  <c:pt idx="6">
                    <c:v>0.18469313560379014</c:v>
                  </c:pt>
                </c:numCache>
              </c:numRef>
            </c:plus>
            <c:minus>
              <c:numRef>
                <c:f>'muscle ror'!$Y$34:$AE$34</c:f>
                <c:numCache>
                  <c:formatCode>General</c:formatCode>
                  <c:ptCount val="7"/>
                  <c:pt idx="0">
                    <c:v>0.18469313560379014</c:v>
                  </c:pt>
                  <c:pt idx="1">
                    <c:v>0.10595538271042272</c:v>
                  </c:pt>
                  <c:pt idx="2">
                    <c:v>0.12638660455525683</c:v>
                  </c:pt>
                  <c:pt idx="3">
                    <c:v>0.11901392368437332</c:v>
                  </c:pt>
                  <c:pt idx="4">
                    <c:v>0.12337744000469496</c:v>
                  </c:pt>
                  <c:pt idx="5">
                    <c:v>9.430656477254562E-2</c:v>
                  </c:pt>
                  <c:pt idx="6">
                    <c:v>0.184693135603790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ror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ror'!$K$39:$Q$39</c:f>
              <c:numCache>
                <c:formatCode>0.00</c:formatCode>
                <c:ptCount val="7"/>
                <c:pt idx="0">
                  <c:v>1.4107336804806696</c:v>
                </c:pt>
                <c:pt idx="1">
                  <c:v>1.7680366878427791</c:v>
                </c:pt>
                <c:pt idx="2">
                  <c:v>1</c:v>
                </c:pt>
                <c:pt idx="3">
                  <c:v>1.683856895324523</c:v>
                </c:pt>
                <c:pt idx="4">
                  <c:v>1.4903514747939082</c:v>
                </c:pt>
                <c:pt idx="5">
                  <c:v>1.0820087816062742</c:v>
                </c:pt>
                <c:pt idx="6">
                  <c:v>1.41073368048066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040-4573-82AA-9A8497DD943B}"/>
            </c:ext>
          </c:extLst>
        </c:ser>
        <c:ser>
          <c:idx val="1"/>
          <c:order val="2"/>
          <c:tx>
            <c:strRef>
              <c:f>'muscle ror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ror'!$R$34:$X$34</c:f>
                <c:numCache>
                  <c:formatCode>General</c:formatCode>
                  <c:ptCount val="7"/>
                  <c:pt idx="0">
                    <c:v>0.46022887828975989</c:v>
                  </c:pt>
                  <c:pt idx="1">
                    <c:v>0.32469240069199162</c:v>
                  </c:pt>
                  <c:pt idx="2">
                    <c:v>0.37323995273401162</c:v>
                  </c:pt>
                  <c:pt idx="3">
                    <c:v>0.46636910722833502</c:v>
                  </c:pt>
                  <c:pt idx="4">
                    <c:v>0.33028837862976007</c:v>
                  </c:pt>
                  <c:pt idx="5">
                    <c:v>0.29302284747354346</c:v>
                  </c:pt>
                  <c:pt idx="6">
                    <c:v>0.46022887828975989</c:v>
                  </c:pt>
                </c:numCache>
              </c:numRef>
            </c:plus>
            <c:minus>
              <c:numRef>
                <c:f>'muscle ror'!$R$34:$X$34</c:f>
                <c:numCache>
                  <c:formatCode>General</c:formatCode>
                  <c:ptCount val="7"/>
                  <c:pt idx="0">
                    <c:v>0.46022887828975989</c:v>
                  </c:pt>
                  <c:pt idx="1">
                    <c:v>0.32469240069199162</c:v>
                  </c:pt>
                  <c:pt idx="2">
                    <c:v>0.37323995273401162</c:v>
                  </c:pt>
                  <c:pt idx="3">
                    <c:v>0.46636910722833502</c:v>
                  </c:pt>
                  <c:pt idx="4">
                    <c:v>0.33028837862976007</c:v>
                  </c:pt>
                  <c:pt idx="5">
                    <c:v>0.29302284747354346</c:v>
                  </c:pt>
                  <c:pt idx="6">
                    <c:v>0.460228878289759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ror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ror'!$K$38:$Q$38</c:f>
              <c:numCache>
                <c:formatCode>0.00</c:formatCode>
                <c:ptCount val="7"/>
                <c:pt idx="0">
                  <c:v>2.650485862259385</c:v>
                </c:pt>
                <c:pt idx="1">
                  <c:v>1</c:v>
                </c:pt>
                <c:pt idx="2">
                  <c:v>2.6470902248863872</c:v>
                </c:pt>
                <c:pt idx="3">
                  <c:v>2.2166598915523945</c:v>
                </c:pt>
                <c:pt idx="4">
                  <c:v>1.576329017144676</c:v>
                </c:pt>
                <c:pt idx="5">
                  <c:v>3.8540599724522973</c:v>
                </c:pt>
                <c:pt idx="6">
                  <c:v>2.6504858622593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B040-4573-82AA-9A8497DD943B}"/>
            </c:ext>
          </c:extLst>
        </c:ser>
        <c:ser>
          <c:idx val="0"/>
          <c:order val="3"/>
          <c:tx>
            <c:strRef>
              <c:f>'muscle ror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ror'!$K$34:$Q$34</c:f>
                <c:numCache>
                  <c:formatCode>General</c:formatCode>
                  <c:ptCount val="7"/>
                  <c:pt idx="0">
                    <c:v>0.12924487941451748</c:v>
                  </c:pt>
                  <c:pt idx="1">
                    <c:v>0.119737065534625</c:v>
                  </c:pt>
                  <c:pt idx="2">
                    <c:v>0.17043686203058128</c:v>
                  </c:pt>
                  <c:pt idx="3">
                    <c:v>0.20284300104022313</c:v>
                  </c:pt>
                  <c:pt idx="4">
                    <c:v>0.16769946793959889</c:v>
                  </c:pt>
                  <c:pt idx="5">
                    <c:v>0.2365001053448757</c:v>
                  </c:pt>
                  <c:pt idx="6">
                    <c:v>0.12924487941451748</c:v>
                  </c:pt>
                </c:numCache>
              </c:numRef>
            </c:plus>
            <c:minus>
              <c:numRef>
                <c:f>'muscle ror'!$K$34:$Q$34</c:f>
                <c:numCache>
                  <c:formatCode>General</c:formatCode>
                  <c:ptCount val="7"/>
                  <c:pt idx="0">
                    <c:v>0.12924487941451748</c:v>
                  </c:pt>
                  <c:pt idx="1">
                    <c:v>0.119737065534625</c:v>
                  </c:pt>
                  <c:pt idx="2">
                    <c:v>0.17043686203058128</c:v>
                  </c:pt>
                  <c:pt idx="3">
                    <c:v>0.20284300104022313</c:v>
                  </c:pt>
                  <c:pt idx="4">
                    <c:v>0.16769946793959889</c:v>
                  </c:pt>
                  <c:pt idx="5">
                    <c:v>0.2365001053448757</c:v>
                  </c:pt>
                  <c:pt idx="6">
                    <c:v>0.129244879414517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ror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ror'!$K$37:$Q$37</c:f>
              <c:numCache>
                <c:formatCode>0.00</c:formatCode>
                <c:ptCount val="7"/>
                <c:pt idx="0">
                  <c:v>1</c:v>
                </c:pt>
                <c:pt idx="1">
                  <c:v>2.017938870270084</c:v>
                </c:pt>
                <c:pt idx="2">
                  <c:v>1.7550829397019925</c:v>
                </c:pt>
                <c:pt idx="3">
                  <c:v>1.334350492320511</c:v>
                </c:pt>
                <c:pt idx="4">
                  <c:v>1.4205508604710935</c:v>
                </c:pt>
                <c:pt idx="5">
                  <c:v>1.4860053490352068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B040-4573-82AA-9A8497DD94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3"/>
          <c:order val="0"/>
          <c:tx>
            <c:strRef>
              <c:f>'muscle per1'!$R$40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per1'!$AF$34:$AL$34</c:f>
                <c:numCache>
                  <c:formatCode>General</c:formatCode>
                  <c:ptCount val="7"/>
                  <c:pt idx="0">
                    <c:v>0.20511149011092319</c:v>
                  </c:pt>
                  <c:pt idx="1">
                    <c:v>7.0116908449475809E-2</c:v>
                  </c:pt>
                  <c:pt idx="2">
                    <c:v>0.10092328593173572</c:v>
                  </c:pt>
                  <c:pt idx="3">
                    <c:v>0.14565450968377006</c:v>
                  </c:pt>
                  <c:pt idx="4">
                    <c:v>0.10904023989753488</c:v>
                  </c:pt>
                  <c:pt idx="5">
                    <c:v>8.9484978840345633E-2</c:v>
                  </c:pt>
                  <c:pt idx="6">
                    <c:v>0.20511149011092319</c:v>
                  </c:pt>
                </c:numCache>
              </c:numRef>
            </c:plus>
            <c:minus>
              <c:numRef>
                <c:f>'muscle per1'!$AF$34:$AL$34</c:f>
                <c:numCache>
                  <c:formatCode>General</c:formatCode>
                  <c:ptCount val="7"/>
                  <c:pt idx="0">
                    <c:v>0.20511149011092319</c:v>
                  </c:pt>
                  <c:pt idx="1">
                    <c:v>7.0116908449475809E-2</c:v>
                  </c:pt>
                  <c:pt idx="2">
                    <c:v>0.10092328593173572</c:v>
                  </c:pt>
                  <c:pt idx="3">
                    <c:v>0.14565450968377006</c:v>
                  </c:pt>
                  <c:pt idx="4">
                    <c:v>0.10904023989753488</c:v>
                  </c:pt>
                  <c:pt idx="5">
                    <c:v>8.9484978840345633E-2</c:v>
                  </c:pt>
                  <c:pt idx="6">
                    <c:v>0.205111490110923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per1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per1'!$K$40:$Q$40</c:f>
              <c:numCache>
                <c:formatCode>0.00</c:formatCode>
                <c:ptCount val="7"/>
                <c:pt idx="0">
                  <c:v>1.6857937471266955</c:v>
                </c:pt>
                <c:pt idx="1">
                  <c:v>1.1952361327075545</c:v>
                </c:pt>
                <c:pt idx="2">
                  <c:v>1.3384278083524019</c:v>
                </c:pt>
                <c:pt idx="3">
                  <c:v>1.1691424787217441</c:v>
                </c:pt>
                <c:pt idx="4">
                  <c:v>1</c:v>
                </c:pt>
                <c:pt idx="5">
                  <c:v>1.3077262934726568</c:v>
                </c:pt>
                <c:pt idx="6">
                  <c:v>1.68579374712669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8E4-49EA-AEE1-E2E14286E7BD}"/>
            </c:ext>
          </c:extLst>
        </c:ser>
        <c:ser>
          <c:idx val="2"/>
          <c:order val="1"/>
          <c:tx>
            <c:strRef>
              <c:f>'muscle per1'!$R$39</c:f>
              <c:strCache>
                <c:ptCount val="1"/>
                <c:pt idx="0">
                  <c:v>control+BHB</c:v>
                </c:pt>
              </c:strCache>
            </c:strRef>
          </c:tx>
          <c:spPr>
            <a:ln w="19050" cap="rnd">
              <a:solidFill>
                <a:srgbClr val="00CC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CC00"/>
              </a:solidFill>
              <a:ln w="9525">
                <a:solidFill>
                  <a:srgbClr val="00CC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per1'!$Y$34:$AE$34</c:f>
                <c:numCache>
                  <c:formatCode>General</c:formatCode>
                  <c:ptCount val="7"/>
                  <c:pt idx="0">
                    <c:v>0.12503169707349704</c:v>
                  </c:pt>
                  <c:pt idx="1">
                    <c:v>0.10105995008592228</c:v>
                  </c:pt>
                  <c:pt idx="2">
                    <c:v>0.16199993523009806</c:v>
                  </c:pt>
                  <c:pt idx="3">
                    <c:v>3.3802971598078962E-2</c:v>
                  </c:pt>
                  <c:pt idx="4">
                    <c:v>6.5635648601247099E-2</c:v>
                  </c:pt>
                  <c:pt idx="5">
                    <c:v>0.14447998024816527</c:v>
                  </c:pt>
                  <c:pt idx="6">
                    <c:v>0.12503169707349704</c:v>
                  </c:pt>
                </c:numCache>
              </c:numRef>
            </c:plus>
            <c:minus>
              <c:numRef>
                <c:f>'muscle per1'!$Y$34:$AE$34</c:f>
                <c:numCache>
                  <c:formatCode>General</c:formatCode>
                  <c:ptCount val="7"/>
                  <c:pt idx="0">
                    <c:v>0.12503169707349704</c:v>
                  </c:pt>
                  <c:pt idx="1">
                    <c:v>0.10105995008592228</c:v>
                  </c:pt>
                  <c:pt idx="2">
                    <c:v>0.16199993523009806</c:v>
                  </c:pt>
                  <c:pt idx="3">
                    <c:v>3.3802971598078962E-2</c:v>
                  </c:pt>
                  <c:pt idx="4">
                    <c:v>6.5635648601247099E-2</c:v>
                  </c:pt>
                  <c:pt idx="5">
                    <c:v>0.14447998024816527</c:v>
                  </c:pt>
                  <c:pt idx="6">
                    <c:v>0.125031697073497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per1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per1'!$K$39:$Q$39</c:f>
              <c:numCache>
                <c:formatCode>0.00</c:formatCode>
                <c:ptCount val="7"/>
                <c:pt idx="0">
                  <c:v>1.485225290385296</c:v>
                </c:pt>
                <c:pt idx="1">
                  <c:v>1.3635885553402538</c:v>
                </c:pt>
                <c:pt idx="2">
                  <c:v>1.0286770216379302</c:v>
                </c:pt>
                <c:pt idx="3">
                  <c:v>1.0651069512707609</c:v>
                </c:pt>
                <c:pt idx="4">
                  <c:v>1</c:v>
                </c:pt>
                <c:pt idx="5">
                  <c:v>1.4459597544695546</c:v>
                </c:pt>
                <c:pt idx="6">
                  <c:v>1.4852252903852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8E4-49EA-AEE1-E2E14286E7BD}"/>
            </c:ext>
          </c:extLst>
        </c:ser>
        <c:ser>
          <c:idx val="1"/>
          <c:order val="2"/>
          <c:tx>
            <c:strRef>
              <c:f>'muscle per1'!$R$38</c:f>
              <c:strCache>
                <c:ptCount val="1"/>
                <c:pt idx="0">
                  <c:v>HF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per1'!$R$34:$X$34</c:f>
                <c:numCache>
                  <c:formatCode>General</c:formatCode>
                  <c:ptCount val="7"/>
                  <c:pt idx="0">
                    <c:v>0.26078422158238052</c:v>
                  </c:pt>
                  <c:pt idx="1">
                    <c:v>0.20734662885487884</c:v>
                  </c:pt>
                  <c:pt idx="2">
                    <c:v>0.2162685797184673</c:v>
                  </c:pt>
                  <c:pt idx="3">
                    <c:v>0.18008778052888527</c:v>
                  </c:pt>
                  <c:pt idx="4">
                    <c:v>0.20669266575623094</c:v>
                  </c:pt>
                  <c:pt idx="5">
                    <c:v>0.15172825370385865</c:v>
                  </c:pt>
                  <c:pt idx="6">
                    <c:v>0.26078422158238052</c:v>
                  </c:pt>
                </c:numCache>
              </c:numRef>
            </c:plus>
            <c:minus>
              <c:numRef>
                <c:f>'muscle per1'!$R$34:$X$34</c:f>
                <c:numCache>
                  <c:formatCode>General</c:formatCode>
                  <c:ptCount val="7"/>
                  <c:pt idx="0">
                    <c:v>0.26078422158238052</c:v>
                  </c:pt>
                  <c:pt idx="1">
                    <c:v>0.20734662885487884</c:v>
                  </c:pt>
                  <c:pt idx="2">
                    <c:v>0.2162685797184673</c:v>
                  </c:pt>
                  <c:pt idx="3">
                    <c:v>0.18008778052888527</c:v>
                  </c:pt>
                  <c:pt idx="4">
                    <c:v>0.20669266575623094</c:v>
                  </c:pt>
                  <c:pt idx="5">
                    <c:v>0.15172825370385865</c:v>
                  </c:pt>
                  <c:pt idx="6">
                    <c:v>0.260784221582380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per1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per1'!$K$38:$Q$38</c:f>
              <c:numCache>
                <c:formatCode>0.00</c:formatCode>
                <c:ptCount val="7"/>
                <c:pt idx="0">
                  <c:v>1.5937539379517727</c:v>
                </c:pt>
                <c:pt idx="1">
                  <c:v>2.2195300608496398</c:v>
                </c:pt>
                <c:pt idx="2">
                  <c:v>1</c:v>
                </c:pt>
                <c:pt idx="3">
                  <c:v>1.0289380737607534</c:v>
                </c:pt>
                <c:pt idx="4">
                  <c:v>1.3275696323991848</c:v>
                </c:pt>
                <c:pt idx="5">
                  <c:v>1.0459049126741928</c:v>
                </c:pt>
                <c:pt idx="6">
                  <c:v>1.593753937951772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68E4-49EA-AEE1-E2E14286E7BD}"/>
            </c:ext>
          </c:extLst>
        </c:ser>
        <c:ser>
          <c:idx val="0"/>
          <c:order val="3"/>
          <c:tx>
            <c:strRef>
              <c:f>'muscle per1'!$R$37</c:f>
              <c:strCache>
                <c:ptCount val="1"/>
                <c:pt idx="0">
                  <c:v>HF+BHB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uscle per1'!$K$34:$Q$34</c:f>
                <c:numCache>
                  <c:formatCode>General</c:formatCode>
                  <c:ptCount val="7"/>
                  <c:pt idx="0">
                    <c:v>9.4555577718000369E-2</c:v>
                  </c:pt>
                  <c:pt idx="1">
                    <c:v>0.22878522989582642</c:v>
                  </c:pt>
                  <c:pt idx="2">
                    <c:v>0.25464666669221536</c:v>
                  </c:pt>
                  <c:pt idx="3">
                    <c:v>0.1974655279167005</c:v>
                  </c:pt>
                  <c:pt idx="4">
                    <c:v>0.16226694120197199</c:v>
                  </c:pt>
                  <c:pt idx="5">
                    <c:v>0.23761870619709666</c:v>
                  </c:pt>
                  <c:pt idx="6">
                    <c:v>9.4555577718000369E-2</c:v>
                  </c:pt>
                </c:numCache>
              </c:numRef>
            </c:plus>
            <c:minus>
              <c:numRef>
                <c:f>'muscle per1'!$K$34:$Q$34</c:f>
                <c:numCache>
                  <c:formatCode>General</c:formatCode>
                  <c:ptCount val="7"/>
                  <c:pt idx="0">
                    <c:v>9.4555577718000369E-2</c:v>
                  </c:pt>
                  <c:pt idx="1">
                    <c:v>0.22878522989582642</c:v>
                  </c:pt>
                  <c:pt idx="2">
                    <c:v>0.25464666669221536</c:v>
                  </c:pt>
                  <c:pt idx="3">
                    <c:v>0.1974655279167005</c:v>
                  </c:pt>
                  <c:pt idx="4">
                    <c:v>0.16226694120197199</c:v>
                  </c:pt>
                  <c:pt idx="5">
                    <c:v>0.23761870619709666</c:v>
                  </c:pt>
                  <c:pt idx="6">
                    <c:v>9.455557771800036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uscle per1'!$K$36:$Q$36</c:f>
              <c:numCache>
                <c:formatCode>0</c:formatCode>
                <c:ptCount val="7"/>
                <c:pt idx="0" formatCode="General">
                  <c:v>24</c:v>
                </c:pt>
                <c:pt idx="1">
                  <c:v>20</c:v>
                </c:pt>
                <c:pt idx="2">
                  <c:v>16</c:v>
                </c:pt>
                <c:pt idx="3">
                  <c:v>12</c:v>
                </c:pt>
                <c:pt idx="4">
                  <c:v>8</c:v>
                </c:pt>
                <c:pt idx="5">
                  <c:v>4</c:v>
                </c:pt>
                <c:pt idx="6">
                  <c:v>0</c:v>
                </c:pt>
              </c:numCache>
            </c:numRef>
          </c:xVal>
          <c:yVal>
            <c:numRef>
              <c:f>'muscle per1'!$K$37:$Q$37</c:f>
              <c:numCache>
                <c:formatCode>0.00</c:formatCode>
                <c:ptCount val="7"/>
                <c:pt idx="0">
                  <c:v>1</c:v>
                </c:pt>
                <c:pt idx="1">
                  <c:v>2.7963635158731313</c:v>
                </c:pt>
                <c:pt idx="2">
                  <c:v>3.4286028226224929</c:v>
                </c:pt>
                <c:pt idx="3">
                  <c:v>2.3869585815867658</c:v>
                </c:pt>
                <c:pt idx="4">
                  <c:v>1.204871831783497</c:v>
                </c:pt>
                <c:pt idx="5">
                  <c:v>2.9771273368956508</c:v>
                </c:pt>
                <c:pt idx="6">
                  <c:v>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68E4-49EA-AEE1-E2E14286E7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4698480"/>
        <c:axId val="564707008"/>
      </c:scatterChart>
      <c:valAx>
        <c:axId val="564698480"/>
        <c:scaling>
          <c:orientation val="minMax"/>
          <c:max val="24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707008"/>
        <c:crosses val="autoZero"/>
        <c:crossBetween val="midCat"/>
        <c:majorUnit val="4"/>
      </c:valAx>
      <c:valAx>
        <c:axId val="564707008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698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43FBC6-00ED-432C-AFE5-606D92363C5F}" type="datetimeFigureOut">
              <a:rPr lang="en-US" smtClean="0"/>
              <a:t>2026-04-0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78025" y="1241425"/>
            <a:ext cx="28416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0B23F2-55A9-418F-8A54-B1A1D4B6C6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496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3868FD-C720-43EF-AFC5-8CF8FA69A367}" type="slidenum">
              <a:rPr lang="he-IL" smtClean="0"/>
              <a:t>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4423609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3868FD-C720-43EF-AFC5-8CF8FA69A367}" type="slidenum">
              <a:rPr lang="he-IL" smtClean="0"/>
              <a:t>2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7849740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3868FD-C720-43EF-AFC5-8CF8FA69A367}" type="slidenum">
              <a:rPr lang="he-IL" smtClean="0"/>
              <a:t>3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4496770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3868FD-C720-43EF-AFC5-8CF8FA69A367}" type="slidenum">
              <a:rPr lang="he-IL" smtClean="0"/>
              <a:t>4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6123745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978025" y="1241425"/>
            <a:ext cx="2841625" cy="33496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0B23F2-55A9-418F-8A54-B1A1D4B6C69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07028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3868FD-C720-43EF-AFC5-8CF8FA69A367}" type="slidenum">
              <a:rPr lang="he-IL" smtClean="0"/>
              <a:t>6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8911770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978025" y="1241425"/>
            <a:ext cx="2841625" cy="33496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0B23F2-55A9-418F-8A54-B1A1D4B6C690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40345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3868FD-C720-43EF-AFC5-8CF8FA69A367}" type="slidenum">
              <a:rPr lang="he-IL" smtClean="0"/>
              <a:t>8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6348424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978025" y="1241425"/>
            <a:ext cx="2841625" cy="33496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0B23F2-55A9-418F-8A54-B1A1D4B6C690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1901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047" y="1944130"/>
            <a:ext cx="8568531" cy="4135743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0078" y="6239364"/>
            <a:ext cx="7560469" cy="2868071"/>
          </a:xfrm>
        </p:spPr>
        <p:txBody>
          <a:bodyPr/>
          <a:lstStyle>
            <a:lvl1pPr marL="0" indent="0" algn="ctr">
              <a:buNone/>
              <a:defRPr sz="2646"/>
            </a:lvl1pPr>
            <a:lvl2pPr marL="504017" indent="0" algn="ctr">
              <a:buNone/>
              <a:defRPr sz="2205"/>
            </a:lvl2pPr>
            <a:lvl3pPr marL="1008035" indent="0" algn="ctr">
              <a:buNone/>
              <a:defRPr sz="1984"/>
            </a:lvl3pPr>
            <a:lvl4pPr marL="1512052" indent="0" algn="ctr">
              <a:buNone/>
              <a:defRPr sz="1764"/>
            </a:lvl4pPr>
            <a:lvl5pPr marL="2016069" indent="0" algn="ctr">
              <a:buNone/>
              <a:defRPr sz="1764"/>
            </a:lvl5pPr>
            <a:lvl6pPr marL="2520086" indent="0" algn="ctr">
              <a:buNone/>
              <a:defRPr sz="1764"/>
            </a:lvl6pPr>
            <a:lvl7pPr marL="3024104" indent="0" algn="ctr">
              <a:buNone/>
              <a:defRPr sz="1764"/>
            </a:lvl7pPr>
            <a:lvl8pPr marL="3528121" indent="0" algn="ctr">
              <a:buNone/>
              <a:defRPr sz="1764"/>
            </a:lvl8pPr>
            <a:lvl9pPr marL="4032138" indent="0" algn="ctr">
              <a:buNone/>
              <a:defRPr sz="176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3A363-09F8-4BE0-A1A3-30F71CBC3623}" type="datetimeFigureOut">
              <a:rPr lang="he-IL" smtClean="0"/>
              <a:t>כ"ב/ניסן/תשפ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04D6F-C1E5-421D-B20F-A1C3D9274A6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58707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3A363-09F8-4BE0-A1A3-30F71CBC3623}" type="datetimeFigureOut">
              <a:rPr lang="he-IL" smtClean="0"/>
              <a:t>כ"ב/ניסן/תשפ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04D6F-C1E5-421D-B20F-A1C3D9274A6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11750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13948" y="632461"/>
            <a:ext cx="2173635" cy="1006712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3044" y="632461"/>
            <a:ext cx="6394896" cy="1006712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3A363-09F8-4BE0-A1A3-30F71CBC3623}" type="datetimeFigureOut">
              <a:rPr lang="he-IL" smtClean="0"/>
              <a:t>כ"ב/ניסן/תשפ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04D6F-C1E5-421D-B20F-A1C3D9274A6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01438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3A363-09F8-4BE0-A1A3-30F71CBC3623}" type="datetimeFigureOut">
              <a:rPr lang="he-IL" smtClean="0"/>
              <a:t>כ"ב/ניסן/תשפ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04D6F-C1E5-421D-B20F-A1C3D9274A6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29327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793" y="2961570"/>
            <a:ext cx="8694539" cy="4941443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793" y="7949760"/>
            <a:ext cx="8694539" cy="2598588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/>
                </a:solidFill>
              </a:defRPr>
            </a:lvl1pPr>
            <a:lvl2pPr marL="504017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8035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205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606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200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4104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812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213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3A363-09F8-4BE0-A1A3-30F71CBC3623}" type="datetimeFigureOut">
              <a:rPr lang="he-IL" smtClean="0"/>
              <a:t>כ"ב/ניסן/תשפ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04D6F-C1E5-421D-B20F-A1C3D9274A6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55234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3043" y="3162304"/>
            <a:ext cx="4284266" cy="7537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3316" y="3162304"/>
            <a:ext cx="4284266" cy="7537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3A363-09F8-4BE0-A1A3-30F71CBC3623}" type="datetimeFigureOut">
              <a:rPr lang="he-IL" smtClean="0"/>
              <a:t>כ"ב/ניסן/תשפ"ו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04D6F-C1E5-421D-B20F-A1C3D9274A6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73389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632464"/>
            <a:ext cx="8694539" cy="229610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4357" y="2912070"/>
            <a:ext cx="4264576" cy="1427161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57" y="4339231"/>
            <a:ext cx="4264576" cy="6382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3317" y="2912070"/>
            <a:ext cx="4285579" cy="1427161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3317" y="4339231"/>
            <a:ext cx="4285579" cy="638235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3A363-09F8-4BE0-A1A3-30F71CBC3623}" type="datetimeFigureOut">
              <a:rPr lang="he-IL" smtClean="0"/>
              <a:t>כ"ב/ניסן/תשפ"ו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04D6F-C1E5-421D-B20F-A1C3D9274A6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69597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3A363-09F8-4BE0-A1A3-30F71CBC3623}" type="datetimeFigureOut">
              <a:rPr lang="he-IL" smtClean="0"/>
              <a:t>כ"ב/ניסן/תשפ"ו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04D6F-C1E5-421D-B20F-A1C3D9274A6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32875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3A363-09F8-4BE0-A1A3-30F71CBC3623}" type="datetimeFigureOut">
              <a:rPr lang="he-IL" smtClean="0"/>
              <a:t>כ"ב/ניסן/תשפ"ו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04D6F-C1E5-421D-B20F-A1C3D9274A6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2686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791951"/>
            <a:ext cx="3251264" cy="2771828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5579" y="1710397"/>
            <a:ext cx="5103316" cy="8441976"/>
          </a:xfrm>
        </p:spPr>
        <p:txBody>
          <a:bodyPr/>
          <a:lstStyle>
            <a:lvl1pPr>
              <a:defRPr sz="3528"/>
            </a:lvl1pPr>
            <a:lvl2pPr>
              <a:defRPr sz="3087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3563779"/>
            <a:ext cx="3251264" cy="6602341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3A363-09F8-4BE0-A1A3-30F71CBC3623}" type="datetimeFigureOut">
              <a:rPr lang="he-IL" smtClean="0"/>
              <a:t>כ"ב/ניסן/תשפ"ו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04D6F-C1E5-421D-B20F-A1C3D9274A6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66074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791951"/>
            <a:ext cx="3251264" cy="2771828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85579" y="1710397"/>
            <a:ext cx="5103316" cy="8441976"/>
          </a:xfrm>
        </p:spPr>
        <p:txBody>
          <a:bodyPr anchor="t"/>
          <a:lstStyle>
            <a:lvl1pPr marL="0" indent="0">
              <a:buNone/>
              <a:defRPr sz="3528"/>
            </a:lvl1pPr>
            <a:lvl2pPr marL="504017" indent="0">
              <a:buNone/>
              <a:defRPr sz="3087"/>
            </a:lvl2pPr>
            <a:lvl3pPr marL="1008035" indent="0">
              <a:buNone/>
              <a:defRPr sz="2646"/>
            </a:lvl3pPr>
            <a:lvl4pPr marL="1512052" indent="0">
              <a:buNone/>
              <a:defRPr sz="2205"/>
            </a:lvl4pPr>
            <a:lvl5pPr marL="2016069" indent="0">
              <a:buNone/>
              <a:defRPr sz="2205"/>
            </a:lvl5pPr>
            <a:lvl6pPr marL="2520086" indent="0">
              <a:buNone/>
              <a:defRPr sz="2205"/>
            </a:lvl6pPr>
            <a:lvl7pPr marL="3024104" indent="0">
              <a:buNone/>
              <a:defRPr sz="2205"/>
            </a:lvl7pPr>
            <a:lvl8pPr marL="3528121" indent="0">
              <a:buNone/>
              <a:defRPr sz="2205"/>
            </a:lvl8pPr>
            <a:lvl9pPr marL="4032138" indent="0">
              <a:buNone/>
              <a:defRPr sz="220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3563779"/>
            <a:ext cx="3251264" cy="6602341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03A363-09F8-4BE0-A1A3-30F71CBC3623}" type="datetimeFigureOut">
              <a:rPr lang="he-IL" smtClean="0"/>
              <a:t>כ"ב/ניסן/תשפ"ו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04D6F-C1E5-421D-B20F-A1C3D9274A6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35550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3043" y="632464"/>
            <a:ext cx="8694539" cy="2296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043" y="3162304"/>
            <a:ext cx="8694539" cy="7537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3043" y="11010319"/>
            <a:ext cx="2268141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03A363-09F8-4BE0-A1A3-30F71CBC3623}" type="datetimeFigureOut">
              <a:rPr lang="he-IL" smtClean="0"/>
              <a:t>כ"ב/ניסן/תשפ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9207" y="11010319"/>
            <a:ext cx="3402211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19441" y="11010319"/>
            <a:ext cx="2268141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704D6F-C1E5-421D-B20F-A1C3D9274A6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92233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08035" rtl="0" eaLnBrk="1" latinLnBrk="0" hangingPunct="1">
        <a:lnSpc>
          <a:spcPct val="90000"/>
        </a:lnSpc>
        <a:spcBef>
          <a:spcPct val="0"/>
        </a:spcBef>
        <a:buNone/>
        <a:defRPr sz="485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2009" indent="-252009" algn="l" defTabSz="1008035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sz="3087" kern="1200">
          <a:solidFill>
            <a:schemeClr val="tx1"/>
          </a:solidFill>
          <a:latin typeface="+mn-lt"/>
          <a:ea typeface="+mn-ea"/>
          <a:cs typeface="+mn-cs"/>
        </a:defRPr>
      </a:lvl1pPr>
      <a:lvl2pPr marL="756026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406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8078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2095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6112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8013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4147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4017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8035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2052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6069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20086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4104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8121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2138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9" Type="http://schemas.openxmlformats.org/officeDocument/2006/relationships/image" Target="../media/image37.png"/><Relationship Id="rId21" Type="http://schemas.openxmlformats.org/officeDocument/2006/relationships/image" Target="../media/image19.png"/><Relationship Id="rId34" Type="http://schemas.openxmlformats.org/officeDocument/2006/relationships/image" Target="../media/image32.png"/><Relationship Id="rId42" Type="http://schemas.openxmlformats.org/officeDocument/2006/relationships/image" Target="../media/image40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41" Type="http://schemas.openxmlformats.org/officeDocument/2006/relationships/image" Target="../media/image3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32" Type="http://schemas.openxmlformats.org/officeDocument/2006/relationships/image" Target="../media/image30.png"/><Relationship Id="rId37" Type="http://schemas.openxmlformats.org/officeDocument/2006/relationships/image" Target="../media/image35.png"/><Relationship Id="rId40" Type="http://schemas.openxmlformats.org/officeDocument/2006/relationships/image" Target="../media/image38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36" Type="http://schemas.openxmlformats.org/officeDocument/2006/relationships/image" Target="../media/image34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31" Type="http://schemas.openxmlformats.org/officeDocument/2006/relationships/image" Target="../media/image29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Relationship Id="rId35" Type="http://schemas.openxmlformats.org/officeDocument/2006/relationships/image" Target="../media/image33.png"/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33" Type="http://schemas.openxmlformats.org/officeDocument/2006/relationships/image" Target="../media/image31.png"/><Relationship Id="rId38" Type="http://schemas.openxmlformats.org/officeDocument/2006/relationships/image" Target="../media/image36.png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45.png"/><Relationship Id="rId18" Type="http://schemas.openxmlformats.org/officeDocument/2006/relationships/image" Target="../media/image50.png"/><Relationship Id="rId26" Type="http://schemas.openxmlformats.org/officeDocument/2006/relationships/image" Target="../media/image58.png"/><Relationship Id="rId39" Type="http://schemas.openxmlformats.org/officeDocument/2006/relationships/image" Target="../media/image71.png"/><Relationship Id="rId21" Type="http://schemas.openxmlformats.org/officeDocument/2006/relationships/image" Target="../media/image53.png"/><Relationship Id="rId34" Type="http://schemas.openxmlformats.org/officeDocument/2006/relationships/image" Target="../media/image66.png"/><Relationship Id="rId7" Type="http://schemas.openxmlformats.org/officeDocument/2006/relationships/image" Target="../media/image5.png"/><Relationship Id="rId12" Type="http://schemas.openxmlformats.org/officeDocument/2006/relationships/image" Target="../media/image44.png"/><Relationship Id="rId17" Type="http://schemas.openxmlformats.org/officeDocument/2006/relationships/image" Target="../media/image49.png"/><Relationship Id="rId25" Type="http://schemas.openxmlformats.org/officeDocument/2006/relationships/image" Target="../media/image57.png"/><Relationship Id="rId33" Type="http://schemas.openxmlformats.org/officeDocument/2006/relationships/image" Target="../media/image65.png"/><Relationship Id="rId38" Type="http://schemas.openxmlformats.org/officeDocument/2006/relationships/image" Target="../media/image70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48.png"/><Relationship Id="rId20" Type="http://schemas.openxmlformats.org/officeDocument/2006/relationships/image" Target="../media/image52.png"/><Relationship Id="rId29" Type="http://schemas.openxmlformats.org/officeDocument/2006/relationships/image" Target="../media/image6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43.png"/><Relationship Id="rId24" Type="http://schemas.openxmlformats.org/officeDocument/2006/relationships/image" Target="../media/image56.png"/><Relationship Id="rId32" Type="http://schemas.openxmlformats.org/officeDocument/2006/relationships/image" Target="../media/image64.png"/><Relationship Id="rId37" Type="http://schemas.openxmlformats.org/officeDocument/2006/relationships/image" Target="../media/image69.png"/><Relationship Id="rId40" Type="http://schemas.openxmlformats.org/officeDocument/2006/relationships/image" Target="../media/image72.png"/><Relationship Id="rId5" Type="http://schemas.openxmlformats.org/officeDocument/2006/relationships/image" Target="../media/image3.png"/><Relationship Id="rId15" Type="http://schemas.openxmlformats.org/officeDocument/2006/relationships/image" Target="../media/image47.png"/><Relationship Id="rId23" Type="http://schemas.openxmlformats.org/officeDocument/2006/relationships/image" Target="../media/image55.png"/><Relationship Id="rId28" Type="http://schemas.openxmlformats.org/officeDocument/2006/relationships/image" Target="../media/image60.png"/><Relationship Id="rId36" Type="http://schemas.openxmlformats.org/officeDocument/2006/relationships/image" Target="../media/image68.png"/><Relationship Id="rId10" Type="http://schemas.openxmlformats.org/officeDocument/2006/relationships/image" Target="../media/image42.png"/><Relationship Id="rId19" Type="http://schemas.openxmlformats.org/officeDocument/2006/relationships/image" Target="../media/image51.png"/><Relationship Id="rId31" Type="http://schemas.openxmlformats.org/officeDocument/2006/relationships/image" Target="../media/image63.png"/><Relationship Id="rId4" Type="http://schemas.openxmlformats.org/officeDocument/2006/relationships/image" Target="../media/image2.png"/><Relationship Id="rId9" Type="http://schemas.openxmlformats.org/officeDocument/2006/relationships/image" Target="../media/image41.png"/><Relationship Id="rId14" Type="http://schemas.openxmlformats.org/officeDocument/2006/relationships/image" Target="../media/image46.png"/><Relationship Id="rId22" Type="http://schemas.openxmlformats.org/officeDocument/2006/relationships/image" Target="../media/image54.png"/><Relationship Id="rId27" Type="http://schemas.openxmlformats.org/officeDocument/2006/relationships/image" Target="../media/image59.png"/><Relationship Id="rId30" Type="http://schemas.openxmlformats.org/officeDocument/2006/relationships/image" Target="../media/image62.png"/><Relationship Id="rId35" Type="http://schemas.openxmlformats.org/officeDocument/2006/relationships/image" Target="../media/image67.png"/><Relationship Id="rId8" Type="http://schemas.openxmlformats.org/officeDocument/2006/relationships/image" Target="../media/image6.png"/><Relationship Id="rId3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77.png"/><Relationship Id="rId18" Type="http://schemas.openxmlformats.org/officeDocument/2006/relationships/image" Target="../media/image82.png"/><Relationship Id="rId26" Type="http://schemas.openxmlformats.org/officeDocument/2006/relationships/image" Target="../media/image90.png"/><Relationship Id="rId39" Type="http://schemas.openxmlformats.org/officeDocument/2006/relationships/image" Target="../media/image103.png"/><Relationship Id="rId21" Type="http://schemas.openxmlformats.org/officeDocument/2006/relationships/image" Target="../media/image85.png"/><Relationship Id="rId34" Type="http://schemas.openxmlformats.org/officeDocument/2006/relationships/image" Target="../media/image98.png"/><Relationship Id="rId42" Type="http://schemas.openxmlformats.org/officeDocument/2006/relationships/image" Target="../media/image106.png"/><Relationship Id="rId47" Type="http://schemas.openxmlformats.org/officeDocument/2006/relationships/image" Target="../media/image11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80.png"/><Relationship Id="rId29" Type="http://schemas.openxmlformats.org/officeDocument/2006/relationships/image" Target="../media/image9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3.png"/><Relationship Id="rId11" Type="http://schemas.openxmlformats.org/officeDocument/2006/relationships/image" Target="../media/image75.png"/><Relationship Id="rId24" Type="http://schemas.openxmlformats.org/officeDocument/2006/relationships/image" Target="../media/image88.png"/><Relationship Id="rId32" Type="http://schemas.openxmlformats.org/officeDocument/2006/relationships/image" Target="../media/image96.png"/><Relationship Id="rId37" Type="http://schemas.openxmlformats.org/officeDocument/2006/relationships/image" Target="../media/image101.png"/><Relationship Id="rId40" Type="http://schemas.openxmlformats.org/officeDocument/2006/relationships/image" Target="../media/image104.png"/><Relationship Id="rId45" Type="http://schemas.openxmlformats.org/officeDocument/2006/relationships/image" Target="../media/image109.png"/><Relationship Id="rId5" Type="http://schemas.openxmlformats.org/officeDocument/2006/relationships/image" Target="../media/image3.png"/><Relationship Id="rId15" Type="http://schemas.openxmlformats.org/officeDocument/2006/relationships/image" Target="../media/image79.png"/><Relationship Id="rId23" Type="http://schemas.openxmlformats.org/officeDocument/2006/relationships/image" Target="../media/image87.png"/><Relationship Id="rId28" Type="http://schemas.openxmlformats.org/officeDocument/2006/relationships/image" Target="../media/image92.png"/><Relationship Id="rId36" Type="http://schemas.openxmlformats.org/officeDocument/2006/relationships/image" Target="../media/image100.png"/><Relationship Id="rId10" Type="http://schemas.openxmlformats.org/officeDocument/2006/relationships/image" Target="../media/image74.png"/><Relationship Id="rId19" Type="http://schemas.openxmlformats.org/officeDocument/2006/relationships/image" Target="../media/image83.png"/><Relationship Id="rId31" Type="http://schemas.openxmlformats.org/officeDocument/2006/relationships/image" Target="../media/image95.png"/><Relationship Id="rId44" Type="http://schemas.openxmlformats.org/officeDocument/2006/relationships/image" Target="../media/image108.png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openxmlformats.org/officeDocument/2006/relationships/image" Target="../media/image78.png"/><Relationship Id="rId22" Type="http://schemas.openxmlformats.org/officeDocument/2006/relationships/image" Target="../media/image86.png"/><Relationship Id="rId27" Type="http://schemas.openxmlformats.org/officeDocument/2006/relationships/image" Target="../media/image91.png"/><Relationship Id="rId30" Type="http://schemas.openxmlformats.org/officeDocument/2006/relationships/image" Target="../media/image94.png"/><Relationship Id="rId35" Type="http://schemas.openxmlformats.org/officeDocument/2006/relationships/image" Target="../media/image99.png"/><Relationship Id="rId43" Type="http://schemas.openxmlformats.org/officeDocument/2006/relationships/image" Target="../media/image107.png"/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12" Type="http://schemas.openxmlformats.org/officeDocument/2006/relationships/image" Target="../media/image76.png"/><Relationship Id="rId17" Type="http://schemas.openxmlformats.org/officeDocument/2006/relationships/image" Target="../media/image81.png"/><Relationship Id="rId25" Type="http://schemas.openxmlformats.org/officeDocument/2006/relationships/image" Target="../media/image89.png"/><Relationship Id="rId33" Type="http://schemas.openxmlformats.org/officeDocument/2006/relationships/image" Target="../media/image97.png"/><Relationship Id="rId38" Type="http://schemas.openxmlformats.org/officeDocument/2006/relationships/image" Target="../media/image102.png"/><Relationship Id="rId46" Type="http://schemas.openxmlformats.org/officeDocument/2006/relationships/image" Target="../media/image110.png"/><Relationship Id="rId20" Type="http://schemas.openxmlformats.org/officeDocument/2006/relationships/image" Target="../media/image84.png"/><Relationship Id="rId41" Type="http://schemas.openxmlformats.org/officeDocument/2006/relationships/image" Target="../media/image10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2.png"/><Relationship Id="rId13" Type="http://schemas.openxmlformats.org/officeDocument/2006/relationships/image" Target="../media/image117.png"/><Relationship Id="rId3" Type="http://schemas.openxmlformats.org/officeDocument/2006/relationships/image" Target="../media/image2.png"/><Relationship Id="rId7" Type="http://schemas.openxmlformats.org/officeDocument/2006/relationships/image" Target="../media/image73.png"/><Relationship Id="rId12" Type="http://schemas.openxmlformats.org/officeDocument/2006/relationships/image" Target="../media/image116.png"/><Relationship Id="rId17" Type="http://schemas.openxmlformats.org/officeDocument/2006/relationships/image" Target="../media/image121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12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15.png"/><Relationship Id="rId5" Type="http://schemas.openxmlformats.org/officeDocument/2006/relationships/image" Target="../media/image4.png"/><Relationship Id="rId15" Type="http://schemas.openxmlformats.org/officeDocument/2006/relationships/image" Target="../media/image119.png"/><Relationship Id="rId10" Type="http://schemas.openxmlformats.org/officeDocument/2006/relationships/image" Target="../media/image114.png"/><Relationship Id="rId4" Type="http://schemas.openxmlformats.org/officeDocument/2006/relationships/image" Target="../media/image3.png"/><Relationship Id="rId9" Type="http://schemas.openxmlformats.org/officeDocument/2006/relationships/image" Target="../media/image113.png"/><Relationship Id="rId14" Type="http://schemas.openxmlformats.org/officeDocument/2006/relationships/image" Target="../media/image11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2.png"/><Relationship Id="rId13" Type="http://schemas.openxmlformats.org/officeDocument/2006/relationships/image" Target="../media/image127.png"/><Relationship Id="rId3" Type="http://schemas.openxmlformats.org/officeDocument/2006/relationships/image" Target="../media/image2.png"/><Relationship Id="rId7" Type="http://schemas.openxmlformats.org/officeDocument/2006/relationships/image" Target="../media/image73.png"/><Relationship Id="rId12" Type="http://schemas.openxmlformats.org/officeDocument/2006/relationships/image" Target="../media/image126.png"/><Relationship Id="rId17" Type="http://schemas.openxmlformats.org/officeDocument/2006/relationships/image" Target="../media/image131.png"/><Relationship Id="rId2" Type="http://schemas.openxmlformats.org/officeDocument/2006/relationships/notesSlide" Target="../notesSlides/notesSlide6.xml"/><Relationship Id="rId16" Type="http://schemas.openxmlformats.org/officeDocument/2006/relationships/image" Target="../media/image13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25.png"/><Relationship Id="rId5" Type="http://schemas.openxmlformats.org/officeDocument/2006/relationships/image" Target="../media/image4.png"/><Relationship Id="rId15" Type="http://schemas.openxmlformats.org/officeDocument/2006/relationships/image" Target="../media/image129.png"/><Relationship Id="rId10" Type="http://schemas.openxmlformats.org/officeDocument/2006/relationships/image" Target="../media/image124.png"/><Relationship Id="rId4" Type="http://schemas.openxmlformats.org/officeDocument/2006/relationships/image" Target="../media/image3.png"/><Relationship Id="rId9" Type="http://schemas.openxmlformats.org/officeDocument/2006/relationships/image" Target="../media/image123.png"/><Relationship Id="rId14" Type="http://schemas.openxmlformats.org/officeDocument/2006/relationships/image" Target="../media/image12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2.xml"/><Relationship Id="rId3" Type="http://schemas.openxmlformats.org/officeDocument/2006/relationships/chart" Target="../charts/chart7.xml"/><Relationship Id="rId7" Type="http://schemas.openxmlformats.org/officeDocument/2006/relationships/chart" Target="../charts/chart11.xml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0.xml"/><Relationship Id="rId5" Type="http://schemas.openxmlformats.org/officeDocument/2006/relationships/chart" Target="../charts/chart9.xml"/><Relationship Id="rId4" Type="http://schemas.openxmlformats.org/officeDocument/2006/relationships/chart" Target="../charts/chart8.xml"/><Relationship Id="rId9" Type="http://schemas.openxmlformats.org/officeDocument/2006/relationships/chart" Target="../charts/chart13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2.png"/><Relationship Id="rId13" Type="http://schemas.openxmlformats.org/officeDocument/2006/relationships/image" Target="../media/image137.png"/><Relationship Id="rId3" Type="http://schemas.openxmlformats.org/officeDocument/2006/relationships/image" Target="../media/image2.png"/><Relationship Id="rId7" Type="http://schemas.openxmlformats.org/officeDocument/2006/relationships/image" Target="../media/image73.png"/><Relationship Id="rId12" Type="http://schemas.openxmlformats.org/officeDocument/2006/relationships/image" Target="../media/image136.png"/><Relationship Id="rId17" Type="http://schemas.openxmlformats.org/officeDocument/2006/relationships/image" Target="../media/image141.png"/><Relationship Id="rId2" Type="http://schemas.openxmlformats.org/officeDocument/2006/relationships/notesSlide" Target="../notesSlides/notesSlide8.xml"/><Relationship Id="rId16" Type="http://schemas.openxmlformats.org/officeDocument/2006/relationships/image" Target="../media/image14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35.png"/><Relationship Id="rId5" Type="http://schemas.openxmlformats.org/officeDocument/2006/relationships/image" Target="../media/image4.png"/><Relationship Id="rId15" Type="http://schemas.openxmlformats.org/officeDocument/2006/relationships/image" Target="../media/image139.png"/><Relationship Id="rId10" Type="http://schemas.openxmlformats.org/officeDocument/2006/relationships/image" Target="../media/image134.png"/><Relationship Id="rId4" Type="http://schemas.openxmlformats.org/officeDocument/2006/relationships/image" Target="../media/image3.png"/><Relationship Id="rId9" Type="http://schemas.openxmlformats.org/officeDocument/2006/relationships/image" Target="../media/image133.png"/><Relationship Id="rId14" Type="http://schemas.openxmlformats.org/officeDocument/2006/relationships/image" Target="../media/image138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9.xml"/><Relationship Id="rId3" Type="http://schemas.openxmlformats.org/officeDocument/2006/relationships/chart" Target="../charts/chart14.xml"/><Relationship Id="rId7" Type="http://schemas.openxmlformats.org/officeDocument/2006/relationships/chart" Target="../charts/chart18.xml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7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טבלה 3">
            <a:extLst>
              <a:ext uri="{FF2B5EF4-FFF2-40B4-BE49-F238E27FC236}">
                <a16:creationId xmlns:a16="http://schemas.microsoft.com/office/drawing/2014/main" id="{F541CAEF-1A26-3B88-7409-B3CFEF6205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4836318"/>
              </p:ext>
            </p:extLst>
          </p:nvPr>
        </p:nvGraphicFramePr>
        <p:xfrm>
          <a:off x="1230309" y="385011"/>
          <a:ext cx="7620004" cy="10912644"/>
        </p:xfrm>
        <a:graphic>
          <a:graphicData uri="http://schemas.openxmlformats.org/drawingml/2006/table">
            <a:tbl>
              <a:tblPr rtl="1" firstRow="1" bandRow="1">
                <a:tableStyleId>{5940675A-B579-460E-94D1-54222C63F5DA}</a:tableStyleId>
              </a:tblPr>
              <a:tblGrid>
                <a:gridCol w="3810002">
                  <a:extLst>
                    <a:ext uri="{9D8B030D-6E8A-4147-A177-3AD203B41FA5}">
                      <a16:colId xmlns:a16="http://schemas.microsoft.com/office/drawing/2014/main" val="2673439277"/>
                    </a:ext>
                  </a:extLst>
                </a:gridCol>
                <a:gridCol w="3810002">
                  <a:extLst>
                    <a:ext uri="{9D8B030D-6E8A-4147-A177-3AD203B41FA5}">
                      <a16:colId xmlns:a16="http://schemas.microsoft.com/office/drawing/2014/main" val="112674736"/>
                    </a:ext>
                  </a:extLst>
                </a:gridCol>
              </a:tblGrid>
              <a:tr h="562362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5894319"/>
                  </a:ext>
                </a:extLst>
              </a:tr>
              <a:tr h="604506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8848110"/>
                  </a:ext>
                </a:extLst>
              </a:tr>
              <a:tr h="597523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5384007"/>
                  </a:ext>
                </a:extLst>
              </a:tr>
              <a:tr h="617863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28102718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8765973"/>
                  </a:ext>
                </a:extLst>
              </a:tr>
              <a:tr h="637674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1069457"/>
                  </a:ext>
                </a:extLst>
              </a:tr>
              <a:tr h="613611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2943920"/>
                  </a:ext>
                </a:extLst>
              </a:tr>
              <a:tr h="601578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3793250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20313756"/>
                  </a:ext>
                </a:extLst>
              </a:tr>
              <a:tr h="637674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7138217"/>
                  </a:ext>
                </a:extLst>
              </a:tr>
              <a:tr h="625642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80046665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1940211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16306057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37959460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1955266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7345177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2313978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6420948"/>
                  </a:ext>
                </a:extLst>
              </a:tr>
            </a:tbl>
          </a:graphicData>
        </a:graphic>
      </p:graphicFrame>
      <p:sp>
        <p:nvSpPr>
          <p:cNvPr id="162" name="תיבת טקסט 73">
            <a:extLst>
              <a:ext uri="{FF2B5EF4-FFF2-40B4-BE49-F238E27FC236}">
                <a16:creationId xmlns:a16="http://schemas.microsoft.com/office/drawing/2014/main" id="{12DD4FBC-88A5-495A-8BBD-DBE92305BD12}"/>
              </a:ext>
            </a:extLst>
          </p:cNvPr>
          <p:cNvSpPr txBox="1"/>
          <p:nvPr/>
        </p:nvSpPr>
        <p:spPr>
          <a:xfrm>
            <a:off x="259055" y="2786108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FASN 273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3" name="תיבת טקסט 74">
            <a:extLst>
              <a:ext uri="{FF2B5EF4-FFF2-40B4-BE49-F238E27FC236}">
                <a16:creationId xmlns:a16="http://schemas.microsoft.com/office/drawing/2014/main" id="{33083F01-98B8-40E2-B9B2-C1A4ABEACEA4}"/>
              </a:ext>
            </a:extLst>
          </p:cNvPr>
          <p:cNvSpPr txBox="1"/>
          <p:nvPr/>
        </p:nvSpPr>
        <p:spPr>
          <a:xfrm>
            <a:off x="251035" y="3383680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mTOR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22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4" name="תיבת טקסט 75">
            <a:extLst>
              <a:ext uri="{FF2B5EF4-FFF2-40B4-BE49-F238E27FC236}">
                <a16:creationId xmlns:a16="http://schemas.microsoft.com/office/drawing/2014/main" id="{D561F2B2-60EB-452C-9E37-868369980D17}"/>
              </a:ext>
            </a:extLst>
          </p:cNvPr>
          <p:cNvSpPr txBox="1"/>
          <p:nvPr/>
        </p:nvSpPr>
        <p:spPr>
          <a:xfrm>
            <a:off x="249988" y="5236716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NFKB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65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5" name="תיבת טקסט 76">
            <a:extLst>
              <a:ext uri="{FF2B5EF4-FFF2-40B4-BE49-F238E27FC236}">
                <a16:creationId xmlns:a16="http://schemas.microsoft.com/office/drawing/2014/main" id="{E825FA9B-5817-4DCC-AB1B-BFD85BA38F5B}"/>
              </a:ext>
            </a:extLst>
          </p:cNvPr>
          <p:cNvSpPr txBox="1"/>
          <p:nvPr/>
        </p:nvSpPr>
        <p:spPr>
          <a:xfrm>
            <a:off x="251037" y="3995450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P70S6K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7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6" name="תיבת טקסט 77">
            <a:extLst>
              <a:ext uri="{FF2B5EF4-FFF2-40B4-BE49-F238E27FC236}">
                <a16:creationId xmlns:a16="http://schemas.microsoft.com/office/drawing/2014/main" id="{94C7B495-7225-4EC5-97A0-01A7A4F5860A}"/>
              </a:ext>
            </a:extLst>
          </p:cNvPr>
          <p:cNvSpPr txBox="1"/>
          <p:nvPr/>
        </p:nvSpPr>
        <p:spPr>
          <a:xfrm>
            <a:off x="243017" y="4597029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pP70S6K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7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7" name="תיבת טקסט 78">
            <a:extLst>
              <a:ext uri="{FF2B5EF4-FFF2-40B4-BE49-F238E27FC236}">
                <a16:creationId xmlns:a16="http://schemas.microsoft.com/office/drawing/2014/main" id="{9B274E60-7A1A-452F-9551-42BB28FF99BE}"/>
              </a:ext>
            </a:extLst>
          </p:cNvPr>
          <p:cNvSpPr txBox="1"/>
          <p:nvPr/>
        </p:nvSpPr>
        <p:spPr>
          <a:xfrm>
            <a:off x="251039" y="7053304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AKT 6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8" name="תיבת טקסט 79">
            <a:extLst>
              <a:ext uri="{FF2B5EF4-FFF2-40B4-BE49-F238E27FC236}">
                <a16:creationId xmlns:a16="http://schemas.microsoft.com/office/drawing/2014/main" id="{F4BD0B9D-537A-4AD8-97DC-5ACF68DEB7B0}"/>
              </a:ext>
            </a:extLst>
          </p:cNvPr>
          <p:cNvSpPr txBox="1"/>
          <p:nvPr/>
        </p:nvSpPr>
        <p:spPr>
          <a:xfrm>
            <a:off x="243019" y="7694990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AKT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56-6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9" name="תיבת טקסט 80">
            <a:extLst>
              <a:ext uri="{FF2B5EF4-FFF2-40B4-BE49-F238E27FC236}">
                <a16:creationId xmlns:a16="http://schemas.microsoft.com/office/drawing/2014/main" id="{86CA37CC-C642-4903-BD12-1A426CB8D92F}"/>
              </a:ext>
            </a:extLst>
          </p:cNvPr>
          <p:cNvSpPr txBox="1"/>
          <p:nvPr/>
        </p:nvSpPr>
        <p:spPr>
          <a:xfrm>
            <a:off x="234999" y="8316618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ACTIN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4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0" name="תיבת טקסט 81">
            <a:extLst>
              <a:ext uri="{FF2B5EF4-FFF2-40B4-BE49-F238E27FC236}">
                <a16:creationId xmlns:a16="http://schemas.microsoft.com/office/drawing/2014/main" id="{9426F297-DABE-499F-A1C0-266666A83C79}"/>
              </a:ext>
            </a:extLst>
          </p:cNvPr>
          <p:cNvSpPr txBox="1"/>
          <p:nvPr/>
        </p:nvSpPr>
        <p:spPr>
          <a:xfrm>
            <a:off x="243021" y="10133398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S6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3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1" name="תיבת טקסט 82">
            <a:extLst>
              <a:ext uri="{FF2B5EF4-FFF2-40B4-BE49-F238E27FC236}">
                <a16:creationId xmlns:a16="http://schemas.microsoft.com/office/drawing/2014/main" id="{07945844-C51E-4DCC-B0AF-B0CF10C07A8A}"/>
              </a:ext>
            </a:extLst>
          </p:cNvPr>
          <p:cNvSpPr txBox="1"/>
          <p:nvPr/>
        </p:nvSpPr>
        <p:spPr>
          <a:xfrm>
            <a:off x="251043" y="10730964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pS6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3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2" name="תיבת טקסט 76">
            <a:extLst>
              <a:ext uri="{FF2B5EF4-FFF2-40B4-BE49-F238E27FC236}">
                <a16:creationId xmlns:a16="http://schemas.microsoft.com/office/drawing/2014/main" id="{040936E6-B3C2-41BA-9F3A-A07F58F7954D}"/>
              </a:ext>
            </a:extLst>
          </p:cNvPr>
          <p:cNvSpPr txBox="1"/>
          <p:nvPr/>
        </p:nvSpPr>
        <p:spPr>
          <a:xfrm>
            <a:off x="247023" y="5856338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AMPK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6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3" name="תיבת טקסט 77">
            <a:extLst>
              <a:ext uri="{FF2B5EF4-FFF2-40B4-BE49-F238E27FC236}">
                <a16:creationId xmlns:a16="http://schemas.microsoft.com/office/drawing/2014/main" id="{C048DAAB-1C94-4DC4-98EF-72A1E3B8EB78}"/>
              </a:ext>
            </a:extLst>
          </p:cNvPr>
          <p:cNvSpPr txBox="1"/>
          <p:nvPr/>
        </p:nvSpPr>
        <p:spPr>
          <a:xfrm>
            <a:off x="239003" y="6457917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AMPK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6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4" name="תיבת טקסט 76">
            <a:extLst>
              <a:ext uri="{FF2B5EF4-FFF2-40B4-BE49-F238E27FC236}">
                <a16:creationId xmlns:a16="http://schemas.microsoft.com/office/drawing/2014/main" id="{E22F69FF-E202-4795-AFCD-53A4FD3EFF83}"/>
              </a:ext>
            </a:extLst>
          </p:cNvPr>
          <p:cNvSpPr txBox="1"/>
          <p:nvPr/>
        </p:nvSpPr>
        <p:spPr>
          <a:xfrm>
            <a:off x="247023" y="8924396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PP2A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36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5" name="תיבת טקסט 77">
            <a:extLst>
              <a:ext uri="{FF2B5EF4-FFF2-40B4-BE49-F238E27FC236}">
                <a16:creationId xmlns:a16="http://schemas.microsoft.com/office/drawing/2014/main" id="{518CB4F7-512C-4D5C-A51E-1E0EBFFDD206}"/>
              </a:ext>
            </a:extLst>
          </p:cNvPr>
          <p:cNvSpPr txBox="1"/>
          <p:nvPr/>
        </p:nvSpPr>
        <p:spPr>
          <a:xfrm>
            <a:off x="239003" y="9525975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pPP2A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36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תיבת טקסט 12">
            <a:extLst>
              <a:ext uri="{FF2B5EF4-FFF2-40B4-BE49-F238E27FC236}">
                <a16:creationId xmlns:a16="http://schemas.microsoft.com/office/drawing/2014/main" id="{10084B39-BF93-0B4C-D672-02D1723073E3}"/>
              </a:ext>
            </a:extLst>
          </p:cNvPr>
          <p:cNvSpPr txBox="1"/>
          <p:nvPr/>
        </p:nvSpPr>
        <p:spPr>
          <a:xfrm>
            <a:off x="275095" y="1041539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mTOR 289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תיבת טקסט 13">
            <a:extLst>
              <a:ext uri="{FF2B5EF4-FFF2-40B4-BE49-F238E27FC236}">
                <a16:creationId xmlns:a16="http://schemas.microsoft.com/office/drawing/2014/main" id="{A148D558-4803-4E6A-4C0D-A61611C4CE0D}"/>
              </a:ext>
            </a:extLst>
          </p:cNvPr>
          <p:cNvSpPr txBox="1"/>
          <p:nvPr/>
        </p:nvSpPr>
        <p:spPr>
          <a:xfrm>
            <a:off x="2077541" y="386145"/>
            <a:ext cx="656718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Chow</a:t>
            </a:r>
            <a:endParaRPr lang="he-IL" sz="1600" dirty="0"/>
          </a:p>
        </p:txBody>
      </p:sp>
      <p:sp>
        <p:nvSpPr>
          <p:cNvPr id="15" name="תיבת טקסט 14">
            <a:extLst>
              <a:ext uri="{FF2B5EF4-FFF2-40B4-BE49-F238E27FC236}">
                <a16:creationId xmlns:a16="http://schemas.microsoft.com/office/drawing/2014/main" id="{8E22B857-D879-D241-DD68-2AE49A469FF4}"/>
              </a:ext>
            </a:extLst>
          </p:cNvPr>
          <p:cNvSpPr txBox="1"/>
          <p:nvPr/>
        </p:nvSpPr>
        <p:spPr>
          <a:xfrm>
            <a:off x="3590696" y="393115"/>
            <a:ext cx="1111971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 err="1"/>
              <a:t>Chow+BHB</a:t>
            </a:r>
            <a:endParaRPr lang="he-IL" sz="1600" dirty="0"/>
          </a:p>
        </p:txBody>
      </p:sp>
      <p:pic>
        <p:nvPicPr>
          <p:cNvPr id="50" name="תמונה 49">
            <a:extLst>
              <a:ext uri="{FF2B5EF4-FFF2-40B4-BE49-F238E27FC236}">
                <a16:creationId xmlns:a16="http://schemas.microsoft.com/office/drawing/2014/main" id="{5E2FE71B-BF53-3C2F-14CA-5B502BC644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90663" y="3264229"/>
            <a:ext cx="266700" cy="219075"/>
          </a:xfrm>
          <a:prstGeom prst="rect">
            <a:avLst/>
          </a:prstGeom>
        </p:spPr>
      </p:pic>
      <p:sp>
        <p:nvSpPr>
          <p:cNvPr id="51" name="תיבת טקסט 50">
            <a:extLst>
              <a:ext uri="{FF2B5EF4-FFF2-40B4-BE49-F238E27FC236}">
                <a16:creationId xmlns:a16="http://schemas.microsoft.com/office/drawing/2014/main" id="{7490128A-00E7-8ED4-7D89-6269FD15C9F6}"/>
              </a:ext>
            </a:extLst>
          </p:cNvPr>
          <p:cNvSpPr txBox="1"/>
          <p:nvPr/>
        </p:nvSpPr>
        <p:spPr>
          <a:xfrm>
            <a:off x="9157363" y="3216107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250 KD</a:t>
            </a:r>
            <a:endParaRPr lang="he-IL" sz="1200" dirty="0"/>
          </a:p>
        </p:txBody>
      </p:sp>
      <p:pic>
        <p:nvPicPr>
          <p:cNvPr id="52" name="תמונה 51">
            <a:extLst>
              <a:ext uri="{FF2B5EF4-FFF2-40B4-BE49-F238E27FC236}">
                <a16:creationId xmlns:a16="http://schemas.microsoft.com/office/drawing/2014/main" id="{8CDE9EE0-CA41-7F68-D899-A653A5C9A1B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89162" y="3778525"/>
            <a:ext cx="285750" cy="180975"/>
          </a:xfrm>
          <a:prstGeom prst="rect">
            <a:avLst/>
          </a:prstGeom>
        </p:spPr>
      </p:pic>
      <p:sp>
        <p:nvSpPr>
          <p:cNvPr id="53" name="תיבת טקסט 52">
            <a:extLst>
              <a:ext uri="{FF2B5EF4-FFF2-40B4-BE49-F238E27FC236}">
                <a16:creationId xmlns:a16="http://schemas.microsoft.com/office/drawing/2014/main" id="{A8779246-1101-ACEF-38FC-2A94AFDCD7CF}"/>
              </a:ext>
            </a:extLst>
          </p:cNvPr>
          <p:cNvSpPr txBox="1"/>
          <p:nvPr/>
        </p:nvSpPr>
        <p:spPr>
          <a:xfrm>
            <a:off x="9168342" y="3733583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150 KD</a:t>
            </a:r>
            <a:endParaRPr lang="he-IL" sz="1200" dirty="0"/>
          </a:p>
        </p:txBody>
      </p:sp>
      <p:pic>
        <p:nvPicPr>
          <p:cNvPr id="54" name="תמונה 53">
            <a:extLst>
              <a:ext uri="{FF2B5EF4-FFF2-40B4-BE49-F238E27FC236}">
                <a16:creationId xmlns:a16="http://schemas.microsoft.com/office/drawing/2014/main" id="{BE8B14D5-7F92-E9C6-B04B-AB52A45F106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62753" y="4017408"/>
            <a:ext cx="361950" cy="152400"/>
          </a:xfrm>
          <a:prstGeom prst="rect">
            <a:avLst/>
          </a:prstGeom>
        </p:spPr>
      </p:pic>
      <p:sp>
        <p:nvSpPr>
          <p:cNvPr id="55" name="תיבת טקסט 54">
            <a:extLst>
              <a:ext uri="{FF2B5EF4-FFF2-40B4-BE49-F238E27FC236}">
                <a16:creationId xmlns:a16="http://schemas.microsoft.com/office/drawing/2014/main" id="{43FA4DCC-31E0-F113-B69C-C939B1412789}"/>
              </a:ext>
            </a:extLst>
          </p:cNvPr>
          <p:cNvSpPr txBox="1"/>
          <p:nvPr/>
        </p:nvSpPr>
        <p:spPr>
          <a:xfrm>
            <a:off x="9152291" y="4004961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75 KD</a:t>
            </a:r>
            <a:endParaRPr lang="he-IL" sz="1200" dirty="0"/>
          </a:p>
        </p:txBody>
      </p:sp>
      <p:pic>
        <p:nvPicPr>
          <p:cNvPr id="58" name="תמונה 57">
            <a:extLst>
              <a:ext uri="{FF2B5EF4-FFF2-40B4-BE49-F238E27FC236}">
                <a16:creationId xmlns:a16="http://schemas.microsoft.com/office/drawing/2014/main" id="{CB3F7469-FAFC-217D-D19E-68029378764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90663" y="8203368"/>
            <a:ext cx="342900" cy="171450"/>
          </a:xfrm>
          <a:prstGeom prst="rect">
            <a:avLst/>
          </a:prstGeom>
        </p:spPr>
      </p:pic>
      <p:sp>
        <p:nvSpPr>
          <p:cNvPr id="59" name="תיבת טקסט 58">
            <a:extLst>
              <a:ext uri="{FF2B5EF4-FFF2-40B4-BE49-F238E27FC236}">
                <a16:creationId xmlns:a16="http://schemas.microsoft.com/office/drawing/2014/main" id="{B88E4FDA-40FB-15EA-2598-D40993CDB69F}"/>
              </a:ext>
            </a:extLst>
          </p:cNvPr>
          <p:cNvSpPr txBox="1"/>
          <p:nvPr/>
        </p:nvSpPr>
        <p:spPr>
          <a:xfrm>
            <a:off x="9145327" y="8146282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50 KD</a:t>
            </a:r>
            <a:endParaRPr lang="he-IL" sz="1200" dirty="0"/>
          </a:p>
        </p:txBody>
      </p:sp>
      <p:pic>
        <p:nvPicPr>
          <p:cNvPr id="60" name="תמונה 59">
            <a:extLst>
              <a:ext uri="{FF2B5EF4-FFF2-40B4-BE49-F238E27FC236}">
                <a16:creationId xmlns:a16="http://schemas.microsoft.com/office/drawing/2014/main" id="{22B964ED-D404-ECF2-9BD5-A1E53C7FE1A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71918" y="8826332"/>
            <a:ext cx="314325" cy="161925"/>
          </a:xfrm>
          <a:prstGeom prst="rect">
            <a:avLst/>
          </a:prstGeom>
        </p:spPr>
      </p:pic>
      <p:sp>
        <p:nvSpPr>
          <p:cNvPr id="61" name="תיבת טקסט 60">
            <a:extLst>
              <a:ext uri="{FF2B5EF4-FFF2-40B4-BE49-F238E27FC236}">
                <a16:creationId xmlns:a16="http://schemas.microsoft.com/office/drawing/2014/main" id="{82C0C43A-C2A4-882F-9132-0BE298F81047}"/>
              </a:ext>
            </a:extLst>
          </p:cNvPr>
          <p:cNvSpPr txBox="1"/>
          <p:nvPr/>
        </p:nvSpPr>
        <p:spPr>
          <a:xfrm>
            <a:off x="9141315" y="8747795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37 KD</a:t>
            </a:r>
            <a:endParaRPr lang="he-IL" sz="1200" dirty="0"/>
          </a:p>
        </p:txBody>
      </p:sp>
      <p:pic>
        <p:nvPicPr>
          <p:cNvPr id="62" name="תמונה 61">
            <a:extLst>
              <a:ext uri="{FF2B5EF4-FFF2-40B4-BE49-F238E27FC236}">
                <a16:creationId xmlns:a16="http://schemas.microsoft.com/office/drawing/2014/main" id="{0F78848F-134D-E3C8-BABD-7476D283AD8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879585" y="11211770"/>
            <a:ext cx="304800" cy="180975"/>
          </a:xfrm>
          <a:prstGeom prst="rect">
            <a:avLst/>
          </a:prstGeom>
        </p:spPr>
      </p:pic>
      <p:sp>
        <p:nvSpPr>
          <p:cNvPr id="63" name="תיבת טקסט 62">
            <a:extLst>
              <a:ext uri="{FF2B5EF4-FFF2-40B4-BE49-F238E27FC236}">
                <a16:creationId xmlns:a16="http://schemas.microsoft.com/office/drawing/2014/main" id="{C8BFF471-696C-4724-3228-8F61C46BFAC6}"/>
              </a:ext>
            </a:extLst>
          </p:cNvPr>
          <p:cNvSpPr txBox="1"/>
          <p:nvPr/>
        </p:nvSpPr>
        <p:spPr>
          <a:xfrm>
            <a:off x="9152291" y="11167324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25 KD</a:t>
            </a:r>
            <a:endParaRPr lang="he-IL" sz="1200" dirty="0"/>
          </a:p>
        </p:txBody>
      </p:sp>
      <p:sp>
        <p:nvSpPr>
          <p:cNvPr id="74" name="תיבת טקסט 73">
            <a:extLst>
              <a:ext uri="{FF2B5EF4-FFF2-40B4-BE49-F238E27FC236}">
                <a16:creationId xmlns:a16="http://schemas.microsoft.com/office/drawing/2014/main" id="{91B1BEED-6FA7-0927-1357-5075D6D3EC72}"/>
              </a:ext>
            </a:extLst>
          </p:cNvPr>
          <p:cNvSpPr txBox="1"/>
          <p:nvPr/>
        </p:nvSpPr>
        <p:spPr>
          <a:xfrm>
            <a:off x="267075" y="1639101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ACC 28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5" name="תיבת טקסט 74">
            <a:extLst>
              <a:ext uri="{FF2B5EF4-FFF2-40B4-BE49-F238E27FC236}">
                <a16:creationId xmlns:a16="http://schemas.microsoft.com/office/drawing/2014/main" id="{00A37420-FBAE-525A-18E0-A53BFCFEEDA9}"/>
              </a:ext>
            </a:extLst>
          </p:cNvPr>
          <p:cNvSpPr txBox="1"/>
          <p:nvPr/>
        </p:nvSpPr>
        <p:spPr>
          <a:xfrm>
            <a:off x="259055" y="2236673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ACC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28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3" name="TextBox 66">
            <a:extLst>
              <a:ext uri="{FF2B5EF4-FFF2-40B4-BE49-F238E27FC236}">
                <a16:creationId xmlns:a16="http://schemas.microsoft.com/office/drawing/2014/main" id="{0B557832-60B7-B090-7FF9-5DBC777DA6E9}"/>
              </a:ext>
            </a:extLst>
          </p:cNvPr>
          <p:cNvSpPr txBox="1"/>
          <p:nvPr/>
        </p:nvSpPr>
        <p:spPr>
          <a:xfrm>
            <a:off x="-10732" y="2814"/>
            <a:ext cx="20780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. S1</a:t>
            </a:r>
          </a:p>
        </p:txBody>
      </p:sp>
      <p:sp>
        <p:nvSpPr>
          <p:cNvPr id="144" name="Rectangle 1">
            <a:extLst>
              <a:ext uri="{FF2B5EF4-FFF2-40B4-BE49-F238E27FC236}">
                <a16:creationId xmlns:a16="http://schemas.microsoft.com/office/drawing/2014/main" id="{33023028-B64F-BC1F-3D8C-541D342F58BA}"/>
              </a:ext>
            </a:extLst>
          </p:cNvPr>
          <p:cNvSpPr/>
          <p:nvPr/>
        </p:nvSpPr>
        <p:spPr>
          <a:xfrm>
            <a:off x="22799" y="11325422"/>
            <a:ext cx="9834414" cy="462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S1: Western blot protein analysis of the effect of HF and BHB supplementation on liver tissue metabolism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6" name="קבוצה 5">
            <a:extLst>
              <a:ext uri="{FF2B5EF4-FFF2-40B4-BE49-F238E27FC236}">
                <a16:creationId xmlns:a16="http://schemas.microsoft.com/office/drawing/2014/main" id="{4AFD568D-41C8-4AAE-9C08-0407F9153474}"/>
              </a:ext>
            </a:extLst>
          </p:cNvPr>
          <p:cNvGrpSpPr/>
          <p:nvPr/>
        </p:nvGrpSpPr>
        <p:grpSpPr>
          <a:xfrm>
            <a:off x="1709581" y="672815"/>
            <a:ext cx="1367729" cy="329471"/>
            <a:chOff x="1709581" y="1009697"/>
            <a:chExt cx="1367729" cy="329471"/>
          </a:xfrm>
        </p:grpSpPr>
        <p:sp>
          <p:nvSpPr>
            <p:cNvPr id="133" name="סוגר מרובע ימני 132">
              <a:extLst>
                <a:ext uri="{FF2B5EF4-FFF2-40B4-BE49-F238E27FC236}">
                  <a16:creationId xmlns:a16="http://schemas.microsoft.com/office/drawing/2014/main" id="{B9467D85-7C62-837F-2A06-957E29059C2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97" name="TextBox 64">
              <a:extLst>
                <a:ext uri="{FF2B5EF4-FFF2-40B4-BE49-F238E27FC236}">
                  <a16:creationId xmlns:a16="http://schemas.microsoft.com/office/drawing/2014/main" id="{AA912D09-30B1-E356-7B4F-06293C79B1D6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98" name="TextBox 65">
              <a:extLst>
                <a:ext uri="{FF2B5EF4-FFF2-40B4-BE49-F238E27FC236}">
                  <a16:creationId xmlns:a16="http://schemas.microsoft.com/office/drawing/2014/main" id="{A20BC556-D3BC-7379-0531-5B4A8F52A7E6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99" name="TextBox 66">
              <a:extLst>
                <a:ext uri="{FF2B5EF4-FFF2-40B4-BE49-F238E27FC236}">
                  <a16:creationId xmlns:a16="http://schemas.microsoft.com/office/drawing/2014/main" id="{0B83B336-88AD-24DD-C3E1-540421E857AE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00" name="TextBox 67">
              <a:extLst>
                <a:ext uri="{FF2B5EF4-FFF2-40B4-BE49-F238E27FC236}">
                  <a16:creationId xmlns:a16="http://schemas.microsoft.com/office/drawing/2014/main" id="{0099CB3B-5887-94B5-417C-DE4A1F1639E9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01" name="TextBox 68">
              <a:extLst>
                <a:ext uri="{FF2B5EF4-FFF2-40B4-BE49-F238E27FC236}">
                  <a16:creationId xmlns:a16="http://schemas.microsoft.com/office/drawing/2014/main" id="{DAAA0074-528E-8F9E-4979-1323FF279B2E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84" name="TextBox 68">
            <a:extLst>
              <a:ext uri="{FF2B5EF4-FFF2-40B4-BE49-F238E27FC236}">
                <a16:creationId xmlns:a16="http://schemas.microsoft.com/office/drawing/2014/main" id="{059F3F98-4615-47B4-8364-1C126FC84F9D}"/>
              </a:ext>
            </a:extLst>
          </p:cNvPr>
          <p:cNvSpPr txBox="1"/>
          <p:nvPr/>
        </p:nvSpPr>
        <p:spPr>
          <a:xfrm>
            <a:off x="2890382" y="727197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grpSp>
        <p:nvGrpSpPr>
          <p:cNvPr id="104" name="קבוצה 103">
            <a:extLst>
              <a:ext uri="{FF2B5EF4-FFF2-40B4-BE49-F238E27FC236}">
                <a16:creationId xmlns:a16="http://schemas.microsoft.com/office/drawing/2014/main" id="{9EFA4827-C724-44BF-B18A-473DBE8EF8CF}"/>
              </a:ext>
            </a:extLst>
          </p:cNvPr>
          <p:cNvGrpSpPr/>
          <p:nvPr/>
        </p:nvGrpSpPr>
        <p:grpSpPr>
          <a:xfrm>
            <a:off x="3464317" y="675720"/>
            <a:ext cx="1367729" cy="329471"/>
            <a:chOff x="1709581" y="1009697"/>
            <a:chExt cx="1367729" cy="329471"/>
          </a:xfrm>
        </p:grpSpPr>
        <p:sp>
          <p:nvSpPr>
            <p:cNvPr id="105" name="סוגר מרובע ימני 104">
              <a:extLst>
                <a:ext uri="{FF2B5EF4-FFF2-40B4-BE49-F238E27FC236}">
                  <a16:creationId xmlns:a16="http://schemas.microsoft.com/office/drawing/2014/main" id="{BDED5688-72A1-4B2A-AA2A-3CBA0A79E27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06" name="TextBox 64">
              <a:extLst>
                <a:ext uri="{FF2B5EF4-FFF2-40B4-BE49-F238E27FC236}">
                  <a16:creationId xmlns:a16="http://schemas.microsoft.com/office/drawing/2014/main" id="{28BF52E6-BA50-487C-ACA5-6982911FAA0C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07" name="TextBox 65">
              <a:extLst>
                <a:ext uri="{FF2B5EF4-FFF2-40B4-BE49-F238E27FC236}">
                  <a16:creationId xmlns:a16="http://schemas.microsoft.com/office/drawing/2014/main" id="{FFBD7BED-404E-45F4-A258-952F5CD7E222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08" name="TextBox 66">
              <a:extLst>
                <a:ext uri="{FF2B5EF4-FFF2-40B4-BE49-F238E27FC236}">
                  <a16:creationId xmlns:a16="http://schemas.microsoft.com/office/drawing/2014/main" id="{FC9843A3-53C7-4FAA-B4B3-1F0EE56C25B7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09" name="TextBox 67">
              <a:extLst>
                <a:ext uri="{FF2B5EF4-FFF2-40B4-BE49-F238E27FC236}">
                  <a16:creationId xmlns:a16="http://schemas.microsoft.com/office/drawing/2014/main" id="{1B859FF9-24F4-458D-8A53-E997FC5B7F0E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10" name="TextBox 68">
              <a:extLst>
                <a:ext uri="{FF2B5EF4-FFF2-40B4-BE49-F238E27FC236}">
                  <a16:creationId xmlns:a16="http://schemas.microsoft.com/office/drawing/2014/main" id="{3BE4D8CB-9E84-42AD-8179-9C7C0602D6F1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11" name="TextBox 68">
            <a:extLst>
              <a:ext uri="{FF2B5EF4-FFF2-40B4-BE49-F238E27FC236}">
                <a16:creationId xmlns:a16="http://schemas.microsoft.com/office/drawing/2014/main" id="{212134D3-F29F-48F4-83F9-FD1A955BC73A}"/>
              </a:ext>
            </a:extLst>
          </p:cNvPr>
          <p:cNvSpPr txBox="1"/>
          <p:nvPr/>
        </p:nvSpPr>
        <p:spPr>
          <a:xfrm>
            <a:off x="4631437" y="730529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sp>
        <p:nvSpPr>
          <p:cNvPr id="112" name="תיבת טקסט 13">
            <a:extLst>
              <a:ext uri="{FF2B5EF4-FFF2-40B4-BE49-F238E27FC236}">
                <a16:creationId xmlns:a16="http://schemas.microsoft.com/office/drawing/2014/main" id="{B27A25D1-B7A9-4B6D-A3A0-173CDAABF010}"/>
              </a:ext>
            </a:extLst>
          </p:cNvPr>
          <p:cNvSpPr txBox="1"/>
          <p:nvPr/>
        </p:nvSpPr>
        <p:spPr>
          <a:xfrm>
            <a:off x="5842567" y="388645"/>
            <a:ext cx="407484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HF</a:t>
            </a:r>
            <a:endParaRPr lang="he-IL" sz="1600" dirty="0"/>
          </a:p>
        </p:txBody>
      </p:sp>
      <p:sp>
        <p:nvSpPr>
          <p:cNvPr id="113" name="תיבת טקסט 14">
            <a:extLst>
              <a:ext uri="{FF2B5EF4-FFF2-40B4-BE49-F238E27FC236}">
                <a16:creationId xmlns:a16="http://schemas.microsoft.com/office/drawing/2014/main" id="{4C13841B-9DC1-4201-A63D-F5355298E5B9}"/>
              </a:ext>
            </a:extLst>
          </p:cNvPr>
          <p:cNvSpPr txBox="1"/>
          <p:nvPr/>
        </p:nvSpPr>
        <p:spPr>
          <a:xfrm>
            <a:off x="7355722" y="395615"/>
            <a:ext cx="862737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HF+BHB</a:t>
            </a:r>
            <a:endParaRPr lang="he-IL" sz="1600" dirty="0"/>
          </a:p>
        </p:txBody>
      </p:sp>
      <p:grpSp>
        <p:nvGrpSpPr>
          <p:cNvPr id="114" name="קבוצה 113">
            <a:extLst>
              <a:ext uri="{FF2B5EF4-FFF2-40B4-BE49-F238E27FC236}">
                <a16:creationId xmlns:a16="http://schemas.microsoft.com/office/drawing/2014/main" id="{8181050A-528A-40E5-9454-114F8D16F038}"/>
              </a:ext>
            </a:extLst>
          </p:cNvPr>
          <p:cNvGrpSpPr/>
          <p:nvPr/>
        </p:nvGrpSpPr>
        <p:grpSpPr>
          <a:xfrm>
            <a:off x="5474607" y="675315"/>
            <a:ext cx="1367729" cy="329471"/>
            <a:chOff x="1709581" y="1009697"/>
            <a:chExt cx="1367729" cy="329471"/>
          </a:xfrm>
        </p:grpSpPr>
        <p:sp>
          <p:nvSpPr>
            <p:cNvPr id="137" name="סוגר מרובע ימני 136">
              <a:extLst>
                <a:ext uri="{FF2B5EF4-FFF2-40B4-BE49-F238E27FC236}">
                  <a16:creationId xmlns:a16="http://schemas.microsoft.com/office/drawing/2014/main" id="{392BA01C-5A4F-4E30-8375-892DADCD1EB3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39" name="TextBox 64">
              <a:extLst>
                <a:ext uri="{FF2B5EF4-FFF2-40B4-BE49-F238E27FC236}">
                  <a16:creationId xmlns:a16="http://schemas.microsoft.com/office/drawing/2014/main" id="{5CA97C4B-4E4F-4350-885F-70BA4A65C1DE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41" name="TextBox 65">
              <a:extLst>
                <a:ext uri="{FF2B5EF4-FFF2-40B4-BE49-F238E27FC236}">
                  <a16:creationId xmlns:a16="http://schemas.microsoft.com/office/drawing/2014/main" id="{910161C2-EB0C-4D02-962D-BA04D3697E41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45" name="TextBox 66">
              <a:extLst>
                <a:ext uri="{FF2B5EF4-FFF2-40B4-BE49-F238E27FC236}">
                  <a16:creationId xmlns:a16="http://schemas.microsoft.com/office/drawing/2014/main" id="{069F509B-4416-4CEC-A09D-9613C304B507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46" name="TextBox 67">
              <a:extLst>
                <a:ext uri="{FF2B5EF4-FFF2-40B4-BE49-F238E27FC236}">
                  <a16:creationId xmlns:a16="http://schemas.microsoft.com/office/drawing/2014/main" id="{D1A0B974-A9F6-4CFD-8143-8E8AC797A7A8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47" name="TextBox 68">
              <a:extLst>
                <a:ext uri="{FF2B5EF4-FFF2-40B4-BE49-F238E27FC236}">
                  <a16:creationId xmlns:a16="http://schemas.microsoft.com/office/drawing/2014/main" id="{74983962-1DF6-468A-9D7C-787E0E0D3F64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48" name="TextBox 68">
            <a:extLst>
              <a:ext uri="{FF2B5EF4-FFF2-40B4-BE49-F238E27FC236}">
                <a16:creationId xmlns:a16="http://schemas.microsoft.com/office/drawing/2014/main" id="{A21AB5A2-F4AA-4EA7-8209-B78CB1D8CCFB}"/>
              </a:ext>
            </a:extLst>
          </p:cNvPr>
          <p:cNvSpPr txBox="1"/>
          <p:nvPr/>
        </p:nvSpPr>
        <p:spPr>
          <a:xfrm>
            <a:off x="6655408" y="729697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grpSp>
        <p:nvGrpSpPr>
          <p:cNvPr id="149" name="קבוצה 148">
            <a:extLst>
              <a:ext uri="{FF2B5EF4-FFF2-40B4-BE49-F238E27FC236}">
                <a16:creationId xmlns:a16="http://schemas.microsoft.com/office/drawing/2014/main" id="{CCC49AA6-3540-41C4-80A0-D9170B688B5D}"/>
              </a:ext>
            </a:extLst>
          </p:cNvPr>
          <p:cNvGrpSpPr/>
          <p:nvPr/>
        </p:nvGrpSpPr>
        <p:grpSpPr>
          <a:xfrm>
            <a:off x="7229343" y="678220"/>
            <a:ext cx="1367729" cy="329471"/>
            <a:chOff x="1709581" y="1009697"/>
            <a:chExt cx="1367729" cy="329471"/>
          </a:xfrm>
        </p:grpSpPr>
        <p:sp>
          <p:nvSpPr>
            <p:cNvPr id="150" name="סוגר מרובע ימני 149">
              <a:extLst>
                <a:ext uri="{FF2B5EF4-FFF2-40B4-BE49-F238E27FC236}">
                  <a16:creationId xmlns:a16="http://schemas.microsoft.com/office/drawing/2014/main" id="{B9AD1C17-2C9C-4AF8-BEC7-72259B00F17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51" name="TextBox 64">
              <a:extLst>
                <a:ext uri="{FF2B5EF4-FFF2-40B4-BE49-F238E27FC236}">
                  <a16:creationId xmlns:a16="http://schemas.microsoft.com/office/drawing/2014/main" id="{4700D035-9DCE-405D-B9F2-C115B053D1EB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52" name="TextBox 65">
              <a:extLst>
                <a:ext uri="{FF2B5EF4-FFF2-40B4-BE49-F238E27FC236}">
                  <a16:creationId xmlns:a16="http://schemas.microsoft.com/office/drawing/2014/main" id="{27E089C8-3DB8-4806-8E41-986703E9923A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53" name="TextBox 66">
              <a:extLst>
                <a:ext uri="{FF2B5EF4-FFF2-40B4-BE49-F238E27FC236}">
                  <a16:creationId xmlns:a16="http://schemas.microsoft.com/office/drawing/2014/main" id="{BAD3E3FC-9994-4FF6-86D0-66A1EC6D49AD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54" name="TextBox 67">
              <a:extLst>
                <a:ext uri="{FF2B5EF4-FFF2-40B4-BE49-F238E27FC236}">
                  <a16:creationId xmlns:a16="http://schemas.microsoft.com/office/drawing/2014/main" id="{17A5D0ED-7B6B-419B-B914-2A242B34BD34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55" name="TextBox 68">
              <a:extLst>
                <a:ext uri="{FF2B5EF4-FFF2-40B4-BE49-F238E27FC236}">
                  <a16:creationId xmlns:a16="http://schemas.microsoft.com/office/drawing/2014/main" id="{18B500CA-3022-4D90-9C4B-E3B87E4FB031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56" name="TextBox 68">
            <a:extLst>
              <a:ext uri="{FF2B5EF4-FFF2-40B4-BE49-F238E27FC236}">
                <a16:creationId xmlns:a16="http://schemas.microsoft.com/office/drawing/2014/main" id="{BE1723CA-D04E-49D0-AD3D-B510BC00B2A8}"/>
              </a:ext>
            </a:extLst>
          </p:cNvPr>
          <p:cNvSpPr txBox="1"/>
          <p:nvPr/>
        </p:nvSpPr>
        <p:spPr>
          <a:xfrm>
            <a:off x="8396463" y="733029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pic>
        <p:nvPicPr>
          <p:cNvPr id="115" name="Picture 11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18263" y="1093442"/>
            <a:ext cx="3682303" cy="359695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242805" y="1730802"/>
            <a:ext cx="3505504" cy="32921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242805" y="2318055"/>
            <a:ext cx="3487214" cy="26824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285481" y="2936923"/>
            <a:ext cx="3462828" cy="12802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230612" y="3472706"/>
            <a:ext cx="3517697" cy="37188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183011" y="4180171"/>
            <a:ext cx="3542083" cy="31701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225633" y="4790659"/>
            <a:ext cx="3529890" cy="29873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255326" y="5339516"/>
            <a:ext cx="3499407" cy="359695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224843" y="5932078"/>
            <a:ext cx="3529890" cy="3475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247723" y="6660081"/>
            <a:ext cx="3438442" cy="207282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169647" y="7263406"/>
            <a:ext cx="3578662" cy="231668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155264" y="7820326"/>
            <a:ext cx="3529890" cy="28044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169647" y="8428863"/>
            <a:ext cx="3578662" cy="29873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279795" y="9059883"/>
            <a:ext cx="3505504" cy="20118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316290" y="9661382"/>
            <a:ext cx="3377477" cy="225572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5200129" y="10200106"/>
            <a:ext cx="3548180" cy="384081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316290" y="10843708"/>
            <a:ext cx="3499407" cy="384081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275110" y="1115819"/>
            <a:ext cx="3694496" cy="353599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1387324" y="1747866"/>
            <a:ext cx="3554276" cy="286537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375293" y="2362888"/>
            <a:ext cx="3523793" cy="195089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472569" y="2966925"/>
            <a:ext cx="3505504" cy="15851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1409260" y="3471445"/>
            <a:ext cx="3517697" cy="438950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1434518" y="4164520"/>
            <a:ext cx="3523793" cy="371888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1443662" y="4824501"/>
            <a:ext cx="3505504" cy="249958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1351504" y="5360086"/>
            <a:ext cx="3657917" cy="262151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1400275" y="6050821"/>
            <a:ext cx="3560373" cy="256054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1419276" y="6646276"/>
            <a:ext cx="3554276" cy="29873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1469137" y="7271731"/>
            <a:ext cx="3487214" cy="274344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1548392" y="7893659"/>
            <a:ext cx="3407959" cy="201185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1413179" y="8362376"/>
            <a:ext cx="3566469" cy="402371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1395978" y="9089916"/>
            <a:ext cx="3633531" cy="207282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1463995" y="9663102"/>
            <a:ext cx="3554276" cy="231668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1444498" y="10242561"/>
            <a:ext cx="3566469" cy="256054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>
            <a:off x="1465014" y="10805452"/>
            <a:ext cx="3493311" cy="4023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33980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קבוצה 1">
            <a:extLst>
              <a:ext uri="{FF2B5EF4-FFF2-40B4-BE49-F238E27FC236}">
                <a16:creationId xmlns:a16="http://schemas.microsoft.com/office/drawing/2014/main" id="{FBD17801-301B-44B2-9EA6-73AF4CA08B6A}"/>
              </a:ext>
            </a:extLst>
          </p:cNvPr>
          <p:cNvGrpSpPr/>
          <p:nvPr/>
        </p:nvGrpSpPr>
        <p:grpSpPr>
          <a:xfrm>
            <a:off x="243017" y="2790126"/>
            <a:ext cx="929859" cy="1736569"/>
            <a:chOff x="243017" y="3383680"/>
            <a:chExt cx="929859" cy="1736569"/>
          </a:xfrm>
        </p:grpSpPr>
        <p:sp>
          <p:nvSpPr>
            <p:cNvPr id="163" name="תיבת טקסט 74">
              <a:extLst>
                <a:ext uri="{FF2B5EF4-FFF2-40B4-BE49-F238E27FC236}">
                  <a16:creationId xmlns:a16="http://schemas.microsoft.com/office/drawing/2014/main" id="{33083F01-98B8-40E2-B9B2-C1A4ABEACEA4}"/>
                </a:ext>
              </a:extLst>
            </p:cNvPr>
            <p:cNvSpPr txBox="1"/>
            <p:nvPr/>
          </p:nvSpPr>
          <p:spPr>
            <a:xfrm>
              <a:off x="251035" y="3383680"/>
              <a:ext cx="921839" cy="52322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4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pmTOR</a:t>
              </a:r>
              <a:endParaRPr 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220kDa</a:t>
              </a:r>
              <a:endParaRPr lang="he-IL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5" name="תיבת טקסט 76">
              <a:extLst>
                <a:ext uri="{FF2B5EF4-FFF2-40B4-BE49-F238E27FC236}">
                  <a16:creationId xmlns:a16="http://schemas.microsoft.com/office/drawing/2014/main" id="{E825FA9B-5817-4DCC-AB1B-BFD85BA38F5B}"/>
                </a:ext>
              </a:extLst>
            </p:cNvPr>
            <p:cNvSpPr txBox="1"/>
            <p:nvPr/>
          </p:nvSpPr>
          <p:spPr>
            <a:xfrm>
              <a:off x="251037" y="3995450"/>
              <a:ext cx="921839" cy="52322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P70S6K</a:t>
              </a:r>
            </a:p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70kDa</a:t>
              </a:r>
              <a:endParaRPr lang="he-IL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6" name="תיבת טקסט 77">
              <a:extLst>
                <a:ext uri="{FF2B5EF4-FFF2-40B4-BE49-F238E27FC236}">
                  <a16:creationId xmlns:a16="http://schemas.microsoft.com/office/drawing/2014/main" id="{94C7B495-7225-4EC5-97A0-01A7A4F5860A}"/>
                </a:ext>
              </a:extLst>
            </p:cNvPr>
            <p:cNvSpPr txBox="1"/>
            <p:nvPr/>
          </p:nvSpPr>
          <p:spPr>
            <a:xfrm>
              <a:off x="243017" y="4597029"/>
              <a:ext cx="921839" cy="52322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pP70S6K</a:t>
              </a:r>
            </a:p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70kDa</a:t>
              </a:r>
              <a:endParaRPr lang="he-IL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170" name="תיבת טקסט 81">
            <a:extLst>
              <a:ext uri="{FF2B5EF4-FFF2-40B4-BE49-F238E27FC236}">
                <a16:creationId xmlns:a16="http://schemas.microsoft.com/office/drawing/2014/main" id="{9426F297-DABE-499F-A1C0-266666A83C79}"/>
              </a:ext>
            </a:extLst>
          </p:cNvPr>
          <p:cNvSpPr txBox="1"/>
          <p:nvPr/>
        </p:nvSpPr>
        <p:spPr>
          <a:xfrm>
            <a:off x="243021" y="9523800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S6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3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1" name="תיבת טקסט 82">
            <a:extLst>
              <a:ext uri="{FF2B5EF4-FFF2-40B4-BE49-F238E27FC236}">
                <a16:creationId xmlns:a16="http://schemas.microsoft.com/office/drawing/2014/main" id="{07945844-C51E-4DCC-B0AF-B0CF10C07A8A}"/>
              </a:ext>
            </a:extLst>
          </p:cNvPr>
          <p:cNvSpPr txBox="1"/>
          <p:nvPr/>
        </p:nvSpPr>
        <p:spPr>
          <a:xfrm>
            <a:off x="251043" y="10121366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pS6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3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4" name="טבלה 3">
            <a:extLst>
              <a:ext uri="{FF2B5EF4-FFF2-40B4-BE49-F238E27FC236}">
                <a16:creationId xmlns:a16="http://schemas.microsoft.com/office/drawing/2014/main" id="{F541CAEF-1A26-3B88-7409-B3CFEF620537}"/>
              </a:ext>
            </a:extLst>
          </p:cNvPr>
          <p:cNvGraphicFramePr>
            <a:graphicFrameLocks noGrp="1"/>
          </p:cNvGraphicFramePr>
          <p:nvPr/>
        </p:nvGraphicFramePr>
        <p:xfrm>
          <a:off x="1230309" y="385011"/>
          <a:ext cx="7620004" cy="10311065"/>
        </p:xfrm>
        <a:graphic>
          <a:graphicData uri="http://schemas.openxmlformats.org/drawingml/2006/table">
            <a:tbl>
              <a:tblPr rtl="1" firstRow="1" bandRow="1">
                <a:tableStyleId>{5940675A-B579-460E-94D1-54222C63F5DA}</a:tableStyleId>
              </a:tblPr>
              <a:tblGrid>
                <a:gridCol w="3810002">
                  <a:extLst>
                    <a:ext uri="{9D8B030D-6E8A-4147-A177-3AD203B41FA5}">
                      <a16:colId xmlns:a16="http://schemas.microsoft.com/office/drawing/2014/main" val="2673439277"/>
                    </a:ext>
                  </a:extLst>
                </a:gridCol>
                <a:gridCol w="3810002">
                  <a:extLst>
                    <a:ext uri="{9D8B030D-6E8A-4147-A177-3AD203B41FA5}">
                      <a16:colId xmlns:a16="http://schemas.microsoft.com/office/drawing/2014/main" val="112674736"/>
                    </a:ext>
                  </a:extLst>
                </a:gridCol>
              </a:tblGrid>
              <a:tr h="562362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5894319"/>
                  </a:ext>
                </a:extLst>
              </a:tr>
              <a:tr h="604506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8848110"/>
                  </a:ext>
                </a:extLst>
              </a:tr>
              <a:tr h="597523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5384007"/>
                  </a:ext>
                </a:extLst>
              </a:tr>
              <a:tr h="617863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28102718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8765973"/>
                  </a:ext>
                </a:extLst>
              </a:tr>
              <a:tr h="637674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1069457"/>
                  </a:ext>
                </a:extLst>
              </a:tr>
              <a:tr h="613611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2943920"/>
                  </a:ext>
                </a:extLst>
              </a:tr>
              <a:tr h="601578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3793250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20313756"/>
                  </a:ext>
                </a:extLst>
              </a:tr>
              <a:tr h="637674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7138217"/>
                  </a:ext>
                </a:extLst>
              </a:tr>
              <a:tr h="625642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80046665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1940211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16306057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37959460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1955266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7345177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2313978"/>
                  </a:ext>
                </a:extLst>
              </a:tr>
            </a:tbl>
          </a:graphicData>
        </a:graphic>
      </p:graphicFrame>
      <p:sp>
        <p:nvSpPr>
          <p:cNvPr id="13" name="תיבת טקסט 12">
            <a:extLst>
              <a:ext uri="{FF2B5EF4-FFF2-40B4-BE49-F238E27FC236}">
                <a16:creationId xmlns:a16="http://schemas.microsoft.com/office/drawing/2014/main" id="{10084B39-BF93-0B4C-D672-02D1723073E3}"/>
              </a:ext>
            </a:extLst>
          </p:cNvPr>
          <p:cNvSpPr txBox="1"/>
          <p:nvPr/>
        </p:nvSpPr>
        <p:spPr>
          <a:xfrm>
            <a:off x="275095" y="1041539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mTOR 289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תיבת טקסט 13">
            <a:extLst>
              <a:ext uri="{FF2B5EF4-FFF2-40B4-BE49-F238E27FC236}">
                <a16:creationId xmlns:a16="http://schemas.microsoft.com/office/drawing/2014/main" id="{A148D558-4803-4E6A-4C0D-A61611C4CE0D}"/>
              </a:ext>
            </a:extLst>
          </p:cNvPr>
          <p:cNvSpPr txBox="1"/>
          <p:nvPr/>
        </p:nvSpPr>
        <p:spPr>
          <a:xfrm>
            <a:off x="2077541" y="386145"/>
            <a:ext cx="656718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Chow</a:t>
            </a:r>
            <a:endParaRPr lang="he-IL" sz="1600" dirty="0"/>
          </a:p>
        </p:txBody>
      </p:sp>
      <p:sp>
        <p:nvSpPr>
          <p:cNvPr id="15" name="תיבת טקסט 14">
            <a:extLst>
              <a:ext uri="{FF2B5EF4-FFF2-40B4-BE49-F238E27FC236}">
                <a16:creationId xmlns:a16="http://schemas.microsoft.com/office/drawing/2014/main" id="{8E22B857-D879-D241-DD68-2AE49A469FF4}"/>
              </a:ext>
            </a:extLst>
          </p:cNvPr>
          <p:cNvSpPr txBox="1"/>
          <p:nvPr/>
        </p:nvSpPr>
        <p:spPr>
          <a:xfrm>
            <a:off x="3590696" y="393115"/>
            <a:ext cx="1111971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 err="1"/>
              <a:t>Chow+BHB</a:t>
            </a:r>
            <a:endParaRPr lang="he-IL" sz="1600" dirty="0"/>
          </a:p>
        </p:txBody>
      </p:sp>
      <p:sp>
        <p:nvSpPr>
          <p:cNvPr id="74" name="תיבת טקסט 73">
            <a:extLst>
              <a:ext uri="{FF2B5EF4-FFF2-40B4-BE49-F238E27FC236}">
                <a16:creationId xmlns:a16="http://schemas.microsoft.com/office/drawing/2014/main" id="{91B1BEED-6FA7-0927-1357-5075D6D3EC72}"/>
              </a:ext>
            </a:extLst>
          </p:cNvPr>
          <p:cNvSpPr txBox="1"/>
          <p:nvPr/>
        </p:nvSpPr>
        <p:spPr>
          <a:xfrm>
            <a:off x="267075" y="1639101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ACC 28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5" name="תיבת טקסט 74">
            <a:extLst>
              <a:ext uri="{FF2B5EF4-FFF2-40B4-BE49-F238E27FC236}">
                <a16:creationId xmlns:a16="http://schemas.microsoft.com/office/drawing/2014/main" id="{00A37420-FBAE-525A-18E0-A53BFCFEEDA9}"/>
              </a:ext>
            </a:extLst>
          </p:cNvPr>
          <p:cNvSpPr txBox="1"/>
          <p:nvPr/>
        </p:nvSpPr>
        <p:spPr>
          <a:xfrm>
            <a:off x="259055" y="2236673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ACC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28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3" name="TextBox 66">
            <a:extLst>
              <a:ext uri="{FF2B5EF4-FFF2-40B4-BE49-F238E27FC236}">
                <a16:creationId xmlns:a16="http://schemas.microsoft.com/office/drawing/2014/main" id="{0B557832-60B7-B090-7FF9-5DBC777DA6E9}"/>
              </a:ext>
            </a:extLst>
          </p:cNvPr>
          <p:cNvSpPr txBox="1"/>
          <p:nvPr/>
        </p:nvSpPr>
        <p:spPr>
          <a:xfrm>
            <a:off x="-10732" y="2814"/>
            <a:ext cx="20780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. S2</a:t>
            </a:r>
          </a:p>
        </p:txBody>
      </p:sp>
      <p:grpSp>
        <p:nvGrpSpPr>
          <p:cNvPr id="6" name="קבוצה 5">
            <a:extLst>
              <a:ext uri="{FF2B5EF4-FFF2-40B4-BE49-F238E27FC236}">
                <a16:creationId xmlns:a16="http://schemas.microsoft.com/office/drawing/2014/main" id="{4AFD568D-41C8-4AAE-9C08-0407F9153474}"/>
              </a:ext>
            </a:extLst>
          </p:cNvPr>
          <p:cNvGrpSpPr/>
          <p:nvPr/>
        </p:nvGrpSpPr>
        <p:grpSpPr>
          <a:xfrm>
            <a:off x="1709581" y="672815"/>
            <a:ext cx="1367729" cy="329471"/>
            <a:chOff x="1709581" y="1009697"/>
            <a:chExt cx="1367729" cy="329471"/>
          </a:xfrm>
        </p:grpSpPr>
        <p:sp>
          <p:nvSpPr>
            <p:cNvPr id="133" name="סוגר מרובע ימני 132">
              <a:extLst>
                <a:ext uri="{FF2B5EF4-FFF2-40B4-BE49-F238E27FC236}">
                  <a16:creationId xmlns:a16="http://schemas.microsoft.com/office/drawing/2014/main" id="{B9467D85-7C62-837F-2A06-957E29059C2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97" name="TextBox 64">
              <a:extLst>
                <a:ext uri="{FF2B5EF4-FFF2-40B4-BE49-F238E27FC236}">
                  <a16:creationId xmlns:a16="http://schemas.microsoft.com/office/drawing/2014/main" id="{AA912D09-30B1-E356-7B4F-06293C79B1D6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98" name="TextBox 65">
              <a:extLst>
                <a:ext uri="{FF2B5EF4-FFF2-40B4-BE49-F238E27FC236}">
                  <a16:creationId xmlns:a16="http://schemas.microsoft.com/office/drawing/2014/main" id="{A20BC556-D3BC-7379-0531-5B4A8F52A7E6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99" name="TextBox 66">
              <a:extLst>
                <a:ext uri="{FF2B5EF4-FFF2-40B4-BE49-F238E27FC236}">
                  <a16:creationId xmlns:a16="http://schemas.microsoft.com/office/drawing/2014/main" id="{0B83B336-88AD-24DD-C3E1-540421E857AE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00" name="TextBox 67">
              <a:extLst>
                <a:ext uri="{FF2B5EF4-FFF2-40B4-BE49-F238E27FC236}">
                  <a16:creationId xmlns:a16="http://schemas.microsoft.com/office/drawing/2014/main" id="{0099CB3B-5887-94B5-417C-DE4A1F1639E9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01" name="TextBox 68">
              <a:extLst>
                <a:ext uri="{FF2B5EF4-FFF2-40B4-BE49-F238E27FC236}">
                  <a16:creationId xmlns:a16="http://schemas.microsoft.com/office/drawing/2014/main" id="{DAAA0074-528E-8F9E-4979-1323FF279B2E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84" name="TextBox 68">
            <a:extLst>
              <a:ext uri="{FF2B5EF4-FFF2-40B4-BE49-F238E27FC236}">
                <a16:creationId xmlns:a16="http://schemas.microsoft.com/office/drawing/2014/main" id="{059F3F98-4615-47B4-8364-1C126FC84F9D}"/>
              </a:ext>
            </a:extLst>
          </p:cNvPr>
          <p:cNvSpPr txBox="1"/>
          <p:nvPr/>
        </p:nvSpPr>
        <p:spPr>
          <a:xfrm>
            <a:off x="2890382" y="727197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grpSp>
        <p:nvGrpSpPr>
          <p:cNvPr id="104" name="קבוצה 103">
            <a:extLst>
              <a:ext uri="{FF2B5EF4-FFF2-40B4-BE49-F238E27FC236}">
                <a16:creationId xmlns:a16="http://schemas.microsoft.com/office/drawing/2014/main" id="{9EFA4827-C724-44BF-B18A-473DBE8EF8CF}"/>
              </a:ext>
            </a:extLst>
          </p:cNvPr>
          <p:cNvGrpSpPr/>
          <p:nvPr/>
        </p:nvGrpSpPr>
        <p:grpSpPr>
          <a:xfrm>
            <a:off x="3464317" y="675720"/>
            <a:ext cx="1367729" cy="329471"/>
            <a:chOff x="1709581" y="1009697"/>
            <a:chExt cx="1367729" cy="329471"/>
          </a:xfrm>
        </p:grpSpPr>
        <p:sp>
          <p:nvSpPr>
            <p:cNvPr id="105" name="סוגר מרובע ימני 104">
              <a:extLst>
                <a:ext uri="{FF2B5EF4-FFF2-40B4-BE49-F238E27FC236}">
                  <a16:creationId xmlns:a16="http://schemas.microsoft.com/office/drawing/2014/main" id="{BDED5688-72A1-4B2A-AA2A-3CBA0A79E27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06" name="TextBox 64">
              <a:extLst>
                <a:ext uri="{FF2B5EF4-FFF2-40B4-BE49-F238E27FC236}">
                  <a16:creationId xmlns:a16="http://schemas.microsoft.com/office/drawing/2014/main" id="{28BF52E6-BA50-487C-ACA5-6982911FAA0C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07" name="TextBox 65">
              <a:extLst>
                <a:ext uri="{FF2B5EF4-FFF2-40B4-BE49-F238E27FC236}">
                  <a16:creationId xmlns:a16="http://schemas.microsoft.com/office/drawing/2014/main" id="{FFBD7BED-404E-45F4-A258-952F5CD7E222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08" name="TextBox 66">
              <a:extLst>
                <a:ext uri="{FF2B5EF4-FFF2-40B4-BE49-F238E27FC236}">
                  <a16:creationId xmlns:a16="http://schemas.microsoft.com/office/drawing/2014/main" id="{FC9843A3-53C7-4FAA-B4B3-1F0EE56C25B7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09" name="TextBox 67">
              <a:extLst>
                <a:ext uri="{FF2B5EF4-FFF2-40B4-BE49-F238E27FC236}">
                  <a16:creationId xmlns:a16="http://schemas.microsoft.com/office/drawing/2014/main" id="{1B859FF9-24F4-458D-8A53-E997FC5B7F0E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10" name="TextBox 68">
              <a:extLst>
                <a:ext uri="{FF2B5EF4-FFF2-40B4-BE49-F238E27FC236}">
                  <a16:creationId xmlns:a16="http://schemas.microsoft.com/office/drawing/2014/main" id="{3BE4D8CB-9E84-42AD-8179-9C7C0602D6F1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11" name="TextBox 68">
            <a:extLst>
              <a:ext uri="{FF2B5EF4-FFF2-40B4-BE49-F238E27FC236}">
                <a16:creationId xmlns:a16="http://schemas.microsoft.com/office/drawing/2014/main" id="{212134D3-F29F-48F4-83F9-FD1A955BC73A}"/>
              </a:ext>
            </a:extLst>
          </p:cNvPr>
          <p:cNvSpPr txBox="1"/>
          <p:nvPr/>
        </p:nvSpPr>
        <p:spPr>
          <a:xfrm>
            <a:off x="4631437" y="730529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sp>
        <p:nvSpPr>
          <p:cNvPr id="112" name="תיבת טקסט 13">
            <a:extLst>
              <a:ext uri="{FF2B5EF4-FFF2-40B4-BE49-F238E27FC236}">
                <a16:creationId xmlns:a16="http://schemas.microsoft.com/office/drawing/2014/main" id="{B27A25D1-B7A9-4B6D-A3A0-173CDAABF010}"/>
              </a:ext>
            </a:extLst>
          </p:cNvPr>
          <p:cNvSpPr txBox="1"/>
          <p:nvPr/>
        </p:nvSpPr>
        <p:spPr>
          <a:xfrm>
            <a:off x="5842567" y="388645"/>
            <a:ext cx="407484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HF</a:t>
            </a:r>
            <a:endParaRPr lang="he-IL" sz="1600" dirty="0"/>
          </a:p>
        </p:txBody>
      </p:sp>
      <p:sp>
        <p:nvSpPr>
          <p:cNvPr id="113" name="תיבת טקסט 14">
            <a:extLst>
              <a:ext uri="{FF2B5EF4-FFF2-40B4-BE49-F238E27FC236}">
                <a16:creationId xmlns:a16="http://schemas.microsoft.com/office/drawing/2014/main" id="{4C13841B-9DC1-4201-A63D-F5355298E5B9}"/>
              </a:ext>
            </a:extLst>
          </p:cNvPr>
          <p:cNvSpPr txBox="1"/>
          <p:nvPr/>
        </p:nvSpPr>
        <p:spPr>
          <a:xfrm>
            <a:off x="7355722" y="395615"/>
            <a:ext cx="862737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HF+BHB</a:t>
            </a:r>
            <a:endParaRPr lang="he-IL" sz="1600" dirty="0"/>
          </a:p>
        </p:txBody>
      </p:sp>
      <p:grpSp>
        <p:nvGrpSpPr>
          <p:cNvPr id="114" name="קבוצה 113">
            <a:extLst>
              <a:ext uri="{FF2B5EF4-FFF2-40B4-BE49-F238E27FC236}">
                <a16:creationId xmlns:a16="http://schemas.microsoft.com/office/drawing/2014/main" id="{8181050A-528A-40E5-9454-114F8D16F038}"/>
              </a:ext>
            </a:extLst>
          </p:cNvPr>
          <p:cNvGrpSpPr/>
          <p:nvPr/>
        </p:nvGrpSpPr>
        <p:grpSpPr>
          <a:xfrm>
            <a:off x="5474607" y="675315"/>
            <a:ext cx="1367729" cy="329471"/>
            <a:chOff x="1709581" y="1009697"/>
            <a:chExt cx="1367729" cy="329471"/>
          </a:xfrm>
        </p:grpSpPr>
        <p:sp>
          <p:nvSpPr>
            <p:cNvPr id="137" name="סוגר מרובע ימני 136">
              <a:extLst>
                <a:ext uri="{FF2B5EF4-FFF2-40B4-BE49-F238E27FC236}">
                  <a16:creationId xmlns:a16="http://schemas.microsoft.com/office/drawing/2014/main" id="{392BA01C-5A4F-4E30-8375-892DADCD1EB3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39" name="TextBox 64">
              <a:extLst>
                <a:ext uri="{FF2B5EF4-FFF2-40B4-BE49-F238E27FC236}">
                  <a16:creationId xmlns:a16="http://schemas.microsoft.com/office/drawing/2014/main" id="{5CA97C4B-4E4F-4350-885F-70BA4A65C1DE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41" name="TextBox 65">
              <a:extLst>
                <a:ext uri="{FF2B5EF4-FFF2-40B4-BE49-F238E27FC236}">
                  <a16:creationId xmlns:a16="http://schemas.microsoft.com/office/drawing/2014/main" id="{910161C2-EB0C-4D02-962D-BA04D3697E41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45" name="TextBox 66">
              <a:extLst>
                <a:ext uri="{FF2B5EF4-FFF2-40B4-BE49-F238E27FC236}">
                  <a16:creationId xmlns:a16="http://schemas.microsoft.com/office/drawing/2014/main" id="{069F509B-4416-4CEC-A09D-9613C304B507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46" name="TextBox 67">
              <a:extLst>
                <a:ext uri="{FF2B5EF4-FFF2-40B4-BE49-F238E27FC236}">
                  <a16:creationId xmlns:a16="http://schemas.microsoft.com/office/drawing/2014/main" id="{D1A0B974-A9F6-4CFD-8143-8E8AC797A7A8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47" name="TextBox 68">
              <a:extLst>
                <a:ext uri="{FF2B5EF4-FFF2-40B4-BE49-F238E27FC236}">
                  <a16:creationId xmlns:a16="http://schemas.microsoft.com/office/drawing/2014/main" id="{74983962-1DF6-468A-9D7C-787E0E0D3F64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48" name="TextBox 68">
            <a:extLst>
              <a:ext uri="{FF2B5EF4-FFF2-40B4-BE49-F238E27FC236}">
                <a16:creationId xmlns:a16="http://schemas.microsoft.com/office/drawing/2014/main" id="{A21AB5A2-F4AA-4EA7-8209-B78CB1D8CCFB}"/>
              </a:ext>
            </a:extLst>
          </p:cNvPr>
          <p:cNvSpPr txBox="1"/>
          <p:nvPr/>
        </p:nvSpPr>
        <p:spPr>
          <a:xfrm>
            <a:off x="6655408" y="729697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grpSp>
        <p:nvGrpSpPr>
          <p:cNvPr id="149" name="קבוצה 148">
            <a:extLst>
              <a:ext uri="{FF2B5EF4-FFF2-40B4-BE49-F238E27FC236}">
                <a16:creationId xmlns:a16="http://schemas.microsoft.com/office/drawing/2014/main" id="{CCC49AA6-3540-41C4-80A0-D9170B688B5D}"/>
              </a:ext>
            </a:extLst>
          </p:cNvPr>
          <p:cNvGrpSpPr/>
          <p:nvPr/>
        </p:nvGrpSpPr>
        <p:grpSpPr>
          <a:xfrm>
            <a:off x="7229343" y="678220"/>
            <a:ext cx="1367729" cy="329471"/>
            <a:chOff x="1709581" y="1009697"/>
            <a:chExt cx="1367729" cy="329471"/>
          </a:xfrm>
        </p:grpSpPr>
        <p:sp>
          <p:nvSpPr>
            <p:cNvPr id="150" name="סוגר מרובע ימני 149">
              <a:extLst>
                <a:ext uri="{FF2B5EF4-FFF2-40B4-BE49-F238E27FC236}">
                  <a16:creationId xmlns:a16="http://schemas.microsoft.com/office/drawing/2014/main" id="{B9AD1C17-2C9C-4AF8-BEC7-72259B00F17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51" name="TextBox 64">
              <a:extLst>
                <a:ext uri="{FF2B5EF4-FFF2-40B4-BE49-F238E27FC236}">
                  <a16:creationId xmlns:a16="http://schemas.microsoft.com/office/drawing/2014/main" id="{4700D035-9DCE-405D-B9F2-C115B053D1EB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52" name="TextBox 65">
              <a:extLst>
                <a:ext uri="{FF2B5EF4-FFF2-40B4-BE49-F238E27FC236}">
                  <a16:creationId xmlns:a16="http://schemas.microsoft.com/office/drawing/2014/main" id="{27E089C8-3DB8-4806-8E41-986703E9923A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53" name="TextBox 66">
              <a:extLst>
                <a:ext uri="{FF2B5EF4-FFF2-40B4-BE49-F238E27FC236}">
                  <a16:creationId xmlns:a16="http://schemas.microsoft.com/office/drawing/2014/main" id="{BAD3E3FC-9994-4FF6-86D0-66A1EC6D49AD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54" name="TextBox 67">
              <a:extLst>
                <a:ext uri="{FF2B5EF4-FFF2-40B4-BE49-F238E27FC236}">
                  <a16:creationId xmlns:a16="http://schemas.microsoft.com/office/drawing/2014/main" id="{17A5D0ED-7B6B-419B-B914-2A242B34BD34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55" name="TextBox 68">
              <a:extLst>
                <a:ext uri="{FF2B5EF4-FFF2-40B4-BE49-F238E27FC236}">
                  <a16:creationId xmlns:a16="http://schemas.microsoft.com/office/drawing/2014/main" id="{18B500CA-3022-4D90-9C4B-E3B87E4FB031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56" name="TextBox 68">
            <a:extLst>
              <a:ext uri="{FF2B5EF4-FFF2-40B4-BE49-F238E27FC236}">
                <a16:creationId xmlns:a16="http://schemas.microsoft.com/office/drawing/2014/main" id="{BE1723CA-D04E-49D0-AD3D-B510BC00B2A8}"/>
              </a:ext>
            </a:extLst>
          </p:cNvPr>
          <p:cNvSpPr txBox="1"/>
          <p:nvPr/>
        </p:nvSpPr>
        <p:spPr>
          <a:xfrm>
            <a:off x="8396463" y="733029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grpSp>
        <p:nvGrpSpPr>
          <p:cNvPr id="76" name="קבוצה 75">
            <a:extLst>
              <a:ext uri="{FF2B5EF4-FFF2-40B4-BE49-F238E27FC236}">
                <a16:creationId xmlns:a16="http://schemas.microsoft.com/office/drawing/2014/main" id="{459FD927-AA23-44CD-8DC0-6C7E9FB1E1D1}"/>
              </a:ext>
            </a:extLst>
          </p:cNvPr>
          <p:cNvGrpSpPr/>
          <p:nvPr/>
        </p:nvGrpSpPr>
        <p:grpSpPr>
          <a:xfrm>
            <a:off x="226979" y="4629121"/>
            <a:ext cx="937879" cy="4192857"/>
            <a:chOff x="234999" y="5856338"/>
            <a:chExt cx="937879" cy="4192857"/>
          </a:xfrm>
        </p:grpSpPr>
        <p:sp>
          <p:nvSpPr>
            <p:cNvPr id="77" name="תיבת טקסט 78">
              <a:extLst>
                <a:ext uri="{FF2B5EF4-FFF2-40B4-BE49-F238E27FC236}">
                  <a16:creationId xmlns:a16="http://schemas.microsoft.com/office/drawing/2014/main" id="{CC1EB7A9-5AB5-4536-A711-958A27000B64}"/>
                </a:ext>
              </a:extLst>
            </p:cNvPr>
            <p:cNvSpPr txBox="1"/>
            <p:nvPr/>
          </p:nvSpPr>
          <p:spPr>
            <a:xfrm>
              <a:off x="251039" y="7053304"/>
              <a:ext cx="921839" cy="52322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AKT 60kDa</a:t>
              </a:r>
              <a:endParaRPr lang="he-IL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8" name="תיבת טקסט 79">
              <a:extLst>
                <a:ext uri="{FF2B5EF4-FFF2-40B4-BE49-F238E27FC236}">
                  <a16:creationId xmlns:a16="http://schemas.microsoft.com/office/drawing/2014/main" id="{0600DC1C-1CB1-4755-8CE9-A6761B037D6E}"/>
                </a:ext>
              </a:extLst>
            </p:cNvPr>
            <p:cNvSpPr txBox="1"/>
            <p:nvPr/>
          </p:nvSpPr>
          <p:spPr>
            <a:xfrm>
              <a:off x="243019" y="7694990"/>
              <a:ext cx="921839" cy="52322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4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pAKT</a:t>
              </a:r>
              <a:endParaRPr 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56-62kDa</a:t>
              </a:r>
              <a:endParaRPr lang="he-IL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9" name="תיבת טקסט 80">
              <a:extLst>
                <a:ext uri="{FF2B5EF4-FFF2-40B4-BE49-F238E27FC236}">
                  <a16:creationId xmlns:a16="http://schemas.microsoft.com/office/drawing/2014/main" id="{65005945-20E5-4CC5-85AF-E4F748AADBAA}"/>
                </a:ext>
              </a:extLst>
            </p:cNvPr>
            <p:cNvSpPr txBox="1"/>
            <p:nvPr/>
          </p:nvSpPr>
          <p:spPr>
            <a:xfrm>
              <a:off x="234999" y="8316618"/>
              <a:ext cx="921839" cy="52322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ACTIN</a:t>
              </a:r>
            </a:p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42kDa</a:t>
              </a:r>
              <a:endParaRPr lang="he-IL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0" name="תיבת טקסט 76">
              <a:extLst>
                <a:ext uri="{FF2B5EF4-FFF2-40B4-BE49-F238E27FC236}">
                  <a16:creationId xmlns:a16="http://schemas.microsoft.com/office/drawing/2014/main" id="{4B5A487B-377D-4984-BF4F-08E33BCC7248}"/>
                </a:ext>
              </a:extLst>
            </p:cNvPr>
            <p:cNvSpPr txBox="1"/>
            <p:nvPr/>
          </p:nvSpPr>
          <p:spPr>
            <a:xfrm>
              <a:off x="247023" y="5856338"/>
              <a:ext cx="921839" cy="52322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AMPK</a:t>
              </a:r>
            </a:p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62kDa</a:t>
              </a:r>
              <a:endParaRPr lang="he-IL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1" name="תיבת טקסט 77">
              <a:extLst>
                <a:ext uri="{FF2B5EF4-FFF2-40B4-BE49-F238E27FC236}">
                  <a16:creationId xmlns:a16="http://schemas.microsoft.com/office/drawing/2014/main" id="{EC372229-7A83-41F3-A890-7FD4C9D69BF4}"/>
                </a:ext>
              </a:extLst>
            </p:cNvPr>
            <p:cNvSpPr txBox="1"/>
            <p:nvPr/>
          </p:nvSpPr>
          <p:spPr>
            <a:xfrm>
              <a:off x="239003" y="6457917"/>
              <a:ext cx="921839" cy="52322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4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pAMPK</a:t>
              </a:r>
              <a:endParaRPr 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62kDa</a:t>
              </a:r>
              <a:endParaRPr lang="he-IL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2" name="תיבת טקסט 76">
              <a:extLst>
                <a:ext uri="{FF2B5EF4-FFF2-40B4-BE49-F238E27FC236}">
                  <a16:creationId xmlns:a16="http://schemas.microsoft.com/office/drawing/2014/main" id="{7BBF854E-733C-4D03-A042-9F388DA94CB3}"/>
                </a:ext>
              </a:extLst>
            </p:cNvPr>
            <p:cNvSpPr txBox="1"/>
            <p:nvPr/>
          </p:nvSpPr>
          <p:spPr>
            <a:xfrm>
              <a:off x="247023" y="8924396"/>
              <a:ext cx="921839" cy="52322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PP2A</a:t>
              </a:r>
            </a:p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36kDa</a:t>
              </a:r>
              <a:endParaRPr lang="he-IL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3" name="תיבת טקסט 77">
              <a:extLst>
                <a:ext uri="{FF2B5EF4-FFF2-40B4-BE49-F238E27FC236}">
                  <a16:creationId xmlns:a16="http://schemas.microsoft.com/office/drawing/2014/main" id="{F7233C4C-39D6-4B48-B092-FD108BD5BFC1}"/>
                </a:ext>
              </a:extLst>
            </p:cNvPr>
            <p:cNvSpPr txBox="1"/>
            <p:nvPr/>
          </p:nvSpPr>
          <p:spPr>
            <a:xfrm>
              <a:off x="239003" y="9525975"/>
              <a:ext cx="921839" cy="523220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pPP2A</a:t>
              </a:r>
            </a:p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36kDa</a:t>
              </a:r>
              <a:endParaRPr lang="he-IL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85" name="תיבת טקסט 81">
            <a:extLst>
              <a:ext uri="{FF2B5EF4-FFF2-40B4-BE49-F238E27FC236}">
                <a16:creationId xmlns:a16="http://schemas.microsoft.com/office/drawing/2014/main" id="{5B9A02CD-11FA-4B9D-8031-C8593CCA746E}"/>
              </a:ext>
            </a:extLst>
          </p:cNvPr>
          <p:cNvSpPr txBox="1"/>
          <p:nvPr/>
        </p:nvSpPr>
        <p:spPr>
          <a:xfrm>
            <a:off x="235001" y="8922224"/>
            <a:ext cx="1011340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MYOGENIN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34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86" name="תמונה 85">
            <a:extLst>
              <a:ext uri="{FF2B5EF4-FFF2-40B4-BE49-F238E27FC236}">
                <a16:creationId xmlns:a16="http://schemas.microsoft.com/office/drawing/2014/main" id="{7AC78CBD-239C-4C51-B92F-A4CE0A5FB3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20643" y="2649639"/>
            <a:ext cx="266700" cy="219075"/>
          </a:xfrm>
          <a:prstGeom prst="rect">
            <a:avLst/>
          </a:prstGeom>
        </p:spPr>
      </p:pic>
      <p:sp>
        <p:nvSpPr>
          <p:cNvPr id="87" name="תיבת טקסט 50">
            <a:extLst>
              <a:ext uri="{FF2B5EF4-FFF2-40B4-BE49-F238E27FC236}">
                <a16:creationId xmlns:a16="http://schemas.microsoft.com/office/drawing/2014/main" id="{81E3BFB8-FCFB-489E-93EE-CD854D9E8799}"/>
              </a:ext>
            </a:extLst>
          </p:cNvPr>
          <p:cNvSpPr txBox="1"/>
          <p:nvPr/>
        </p:nvSpPr>
        <p:spPr>
          <a:xfrm>
            <a:off x="9187343" y="2601517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250 KD</a:t>
            </a:r>
            <a:endParaRPr lang="he-IL" sz="1200" dirty="0"/>
          </a:p>
        </p:txBody>
      </p:sp>
      <p:pic>
        <p:nvPicPr>
          <p:cNvPr id="88" name="תמונה 87">
            <a:extLst>
              <a:ext uri="{FF2B5EF4-FFF2-40B4-BE49-F238E27FC236}">
                <a16:creationId xmlns:a16="http://schemas.microsoft.com/office/drawing/2014/main" id="{A19EAB7D-DECC-42B2-ACD9-0F9D3B2F85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04152" y="3133955"/>
            <a:ext cx="285750" cy="180975"/>
          </a:xfrm>
          <a:prstGeom prst="rect">
            <a:avLst/>
          </a:prstGeom>
        </p:spPr>
      </p:pic>
      <p:sp>
        <p:nvSpPr>
          <p:cNvPr id="89" name="תיבת טקסט 52">
            <a:extLst>
              <a:ext uri="{FF2B5EF4-FFF2-40B4-BE49-F238E27FC236}">
                <a16:creationId xmlns:a16="http://schemas.microsoft.com/office/drawing/2014/main" id="{4DFA10AD-FBBE-4D6F-9305-9A5C6C3DEF69}"/>
              </a:ext>
            </a:extLst>
          </p:cNvPr>
          <p:cNvSpPr txBox="1"/>
          <p:nvPr/>
        </p:nvSpPr>
        <p:spPr>
          <a:xfrm>
            <a:off x="9183332" y="3089013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150 KD</a:t>
            </a:r>
            <a:endParaRPr lang="he-IL" sz="1200" dirty="0"/>
          </a:p>
        </p:txBody>
      </p:sp>
      <p:pic>
        <p:nvPicPr>
          <p:cNvPr id="90" name="תמונה 89">
            <a:extLst>
              <a:ext uri="{FF2B5EF4-FFF2-40B4-BE49-F238E27FC236}">
                <a16:creationId xmlns:a16="http://schemas.microsoft.com/office/drawing/2014/main" id="{2A491195-2343-4127-80F2-7105BB2763F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62753" y="3342855"/>
            <a:ext cx="361950" cy="152400"/>
          </a:xfrm>
          <a:prstGeom prst="rect">
            <a:avLst/>
          </a:prstGeom>
        </p:spPr>
      </p:pic>
      <p:sp>
        <p:nvSpPr>
          <p:cNvPr id="91" name="תיבת טקסט 54">
            <a:extLst>
              <a:ext uri="{FF2B5EF4-FFF2-40B4-BE49-F238E27FC236}">
                <a16:creationId xmlns:a16="http://schemas.microsoft.com/office/drawing/2014/main" id="{25ADFE01-6B51-4BC0-88F3-BF39BD943BC4}"/>
              </a:ext>
            </a:extLst>
          </p:cNvPr>
          <p:cNvSpPr txBox="1"/>
          <p:nvPr/>
        </p:nvSpPr>
        <p:spPr>
          <a:xfrm>
            <a:off x="9167281" y="3330408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75 KD</a:t>
            </a:r>
            <a:endParaRPr lang="he-IL" sz="1200" dirty="0"/>
          </a:p>
        </p:txBody>
      </p:sp>
      <p:pic>
        <p:nvPicPr>
          <p:cNvPr id="92" name="תמונה 91">
            <a:extLst>
              <a:ext uri="{FF2B5EF4-FFF2-40B4-BE49-F238E27FC236}">
                <a16:creationId xmlns:a16="http://schemas.microsoft.com/office/drawing/2014/main" id="{7621C750-9D45-40E8-AA5B-F8DBE128BB7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20643" y="6989173"/>
            <a:ext cx="342900" cy="171450"/>
          </a:xfrm>
          <a:prstGeom prst="rect">
            <a:avLst/>
          </a:prstGeom>
        </p:spPr>
      </p:pic>
      <p:sp>
        <p:nvSpPr>
          <p:cNvPr id="93" name="תיבת טקסט 58">
            <a:extLst>
              <a:ext uri="{FF2B5EF4-FFF2-40B4-BE49-F238E27FC236}">
                <a16:creationId xmlns:a16="http://schemas.microsoft.com/office/drawing/2014/main" id="{F3B7750C-13E1-4530-89FA-D8E8B606735D}"/>
              </a:ext>
            </a:extLst>
          </p:cNvPr>
          <p:cNvSpPr txBox="1"/>
          <p:nvPr/>
        </p:nvSpPr>
        <p:spPr>
          <a:xfrm>
            <a:off x="9175307" y="6932087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50 KD</a:t>
            </a:r>
            <a:endParaRPr lang="he-IL" sz="1200" dirty="0"/>
          </a:p>
        </p:txBody>
      </p:sp>
      <p:pic>
        <p:nvPicPr>
          <p:cNvPr id="94" name="תמונה 93">
            <a:extLst>
              <a:ext uri="{FF2B5EF4-FFF2-40B4-BE49-F238E27FC236}">
                <a16:creationId xmlns:a16="http://schemas.microsoft.com/office/drawing/2014/main" id="{D0582338-8909-4357-80B3-9E86F4B1494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901898" y="7642117"/>
            <a:ext cx="314325" cy="161925"/>
          </a:xfrm>
          <a:prstGeom prst="rect">
            <a:avLst/>
          </a:prstGeom>
        </p:spPr>
      </p:pic>
      <p:sp>
        <p:nvSpPr>
          <p:cNvPr id="95" name="תיבת טקסט 60">
            <a:extLst>
              <a:ext uri="{FF2B5EF4-FFF2-40B4-BE49-F238E27FC236}">
                <a16:creationId xmlns:a16="http://schemas.microsoft.com/office/drawing/2014/main" id="{890B4289-9732-4885-9A39-C9C2F2350F57}"/>
              </a:ext>
            </a:extLst>
          </p:cNvPr>
          <p:cNvSpPr txBox="1"/>
          <p:nvPr/>
        </p:nvSpPr>
        <p:spPr>
          <a:xfrm>
            <a:off x="9171295" y="7563580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37 KD</a:t>
            </a:r>
            <a:endParaRPr lang="he-IL" sz="1200" dirty="0"/>
          </a:p>
        </p:txBody>
      </p:sp>
      <p:pic>
        <p:nvPicPr>
          <p:cNvPr id="96" name="תמונה 95">
            <a:extLst>
              <a:ext uri="{FF2B5EF4-FFF2-40B4-BE49-F238E27FC236}">
                <a16:creationId xmlns:a16="http://schemas.microsoft.com/office/drawing/2014/main" id="{2433C319-BC2C-4535-B8B9-9BE3F72068F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894575" y="10672129"/>
            <a:ext cx="304800" cy="180975"/>
          </a:xfrm>
          <a:prstGeom prst="rect">
            <a:avLst/>
          </a:prstGeom>
        </p:spPr>
      </p:pic>
      <p:sp>
        <p:nvSpPr>
          <p:cNvPr id="102" name="תיבת טקסט 62">
            <a:extLst>
              <a:ext uri="{FF2B5EF4-FFF2-40B4-BE49-F238E27FC236}">
                <a16:creationId xmlns:a16="http://schemas.microsoft.com/office/drawing/2014/main" id="{790AFF8E-3A6E-4DAB-8629-636A0E5EF999}"/>
              </a:ext>
            </a:extLst>
          </p:cNvPr>
          <p:cNvSpPr txBox="1"/>
          <p:nvPr/>
        </p:nvSpPr>
        <p:spPr>
          <a:xfrm>
            <a:off x="9167281" y="10627683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25 KD</a:t>
            </a:r>
            <a:endParaRPr lang="he-IL" sz="1200" dirty="0"/>
          </a:p>
        </p:txBody>
      </p:sp>
      <p:sp>
        <p:nvSpPr>
          <p:cNvPr id="103" name="Rectangle 1">
            <a:extLst>
              <a:ext uri="{FF2B5EF4-FFF2-40B4-BE49-F238E27FC236}">
                <a16:creationId xmlns:a16="http://schemas.microsoft.com/office/drawing/2014/main" id="{A7B808D6-384E-4A9E-AE80-CA2CC6D516A9}"/>
              </a:ext>
            </a:extLst>
          </p:cNvPr>
          <p:cNvSpPr/>
          <p:nvPr/>
        </p:nvSpPr>
        <p:spPr>
          <a:xfrm>
            <a:off x="67769" y="11325422"/>
            <a:ext cx="9834414" cy="462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S2: Western blot protein analysis of the effect of HF and BHB supplementation on muscle tissue metabolism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06133" y="1124849"/>
            <a:ext cx="3584759" cy="30482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057852" y="1761219"/>
            <a:ext cx="3682303" cy="26215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114154" y="2291116"/>
            <a:ext cx="3627434" cy="34140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84497" y="2971127"/>
            <a:ext cx="3615241" cy="21337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129395" y="3485907"/>
            <a:ext cx="3596952" cy="256054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147917" y="4166530"/>
            <a:ext cx="3651821" cy="28044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139527" y="4671228"/>
            <a:ext cx="3578662" cy="469433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273641" y="5344969"/>
            <a:ext cx="3523793" cy="347502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118858" y="5981658"/>
            <a:ext cx="3682303" cy="426757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182250" y="6669108"/>
            <a:ext cx="3578662" cy="28044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052728" y="7130870"/>
            <a:ext cx="3688400" cy="469433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109044" y="7881767"/>
            <a:ext cx="3609145" cy="256054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118825" y="8380765"/>
            <a:ext cx="3682303" cy="426757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178400" y="9107787"/>
            <a:ext cx="3627434" cy="262151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147917" y="9621206"/>
            <a:ext cx="3621338" cy="335309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5163158" y="10251026"/>
            <a:ext cx="3657917" cy="274344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1396191" y="1035407"/>
            <a:ext cx="3633531" cy="396274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303433" y="1713783"/>
            <a:ext cx="3694496" cy="268247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1517924" y="2285659"/>
            <a:ext cx="3450635" cy="353599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365511" y="2906256"/>
            <a:ext cx="3603048" cy="341406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472397" y="3475078"/>
            <a:ext cx="3481118" cy="408467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1441915" y="4166316"/>
            <a:ext cx="3511600" cy="304826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1436796" y="4760872"/>
            <a:ext cx="3548180" cy="317019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1406313" y="5367621"/>
            <a:ext cx="3609145" cy="365792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1427246" y="5966600"/>
            <a:ext cx="3505504" cy="365792"/>
          </a:xfrm>
          <a:prstGeom prst="rect">
            <a:avLst/>
          </a:prstGeom>
        </p:spPr>
      </p:pic>
      <p:pic>
        <p:nvPicPr>
          <p:cNvPr id="65" name="Picture 64"/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1467278" y="6577566"/>
            <a:ext cx="3487214" cy="408467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1379891" y="7194096"/>
            <a:ext cx="3603048" cy="420660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1287663" y="7887996"/>
            <a:ext cx="3670110" cy="213378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1312576" y="8381250"/>
            <a:ext cx="3706689" cy="420660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1364398" y="9081441"/>
            <a:ext cx="3633531" cy="225572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1335028" y="9566686"/>
            <a:ext cx="3633531" cy="451143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1373543" y="10250336"/>
            <a:ext cx="3554276" cy="2560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46882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תיבת טקסט 56">
            <a:extLst>
              <a:ext uri="{FF2B5EF4-FFF2-40B4-BE49-F238E27FC236}">
                <a16:creationId xmlns:a16="http://schemas.microsoft.com/office/drawing/2014/main" id="{48AA65FB-32EC-2F55-1981-89AD882B4BED}"/>
              </a:ext>
            </a:extLst>
          </p:cNvPr>
          <p:cNvSpPr txBox="1"/>
          <p:nvPr/>
        </p:nvSpPr>
        <p:spPr>
          <a:xfrm>
            <a:off x="9196502" y="3580244"/>
            <a:ext cx="884123" cy="2784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100 KD</a:t>
            </a:r>
            <a:endParaRPr lang="he-IL" sz="1200" dirty="0"/>
          </a:p>
        </p:txBody>
      </p:sp>
      <p:graphicFrame>
        <p:nvGraphicFramePr>
          <p:cNvPr id="4" name="טבלה 3">
            <a:extLst>
              <a:ext uri="{FF2B5EF4-FFF2-40B4-BE49-F238E27FC236}">
                <a16:creationId xmlns:a16="http://schemas.microsoft.com/office/drawing/2014/main" id="{F541CAEF-1A26-3B88-7409-B3CFEF620537}"/>
              </a:ext>
            </a:extLst>
          </p:cNvPr>
          <p:cNvGraphicFramePr>
            <a:graphicFrameLocks noGrp="1"/>
          </p:cNvGraphicFramePr>
          <p:nvPr/>
        </p:nvGraphicFramePr>
        <p:xfrm>
          <a:off x="1230309" y="385011"/>
          <a:ext cx="7620004" cy="10907999"/>
        </p:xfrm>
        <a:graphic>
          <a:graphicData uri="http://schemas.openxmlformats.org/drawingml/2006/table">
            <a:tbl>
              <a:tblPr rtl="1" firstRow="1" bandRow="1">
                <a:tableStyleId>{5940675A-B579-460E-94D1-54222C63F5DA}</a:tableStyleId>
              </a:tblPr>
              <a:tblGrid>
                <a:gridCol w="3810002">
                  <a:extLst>
                    <a:ext uri="{9D8B030D-6E8A-4147-A177-3AD203B41FA5}">
                      <a16:colId xmlns:a16="http://schemas.microsoft.com/office/drawing/2014/main" val="2673439277"/>
                    </a:ext>
                  </a:extLst>
                </a:gridCol>
                <a:gridCol w="3810002">
                  <a:extLst>
                    <a:ext uri="{9D8B030D-6E8A-4147-A177-3AD203B41FA5}">
                      <a16:colId xmlns:a16="http://schemas.microsoft.com/office/drawing/2014/main" val="112674736"/>
                    </a:ext>
                  </a:extLst>
                </a:gridCol>
              </a:tblGrid>
              <a:tr h="572985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5894319"/>
                  </a:ext>
                </a:extLst>
              </a:tr>
              <a:tr h="540756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8848110"/>
                  </a:ext>
                </a:extLst>
              </a:tr>
              <a:tr h="534513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5384007"/>
                  </a:ext>
                </a:extLst>
              </a:tr>
              <a:tr h="552709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28102718"/>
                  </a:ext>
                </a:extLst>
              </a:tr>
              <a:tr h="538135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8765973"/>
                  </a:ext>
                </a:extLst>
              </a:tr>
              <a:tr h="570424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1069457"/>
                  </a:ext>
                </a:extLst>
              </a:tr>
              <a:tr h="548905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2943920"/>
                  </a:ext>
                </a:extLst>
              </a:tr>
              <a:tr h="538135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3793250"/>
                  </a:ext>
                </a:extLst>
              </a:tr>
              <a:tr h="538135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20313756"/>
                  </a:ext>
                </a:extLst>
              </a:tr>
              <a:tr h="570424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7138217"/>
                  </a:ext>
                </a:extLst>
              </a:tr>
              <a:tr h="559663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80046665"/>
                  </a:ext>
                </a:extLst>
              </a:tr>
              <a:tr h="538135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1940211"/>
                  </a:ext>
                </a:extLst>
              </a:tr>
              <a:tr h="538135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16306057"/>
                  </a:ext>
                </a:extLst>
              </a:tr>
              <a:tr h="538135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37959460"/>
                  </a:ext>
                </a:extLst>
              </a:tr>
              <a:tr h="538135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1955266"/>
                  </a:ext>
                </a:extLst>
              </a:tr>
              <a:tr h="538135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7345177"/>
                  </a:ext>
                </a:extLst>
              </a:tr>
              <a:tr h="538135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2313978"/>
                  </a:ext>
                </a:extLst>
              </a:tr>
              <a:tr h="538135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6420948"/>
                  </a:ext>
                </a:extLst>
              </a:tr>
              <a:tr h="538135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26002299"/>
                  </a:ext>
                </a:extLst>
              </a:tr>
              <a:tr h="538135"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07215811"/>
                  </a:ext>
                </a:extLst>
              </a:tr>
            </a:tbl>
          </a:graphicData>
        </a:graphic>
      </p:graphicFrame>
      <p:grpSp>
        <p:nvGrpSpPr>
          <p:cNvPr id="2" name="קבוצה 1">
            <a:extLst>
              <a:ext uri="{FF2B5EF4-FFF2-40B4-BE49-F238E27FC236}">
                <a16:creationId xmlns:a16="http://schemas.microsoft.com/office/drawing/2014/main" id="{500885F5-07C8-46DE-A1ED-6068EF042542}"/>
              </a:ext>
            </a:extLst>
          </p:cNvPr>
          <p:cNvGrpSpPr/>
          <p:nvPr/>
        </p:nvGrpSpPr>
        <p:grpSpPr>
          <a:xfrm>
            <a:off x="1709581" y="386145"/>
            <a:ext cx="7100692" cy="623883"/>
            <a:chOff x="1709581" y="386145"/>
            <a:chExt cx="7100692" cy="623883"/>
          </a:xfrm>
        </p:grpSpPr>
        <p:sp>
          <p:nvSpPr>
            <p:cNvPr id="14" name="תיבת טקסט 13">
              <a:extLst>
                <a:ext uri="{FF2B5EF4-FFF2-40B4-BE49-F238E27FC236}">
                  <a16:creationId xmlns:a16="http://schemas.microsoft.com/office/drawing/2014/main" id="{A148D558-4803-4E6A-4C0D-A61611C4CE0D}"/>
                </a:ext>
              </a:extLst>
            </p:cNvPr>
            <p:cNvSpPr txBox="1"/>
            <p:nvPr/>
          </p:nvSpPr>
          <p:spPr>
            <a:xfrm>
              <a:off x="2077541" y="386145"/>
              <a:ext cx="656718" cy="338554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600" dirty="0"/>
                <a:t>Chow</a:t>
              </a:r>
              <a:endParaRPr lang="he-IL" sz="1600" dirty="0"/>
            </a:p>
          </p:txBody>
        </p:sp>
        <p:sp>
          <p:nvSpPr>
            <p:cNvPr id="15" name="תיבת טקסט 14">
              <a:extLst>
                <a:ext uri="{FF2B5EF4-FFF2-40B4-BE49-F238E27FC236}">
                  <a16:creationId xmlns:a16="http://schemas.microsoft.com/office/drawing/2014/main" id="{8E22B857-D879-D241-DD68-2AE49A469FF4}"/>
                </a:ext>
              </a:extLst>
            </p:cNvPr>
            <p:cNvSpPr txBox="1"/>
            <p:nvPr/>
          </p:nvSpPr>
          <p:spPr>
            <a:xfrm>
              <a:off x="3590696" y="393115"/>
              <a:ext cx="1111971" cy="338554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600" dirty="0" err="1"/>
                <a:t>Chow+BHB</a:t>
              </a:r>
              <a:endParaRPr lang="he-IL" sz="1600" dirty="0"/>
            </a:p>
          </p:txBody>
        </p:sp>
        <p:grpSp>
          <p:nvGrpSpPr>
            <p:cNvPr id="6" name="קבוצה 5">
              <a:extLst>
                <a:ext uri="{FF2B5EF4-FFF2-40B4-BE49-F238E27FC236}">
                  <a16:creationId xmlns:a16="http://schemas.microsoft.com/office/drawing/2014/main" id="{4AFD568D-41C8-4AAE-9C08-0407F9153474}"/>
                </a:ext>
              </a:extLst>
            </p:cNvPr>
            <p:cNvGrpSpPr/>
            <p:nvPr/>
          </p:nvGrpSpPr>
          <p:grpSpPr>
            <a:xfrm>
              <a:off x="1709581" y="672815"/>
              <a:ext cx="1367729" cy="329471"/>
              <a:chOff x="1709581" y="1009697"/>
              <a:chExt cx="1367729" cy="329471"/>
            </a:xfrm>
          </p:grpSpPr>
          <p:sp>
            <p:nvSpPr>
              <p:cNvPr id="133" name="סוגר מרובע ימני 132">
                <a:extLst>
                  <a:ext uri="{FF2B5EF4-FFF2-40B4-BE49-F238E27FC236}">
                    <a16:creationId xmlns:a16="http://schemas.microsoft.com/office/drawing/2014/main" id="{B9467D85-7C62-837F-2A06-957E29059C27}"/>
                  </a:ext>
                </a:extLst>
              </p:cNvPr>
              <p:cNvSpPr/>
              <p:nvPr/>
            </p:nvSpPr>
            <p:spPr>
              <a:xfrm rot="16200000">
                <a:off x="2434570" y="412676"/>
                <a:ext cx="45719" cy="1239761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97" name="TextBox 64">
                <a:extLst>
                  <a:ext uri="{FF2B5EF4-FFF2-40B4-BE49-F238E27FC236}">
                    <a16:creationId xmlns:a16="http://schemas.microsoft.com/office/drawing/2014/main" id="{AA912D09-30B1-E356-7B4F-06293C79B1D6}"/>
                  </a:ext>
                </a:extLst>
              </p:cNvPr>
              <p:cNvSpPr txBox="1"/>
              <p:nvPr/>
            </p:nvSpPr>
            <p:spPr>
              <a:xfrm>
                <a:off x="1709581" y="1060559"/>
                <a:ext cx="25056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0</a:t>
                </a:r>
              </a:p>
            </p:txBody>
          </p:sp>
          <p:sp>
            <p:nvSpPr>
              <p:cNvPr id="98" name="TextBox 65">
                <a:extLst>
                  <a:ext uri="{FF2B5EF4-FFF2-40B4-BE49-F238E27FC236}">
                    <a16:creationId xmlns:a16="http://schemas.microsoft.com/office/drawing/2014/main" id="{A20BC556-D3BC-7379-0531-5B4A8F52A7E6}"/>
                  </a:ext>
                </a:extLst>
              </p:cNvPr>
              <p:cNvSpPr txBox="1"/>
              <p:nvPr/>
            </p:nvSpPr>
            <p:spPr>
              <a:xfrm>
                <a:off x="1915478" y="1062169"/>
                <a:ext cx="3618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4</a:t>
                </a:r>
              </a:p>
            </p:txBody>
          </p:sp>
          <p:sp>
            <p:nvSpPr>
              <p:cNvPr id="99" name="TextBox 66">
                <a:extLst>
                  <a:ext uri="{FF2B5EF4-FFF2-40B4-BE49-F238E27FC236}">
                    <a16:creationId xmlns:a16="http://schemas.microsoft.com/office/drawing/2014/main" id="{0B83B336-88AD-24DD-C3E1-540421E857AE}"/>
                  </a:ext>
                </a:extLst>
              </p:cNvPr>
              <p:cNvSpPr txBox="1"/>
              <p:nvPr/>
            </p:nvSpPr>
            <p:spPr>
              <a:xfrm>
                <a:off x="2152125" y="1061061"/>
                <a:ext cx="35955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8</a:t>
                </a:r>
              </a:p>
            </p:txBody>
          </p:sp>
          <p:sp>
            <p:nvSpPr>
              <p:cNvPr id="100" name="TextBox 67">
                <a:extLst>
                  <a:ext uri="{FF2B5EF4-FFF2-40B4-BE49-F238E27FC236}">
                    <a16:creationId xmlns:a16="http://schemas.microsoft.com/office/drawing/2014/main" id="{0099CB3B-5887-94B5-417C-DE4A1F1639E9}"/>
                  </a:ext>
                </a:extLst>
              </p:cNvPr>
              <p:cNvSpPr txBox="1"/>
              <p:nvPr/>
            </p:nvSpPr>
            <p:spPr>
              <a:xfrm>
                <a:off x="2353711" y="1061399"/>
                <a:ext cx="4138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2</a:t>
                </a:r>
              </a:p>
            </p:txBody>
          </p:sp>
          <p:sp>
            <p:nvSpPr>
              <p:cNvPr id="101" name="TextBox 68">
                <a:extLst>
                  <a:ext uri="{FF2B5EF4-FFF2-40B4-BE49-F238E27FC236}">
                    <a16:creationId xmlns:a16="http://schemas.microsoft.com/office/drawing/2014/main" id="{DAAA0074-528E-8F9E-4979-1323FF279B2E}"/>
                  </a:ext>
                </a:extLst>
              </p:cNvPr>
              <p:cNvSpPr txBox="1"/>
              <p:nvPr/>
            </p:nvSpPr>
            <p:spPr>
              <a:xfrm>
                <a:off x="2618062" y="1061579"/>
                <a:ext cx="4138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6</a:t>
                </a:r>
              </a:p>
            </p:txBody>
          </p:sp>
        </p:grpSp>
        <p:sp>
          <p:nvSpPr>
            <p:cNvPr id="84" name="TextBox 68">
              <a:extLst>
                <a:ext uri="{FF2B5EF4-FFF2-40B4-BE49-F238E27FC236}">
                  <a16:creationId xmlns:a16="http://schemas.microsoft.com/office/drawing/2014/main" id="{059F3F98-4615-47B4-8364-1C126FC84F9D}"/>
                </a:ext>
              </a:extLst>
            </p:cNvPr>
            <p:cNvSpPr txBox="1"/>
            <p:nvPr/>
          </p:nvSpPr>
          <p:spPr>
            <a:xfrm>
              <a:off x="2890382" y="727197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20</a:t>
              </a:r>
            </a:p>
          </p:txBody>
        </p:sp>
        <p:grpSp>
          <p:nvGrpSpPr>
            <p:cNvPr id="104" name="קבוצה 103">
              <a:extLst>
                <a:ext uri="{FF2B5EF4-FFF2-40B4-BE49-F238E27FC236}">
                  <a16:creationId xmlns:a16="http://schemas.microsoft.com/office/drawing/2014/main" id="{9EFA4827-C724-44BF-B18A-473DBE8EF8CF}"/>
                </a:ext>
              </a:extLst>
            </p:cNvPr>
            <p:cNvGrpSpPr/>
            <p:nvPr/>
          </p:nvGrpSpPr>
          <p:grpSpPr>
            <a:xfrm>
              <a:off x="3464317" y="675720"/>
              <a:ext cx="1367729" cy="329471"/>
              <a:chOff x="1709581" y="1009697"/>
              <a:chExt cx="1367729" cy="329471"/>
            </a:xfrm>
          </p:grpSpPr>
          <p:sp>
            <p:nvSpPr>
              <p:cNvPr id="105" name="סוגר מרובע ימני 104">
                <a:extLst>
                  <a:ext uri="{FF2B5EF4-FFF2-40B4-BE49-F238E27FC236}">
                    <a16:creationId xmlns:a16="http://schemas.microsoft.com/office/drawing/2014/main" id="{BDED5688-72A1-4B2A-AA2A-3CBA0A79E277}"/>
                  </a:ext>
                </a:extLst>
              </p:cNvPr>
              <p:cNvSpPr/>
              <p:nvPr/>
            </p:nvSpPr>
            <p:spPr>
              <a:xfrm rot="16200000">
                <a:off x="2434570" y="412676"/>
                <a:ext cx="45719" cy="1239761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106" name="TextBox 64">
                <a:extLst>
                  <a:ext uri="{FF2B5EF4-FFF2-40B4-BE49-F238E27FC236}">
                    <a16:creationId xmlns:a16="http://schemas.microsoft.com/office/drawing/2014/main" id="{28BF52E6-BA50-487C-ACA5-6982911FAA0C}"/>
                  </a:ext>
                </a:extLst>
              </p:cNvPr>
              <p:cNvSpPr txBox="1"/>
              <p:nvPr/>
            </p:nvSpPr>
            <p:spPr>
              <a:xfrm>
                <a:off x="1709581" y="1060559"/>
                <a:ext cx="25056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0</a:t>
                </a:r>
              </a:p>
            </p:txBody>
          </p:sp>
          <p:sp>
            <p:nvSpPr>
              <p:cNvPr id="107" name="TextBox 65">
                <a:extLst>
                  <a:ext uri="{FF2B5EF4-FFF2-40B4-BE49-F238E27FC236}">
                    <a16:creationId xmlns:a16="http://schemas.microsoft.com/office/drawing/2014/main" id="{FFBD7BED-404E-45F4-A258-952F5CD7E222}"/>
                  </a:ext>
                </a:extLst>
              </p:cNvPr>
              <p:cNvSpPr txBox="1"/>
              <p:nvPr/>
            </p:nvSpPr>
            <p:spPr>
              <a:xfrm>
                <a:off x="1915478" y="1062169"/>
                <a:ext cx="3618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4</a:t>
                </a:r>
              </a:p>
            </p:txBody>
          </p:sp>
          <p:sp>
            <p:nvSpPr>
              <p:cNvPr id="108" name="TextBox 66">
                <a:extLst>
                  <a:ext uri="{FF2B5EF4-FFF2-40B4-BE49-F238E27FC236}">
                    <a16:creationId xmlns:a16="http://schemas.microsoft.com/office/drawing/2014/main" id="{FC9843A3-53C7-4FAA-B4B3-1F0EE56C25B7}"/>
                  </a:ext>
                </a:extLst>
              </p:cNvPr>
              <p:cNvSpPr txBox="1"/>
              <p:nvPr/>
            </p:nvSpPr>
            <p:spPr>
              <a:xfrm>
                <a:off x="2152125" y="1061061"/>
                <a:ext cx="35955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8</a:t>
                </a:r>
              </a:p>
            </p:txBody>
          </p:sp>
          <p:sp>
            <p:nvSpPr>
              <p:cNvPr id="109" name="TextBox 67">
                <a:extLst>
                  <a:ext uri="{FF2B5EF4-FFF2-40B4-BE49-F238E27FC236}">
                    <a16:creationId xmlns:a16="http://schemas.microsoft.com/office/drawing/2014/main" id="{1B859FF9-24F4-458D-8A53-E997FC5B7F0E}"/>
                  </a:ext>
                </a:extLst>
              </p:cNvPr>
              <p:cNvSpPr txBox="1"/>
              <p:nvPr/>
            </p:nvSpPr>
            <p:spPr>
              <a:xfrm>
                <a:off x="2353711" y="1061399"/>
                <a:ext cx="4138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2</a:t>
                </a:r>
              </a:p>
            </p:txBody>
          </p:sp>
          <p:sp>
            <p:nvSpPr>
              <p:cNvPr id="110" name="TextBox 68">
                <a:extLst>
                  <a:ext uri="{FF2B5EF4-FFF2-40B4-BE49-F238E27FC236}">
                    <a16:creationId xmlns:a16="http://schemas.microsoft.com/office/drawing/2014/main" id="{3BE4D8CB-9E84-42AD-8179-9C7C0602D6F1}"/>
                  </a:ext>
                </a:extLst>
              </p:cNvPr>
              <p:cNvSpPr txBox="1"/>
              <p:nvPr/>
            </p:nvSpPr>
            <p:spPr>
              <a:xfrm>
                <a:off x="2618062" y="1061579"/>
                <a:ext cx="4138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6</a:t>
                </a:r>
              </a:p>
            </p:txBody>
          </p:sp>
        </p:grpSp>
        <p:sp>
          <p:nvSpPr>
            <p:cNvPr id="111" name="TextBox 68">
              <a:extLst>
                <a:ext uri="{FF2B5EF4-FFF2-40B4-BE49-F238E27FC236}">
                  <a16:creationId xmlns:a16="http://schemas.microsoft.com/office/drawing/2014/main" id="{212134D3-F29F-48F4-83F9-FD1A955BC73A}"/>
                </a:ext>
              </a:extLst>
            </p:cNvPr>
            <p:cNvSpPr txBox="1"/>
            <p:nvPr/>
          </p:nvSpPr>
          <p:spPr>
            <a:xfrm>
              <a:off x="4631437" y="73052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20</a:t>
              </a:r>
            </a:p>
          </p:txBody>
        </p:sp>
        <p:sp>
          <p:nvSpPr>
            <p:cNvPr id="112" name="תיבת טקסט 13">
              <a:extLst>
                <a:ext uri="{FF2B5EF4-FFF2-40B4-BE49-F238E27FC236}">
                  <a16:creationId xmlns:a16="http://schemas.microsoft.com/office/drawing/2014/main" id="{B27A25D1-B7A9-4B6D-A3A0-173CDAABF010}"/>
                </a:ext>
              </a:extLst>
            </p:cNvPr>
            <p:cNvSpPr txBox="1"/>
            <p:nvPr/>
          </p:nvSpPr>
          <p:spPr>
            <a:xfrm>
              <a:off x="5842567" y="388645"/>
              <a:ext cx="407484" cy="338554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600" dirty="0"/>
                <a:t>HF</a:t>
              </a:r>
              <a:endParaRPr lang="he-IL" sz="1600" dirty="0"/>
            </a:p>
          </p:txBody>
        </p:sp>
        <p:sp>
          <p:nvSpPr>
            <p:cNvPr id="113" name="תיבת טקסט 14">
              <a:extLst>
                <a:ext uri="{FF2B5EF4-FFF2-40B4-BE49-F238E27FC236}">
                  <a16:creationId xmlns:a16="http://schemas.microsoft.com/office/drawing/2014/main" id="{4C13841B-9DC1-4201-A63D-F5355298E5B9}"/>
                </a:ext>
              </a:extLst>
            </p:cNvPr>
            <p:cNvSpPr txBox="1"/>
            <p:nvPr/>
          </p:nvSpPr>
          <p:spPr>
            <a:xfrm>
              <a:off x="7355722" y="395615"/>
              <a:ext cx="862737" cy="338554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600" dirty="0"/>
                <a:t>HF+BHB</a:t>
              </a:r>
              <a:endParaRPr lang="he-IL" sz="1600" dirty="0"/>
            </a:p>
          </p:txBody>
        </p:sp>
        <p:grpSp>
          <p:nvGrpSpPr>
            <p:cNvPr id="114" name="קבוצה 113">
              <a:extLst>
                <a:ext uri="{FF2B5EF4-FFF2-40B4-BE49-F238E27FC236}">
                  <a16:creationId xmlns:a16="http://schemas.microsoft.com/office/drawing/2014/main" id="{8181050A-528A-40E5-9454-114F8D16F038}"/>
                </a:ext>
              </a:extLst>
            </p:cNvPr>
            <p:cNvGrpSpPr/>
            <p:nvPr/>
          </p:nvGrpSpPr>
          <p:grpSpPr>
            <a:xfrm>
              <a:off x="5474607" y="675315"/>
              <a:ext cx="1367729" cy="329471"/>
              <a:chOff x="1709581" y="1009697"/>
              <a:chExt cx="1367729" cy="329471"/>
            </a:xfrm>
          </p:grpSpPr>
          <p:sp>
            <p:nvSpPr>
              <p:cNvPr id="137" name="סוגר מרובע ימני 136">
                <a:extLst>
                  <a:ext uri="{FF2B5EF4-FFF2-40B4-BE49-F238E27FC236}">
                    <a16:creationId xmlns:a16="http://schemas.microsoft.com/office/drawing/2014/main" id="{392BA01C-5A4F-4E30-8375-892DADCD1EB3}"/>
                  </a:ext>
                </a:extLst>
              </p:cNvPr>
              <p:cNvSpPr/>
              <p:nvPr/>
            </p:nvSpPr>
            <p:spPr>
              <a:xfrm rot="16200000">
                <a:off x="2434570" y="412676"/>
                <a:ext cx="45719" cy="1239761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139" name="TextBox 64">
                <a:extLst>
                  <a:ext uri="{FF2B5EF4-FFF2-40B4-BE49-F238E27FC236}">
                    <a16:creationId xmlns:a16="http://schemas.microsoft.com/office/drawing/2014/main" id="{5CA97C4B-4E4F-4350-885F-70BA4A65C1DE}"/>
                  </a:ext>
                </a:extLst>
              </p:cNvPr>
              <p:cNvSpPr txBox="1"/>
              <p:nvPr/>
            </p:nvSpPr>
            <p:spPr>
              <a:xfrm>
                <a:off x="1709581" y="1060559"/>
                <a:ext cx="25056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0</a:t>
                </a:r>
              </a:p>
            </p:txBody>
          </p:sp>
          <p:sp>
            <p:nvSpPr>
              <p:cNvPr id="141" name="TextBox 65">
                <a:extLst>
                  <a:ext uri="{FF2B5EF4-FFF2-40B4-BE49-F238E27FC236}">
                    <a16:creationId xmlns:a16="http://schemas.microsoft.com/office/drawing/2014/main" id="{910161C2-EB0C-4D02-962D-BA04D3697E41}"/>
                  </a:ext>
                </a:extLst>
              </p:cNvPr>
              <p:cNvSpPr txBox="1"/>
              <p:nvPr/>
            </p:nvSpPr>
            <p:spPr>
              <a:xfrm>
                <a:off x="1915478" y="1062169"/>
                <a:ext cx="3618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4</a:t>
                </a:r>
              </a:p>
            </p:txBody>
          </p:sp>
          <p:sp>
            <p:nvSpPr>
              <p:cNvPr id="145" name="TextBox 66">
                <a:extLst>
                  <a:ext uri="{FF2B5EF4-FFF2-40B4-BE49-F238E27FC236}">
                    <a16:creationId xmlns:a16="http://schemas.microsoft.com/office/drawing/2014/main" id="{069F509B-4416-4CEC-A09D-9613C304B507}"/>
                  </a:ext>
                </a:extLst>
              </p:cNvPr>
              <p:cNvSpPr txBox="1"/>
              <p:nvPr/>
            </p:nvSpPr>
            <p:spPr>
              <a:xfrm>
                <a:off x="2152125" y="1061061"/>
                <a:ext cx="35955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8</a:t>
                </a:r>
              </a:p>
            </p:txBody>
          </p:sp>
          <p:sp>
            <p:nvSpPr>
              <p:cNvPr id="146" name="TextBox 67">
                <a:extLst>
                  <a:ext uri="{FF2B5EF4-FFF2-40B4-BE49-F238E27FC236}">
                    <a16:creationId xmlns:a16="http://schemas.microsoft.com/office/drawing/2014/main" id="{D1A0B974-A9F6-4CFD-8143-8E8AC797A7A8}"/>
                  </a:ext>
                </a:extLst>
              </p:cNvPr>
              <p:cNvSpPr txBox="1"/>
              <p:nvPr/>
            </p:nvSpPr>
            <p:spPr>
              <a:xfrm>
                <a:off x="2353711" y="1061399"/>
                <a:ext cx="4138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2</a:t>
                </a:r>
              </a:p>
            </p:txBody>
          </p:sp>
          <p:sp>
            <p:nvSpPr>
              <p:cNvPr id="147" name="TextBox 68">
                <a:extLst>
                  <a:ext uri="{FF2B5EF4-FFF2-40B4-BE49-F238E27FC236}">
                    <a16:creationId xmlns:a16="http://schemas.microsoft.com/office/drawing/2014/main" id="{74983962-1DF6-468A-9D7C-787E0E0D3F64}"/>
                  </a:ext>
                </a:extLst>
              </p:cNvPr>
              <p:cNvSpPr txBox="1"/>
              <p:nvPr/>
            </p:nvSpPr>
            <p:spPr>
              <a:xfrm>
                <a:off x="2618062" y="1061579"/>
                <a:ext cx="4138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6</a:t>
                </a:r>
              </a:p>
            </p:txBody>
          </p:sp>
        </p:grpSp>
        <p:sp>
          <p:nvSpPr>
            <p:cNvPr id="148" name="TextBox 68">
              <a:extLst>
                <a:ext uri="{FF2B5EF4-FFF2-40B4-BE49-F238E27FC236}">
                  <a16:creationId xmlns:a16="http://schemas.microsoft.com/office/drawing/2014/main" id="{A21AB5A2-F4AA-4EA7-8209-B78CB1D8CCFB}"/>
                </a:ext>
              </a:extLst>
            </p:cNvPr>
            <p:cNvSpPr txBox="1"/>
            <p:nvPr/>
          </p:nvSpPr>
          <p:spPr>
            <a:xfrm>
              <a:off x="6655408" y="729697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20</a:t>
              </a:r>
            </a:p>
          </p:txBody>
        </p:sp>
        <p:grpSp>
          <p:nvGrpSpPr>
            <p:cNvPr id="149" name="קבוצה 148">
              <a:extLst>
                <a:ext uri="{FF2B5EF4-FFF2-40B4-BE49-F238E27FC236}">
                  <a16:creationId xmlns:a16="http://schemas.microsoft.com/office/drawing/2014/main" id="{CCC49AA6-3540-41C4-80A0-D9170B688B5D}"/>
                </a:ext>
              </a:extLst>
            </p:cNvPr>
            <p:cNvGrpSpPr/>
            <p:nvPr/>
          </p:nvGrpSpPr>
          <p:grpSpPr>
            <a:xfrm>
              <a:off x="7229343" y="678220"/>
              <a:ext cx="1367729" cy="329471"/>
              <a:chOff x="1709581" y="1009697"/>
              <a:chExt cx="1367729" cy="329471"/>
            </a:xfrm>
          </p:grpSpPr>
          <p:sp>
            <p:nvSpPr>
              <p:cNvPr id="150" name="סוגר מרובע ימני 149">
                <a:extLst>
                  <a:ext uri="{FF2B5EF4-FFF2-40B4-BE49-F238E27FC236}">
                    <a16:creationId xmlns:a16="http://schemas.microsoft.com/office/drawing/2014/main" id="{B9AD1C17-2C9C-4AF8-BEC7-72259B00F177}"/>
                  </a:ext>
                </a:extLst>
              </p:cNvPr>
              <p:cNvSpPr/>
              <p:nvPr/>
            </p:nvSpPr>
            <p:spPr>
              <a:xfrm rot="16200000">
                <a:off x="2434570" y="412676"/>
                <a:ext cx="45719" cy="1239761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151" name="TextBox 64">
                <a:extLst>
                  <a:ext uri="{FF2B5EF4-FFF2-40B4-BE49-F238E27FC236}">
                    <a16:creationId xmlns:a16="http://schemas.microsoft.com/office/drawing/2014/main" id="{4700D035-9DCE-405D-B9F2-C115B053D1EB}"/>
                  </a:ext>
                </a:extLst>
              </p:cNvPr>
              <p:cNvSpPr txBox="1"/>
              <p:nvPr/>
            </p:nvSpPr>
            <p:spPr>
              <a:xfrm>
                <a:off x="1709581" y="1060559"/>
                <a:ext cx="25056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0</a:t>
                </a:r>
              </a:p>
            </p:txBody>
          </p:sp>
          <p:sp>
            <p:nvSpPr>
              <p:cNvPr id="152" name="TextBox 65">
                <a:extLst>
                  <a:ext uri="{FF2B5EF4-FFF2-40B4-BE49-F238E27FC236}">
                    <a16:creationId xmlns:a16="http://schemas.microsoft.com/office/drawing/2014/main" id="{27E089C8-3DB8-4806-8E41-986703E9923A}"/>
                  </a:ext>
                </a:extLst>
              </p:cNvPr>
              <p:cNvSpPr txBox="1"/>
              <p:nvPr/>
            </p:nvSpPr>
            <p:spPr>
              <a:xfrm>
                <a:off x="1915478" y="1062169"/>
                <a:ext cx="3618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4</a:t>
                </a:r>
              </a:p>
            </p:txBody>
          </p:sp>
          <p:sp>
            <p:nvSpPr>
              <p:cNvPr id="153" name="TextBox 66">
                <a:extLst>
                  <a:ext uri="{FF2B5EF4-FFF2-40B4-BE49-F238E27FC236}">
                    <a16:creationId xmlns:a16="http://schemas.microsoft.com/office/drawing/2014/main" id="{BAD3E3FC-9994-4FF6-86D0-66A1EC6D49AD}"/>
                  </a:ext>
                </a:extLst>
              </p:cNvPr>
              <p:cNvSpPr txBox="1"/>
              <p:nvPr/>
            </p:nvSpPr>
            <p:spPr>
              <a:xfrm>
                <a:off x="2152125" y="1061061"/>
                <a:ext cx="35955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8</a:t>
                </a:r>
              </a:p>
            </p:txBody>
          </p:sp>
          <p:sp>
            <p:nvSpPr>
              <p:cNvPr id="154" name="TextBox 67">
                <a:extLst>
                  <a:ext uri="{FF2B5EF4-FFF2-40B4-BE49-F238E27FC236}">
                    <a16:creationId xmlns:a16="http://schemas.microsoft.com/office/drawing/2014/main" id="{17A5D0ED-7B6B-419B-B914-2A242B34BD34}"/>
                  </a:ext>
                </a:extLst>
              </p:cNvPr>
              <p:cNvSpPr txBox="1"/>
              <p:nvPr/>
            </p:nvSpPr>
            <p:spPr>
              <a:xfrm>
                <a:off x="2353711" y="1061399"/>
                <a:ext cx="4138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2</a:t>
                </a:r>
              </a:p>
            </p:txBody>
          </p:sp>
          <p:sp>
            <p:nvSpPr>
              <p:cNvPr id="155" name="TextBox 68">
                <a:extLst>
                  <a:ext uri="{FF2B5EF4-FFF2-40B4-BE49-F238E27FC236}">
                    <a16:creationId xmlns:a16="http://schemas.microsoft.com/office/drawing/2014/main" id="{18B500CA-3022-4D90-9C4B-E3B87E4FB031}"/>
                  </a:ext>
                </a:extLst>
              </p:cNvPr>
              <p:cNvSpPr txBox="1"/>
              <p:nvPr/>
            </p:nvSpPr>
            <p:spPr>
              <a:xfrm>
                <a:off x="2618062" y="1061579"/>
                <a:ext cx="4138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6</a:t>
                </a:r>
              </a:p>
            </p:txBody>
          </p:sp>
        </p:grpSp>
        <p:sp>
          <p:nvSpPr>
            <p:cNvPr id="156" name="TextBox 68">
              <a:extLst>
                <a:ext uri="{FF2B5EF4-FFF2-40B4-BE49-F238E27FC236}">
                  <a16:creationId xmlns:a16="http://schemas.microsoft.com/office/drawing/2014/main" id="{BE1723CA-D04E-49D0-AD3D-B510BC00B2A8}"/>
                </a:ext>
              </a:extLst>
            </p:cNvPr>
            <p:cNvSpPr txBox="1"/>
            <p:nvPr/>
          </p:nvSpPr>
          <p:spPr>
            <a:xfrm>
              <a:off x="8396463" y="73302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20</a:t>
              </a:r>
            </a:p>
          </p:txBody>
        </p:sp>
      </p:grpSp>
      <p:sp>
        <p:nvSpPr>
          <p:cNvPr id="162" name="תיבת טקסט 73">
            <a:extLst>
              <a:ext uri="{FF2B5EF4-FFF2-40B4-BE49-F238E27FC236}">
                <a16:creationId xmlns:a16="http://schemas.microsoft.com/office/drawing/2014/main" id="{12DD4FBC-88A5-495A-8BBD-DBE92305BD12}"/>
              </a:ext>
            </a:extLst>
          </p:cNvPr>
          <p:cNvSpPr txBox="1"/>
          <p:nvPr/>
        </p:nvSpPr>
        <p:spPr>
          <a:xfrm>
            <a:off x="259055" y="2561258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FASN 273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3" name="תיבת טקסט 74">
            <a:extLst>
              <a:ext uri="{FF2B5EF4-FFF2-40B4-BE49-F238E27FC236}">
                <a16:creationId xmlns:a16="http://schemas.microsoft.com/office/drawing/2014/main" id="{33083F01-98B8-40E2-B9B2-C1A4ABEACEA4}"/>
              </a:ext>
            </a:extLst>
          </p:cNvPr>
          <p:cNvSpPr txBox="1"/>
          <p:nvPr/>
        </p:nvSpPr>
        <p:spPr>
          <a:xfrm>
            <a:off x="251035" y="3068890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mTOR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22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4" name="תיבת טקסט 75">
            <a:extLst>
              <a:ext uri="{FF2B5EF4-FFF2-40B4-BE49-F238E27FC236}">
                <a16:creationId xmlns:a16="http://schemas.microsoft.com/office/drawing/2014/main" id="{D561F2B2-60EB-452C-9E37-868369980D17}"/>
              </a:ext>
            </a:extLst>
          </p:cNvPr>
          <p:cNvSpPr txBox="1"/>
          <p:nvPr/>
        </p:nvSpPr>
        <p:spPr>
          <a:xfrm>
            <a:off x="249988" y="5881289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NFKB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65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5" name="תיבת טקסט 76">
            <a:extLst>
              <a:ext uri="{FF2B5EF4-FFF2-40B4-BE49-F238E27FC236}">
                <a16:creationId xmlns:a16="http://schemas.microsoft.com/office/drawing/2014/main" id="{E825FA9B-5817-4DCC-AB1B-BFD85BA38F5B}"/>
              </a:ext>
            </a:extLst>
          </p:cNvPr>
          <p:cNvSpPr txBox="1"/>
          <p:nvPr/>
        </p:nvSpPr>
        <p:spPr>
          <a:xfrm>
            <a:off x="251037" y="4759943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P70S6K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7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6" name="תיבת טקסט 77">
            <a:extLst>
              <a:ext uri="{FF2B5EF4-FFF2-40B4-BE49-F238E27FC236}">
                <a16:creationId xmlns:a16="http://schemas.microsoft.com/office/drawing/2014/main" id="{94C7B495-7225-4EC5-97A0-01A7A4F5860A}"/>
              </a:ext>
            </a:extLst>
          </p:cNvPr>
          <p:cNvSpPr txBox="1"/>
          <p:nvPr/>
        </p:nvSpPr>
        <p:spPr>
          <a:xfrm>
            <a:off x="243017" y="5301562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pP70S6K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7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7" name="תיבת טקסט 78">
            <a:extLst>
              <a:ext uri="{FF2B5EF4-FFF2-40B4-BE49-F238E27FC236}">
                <a16:creationId xmlns:a16="http://schemas.microsoft.com/office/drawing/2014/main" id="{9B274E60-7A1A-452F-9551-42BB28FF99BE}"/>
              </a:ext>
            </a:extLst>
          </p:cNvPr>
          <p:cNvSpPr txBox="1"/>
          <p:nvPr/>
        </p:nvSpPr>
        <p:spPr>
          <a:xfrm>
            <a:off x="251039" y="7503007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AKT 6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8" name="תיבת טקסט 79">
            <a:extLst>
              <a:ext uri="{FF2B5EF4-FFF2-40B4-BE49-F238E27FC236}">
                <a16:creationId xmlns:a16="http://schemas.microsoft.com/office/drawing/2014/main" id="{F4BD0B9D-537A-4AD8-97DC-5ACF68DEB7B0}"/>
              </a:ext>
            </a:extLst>
          </p:cNvPr>
          <p:cNvSpPr txBox="1"/>
          <p:nvPr/>
        </p:nvSpPr>
        <p:spPr>
          <a:xfrm>
            <a:off x="243019" y="8054753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AKT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56-6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9" name="תיבת טקסט 80">
            <a:extLst>
              <a:ext uri="{FF2B5EF4-FFF2-40B4-BE49-F238E27FC236}">
                <a16:creationId xmlns:a16="http://schemas.microsoft.com/office/drawing/2014/main" id="{86CA37CC-C642-4903-BD12-1A426CB8D92F}"/>
              </a:ext>
            </a:extLst>
          </p:cNvPr>
          <p:cNvSpPr txBox="1"/>
          <p:nvPr/>
        </p:nvSpPr>
        <p:spPr>
          <a:xfrm>
            <a:off x="234999" y="8586441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ACTIN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4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0" name="תיבת טקסט 81">
            <a:extLst>
              <a:ext uri="{FF2B5EF4-FFF2-40B4-BE49-F238E27FC236}">
                <a16:creationId xmlns:a16="http://schemas.microsoft.com/office/drawing/2014/main" id="{9426F297-DABE-499F-A1C0-266666A83C79}"/>
              </a:ext>
            </a:extLst>
          </p:cNvPr>
          <p:cNvSpPr txBox="1"/>
          <p:nvPr/>
        </p:nvSpPr>
        <p:spPr>
          <a:xfrm>
            <a:off x="243021" y="10208351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S6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3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1" name="תיבת טקסט 82">
            <a:extLst>
              <a:ext uri="{FF2B5EF4-FFF2-40B4-BE49-F238E27FC236}">
                <a16:creationId xmlns:a16="http://schemas.microsoft.com/office/drawing/2014/main" id="{07945844-C51E-4DCC-B0AF-B0CF10C07A8A}"/>
              </a:ext>
            </a:extLst>
          </p:cNvPr>
          <p:cNvSpPr txBox="1"/>
          <p:nvPr/>
        </p:nvSpPr>
        <p:spPr>
          <a:xfrm>
            <a:off x="251043" y="10745957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pS6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3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2" name="תיבת טקסט 76">
            <a:extLst>
              <a:ext uri="{FF2B5EF4-FFF2-40B4-BE49-F238E27FC236}">
                <a16:creationId xmlns:a16="http://schemas.microsoft.com/office/drawing/2014/main" id="{040936E6-B3C2-41BA-9F3A-A07F58F7954D}"/>
              </a:ext>
            </a:extLst>
          </p:cNvPr>
          <p:cNvSpPr txBox="1"/>
          <p:nvPr/>
        </p:nvSpPr>
        <p:spPr>
          <a:xfrm>
            <a:off x="247023" y="6440951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AMPK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6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3" name="תיבת טקסט 77">
            <a:extLst>
              <a:ext uri="{FF2B5EF4-FFF2-40B4-BE49-F238E27FC236}">
                <a16:creationId xmlns:a16="http://schemas.microsoft.com/office/drawing/2014/main" id="{C048DAAB-1C94-4DC4-98EF-72A1E3B8EB78}"/>
              </a:ext>
            </a:extLst>
          </p:cNvPr>
          <p:cNvSpPr txBox="1"/>
          <p:nvPr/>
        </p:nvSpPr>
        <p:spPr>
          <a:xfrm>
            <a:off x="239003" y="6997560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AMPK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6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4" name="תיבת טקסט 76">
            <a:extLst>
              <a:ext uri="{FF2B5EF4-FFF2-40B4-BE49-F238E27FC236}">
                <a16:creationId xmlns:a16="http://schemas.microsoft.com/office/drawing/2014/main" id="{E22F69FF-E202-4795-AFCD-53A4FD3EFF83}"/>
              </a:ext>
            </a:extLst>
          </p:cNvPr>
          <p:cNvSpPr txBox="1"/>
          <p:nvPr/>
        </p:nvSpPr>
        <p:spPr>
          <a:xfrm>
            <a:off x="247023" y="9134259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PP2A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36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5" name="תיבת טקסט 77">
            <a:extLst>
              <a:ext uri="{FF2B5EF4-FFF2-40B4-BE49-F238E27FC236}">
                <a16:creationId xmlns:a16="http://schemas.microsoft.com/office/drawing/2014/main" id="{518CB4F7-512C-4D5C-A51E-1E0EBFFDD206}"/>
              </a:ext>
            </a:extLst>
          </p:cNvPr>
          <p:cNvSpPr txBox="1"/>
          <p:nvPr/>
        </p:nvSpPr>
        <p:spPr>
          <a:xfrm>
            <a:off x="239003" y="9660886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pPP2A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36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תיבת טקסט 12">
            <a:extLst>
              <a:ext uri="{FF2B5EF4-FFF2-40B4-BE49-F238E27FC236}">
                <a16:creationId xmlns:a16="http://schemas.microsoft.com/office/drawing/2014/main" id="{10084B39-BF93-0B4C-D672-02D1723073E3}"/>
              </a:ext>
            </a:extLst>
          </p:cNvPr>
          <p:cNvSpPr txBox="1"/>
          <p:nvPr/>
        </p:nvSpPr>
        <p:spPr>
          <a:xfrm>
            <a:off x="275095" y="936609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mTOR 289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50" name="תמונה 49">
            <a:extLst>
              <a:ext uri="{FF2B5EF4-FFF2-40B4-BE49-F238E27FC236}">
                <a16:creationId xmlns:a16="http://schemas.microsoft.com/office/drawing/2014/main" id="{5E2FE71B-BF53-3C2F-14CA-5B502BC644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20645" y="2994407"/>
            <a:ext cx="266700" cy="219075"/>
          </a:xfrm>
          <a:prstGeom prst="rect">
            <a:avLst/>
          </a:prstGeom>
        </p:spPr>
      </p:pic>
      <p:sp>
        <p:nvSpPr>
          <p:cNvPr id="51" name="תיבת טקסט 50">
            <a:extLst>
              <a:ext uri="{FF2B5EF4-FFF2-40B4-BE49-F238E27FC236}">
                <a16:creationId xmlns:a16="http://schemas.microsoft.com/office/drawing/2014/main" id="{7490128A-00E7-8ED4-7D89-6269FD15C9F6}"/>
              </a:ext>
            </a:extLst>
          </p:cNvPr>
          <p:cNvSpPr txBox="1"/>
          <p:nvPr/>
        </p:nvSpPr>
        <p:spPr>
          <a:xfrm>
            <a:off x="9187345" y="2946285"/>
            <a:ext cx="89328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250 KD</a:t>
            </a:r>
            <a:endParaRPr lang="he-IL" sz="1200" dirty="0"/>
          </a:p>
        </p:txBody>
      </p:sp>
      <p:pic>
        <p:nvPicPr>
          <p:cNvPr id="52" name="תמונה 51">
            <a:extLst>
              <a:ext uri="{FF2B5EF4-FFF2-40B4-BE49-F238E27FC236}">
                <a16:creationId xmlns:a16="http://schemas.microsoft.com/office/drawing/2014/main" id="{8CDE9EE0-CA41-7F68-D899-A653A5C9A1B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21337" y="3513542"/>
            <a:ext cx="285750" cy="180975"/>
          </a:xfrm>
          <a:prstGeom prst="rect">
            <a:avLst/>
          </a:prstGeom>
        </p:spPr>
      </p:pic>
      <p:sp>
        <p:nvSpPr>
          <p:cNvPr id="53" name="תיבת טקסט 52">
            <a:extLst>
              <a:ext uri="{FF2B5EF4-FFF2-40B4-BE49-F238E27FC236}">
                <a16:creationId xmlns:a16="http://schemas.microsoft.com/office/drawing/2014/main" id="{A8779246-1101-ACEF-38FC-2A94AFDCD7CF}"/>
              </a:ext>
            </a:extLst>
          </p:cNvPr>
          <p:cNvSpPr txBox="1"/>
          <p:nvPr/>
        </p:nvSpPr>
        <p:spPr>
          <a:xfrm>
            <a:off x="9200517" y="3468601"/>
            <a:ext cx="880108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150 KD</a:t>
            </a:r>
            <a:endParaRPr lang="he-IL" sz="1200" dirty="0"/>
          </a:p>
        </p:txBody>
      </p:sp>
      <p:pic>
        <p:nvPicPr>
          <p:cNvPr id="54" name="תמונה 53">
            <a:extLst>
              <a:ext uri="{FF2B5EF4-FFF2-40B4-BE49-F238E27FC236}">
                <a16:creationId xmlns:a16="http://schemas.microsoft.com/office/drawing/2014/main" id="{BE8B14D5-7F92-E9C6-B04B-AB52A45F106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92739" y="4721940"/>
            <a:ext cx="361950" cy="152400"/>
          </a:xfrm>
          <a:prstGeom prst="rect">
            <a:avLst/>
          </a:prstGeom>
        </p:spPr>
      </p:pic>
      <p:sp>
        <p:nvSpPr>
          <p:cNvPr id="55" name="תיבת טקסט 54">
            <a:extLst>
              <a:ext uri="{FF2B5EF4-FFF2-40B4-BE49-F238E27FC236}">
                <a16:creationId xmlns:a16="http://schemas.microsoft.com/office/drawing/2014/main" id="{43FA4DCC-31E0-F113-B69C-C939B1412789}"/>
              </a:ext>
            </a:extLst>
          </p:cNvPr>
          <p:cNvSpPr txBox="1"/>
          <p:nvPr/>
        </p:nvSpPr>
        <p:spPr>
          <a:xfrm>
            <a:off x="9194314" y="4655606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75 KD</a:t>
            </a:r>
            <a:endParaRPr lang="he-IL" sz="1200" dirty="0"/>
          </a:p>
        </p:txBody>
      </p:sp>
      <p:pic>
        <p:nvPicPr>
          <p:cNvPr id="56" name="תמונה 55">
            <a:extLst>
              <a:ext uri="{FF2B5EF4-FFF2-40B4-BE49-F238E27FC236}">
                <a16:creationId xmlns:a16="http://schemas.microsoft.com/office/drawing/2014/main" id="{AB493768-AA89-38AB-ECD2-235511B89BB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96770" y="3656709"/>
            <a:ext cx="304800" cy="152400"/>
          </a:xfrm>
          <a:prstGeom prst="rect">
            <a:avLst/>
          </a:prstGeom>
        </p:spPr>
      </p:pic>
      <p:pic>
        <p:nvPicPr>
          <p:cNvPr id="58" name="תמונה 57">
            <a:extLst>
              <a:ext uri="{FF2B5EF4-FFF2-40B4-BE49-F238E27FC236}">
                <a16:creationId xmlns:a16="http://schemas.microsoft.com/office/drawing/2014/main" id="{CB3F7469-FAFC-217D-D19E-68029378764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75678" y="8503169"/>
            <a:ext cx="342900" cy="171450"/>
          </a:xfrm>
          <a:prstGeom prst="rect">
            <a:avLst/>
          </a:prstGeom>
        </p:spPr>
      </p:pic>
      <p:sp>
        <p:nvSpPr>
          <p:cNvPr id="59" name="תיבת טקסט 58">
            <a:extLst>
              <a:ext uri="{FF2B5EF4-FFF2-40B4-BE49-F238E27FC236}">
                <a16:creationId xmlns:a16="http://schemas.microsoft.com/office/drawing/2014/main" id="{B88E4FDA-40FB-15EA-2598-D40993CDB69F}"/>
              </a:ext>
            </a:extLst>
          </p:cNvPr>
          <p:cNvSpPr txBox="1"/>
          <p:nvPr/>
        </p:nvSpPr>
        <p:spPr>
          <a:xfrm>
            <a:off x="9130342" y="8446083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50 KD</a:t>
            </a:r>
            <a:endParaRPr lang="he-IL" sz="1200" dirty="0"/>
          </a:p>
        </p:txBody>
      </p:sp>
      <p:pic>
        <p:nvPicPr>
          <p:cNvPr id="60" name="תמונה 59">
            <a:extLst>
              <a:ext uri="{FF2B5EF4-FFF2-40B4-BE49-F238E27FC236}">
                <a16:creationId xmlns:a16="http://schemas.microsoft.com/office/drawing/2014/main" id="{22B964ED-D404-ECF2-9BD5-A1E53C7FE1A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871915" y="9051182"/>
            <a:ext cx="314325" cy="161925"/>
          </a:xfrm>
          <a:prstGeom prst="rect">
            <a:avLst/>
          </a:prstGeom>
        </p:spPr>
      </p:pic>
      <p:sp>
        <p:nvSpPr>
          <p:cNvPr id="61" name="תיבת טקסט 60">
            <a:extLst>
              <a:ext uri="{FF2B5EF4-FFF2-40B4-BE49-F238E27FC236}">
                <a16:creationId xmlns:a16="http://schemas.microsoft.com/office/drawing/2014/main" id="{82C0C43A-C2A4-882F-9132-0BE298F81047}"/>
              </a:ext>
            </a:extLst>
          </p:cNvPr>
          <p:cNvSpPr txBox="1"/>
          <p:nvPr/>
        </p:nvSpPr>
        <p:spPr>
          <a:xfrm>
            <a:off x="9141312" y="8972645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37 KD</a:t>
            </a:r>
            <a:endParaRPr lang="he-IL" sz="1200" dirty="0"/>
          </a:p>
        </p:txBody>
      </p:sp>
      <p:pic>
        <p:nvPicPr>
          <p:cNvPr id="62" name="תמונה 61">
            <a:extLst>
              <a:ext uri="{FF2B5EF4-FFF2-40B4-BE49-F238E27FC236}">
                <a16:creationId xmlns:a16="http://schemas.microsoft.com/office/drawing/2014/main" id="{0F78848F-134D-E3C8-BABD-7476D283AD8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879591" y="11256746"/>
            <a:ext cx="304800" cy="180975"/>
          </a:xfrm>
          <a:prstGeom prst="rect">
            <a:avLst/>
          </a:prstGeom>
        </p:spPr>
      </p:pic>
      <p:sp>
        <p:nvSpPr>
          <p:cNvPr id="63" name="תיבת טקסט 62">
            <a:extLst>
              <a:ext uri="{FF2B5EF4-FFF2-40B4-BE49-F238E27FC236}">
                <a16:creationId xmlns:a16="http://schemas.microsoft.com/office/drawing/2014/main" id="{C8BFF471-696C-4724-3228-8F61C46BFAC6}"/>
              </a:ext>
            </a:extLst>
          </p:cNvPr>
          <p:cNvSpPr txBox="1"/>
          <p:nvPr/>
        </p:nvSpPr>
        <p:spPr>
          <a:xfrm>
            <a:off x="9152297" y="11212300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25 KD</a:t>
            </a:r>
            <a:endParaRPr lang="he-IL" sz="1200" dirty="0"/>
          </a:p>
        </p:txBody>
      </p:sp>
      <p:sp>
        <p:nvSpPr>
          <p:cNvPr id="74" name="תיבת טקסט 73">
            <a:extLst>
              <a:ext uri="{FF2B5EF4-FFF2-40B4-BE49-F238E27FC236}">
                <a16:creationId xmlns:a16="http://schemas.microsoft.com/office/drawing/2014/main" id="{91B1BEED-6FA7-0927-1357-5075D6D3EC72}"/>
              </a:ext>
            </a:extLst>
          </p:cNvPr>
          <p:cNvSpPr txBox="1"/>
          <p:nvPr/>
        </p:nvSpPr>
        <p:spPr>
          <a:xfrm>
            <a:off x="267075" y="1504191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ACC 28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5" name="תיבת טקסט 74">
            <a:extLst>
              <a:ext uri="{FF2B5EF4-FFF2-40B4-BE49-F238E27FC236}">
                <a16:creationId xmlns:a16="http://schemas.microsoft.com/office/drawing/2014/main" id="{00A37420-FBAE-525A-18E0-A53BFCFEEDA9}"/>
              </a:ext>
            </a:extLst>
          </p:cNvPr>
          <p:cNvSpPr txBox="1"/>
          <p:nvPr/>
        </p:nvSpPr>
        <p:spPr>
          <a:xfrm>
            <a:off x="259055" y="2026813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ACC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28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3" name="TextBox 66">
            <a:extLst>
              <a:ext uri="{FF2B5EF4-FFF2-40B4-BE49-F238E27FC236}">
                <a16:creationId xmlns:a16="http://schemas.microsoft.com/office/drawing/2014/main" id="{0B557832-60B7-B090-7FF9-5DBC777DA6E9}"/>
              </a:ext>
            </a:extLst>
          </p:cNvPr>
          <p:cNvSpPr txBox="1"/>
          <p:nvPr/>
        </p:nvSpPr>
        <p:spPr>
          <a:xfrm>
            <a:off x="-10732" y="2814"/>
            <a:ext cx="20780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. S3</a:t>
            </a:r>
          </a:p>
        </p:txBody>
      </p:sp>
      <p:sp>
        <p:nvSpPr>
          <p:cNvPr id="76" name="תיבת טקסט 76">
            <a:extLst>
              <a:ext uri="{FF2B5EF4-FFF2-40B4-BE49-F238E27FC236}">
                <a16:creationId xmlns:a16="http://schemas.microsoft.com/office/drawing/2014/main" id="{9097456A-A9A5-47A9-80EF-F921EA9B33A3}"/>
              </a:ext>
            </a:extLst>
          </p:cNvPr>
          <p:cNvSpPr txBox="1"/>
          <p:nvPr/>
        </p:nvSpPr>
        <p:spPr>
          <a:xfrm>
            <a:off x="253537" y="3623193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FOXO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78-8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7" name="תיבת טקסט 77">
            <a:extLst>
              <a:ext uri="{FF2B5EF4-FFF2-40B4-BE49-F238E27FC236}">
                <a16:creationId xmlns:a16="http://schemas.microsoft.com/office/drawing/2014/main" id="{509EB410-B8AB-4566-8935-F5595C8B667B}"/>
              </a:ext>
            </a:extLst>
          </p:cNvPr>
          <p:cNvSpPr txBox="1"/>
          <p:nvPr/>
        </p:nvSpPr>
        <p:spPr>
          <a:xfrm>
            <a:off x="245517" y="4179802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FOXO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78-8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8" name="Rectangle 1">
            <a:extLst>
              <a:ext uri="{FF2B5EF4-FFF2-40B4-BE49-F238E27FC236}">
                <a16:creationId xmlns:a16="http://schemas.microsoft.com/office/drawing/2014/main" id="{0E82654F-906A-44D0-A4A2-93AAC4B2E102}"/>
              </a:ext>
            </a:extLst>
          </p:cNvPr>
          <p:cNvSpPr/>
          <p:nvPr/>
        </p:nvSpPr>
        <p:spPr>
          <a:xfrm>
            <a:off x="-22171" y="11325422"/>
            <a:ext cx="9967886" cy="462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S3: Western blot protein analysis of the effect of HF and BHB supplementation on adipose tissue metabolism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247428" y="1028140"/>
            <a:ext cx="3487214" cy="40846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263513" y="1621377"/>
            <a:ext cx="3542083" cy="30482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219993" y="2090868"/>
            <a:ext cx="3542083" cy="44504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139223" y="2657762"/>
            <a:ext cx="3639627" cy="38408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161822" y="3203960"/>
            <a:ext cx="3621338" cy="43895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176719" y="3878707"/>
            <a:ext cx="3596952" cy="16460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248523" y="4311340"/>
            <a:ext cx="3572566" cy="408467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251762" y="4902019"/>
            <a:ext cx="3554276" cy="304826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309489" y="5420164"/>
            <a:ext cx="3511600" cy="377985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162625" y="5945256"/>
            <a:ext cx="3651821" cy="43895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094188" y="6539971"/>
            <a:ext cx="3731075" cy="414564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260890" y="7020038"/>
            <a:ext cx="3548180" cy="481626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198402" y="7676504"/>
            <a:ext cx="3639627" cy="213378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265873" y="8154073"/>
            <a:ext cx="3535986" cy="365792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5138960" y="8659783"/>
            <a:ext cx="3670110" cy="408467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240788" y="9217696"/>
            <a:ext cx="3584759" cy="371888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149632" y="9841672"/>
            <a:ext cx="3627434" cy="231668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5182048" y="10351213"/>
            <a:ext cx="3609145" cy="262151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312537" y="10797228"/>
            <a:ext cx="3505504" cy="475529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238690" y="1023213"/>
            <a:ext cx="3792041" cy="420660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1442878" y="1634614"/>
            <a:ext cx="3566469" cy="335309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1507142" y="2130982"/>
            <a:ext cx="3487214" cy="359695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1349077" y="2666518"/>
            <a:ext cx="3633531" cy="365792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1472870" y="3157436"/>
            <a:ext cx="3535986" cy="499915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1457868" y="3772017"/>
            <a:ext cx="3535986" cy="377985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1541713" y="4334930"/>
            <a:ext cx="3456732" cy="359695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1303253" y="4886372"/>
            <a:ext cx="3694496" cy="335309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1485998" y="5408738"/>
            <a:ext cx="3511600" cy="371888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1421481" y="6017917"/>
            <a:ext cx="3578662" cy="323116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1507142" y="6582190"/>
            <a:ext cx="3493311" cy="335309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1451712" y="7038873"/>
            <a:ext cx="3548180" cy="438950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1409539" y="7598828"/>
            <a:ext cx="3572566" cy="371888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>
            <a:off x="1488291" y="8210360"/>
            <a:ext cx="3475021" cy="256054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>
            <a:off x="1488290" y="8792229"/>
            <a:ext cx="3475021" cy="201185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>
            <a:off x="1583063" y="9217201"/>
            <a:ext cx="3383573" cy="371888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>
            <a:off x="1583063" y="9851780"/>
            <a:ext cx="3407959" cy="213378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>
          <a:blip r:embed="rId46"/>
          <a:stretch>
            <a:fillRect/>
          </a:stretch>
        </p:blipFill>
        <p:spPr>
          <a:xfrm>
            <a:off x="1503352" y="10256465"/>
            <a:ext cx="3475021" cy="481626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>
          <a:blip r:embed="rId47"/>
          <a:stretch>
            <a:fillRect/>
          </a:stretch>
        </p:blipFill>
        <p:spPr>
          <a:xfrm>
            <a:off x="1552013" y="10796724"/>
            <a:ext cx="3468925" cy="4755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92830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תיבת טקסט 73">
            <a:extLst>
              <a:ext uri="{FF2B5EF4-FFF2-40B4-BE49-F238E27FC236}">
                <a16:creationId xmlns:a16="http://schemas.microsoft.com/office/drawing/2014/main" id="{12DD4FBC-88A5-495A-8BBD-DBE92305BD12}"/>
              </a:ext>
            </a:extLst>
          </p:cNvPr>
          <p:cNvSpPr txBox="1"/>
          <p:nvPr/>
        </p:nvSpPr>
        <p:spPr>
          <a:xfrm>
            <a:off x="259055" y="2936008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CRY1 66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3" name="תיבת טקסט 74">
            <a:extLst>
              <a:ext uri="{FF2B5EF4-FFF2-40B4-BE49-F238E27FC236}">
                <a16:creationId xmlns:a16="http://schemas.microsoft.com/office/drawing/2014/main" id="{33083F01-98B8-40E2-B9B2-C1A4ABEACEA4}"/>
              </a:ext>
            </a:extLst>
          </p:cNvPr>
          <p:cNvSpPr txBox="1"/>
          <p:nvPr/>
        </p:nvSpPr>
        <p:spPr>
          <a:xfrm>
            <a:off x="251035" y="3533580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ACTIN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4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4" name="טבלה 3">
            <a:extLst>
              <a:ext uri="{FF2B5EF4-FFF2-40B4-BE49-F238E27FC236}">
                <a16:creationId xmlns:a16="http://schemas.microsoft.com/office/drawing/2014/main" id="{F541CAEF-1A26-3B88-7409-B3CFEF620537}"/>
              </a:ext>
            </a:extLst>
          </p:cNvPr>
          <p:cNvGraphicFramePr>
            <a:graphicFrameLocks noGrp="1"/>
          </p:cNvGraphicFramePr>
          <p:nvPr/>
        </p:nvGraphicFramePr>
        <p:xfrm>
          <a:off x="1230309" y="534911"/>
          <a:ext cx="7620004" cy="3621507"/>
        </p:xfrm>
        <a:graphic>
          <a:graphicData uri="http://schemas.openxmlformats.org/drawingml/2006/table">
            <a:tbl>
              <a:tblPr rtl="1" firstRow="1" bandRow="1">
                <a:tableStyleId>{5940675A-B579-460E-94D1-54222C63F5DA}</a:tableStyleId>
              </a:tblPr>
              <a:tblGrid>
                <a:gridCol w="3810002">
                  <a:extLst>
                    <a:ext uri="{9D8B030D-6E8A-4147-A177-3AD203B41FA5}">
                      <a16:colId xmlns:a16="http://schemas.microsoft.com/office/drawing/2014/main" val="2673439277"/>
                    </a:ext>
                  </a:extLst>
                </a:gridCol>
                <a:gridCol w="3810002">
                  <a:extLst>
                    <a:ext uri="{9D8B030D-6E8A-4147-A177-3AD203B41FA5}">
                      <a16:colId xmlns:a16="http://schemas.microsoft.com/office/drawing/2014/main" val="112674736"/>
                    </a:ext>
                  </a:extLst>
                </a:gridCol>
              </a:tblGrid>
              <a:tr h="562362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5894319"/>
                  </a:ext>
                </a:extLst>
              </a:tr>
              <a:tr h="604506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8848110"/>
                  </a:ext>
                </a:extLst>
              </a:tr>
              <a:tr h="597523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5384007"/>
                  </a:ext>
                </a:extLst>
              </a:tr>
              <a:tr h="617863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28102718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8765973"/>
                  </a:ext>
                </a:extLst>
              </a:tr>
              <a:tr h="637674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1069457"/>
                  </a:ext>
                </a:extLst>
              </a:tr>
            </a:tbl>
          </a:graphicData>
        </a:graphic>
      </p:graphicFrame>
      <p:sp>
        <p:nvSpPr>
          <p:cNvPr id="13" name="תיבת טקסט 12">
            <a:extLst>
              <a:ext uri="{FF2B5EF4-FFF2-40B4-BE49-F238E27FC236}">
                <a16:creationId xmlns:a16="http://schemas.microsoft.com/office/drawing/2014/main" id="{10084B39-BF93-0B4C-D672-02D1723073E3}"/>
              </a:ext>
            </a:extLst>
          </p:cNvPr>
          <p:cNvSpPr txBox="1"/>
          <p:nvPr/>
        </p:nvSpPr>
        <p:spPr>
          <a:xfrm>
            <a:off x="275095" y="1191439"/>
            <a:ext cx="971241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CLOCK   90-11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תיבת טקסט 13">
            <a:extLst>
              <a:ext uri="{FF2B5EF4-FFF2-40B4-BE49-F238E27FC236}">
                <a16:creationId xmlns:a16="http://schemas.microsoft.com/office/drawing/2014/main" id="{A148D558-4803-4E6A-4C0D-A61611C4CE0D}"/>
              </a:ext>
            </a:extLst>
          </p:cNvPr>
          <p:cNvSpPr txBox="1"/>
          <p:nvPr/>
        </p:nvSpPr>
        <p:spPr>
          <a:xfrm>
            <a:off x="2077541" y="536045"/>
            <a:ext cx="656718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Chow</a:t>
            </a:r>
            <a:endParaRPr lang="he-IL" sz="1600" dirty="0"/>
          </a:p>
        </p:txBody>
      </p:sp>
      <p:sp>
        <p:nvSpPr>
          <p:cNvPr id="15" name="תיבת טקסט 14">
            <a:extLst>
              <a:ext uri="{FF2B5EF4-FFF2-40B4-BE49-F238E27FC236}">
                <a16:creationId xmlns:a16="http://schemas.microsoft.com/office/drawing/2014/main" id="{8E22B857-D879-D241-DD68-2AE49A469FF4}"/>
              </a:ext>
            </a:extLst>
          </p:cNvPr>
          <p:cNvSpPr txBox="1"/>
          <p:nvPr/>
        </p:nvSpPr>
        <p:spPr>
          <a:xfrm>
            <a:off x="3590696" y="543015"/>
            <a:ext cx="1111971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 err="1"/>
              <a:t>Chow+BHB</a:t>
            </a:r>
            <a:endParaRPr lang="he-IL" sz="1600" dirty="0"/>
          </a:p>
        </p:txBody>
      </p:sp>
      <p:pic>
        <p:nvPicPr>
          <p:cNvPr id="52" name="תמונה 51">
            <a:extLst>
              <a:ext uri="{FF2B5EF4-FFF2-40B4-BE49-F238E27FC236}">
                <a16:creationId xmlns:a16="http://schemas.microsoft.com/office/drawing/2014/main" id="{8CDE9EE0-CA41-7F68-D899-A653A5C9A1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89162" y="1080299"/>
            <a:ext cx="285750" cy="180975"/>
          </a:xfrm>
          <a:prstGeom prst="rect">
            <a:avLst/>
          </a:prstGeom>
        </p:spPr>
      </p:pic>
      <p:sp>
        <p:nvSpPr>
          <p:cNvPr id="53" name="תיבת טקסט 52">
            <a:extLst>
              <a:ext uri="{FF2B5EF4-FFF2-40B4-BE49-F238E27FC236}">
                <a16:creationId xmlns:a16="http://schemas.microsoft.com/office/drawing/2014/main" id="{A8779246-1101-ACEF-38FC-2A94AFDCD7CF}"/>
              </a:ext>
            </a:extLst>
          </p:cNvPr>
          <p:cNvSpPr txBox="1"/>
          <p:nvPr/>
        </p:nvSpPr>
        <p:spPr>
          <a:xfrm>
            <a:off x="9168342" y="1035357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150 KD</a:t>
            </a:r>
            <a:endParaRPr lang="he-IL" sz="1200" dirty="0"/>
          </a:p>
        </p:txBody>
      </p:sp>
      <p:pic>
        <p:nvPicPr>
          <p:cNvPr id="54" name="תמונה 53">
            <a:extLst>
              <a:ext uri="{FF2B5EF4-FFF2-40B4-BE49-F238E27FC236}">
                <a16:creationId xmlns:a16="http://schemas.microsoft.com/office/drawing/2014/main" id="{BE8B14D5-7F92-E9C6-B04B-AB52A45F10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62753" y="2848181"/>
            <a:ext cx="361950" cy="152400"/>
          </a:xfrm>
          <a:prstGeom prst="rect">
            <a:avLst/>
          </a:prstGeom>
        </p:spPr>
      </p:pic>
      <p:sp>
        <p:nvSpPr>
          <p:cNvPr id="55" name="תיבת טקסט 54">
            <a:extLst>
              <a:ext uri="{FF2B5EF4-FFF2-40B4-BE49-F238E27FC236}">
                <a16:creationId xmlns:a16="http://schemas.microsoft.com/office/drawing/2014/main" id="{43FA4DCC-31E0-F113-B69C-C939B1412789}"/>
              </a:ext>
            </a:extLst>
          </p:cNvPr>
          <p:cNvSpPr txBox="1"/>
          <p:nvPr/>
        </p:nvSpPr>
        <p:spPr>
          <a:xfrm>
            <a:off x="9152291" y="2835734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75 KD</a:t>
            </a:r>
            <a:endParaRPr lang="he-IL" sz="1200" dirty="0"/>
          </a:p>
        </p:txBody>
      </p:sp>
      <p:pic>
        <p:nvPicPr>
          <p:cNvPr id="58" name="תמונה 57">
            <a:extLst>
              <a:ext uri="{FF2B5EF4-FFF2-40B4-BE49-F238E27FC236}">
                <a16:creationId xmlns:a16="http://schemas.microsoft.com/office/drawing/2014/main" id="{CB3F7469-FAFC-217D-D19E-6802937876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90663" y="3391526"/>
            <a:ext cx="342900" cy="171450"/>
          </a:xfrm>
          <a:prstGeom prst="rect">
            <a:avLst/>
          </a:prstGeom>
        </p:spPr>
      </p:pic>
      <p:sp>
        <p:nvSpPr>
          <p:cNvPr id="59" name="תיבת טקסט 58">
            <a:extLst>
              <a:ext uri="{FF2B5EF4-FFF2-40B4-BE49-F238E27FC236}">
                <a16:creationId xmlns:a16="http://schemas.microsoft.com/office/drawing/2014/main" id="{B88E4FDA-40FB-15EA-2598-D40993CDB69F}"/>
              </a:ext>
            </a:extLst>
          </p:cNvPr>
          <p:cNvSpPr txBox="1"/>
          <p:nvPr/>
        </p:nvSpPr>
        <p:spPr>
          <a:xfrm>
            <a:off x="9145327" y="3334440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50 KD</a:t>
            </a:r>
            <a:endParaRPr lang="he-IL" sz="1200" dirty="0"/>
          </a:p>
        </p:txBody>
      </p:sp>
      <p:pic>
        <p:nvPicPr>
          <p:cNvPr id="60" name="תמונה 59">
            <a:extLst>
              <a:ext uri="{FF2B5EF4-FFF2-40B4-BE49-F238E27FC236}">
                <a16:creationId xmlns:a16="http://schemas.microsoft.com/office/drawing/2014/main" id="{22B964ED-D404-ECF2-9BD5-A1E53C7FE1A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71918" y="4089440"/>
            <a:ext cx="314325" cy="161925"/>
          </a:xfrm>
          <a:prstGeom prst="rect">
            <a:avLst/>
          </a:prstGeom>
        </p:spPr>
      </p:pic>
      <p:sp>
        <p:nvSpPr>
          <p:cNvPr id="61" name="תיבת טקסט 60">
            <a:extLst>
              <a:ext uri="{FF2B5EF4-FFF2-40B4-BE49-F238E27FC236}">
                <a16:creationId xmlns:a16="http://schemas.microsoft.com/office/drawing/2014/main" id="{82C0C43A-C2A4-882F-9132-0BE298F81047}"/>
              </a:ext>
            </a:extLst>
          </p:cNvPr>
          <p:cNvSpPr txBox="1"/>
          <p:nvPr/>
        </p:nvSpPr>
        <p:spPr>
          <a:xfrm>
            <a:off x="9141315" y="4010903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37 KD</a:t>
            </a:r>
            <a:endParaRPr lang="he-IL" sz="1200" dirty="0"/>
          </a:p>
        </p:txBody>
      </p:sp>
      <p:sp>
        <p:nvSpPr>
          <p:cNvPr id="74" name="תיבת טקסט 73">
            <a:extLst>
              <a:ext uri="{FF2B5EF4-FFF2-40B4-BE49-F238E27FC236}">
                <a16:creationId xmlns:a16="http://schemas.microsoft.com/office/drawing/2014/main" id="{91B1BEED-6FA7-0927-1357-5075D6D3EC72}"/>
              </a:ext>
            </a:extLst>
          </p:cNvPr>
          <p:cNvSpPr txBox="1"/>
          <p:nvPr/>
        </p:nvSpPr>
        <p:spPr>
          <a:xfrm>
            <a:off x="267075" y="1789001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BMALL 78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5" name="תיבת טקסט 74">
            <a:extLst>
              <a:ext uri="{FF2B5EF4-FFF2-40B4-BE49-F238E27FC236}">
                <a16:creationId xmlns:a16="http://schemas.microsoft.com/office/drawing/2014/main" id="{00A37420-FBAE-525A-18E0-A53BFCFEEDA9}"/>
              </a:ext>
            </a:extLst>
          </p:cNvPr>
          <p:cNvSpPr txBox="1"/>
          <p:nvPr/>
        </p:nvSpPr>
        <p:spPr>
          <a:xfrm>
            <a:off x="259055" y="2386573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BMALL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78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3" name="TextBox 66">
            <a:extLst>
              <a:ext uri="{FF2B5EF4-FFF2-40B4-BE49-F238E27FC236}">
                <a16:creationId xmlns:a16="http://schemas.microsoft.com/office/drawing/2014/main" id="{0B557832-60B7-B090-7FF9-5DBC777DA6E9}"/>
              </a:ext>
            </a:extLst>
          </p:cNvPr>
          <p:cNvSpPr txBox="1"/>
          <p:nvPr/>
        </p:nvSpPr>
        <p:spPr>
          <a:xfrm>
            <a:off x="-10732" y="2814"/>
            <a:ext cx="20780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. S4</a:t>
            </a:r>
          </a:p>
        </p:txBody>
      </p:sp>
      <p:sp>
        <p:nvSpPr>
          <p:cNvPr id="144" name="Rectangle 1">
            <a:extLst>
              <a:ext uri="{FF2B5EF4-FFF2-40B4-BE49-F238E27FC236}">
                <a16:creationId xmlns:a16="http://schemas.microsoft.com/office/drawing/2014/main" id="{33023028-B64F-BC1F-3D8C-541D342F58BA}"/>
              </a:ext>
            </a:extLst>
          </p:cNvPr>
          <p:cNvSpPr/>
          <p:nvPr/>
        </p:nvSpPr>
        <p:spPr>
          <a:xfrm>
            <a:off x="127735" y="4594836"/>
            <a:ext cx="9834414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S4: Western blot protein analysis of the </a:t>
            </a:r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effect of HF and BHB supplementation on the circadian clock in liver tissue.</a:t>
            </a:r>
          </a:p>
          <a:p>
            <a:pPr algn="ctr"/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6" name="קבוצה 5">
            <a:extLst>
              <a:ext uri="{FF2B5EF4-FFF2-40B4-BE49-F238E27FC236}">
                <a16:creationId xmlns:a16="http://schemas.microsoft.com/office/drawing/2014/main" id="{4AFD568D-41C8-4AAE-9C08-0407F9153474}"/>
              </a:ext>
            </a:extLst>
          </p:cNvPr>
          <p:cNvGrpSpPr/>
          <p:nvPr/>
        </p:nvGrpSpPr>
        <p:grpSpPr>
          <a:xfrm>
            <a:off x="1709581" y="822715"/>
            <a:ext cx="1367729" cy="329471"/>
            <a:chOff x="1709581" y="1009697"/>
            <a:chExt cx="1367729" cy="329471"/>
          </a:xfrm>
        </p:grpSpPr>
        <p:sp>
          <p:nvSpPr>
            <p:cNvPr id="133" name="סוגר מרובע ימני 132">
              <a:extLst>
                <a:ext uri="{FF2B5EF4-FFF2-40B4-BE49-F238E27FC236}">
                  <a16:creationId xmlns:a16="http://schemas.microsoft.com/office/drawing/2014/main" id="{B9467D85-7C62-837F-2A06-957E29059C2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97" name="TextBox 64">
              <a:extLst>
                <a:ext uri="{FF2B5EF4-FFF2-40B4-BE49-F238E27FC236}">
                  <a16:creationId xmlns:a16="http://schemas.microsoft.com/office/drawing/2014/main" id="{AA912D09-30B1-E356-7B4F-06293C79B1D6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98" name="TextBox 65">
              <a:extLst>
                <a:ext uri="{FF2B5EF4-FFF2-40B4-BE49-F238E27FC236}">
                  <a16:creationId xmlns:a16="http://schemas.microsoft.com/office/drawing/2014/main" id="{A20BC556-D3BC-7379-0531-5B4A8F52A7E6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99" name="TextBox 66">
              <a:extLst>
                <a:ext uri="{FF2B5EF4-FFF2-40B4-BE49-F238E27FC236}">
                  <a16:creationId xmlns:a16="http://schemas.microsoft.com/office/drawing/2014/main" id="{0B83B336-88AD-24DD-C3E1-540421E857AE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00" name="TextBox 67">
              <a:extLst>
                <a:ext uri="{FF2B5EF4-FFF2-40B4-BE49-F238E27FC236}">
                  <a16:creationId xmlns:a16="http://schemas.microsoft.com/office/drawing/2014/main" id="{0099CB3B-5887-94B5-417C-DE4A1F1639E9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01" name="TextBox 68">
              <a:extLst>
                <a:ext uri="{FF2B5EF4-FFF2-40B4-BE49-F238E27FC236}">
                  <a16:creationId xmlns:a16="http://schemas.microsoft.com/office/drawing/2014/main" id="{DAAA0074-528E-8F9E-4979-1323FF279B2E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84" name="TextBox 68">
            <a:extLst>
              <a:ext uri="{FF2B5EF4-FFF2-40B4-BE49-F238E27FC236}">
                <a16:creationId xmlns:a16="http://schemas.microsoft.com/office/drawing/2014/main" id="{059F3F98-4615-47B4-8364-1C126FC84F9D}"/>
              </a:ext>
            </a:extLst>
          </p:cNvPr>
          <p:cNvSpPr txBox="1"/>
          <p:nvPr/>
        </p:nvSpPr>
        <p:spPr>
          <a:xfrm>
            <a:off x="2890382" y="877097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grpSp>
        <p:nvGrpSpPr>
          <p:cNvPr id="104" name="קבוצה 103">
            <a:extLst>
              <a:ext uri="{FF2B5EF4-FFF2-40B4-BE49-F238E27FC236}">
                <a16:creationId xmlns:a16="http://schemas.microsoft.com/office/drawing/2014/main" id="{9EFA4827-C724-44BF-B18A-473DBE8EF8CF}"/>
              </a:ext>
            </a:extLst>
          </p:cNvPr>
          <p:cNvGrpSpPr/>
          <p:nvPr/>
        </p:nvGrpSpPr>
        <p:grpSpPr>
          <a:xfrm>
            <a:off x="3464317" y="825620"/>
            <a:ext cx="1367729" cy="329471"/>
            <a:chOff x="1709581" y="1009697"/>
            <a:chExt cx="1367729" cy="329471"/>
          </a:xfrm>
        </p:grpSpPr>
        <p:sp>
          <p:nvSpPr>
            <p:cNvPr id="105" name="סוגר מרובע ימני 104">
              <a:extLst>
                <a:ext uri="{FF2B5EF4-FFF2-40B4-BE49-F238E27FC236}">
                  <a16:creationId xmlns:a16="http://schemas.microsoft.com/office/drawing/2014/main" id="{BDED5688-72A1-4B2A-AA2A-3CBA0A79E27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06" name="TextBox 64">
              <a:extLst>
                <a:ext uri="{FF2B5EF4-FFF2-40B4-BE49-F238E27FC236}">
                  <a16:creationId xmlns:a16="http://schemas.microsoft.com/office/drawing/2014/main" id="{28BF52E6-BA50-487C-ACA5-6982911FAA0C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07" name="TextBox 65">
              <a:extLst>
                <a:ext uri="{FF2B5EF4-FFF2-40B4-BE49-F238E27FC236}">
                  <a16:creationId xmlns:a16="http://schemas.microsoft.com/office/drawing/2014/main" id="{FFBD7BED-404E-45F4-A258-952F5CD7E222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08" name="TextBox 66">
              <a:extLst>
                <a:ext uri="{FF2B5EF4-FFF2-40B4-BE49-F238E27FC236}">
                  <a16:creationId xmlns:a16="http://schemas.microsoft.com/office/drawing/2014/main" id="{FC9843A3-53C7-4FAA-B4B3-1F0EE56C25B7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09" name="TextBox 67">
              <a:extLst>
                <a:ext uri="{FF2B5EF4-FFF2-40B4-BE49-F238E27FC236}">
                  <a16:creationId xmlns:a16="http://schemas.microsoft.com/office/drawing/2014/main" id="{1B859FF9-24F4-458D-8A53-E997FC5B7F0E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10" name="TextBox 68">
              <a:extLst>
                <a:ext uri="{FF2B5EF4-FFF2-40B4-BE49-F238E27FC236}">
                  <a16:creationId xmlns:a16="http://schemas.microsoft.com/office/drawing/2014/main" id="{3BE4D8CB-9E84-42AD-8179-9C7C0602D6F1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11" name="TextBox 68">
            <a:extLst>
              <a:ext uri="{FF2B5EF4-FFF2-40B4-BE49-F238E27FC236}">
                <a16:creationId xmlns:a16="http://schemas.microsoft.com/office/drawing/2014/main" id="{212134D3-F29F-48F4-83F9-FD1A955BC73A}"/>
              </a:ext>
            </a:extLst>
          </p:cNvPr>
          <p:cNvSpPr txBox="1"/>
          <p:nvPr/>
        </p:nvSpPr>
        <p:spPr>
          <a:xfrm>
            <a:off x="4631437" y="880429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sp>
        <p:nvSpPr>
          <p:cNvPr id="112" name="תיבת טקסט 13">
            <a:extLst>
              <a:ext uri="{FF2B5EF4-FFF2-40B4-BE49-F238E27FC236}">
                <a16:creationId xmlns:a16="http://schemas.microsoft.com/office/drawing/2014/main" id="{B27A25D1-B7A9-4B6D-A3A0-173CDAABF010}"/>
              </a:ext>
            </a:extLst>
          </p:cNvPr>
          <p:cNvSpPr txBox="1"/>
          <p:nvPr/>
        </p:nvSpPr>
        <p:spPr>
          <a:xfrm>
            <a:off x="5842567" y="538545"/>
            <a:ext cx="407484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HF</a:t>
            </a:r>
            <a:endParaRPr lang="he-IL" sz="1600" dirty="0"/>
          </a:p>
        </p:txBody>
      </p:sp>
      <p:sp>
        <p:nvSpPr>
          <p:cNvPr id="113" name="תיבת טקסט 14">
            <a:extLst>
              <a:ext uri="{FF2B5EF4-FFF2-40B4-BE49-F238E27FC236}">
                <a16:creationId xmlns:a16="http://schemas.microsoft.com/office/drawing/2014/main" id="{4C13841B-9DC1-4201-A63D-F5355298E5B9}"/>
              </a:ext>
            </a:extLst>
          </p:cNvPr>
          <p:cNvSpPr txBox="1"/>
          <p:nvPr/>
        </p:nvSpPr>
        <p:spPr>
          <a:xfrm>
            <a:off x="7355722" y="545515"/>
            <a:ext cx="862737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HF+BHB</a:t>
            </a:r>
            <a:endParaRPr lang="he-IL" sz="1600" dirty="0"/>
          </a:p>
        </p:txBody>
      </p:sp>
      <p:grpSp>
        <p:nvGrpSpPr>
          <p:cNvPr id="114" name="קבוצה 113">
            <a:extLst>
              <a:ext uri="{FF2B5EF4-FFF2-40B4-BE49-F238E27FC236}">
                <a16:creationId xmlns:a16="http://schemas.microsoft.com/office/drawing/2014/main" id="{8181050A-528A-40E5-9454-114F8D16F038}"/>
              </a:ext>
            </a:extLst>
          </p:cNvPr>
          <p:cNvGrpSpPr/>
          <p:nvPr/>
        </p:nvGrpSpPr>
        <p:grpSpPr>
          <a:xfrm>
            <a:off x="5474607" y="825215"/>
            <a:ext cx="1367729" cy="329471"/>
            <a:chOff x="1709581" y="1009697"/>
            <a:chExt cx="1367729" cy="329471"/>
          </a:xfrm>
        </p:grpSpPr>
        <p:sp>
          <p:nvSpPr>
            <p:cNvPr id="137" name="סוגר מרובע ימני 136">
              <a:extLst>
                <a:ext uri="{FF2B5EF4-FFF2-40B4-BE49-F238E27FC236}">
                  <a16:creationId xmlns:a16="http://schemas.microsoft.com/office/drawing/2014/main" id="{392BA01C-5A4F-4E30-8375-892DADCD1EB3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39" name="TextBox 64">
              <a:extLst>
                <a:ext uri="{FF2B5EF4-FFF2-40B4-BE49-F238E27FC236}">
                  <a16:creationId xmlns:a16="http://schemas.microsoft.com/office/drawing/2014/main" id="{5CA97C4B-4E4F-4350-885F-70BA4A65C1DE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41" name="TextBox 65">
              <a:extLst>
                <a:ext uri="{FF2B5EF4-FFF2-40B4-BE49-F238E27FC236}">
                  <a16:creationId xmlns:a16="http://schemas.microsoft.com/office/drawing/2014/main" id="{910161C2-EB0C-4D02-962D-BA04D3697E41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45" name="TextBox 66">
              <a:extLst>
                <a:ext uri="{FF2B5EF4-FFF2-40B4-BE49-F238E27FC236}">
                  <a16:creationId xmlns:a16="http://schemas.microsoft.com/office/drawing/2014/main" id="{069F509B-4416-4CEC-A09D-9613C304B507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46" name="TextBox 67">
              <a:extLst>
                <a:ext uri="{FF2B5EF4-FFF2-40B4-BE49-F238E27FC236}">
                  <a16:creationId xmlns:a16="http://schemas.microsoft.com/office/drawing/2014/main" id="{D1A0B974-A9F6-4CFD-8143-8E8AC797A7A8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47" name="TextBox 68">
              <a:extLst>
                <a:ext uri="{FF2B5EF4-FFF2-40B4-BE49-F238E27FC236}">
                  <a16:creationId xmlns:a16="http://schemas.microsoft.com/office/drawing/2014/main" id="{74983962-1DF6-468A-9D7C-787E0E0D3F64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48" name="TextBox 68">
            <a:extLst>
              <a:ext uri="{FF2B5EF4-FFF2-40B4-BE49-F238E27FC236}">
                <a16:creationId xmlns:a16="http://schemas.microsoft.com/office/drawing/2014/main" id="{A21AB5A2-F4AA-4EA7-8209-B78CB1D8CCFB}"/>
              </a:ext>
            </a:extLst>
          </p:cNvPr>
          <p:cNvSpPr txBox="1"/>
          <p:nvPr/>
        </p:nvSpPr>
        <p:spPr>
          <a:xfrm>
            <a:off x="6655408" y="879597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grpSp>
        <p:nvGrpSpPr>
          <p:cNvPr id="149" name="קבוצה 148">
            <a:extLst>
              <a:ext uri="{FF2B5EF4-FFF2-40B4-BE49-F238E27FC236}">
                <a16:creationId xmlns:a16="http://schemas.microsoft.com/office/drawing/2014/main" id="{CCC49AA6-3540-41C4-80A0-D9170B688B5D}"/>
              </a:ext>
            </a:extLst>
          </p:cNvPr>
          <p:cNvGrpSpPr/>
          <p:nvPr/>
        </p:nvGrpSpPr>
        <p:grpSpPr>
          <a:xfrm>
            <a:off x="7229343" y="828120"/>
            <a:ext cx="1367729" cy="329471"/>
            <a:chOff x="1709581" y="1009697"/>
            <a:chExt cx="1367729" cy="329471"/>
          </a:xfrm>
        </p:grpSpPr>
        <p:sp>
          <p:nvSpPr>
            <p:cNvPr id="150" name="סוגר מרובע ימני 149">
              <a:extLst>
                <a:ext uri="{FF2B5EF4-FFF2-40B4-BE49-F238E27FC236}">
                  <a16:creationId xmlns:a16="http://schemas.microsoft.com/office/drawing/2014/main" id="{B9AD1C17-2C9C-4AF8-BEC7-72259B00F17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51" name="TextBox 64">
              <a:extLst>
                <a:ext uri="{FF2B5EF4-FFF2-40B4-BE49-F238E27FC236}">
                  <a16:creationId xmlns:a16="http://schemas.microsoft.com/office/drawing/2014/main" id="{4700D035-9DCE-405D-B9F2-C115B053D1EB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52" name="TextBox 65">
              <a:extLst>
                <a:ext uri="{FF2B5EF4-FFF2-40B4-BE49-F238E27FC236}">
                  <a16:creationId xmlns:a16="http://schemas.microsoft.com/office/drawing/2014/main" id="{27E089C8-3DB8-4806-8E41-986703E9923A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53" name="TextBox 66">
              <a:extLst>
                <a:ext uri="{FF2B5EF4-FFF2-40B4-BE49-F238E27FC236}">
                  <a16:creationId xmlns:a16="http://schemas.microsoft.com/office/drawing/2014/main" id="{BAD3E3FC-9994-4FF6-86D0-66A1EC6D49AD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54" name="TextBox 67">
              <a:extLst>
                <a:ext uri="{FF2B5EF4-FFF2-40B4-BE49-F238E27FC236}">
                  <a16:creationId xmlns:a16="http://schemas.microsoft.com/office/drawing/2014/main" id="{17A5D0ED-7B6B-419B-B914-2A242B34BD34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55" name="TextBox 68">
              <a:extLst>
                <a:ext uri="{FF2B5EF4-FFF2-40B4-BE49-F238E27FC236}">
                  <a16:creationId xmlns:a16="http://schemas.microsoft.com/office/drawing/2014/main" id="{18B500CA-3022-4D90-9C4B-E3B87E4FB031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56" name="TextBox 68">
            <a:extLst>
              <a:ext uri="{FF2B5EF4-FFF2-40B4-BE49-F238E27FC236}">
                <a16:creationId xmlns:a16="http://schemas.microsoft.com/office/drawing/2014/main" id="{BE1723CA-D04E-49D0-AD3D-B510BC00B2A8}"/>
              </a:ext>
            </a:extLst>
          </p:cNvPr>
          <p:cNvSpPr txBox="1"/>
          <p:nvPr/>
        </p:nvSpPr>
        <p:spPr>
          <a:xfrm>
            <a:off x="8396463" y="882929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pic>
        <p:nvPicPr>
          <p:cNvPr id="72" name="תמונה 71">
            <a:extLst>
              <a:ext uri="{FF2B5EF4-FFF2-40B4-BE49-F238E27FC236}">
                <a16:creationId xmlns:a16="http://schemas.microsoft.com/office/drawing/2014/main" id="{3D14EB1E-D1BE-4BFC-A533-61AA75834B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94574" y="1594810"/>
            <a:ext cx="304800" cy="152400"/>
          </a:xfrm>
          <a:prstGeom prst="rect">
            <a:avLst/>
          </a:prstGeom>
        </p:spPr>
      </p:pic>
      <p:sp>
        <p:nvSpPr>
          <p:cNvPr id="73" name="תיבת טקסט 53">
            <a:extLst>
              <a:ext uri="{FF2B5EF4-FFF2-40B4-BE49-F238E27FC236}">
                <a16:creationId xmlns:a16="http://schemas.microsoft.com/office/drawing/2014/main" id="{E8EC8839-AA36-4873-8D22-0999BD495BF5}"/>
              </a:ext>
            </a:extLst>
          </p:cNvPr>
          <p:cNvSpPr txBox="1"/>
          <p:nvPr/>
        </p:nvSpPr>
        <p:spPr>
          <a:xfrm>
            <a:off x="9179316" y="1518345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100 KD</a:t>
            </a:r>
            <a:endParaRPr lang="he-IL" sz="12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48526" y="1291762"/>
            <a:ext cx="3651821" cy="274344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079589" y="1832288"/>
            <a:ext cx="3706689" cy="30482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85105" y="2481491"/>
            <a:ext cx="3578662" cy="292633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079198" y="2974233"/>
            <a:ext cx="3731075" cy="37798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088733" y="3705742"/>
            <a:ext cx="3688400" cy="274344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445080" y="1301350"/>
            <a:ext cx="3535986" cy="19508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438983" y="1774286"/>
            <a:ext cx="3548180" cy="29873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452713" y="2430116"/>
            <a:ext cx="3529890" cy="396274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452713" y="3025682"/>
            <a:ext cx="3548180" cy="341406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452713" y="3679119"/>
            <a:ext cx="3548180" cy="262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19938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1" name="Chart 150">
            <a:extLst>
              <a:ext uri="{FF2B5EF4-FFF2-40B4-BE49-F238E27FC236}">
                <a16:creationId xmlns:a16="http://schemas.microsoft.com/office/drawing/2014/main" id="{00000000-0008-0000-07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8387"/>
              </p:ext>
            </p:extLst>
          </p:nvPr>
        </p:nvGraphicFramePr>
        <p:xfrm>
          <a:off x="782764" y="3387634"/>
          <a:ext cx="2761051" cy="20102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" name="Rectangle 17"/>
          <p:cNvSpPr/>
          <p:nvPr/>
        </p:nvSpPr>
        <p:spPr>
          <a:xfrm rot="16200000">
            <a:off x="-324297" y="4223677"/>
            <a:ext cx="2122184" cy="31781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iver </a:t>
            </a:r>
            <a:r>
              <a:rPr lang="en-US" i="1" dirty="0"/>
              <a:t>Per1</a:t>
            </a:r>
            <a:r>
              <a:rPr lang="en-US" dirty="0"/>
              <a:t> relative mRNA levels</a:t>
            </a:r>
          </a:p>
        </p:txBody>
      </p:sp>
      <p:graphicFrame>
        <p:nvGraphicFramePr>
          <p:cNvPr id="133" name="Chart 132">
            <a:extLst>
              <a:ext uri="{FF2B5EF4-FFF2-40B4-BE49-F238E27FC236}">
                <a16:creationId xmlns:a16="http://schemas.microsoft.com/office/drawing/2014/main" id="{00000000-0008-0000-05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6202875"/>
              </p:ext>
            </p:extLst>
          </p:nvPr>
        </p:nvGraphicFramePr>
        <p:xfrm>
          <a:off x="6908522" y="775322"/>
          <a:ext cx="2759861" cy="19848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5" name="Rectangle 14"/>
          <p:cNvSpPr/>
          <p:nvPr/>
        </p:nvSpPr>
        <p:spPr>
          <a:xfrm rot="16200000">
            <a:off x="5807459" y="1580530"/>
            <a:ext cx="211961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iver </a:t>
            </a:r>
            <a:r>
              <a:rPr lang="en-US" i="1" dirty="0"/>
              <a:t>Cry1</a:t>
            </a:r>
            <a:r>
              <a:rPr lang="en-US" dirty="0"/>
              <a:t> relative mRNA levels</a:t>
            </a:r>
          </a:p>
        </p:txBody>
      </p:sp>
      <p:graphicFrame>
        <p:nvGraphicFramePr>
          <p:cNvPr id="72" name="Chart 71">
            <a:extLst>
              <a:ext uri="{FF2B5EF4-FFF2-40B4-BE49-F238E27FC236}">
                <a16:creationId xmlns:a16="http://schemas.microsoft.com/office/drawing/2014/main" id="{00000000-0008-0000-03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4083977"/>
              </p:ext>
            </p:extLst>
          </p:nvPr>
        </p:nvGraphicFramePr>
        <p:xfrm>
          <a:off x="3952938" y="821098"/>
          <a:ext cx="2671662" cy="1933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Rectangle 11"/>
          <p:cNvSpPr/>
          <p:nvPr/>
        </p:nvSpPr>
        <p:spPr>
          <a:xfrm rot="16200000">
            <a:off x="2704099" y="1573192"/>
            <a:ext cx="21525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iver </a:t>
            </a:r>
            <a:r>
              <a:rPr lang="en-US" i="1" dirty="0" err="1"/>
              <a:t>Bmal</a:t>
            </a:r>
            <a:r>
              <a:rPr lang="en-US" dirty="0"/>
              <a:t> relative mRNA levels</a:t>
            </a:r>
          </a:p>
        </p:txBody>
      </p:sp>
      <p:graphicFrame>
        <p:nvGraphicFramePr>
          <p:cNvPr id="47" name="Chart 46">
            <a:extLst>
              <a:ext uri="{FF2B5EF4-FFF2-40B4-BE49-F238E27FC236}">
                <a16:creationId xmlns:a16="http://schemas.microsoft.com/office/drawing/2014/main" id="{00000000-0008-0000-01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2485516"/>
              </p:ext>
            </p:extLst>
          </p:nvPr>
        </p:nvGraphicFramePr>
        <p:xfrm>
          <a:off x="880253" y="826570"/>
          <a:ext cx="2663562" cy="1928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" name="Rectangle 7"/>
          <p:cNvSpPr/>
          <p:nvPr/>
        </p:nvSpPr>
        <p:spPr>
          <a:xfrm rot="16200000">
            <a:off x="-381520" y="1556467"/>
            <a:ext cx="21717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iver </a:t>
            </a:r>
            <a:r>
              <a:rPr lang="en-US" i="1" dirty="0"/>
              <a:t>Clock</a:t>
            </a:r>
            <a:r>
              <a:rPr lang="en-US" dirty="0"/>
              <a:t> relative mRNA levels</a:t>
            </a:r>
          </a:p>
        </p:txBody>
      </p:sp>
      <p:sp>
        <p:nvSpPr>
          <p:cNvPr id="270" name="תיבת טקסט 491">
            <a:extLst>
              <a:ext uri="{FF2B5EF4-FFF2-40B4-BE49-F238E27FC236}">
                <a16:creationId xmlns:a16="http://schemas.microsoft.com/office/drawing/2014/main" id="{47389762-A129-E102-990C-EC1C691C09A3}"/>
              </a:ext>
            </a:extLst>
          </p:cNvPr>
          <p:cNvSpPr txBox="1"/>
          <p:nvPr/>
        </p:nvSpPr>
        <p:spPr>
          <a:xfrm>
            <a:off x="6870260" y="533484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0" y="-540588"/>
            <a:ext cx="3341043" cy="899646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1754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559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754" b="1" dirty="0"/>
              <a:t>Supplementary Fig. S5</a:t>
            </a:r>
            <a:endParaRPr lang="en-US" sz="1754" dirty="0"/>
          </a:p>
        </p:txBody>
      </p:sp>
      <p:sp>
        <p:nvSpPr>
          <p:cNvPr id="251" name="תיבת טקסט 489">
            <a:extLst>
              <a:ext uri="{FF2B5EF4-FFF2-40B4-BE49-F238E27FC236}">
                <a16:creationId xmlns:a16="http://schemas.microsoft.com/office/drawing/2014/main" id="{5E95261A-7113-8B35-1C16-56FFA9CC0336}"/>
              </a:ext>
            </a:extLst>
          </p:cNvPr>
          <p:cNvSpPr txBox="1"/>
          <p:nvPr/>
        </p:nvSpPr>
        <p:spPr>
          <a:xfrm>
            <a:off x="799715" y="540031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2" name="תיבת טקסט 490">
            <a:extLst>
              <a:ext uri="{FF2B5EF4-FFF2-40B4-BE49-F238E27FC236}">
                <a16:creationId xmlns:a16="http://schemas.microsoft.com/office/drawing/2014/main" id="{CCAC697B-8A27-0317-E8AF-064DF803C36A}"/>
              </a:ext>
            </a:extLst>
          </p:cNvPr>
          <p:cNvSpPr txBox="1"/>
          <p:nvPr/>
        </p:nvSpPr>
        <p:spPr>
          <a:xfrm>
            <a:off x="3864102" y="547001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9" name="תיבת טקסט 491">
            <a:extLst>
              <a:ext uri="{FF2B5EF4-FFF2-40B4-BE49-F238E27FC236}">
                <a16:creationId xmlns:a16="http://schemas.microsoft.com/office/drawing/2014/main" id="{47389762-A129-E102-990C-EC1C691C09A3}"/>
              </a:ext>
            </a:extLst>
          </p:cNvPr>
          <p:cNvSpPr txBox="1"/>
          <p:nvPr/>
        </p:nvSpPr>
        <p:spPr>
          <a:xfrm>
            <a:off x="6872760" y="3143071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>
                <a:latin typeface="Calibri" panose="020F0502020204030204" pitchFamily="34" charset="0"/>
                <a:cs typeface="Calibri" panose="020F0502020204030204" pitchFamily="34" charset="0"/>
              </a:rPr>
              <a:t>F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0" name="תיבת טקסט 489">
            <a:extLst>
              <a:ext uri="{FF2B5EF4-FFF2-40B4-BE49-F238E27FC236}">
                <a16:creationId xmlns:a16="http://schemas.microsoft.com/office/drawing/2014/main" id="{5E95261A-7113-8B35-1C16-56FFA9CC0336}"/>
              </a:ext>
            </a:extLst>
          </p:cNvPr>
          <p:cNvSpPr txBox="1"/>
          <p:nvPr/>
        </p:nvSpPr>
        <p:spPr>
          <a:xfrm>
            <a:off x="802215" y="3149618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1" name="תיבת טקסט 490">
            <a:extLst>
              <a:ext uri="{FF2B5EF4-FFF2-40B4-BE49-F238E27FC236}">
                <a16:creationId xmlns:a16="http://schemas.microsoft.com/office/drawing/2014/main" id="{CCAC697B-8A27-0317-E8AF-064DF803C36A}"/>
              </a:ext>
            </a:extLst>
          </p:cNvPr>
          <p:cNvSpPr txBox="1"/>
          <p:nvPr/>
        </p:nvSpPr>
        <p:spPr>
          <a:xfrm>
            <a:off x="3866602" y="3156588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>
                <a:latin typeface="Calibri" panose="020F0502020204030204" pitchFamily="34" charset="0"/>
                <a:cs typeface="Calibri" panose="020F0502020204030204" pitchFamily="34" charset="0"/>
              </a:rPr>
              <a:t>E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816264" y="2774065"/>
            <a:ext cx="2696694" cy="194217"/>
            <a:chOff x="649518" y="2723874"/>
            <a:chExt cx="2696694" cy="194217"/>
          </a:xfrm>
        </p:grpSpPr>
        <p:sp>
          <p:nvSpPr>
            <p:cNvPr id="51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2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3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4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5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6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7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8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9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0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1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2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3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4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5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7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02" name="Group 101"/>
          <p:cNvGrpSpPr/>
          <p:nvPr/>
        </p:nvGrpSpPr>
        <p:grpSpPr>
          <a:xfrm>
            <a:off x="3904722" y="2770052"/>
            <a:ext cx="2696694" cy="194217"/>
            <a:chOff x="649518" y="2723874"/>
            <a:chExt cx="2696694" cy="194217"/>
          </a:xfrm>
        </p:grpSpPr>
        <p:sp>
          <p:nvSpPr>
            <p:cNvPr id="117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8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9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0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1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2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3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4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5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6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7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8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9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0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1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2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34" name="Group 133"/>
          <p:cNvGrpSpPr/>
          <p:nvPr/>
        </p:nvGrpSpPr>
        <p:grpSpPr>
          <a:xfrm>
            <a:off x="6960865" y="2778068"/>
            <a:ext cx="2696694" cy="194217"/>
            <a:chOff x="649518" y="2723874"/>
            <a:chExt cx="2696694" cy="194217"/>
          </a:xfrm>
        </p:grpSpPr>
        <p:sp>
          <p:nvSpPr>
            <p:cNvPr id="135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6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7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8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9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0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1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2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3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4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5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6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7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8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9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0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52" name="Group 151"/>
          <p:cNvGrpSpPr/>
          <p:nvPr/>
        </p:nvGrpSpPr>
        <p:grpSpPr>
          <a:xfrm>
            <a:off x="812248" y="5417008"/>
            <a:ext cx="2696694" cy="194217"/>
            <a:chOff x="649518" y="2723874"/>
            <a:chExt cx="2696694" cy="194217"/>
          </a:xfrm>
        </p:grpSpPr>
        <p:sp>
          <p:nvSpPr>
            <p:cNvPr id="153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4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5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6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7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8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9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0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1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2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3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4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5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6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7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8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69" name="Group 168"/>
          <p:cNvGrpSpPr/>
          <p:nvPr/>
        </p:nvGrpSpPr>
        <p:grpSpPr>
          <a:xfrm>
            <a:off x="3900706" y="5412995"/>
            <a:ext cx="2696694" cy="194217"/>
            <a:chOff x="649518" y="2723874"/>
            <a:chExt cx="2696694" cy="194217"/>
          </a:xfrm>
        </p:grpSpPr>
        <p:sp>
          <p:nvSpPr>
            <p:cNvPr id="170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1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2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3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4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5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6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7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8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9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0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1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2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3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4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5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86" name="Group 185"/>
          <p:cNvGrpSpPr/>
          <p:nvPr/>
        </p:nvGrpSpPr>
        <p:grpSpPr>
          <a:xfrm>
            <a:off x="6956849" y="5421011"/>
            <a:ext cx="2696694" cy="194217"/>
            <a:chOff x="649518" y="2723874"/>
            <a:chExt cx="2696694" cy="194217"/>
          </a:xfrm>
        </p:grpSpPr>
        <p:sp>
          <p:nvSpPr>
            <p:cNvPr id="187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8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9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0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1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2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3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4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5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6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7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8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9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0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1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2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aphicFrame>
        <p:nvGraphicFramePr>
          <p:cNvPr id="203" name="Chart 202">
            <a:extLst>
              <a:ext uri="{FF2B5EF4-FFF2-40B4-BE49-F238E27FC236}">
                <a16:creationId xmlns:a16="http://schemas.microsoft.com/office/drawing/2014/main" id="{00000000-0008-0000-09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75311591"/>
              </p:ext>
            </p:extLst>
          </p:nvPr>
        </p:nvGraphicFramePr>
        <p:xfrm>
          <a:off x="3950401" y="3387634"/>
          <a:ext cx="2674199" cy="20029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2" name="Rectangle 21"/>
          <p:cNvSpPr/>
          <p:nvPr/>
        </p:nvSpPr>
        <p:spPr>
          <a:xfrm rot="16200000">
            <a:off x="2718409" y="4215140"/>
            <a:ext cx="2146164" cy="31781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iver</a:t>
            </a:r>
            <a:r>
              <a:rPr lang="he-IL" dirty="0"/>
              <a:t> </a:t>
            </a:r>
            <a:r>
              <a:rPr lang="en-US" i="1" dirty="0" err="1"/>
              <a:t>Ror</a:t>
            </a:r>
            <a:r>
              <a:rPr lang="el-GR" i="1" dirty="0"/>
              <a:t>α</a:t>
            </a:r>
            <a:r>
              <a:rPr lang="en-US" i="1" dirty="0"/>
              <a:t> </a:t>
            </a:r>
            <a:r>
              <a:rPr lang="en-US" dirty="0"/>
              <a:t>relative mRNA levels</a:t>
            </a:r>
          </a:p>
        </p:txBody>
      </p:sp>
      <p:graphicFrame>
        <p:nvGraphicFramePr>
          <p:cNvPr id="204" name="Chart 203">
            <a:extLst>
              <a:ext uri="{FF2B5EF4-FFF2-40B4-BE49-F238E27FC236}">
                <a16:creationId xmlns:a16="http://schemas.microsoft.com/office/drawing/2014/main" id="{00000000-0008-0000-0B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7626211"/>
              </p:ext>
            </p:extLst>
          </p:nvPr>
        </p:nvGraphicFramePr>
        <p:xfrm>
          <a:off x="7027954" y="3387635"/>
          <a:ext cx="2640429" cy="20102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4" name="Rectangle 23"/>
          <p:cNvSpPr/>
          <p:nvPr/>
        </p:nvSpPr>
        <p:spPr>
          <a:xfrm rot="16200000">
            <a:off x="5710957" y="4161011"/>
            <a:ext cx="22790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iver</a:t>
            </a:r>
            <a:r>
              <a:rPr lang="he-IL" dirty="0"/>
              <a:t> </a:t>
            </a:r>
            <a:r>
              <a:rPr lang="en-US" i="1" dirty="0"/>
              <a:t>Reverb</a:t>
            </a:r>
            <a:r>
              <a:rPr lang="en-US" dirty="0"/>
              <a:t> relative mRNA levels</a:t>
            </a:r>
          </a:p>
        </p:txBody>
      </p:sp>
      <p:sp>
        <p:nvSpPr>
          <p:cNvPr id="3" name="Rectangle 2"/>
          <p:cNvSpPr/>
          <p:nvPr/>
        </p:nvSpPr>
        <p:spPr>
          <a:xfrm>
            <a:off x="296474" y="6837907"/>
            <a:ext cx="955720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ffect of BHB on the circadian clock oscillation in liver tissue. A.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ock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. B.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al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. C.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y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. D.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. E.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r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. F.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v-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b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.</a:t>
            </a:r>
          </a:p>
        </p:txBody>
      </p:sp>
    </p:spTree>
    <p:extLst>
      <p:ext uri="{BB962C8B-B14F-4D97-AF65-F5344CB8AC3E}">
        <p14:creationId xmlns:p14="http://schemas.microsoft.com/office/powerpoint/2010/main" val="16652674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תיבת טקסט 73">
            <a:extLst>
              <a:ext uri="{FF2B5EF4-FFF2-40B4-BE49-F238E27FC236}">
                <a16:creationId xmlns:a16="http://schemas.microsoft.com/office/drawing/2014/main" id="{12DD4FBC-88A5-495A-8BBD-DBE92305BD12}"/>
              </a:ext>
            </a:extLst>
          </p:cNvPr>
          <p:cNvSpPr txBox="1"/>
          <p:nvPr/>
        </p:nvSpPr>
        <p:spPr>
          <a:xfrm>
            <a:off x="259055" y="2936008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CRY1 66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3" name="תיבת טקסט 74">
            <a:extLst>
              <a:ext uri="{FF2B5EF4-FFF2-40B4-BE49-F238E27FC236}">
                <a16:creationId xmlns:a16="http://schemas.microsoft.com/office/drawing/2014/main" id="{33083F01-98B8-40E2-B9B2-C1A4ABEACEA4}"/>
              </a:ext>
            </a:extLst>
          </p:cNvPr>
          <p:cNvSpPr txBox="1"/>
          <p:nvPr/>
        </p:nvSpPr>
        <p:spPr>
          <a:xfrm>
            <a:off x="251035" y="3533580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ACTIN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4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4" name="טבלה 3">
            <a:extLst>
              <a:ext uri="{FF2B5EF4-FFF2-40B4-BE49-F238E27FC236}">
                <a16:creationId xmlns:a16="http://schemas.microsoft.com/office/drawing/2014/main" id="{F541CAEF-1A26-3B88-7409-B3CFEF620537}"/>
              </a:ext>
            </a:extLst>
          </p:cNvPr>
          <p:cNvGraphicFramePr>
            <a:graphicFrameLocks noGrp="1"/>
          </p:cNvGraphicFramePr>
          <p:nvPr/>
        </p:nvGraphicFramePr>
        <p:xfrm>
          <a:off x="1230309" y="534911"/>
          <a:ext cx="7620004" cy="3621507"/>
        </p:xfrm>
        <a:graphic>
          <a:graphicData uri="http://schemas.openxmlformats.org/drawingml/2006/table">
            <a:tbl>
              <a:tblPr rtl="1" firstRow="1" bandRow="1">
                <a:tableStyleId>{5940675A-B579-460E-94D1-54222C63F5DA}</a:tableStyleId>
              </a:tblPr>
              <a:tblGrid>
                <a:gridCol w="3810002">
                  <a:extLst>
                    <a:ext uri="{9D8B030D-6E8A-4147-A177-3AD203B41FA5}">
                      <a16:colId xmlns:a16="http://schemas.microsoft.com/office/drawing/2014/main" val="2673439277"/>
                    </a:ext>
                  </a:extLst>
                </a:gridCol>
                <a:gridCol w="3810002">
                  <a:extLst>
                    <a:ext uri="{9D8B030D-6E8A-4147-A177-3AD203B41FA5}">
                      <a16:colId xmlns:a16="http://schemas.microsoft.com/office/drawing/2014/main" val="112674736"/>
                    </a:ext>
                  </a:extLst>
                </a:gridCol>
              </a:tblGrid>
              <a:tr h="562362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5894319"/>
                  </a:ext>
                </a:extLst>
              </a:tr>
              <a:tr h="604506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8848110"/>
                  </a:ext>
                </a:extLst>
              </a:tr>
              <a:tr h="597523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5384007"/>
                  </a:ext>
                </a:extLst>
              </a:tr>
              <a:tr h="617863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28102718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8765973"/>
                  </a:ext>
                </a:extLst>
              </a:tr>
              <a:tr h="637674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1069457"/>
                  </a:ext>
                </a:extLst>
              </a:tr>
            </a:tbl>
          </a:graphicData>
        </a:graphic>
      </p:graphicFrame>
      <p:sp>
        <p:nvSpPr>
          <p:cNvPr id="13" name="תיבת טקסט 12">
            <a:extLst>
              <a:ext uri="{FF2B5EF4-FFF2-40B4-BE49-F238E27FC236}">
                <a16:creationId xmlns:a16="http://schemas.microsoft.com/office/drawing/2014/main" id="{10084B39-BF93-0B4C-D672-02D1723073E3}"/>
              </a:ext>
            </a:extLst>
          </p:cNvPr>
          <p:cNvSpPr txBox="1"/>
          <p:nvPr/>
        </p:nvSpPr>
        <p:spPr>
          <a:xfrm>
            <a:off x="275095" y="1191439"/>
            <a:ext cx="971241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CLOCK   90-11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תיבת טקסט 13">
            <a:extLst>
              <a:ext uri="{FF2B5EF4-FFF2-40B4-BE49-F238E27FC236}">
                <a16:creationId xmlns:a16="http://schemas.microsoft.com/office/drawing/2014/main" id="{A148D558-4803-4E6A-4C0D-A61611C4CE0D}"/>
              </a:ext>
            </a:extLst>
          </p:cNvPr>
          <p:cNvSpPr txBox="1"/>
          <p:nvPr/>
        </p:nvSpPr>
        <p:spPr>
          <a:xfrm>
            <a:off x="2077541" y="536045"/>
            <a:ext cx="656718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Chow</a:t>
            </a:r>
            <a:endParaRPr lang="he-IL" sz="1600" dirty="0"/>
          </a:p>
        </p:txBody>
      </p:sp>
      <p:sp>
        <p:nvSpPr>
          <p:cNvPr id="15" name="תיבת טקסט 14">
            <a:extLst>
              <a:ext uri="{FF2B5EF4-FFF2-40B4-BE49-F238E27FC236}">
                <a16:creationId xmlns:a16="http://schemas.microsoft.com/office/drawing/2014/main" id="{8E22B857-D879-D241-DD68-2AE49A469FF4}"/>
              </a:ext>
            </a:extLst>
          </p:cNvPr>
          <p:cNvSpPr txBox="1"/>
          <p:nvPr/>
        </p:nvSpPr>
        <p:spPr>
          <a:xfrm>
            <a:off x="3590696" y="543015"/>
            <a:ext cx="1111971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 err="1"/>
              <a:t>Chow+BHB</a:t>
            </a:r>
            <a:endParaRPr lang="he-IL" sz="1600" dirty="0"/>
          </a:p>
        </p:txBody>
      </p:sp>
      <p:pic>
        <p:nvPicPr>
          <p:cNvPr id="52" name="תמונה 51">
            <a:extLst>
              <a:ext uri="{FF2B5EF4-FFF2-40B4-BE49-F238E27FC236}">
                <a16:creationId xmlns:a16="http://schemas.microsoft.com/office/drawing/2014/main" id="{8CDE9EE0-CA41-7F68-D899-A653A5C9A1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89162" y="1080299"/>
            <a:ext cx="285750" cy="180975"/>
          </a:xfrm>
          <a:prstGeom prst="rect">
            <a:avLst/>
          </a:prstGeom>
        </p:spPr>
      </p:pic>
      <p:sp>
        <p:nvSpPr>
          <p:cNvPr id="53" name="תיבת טקסט 52">
            <a:extLst>
              <a:ext uri="{FF2B5EF4-FFF2-40B4-BE49-F238E27FC236}">
                <a16:creationId xmlns:a16="http://schemas.microsoft.com/office/drawing/2014/main" id="{A8779246-1101-ACEF-38FC-2A94AFDCD7CF}"/>
              </a:ext>
            </a:extLst>
          </p:cNvPr>
          <p:cNvSpPr txBox="1"/>
          <p:nvPr/>
        </p:nvSpPr>
        <p:spPr>
          <a:xfrm>
            <a:off x="9168342" y="1035357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150 KD</a:t>
            </a:r>
            <a:endParaRPr lang="he-IL" sz="1200" dirty="0"/>
          </a:p>
        </p:txBody>
      </p:sp>
      <p:pic>
        <p:nvPicPr>
          <p:cNvPr id="54" name="תמונה 53">
            <a:extLst>
              <a:ext uri="{FF2B5EF4-FFF2-40B4-BE49-F238E27FC236}">
                <a16:creationId xmlns:a16="http://schemas.microsoft.com/office/drawing/2014/main" id="{BE8B14D5-7F92-E9C6-B04B-AB52A45F10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62753" y="2848181"/>
            <a:ext cx="361950" cy="152400"/>
          </a:xfrm>
          <a:prstGeom prst="rect">
            <a:avLst/>
          </a:prstGeom>
        </p:spPr>
      </p:pic>
      <p:sp>
        <p:nvSpPr>
          <p:cNvPr id="55" name="תיבת טקסט 54">
            <a:extLst>
              <a:ext uri="{FF2B5EF4-FFF2-40B4-BE49-F238E27FC236}">
                <a16:creationId xmlns:a16="http://schemas.microsoft.com/office/drawing/2014/main" id="{43FA4DCC-31E0-F113-B69C-C939B1412789}"/>
              </a:ext>
            </a:extLst>
          </p:cNvPr>
          <p:cNvSpPr txBox="1"/>
          <p:nvPr/>
        </p:nvSpPr>
        <p:spPr>
          <a:xfrm>
            <a:off x="9152291" y="2835734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75 KD</a:t>
            </a:r>
            <a:endParaRPr lang="he-IL" sz="1200" dirty="0"/>
          </a:p>
        </p:txBody>
      </p:sp>
      <p:pic>
        <p:nvPicPr>
          <p:cNvPr id="58" name="תמונה 57">
            <a:extLst>
              <a:ext uri="{FF2B5EF4-FFF2-40B4-BE49-F238E27FC236}">
                <a16:creationId xmlns:a16="http://schemas.microsoft.com/office/drawing/2014/main" id="{CB3F7469-FAFC-217D-D19E-6802937876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90663" y="3391526"/>
            <a:ext cx="342900" cy="171450"/>
          </a:xfrm>
          <a:prstGeom prst="rect">
            <a:avLst/>
          </a:prstGeom>
        </p:spPr>
      </p:pic>
      <p:sp>
        <p:nvSpPr>
          <p:cNvPr id="59" name="תיבת טקסט 58">
            <a:extLst>
              <a:ext uri="{FF2B5EF4-FFF2-40B4-BE49-F238E27FC236}">
                <a16:creationId xmlns:a16="http://schemas.microsoft.com/office/drawing/2014/main" id="{B88E4FDA-40FB-15EA-2598-D40993CDB69F}"/>
              </a:ext>
            </a:extLst>
          </p:cNvPr>
          <p:cNvSpPr txBox="1"/>
          <p:nvPr/>
        </p:nvSpPr>
        <p:spPr>
          <a:xfrm>
            <a:off x="9145327" y="3334440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50 KD</a:t>
            </a:r>
            <a:endParaRPr lang="he-IL" sz="1200" dirty="0"/>
          </a:p>
        </p:txBody>
      </p:sp>
      <p:pic>
        <p:nvPicPr>
          <p:cNvPr id="60" name="תמונה 59">
            <a:extLst>
              <a:ext uri="{FF2B5EF4-FFF2-40B4-BE49-F238E27FC236}">
                <a16:creationId xmlns:a16="http://schemas.microsoft.com/office/drawing/2014/main" id="{22B964ED-D404-ECF2-9BD5-A1E53C7FE1A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71918" y="4089440"/>
            <a:ext cx="314325" cy="161925"/>
          </a:xfrm>
          <a:prstGeom prst="rect">
            <a:avLst/>
          </a:prstGeom>
        </p:spPr>
      </p:pic>
      <p:sp>
        <p:nvSpPr>
          <p:cNvPr id="61" name="תיבת טקסט 60">
            <a:extLst>
              <a:ext uri="{FF2B5EF4-FFF2-40B4-BE49-F238E27FC236}">
                <a16:creationId xmlns:a16="http://schemas.microsoft.com/office/drawing/2014/main" id="{82C0C43A-C2A4-882F-9132-0BE298F81047}"/>
              </a:ext>
            </a:extLst>
          </p:cNvPr>
          <p:cNvSpPr txBox="1"/>
          <p:nvPr/>
        </p:nvSpPr>
        <p:spPr>
          <a:xfrm>
            <a:off x="9141315" y="4010903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37 KD</a:t>
            </a:r>
            <a:endParaRPr lang="he-IL" sz="1200" dirty="0"/>
          </a:p>
        </p:txBody>
      </p:sp>
      <p:sp>
        <p:nvSpPr>
          <p:cNvPr id="74" name="תיבת טקסט 73">
            <a:extLst>
              <a:ext uri="{FF2B5EF4-FFF2-40B4-BE49-F238E27FC236}">
                <a16:creationId xmlns:a16="http://schemas.microsoft.com/office/drawing/2014/main" id="{91B1BEED-6FA7-0927-1357-5075D6D3EC72}"/>
              </a:ext>
            </a:extLst>
          </p:cNvPr>
          <p:cNvSpPr txBox="1"/>
          <p:nvPr/>
        </p:nvSpPr>
        <p:spPr>
          <a:xfrm>
            <a:off x="267075" y="1789001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BMALL 78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5" name="תיבת טקסט 74">
            <a:extLst>
              <a:ext uri="{FF2B5EF4-FFF2-40B4-BE49-F238E27FC236}">
                <a16:creationId xmlns:a16="http://schemas.microsoft.com/office/drawing/2014/main" id="{00A37420-FBAE-525A-18E0-A53BFCFEEDA9}"/>
              </a:ext>
            </a:extLst>
          </p:cNvPr>
          <p:cNvSpPr txBox="1"/>
          <p:nvPr/>
        </p:nvSpPr>
        <p:spPr>
          <a:xfrm>
            <a:off x="259055" y="2386573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BMALL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78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3" name="TextBox 66">
            <a:extLst>
              <a:ext uri="{FF2B5EF4-FFF2-40B4-BE49-F238E27FC236}">
                <a16:creationId xmlns:a16="http://schemas.microsoft.com/office/drawing/2014/main" id="{0B557832-60B7-B090-7FF9-5DBC777DA6E9}"/>
              </a:ext>
            </a:extLst>
          </p:cNvPr>
          <p:cNvSpPr txBox="1"/>
          <p:nvPr/>
        </p:nvSpPr>
        <p:spPr>
          <a:xfrm>
            <a:off x="-10732" y="2814"/>
            <a:ext cx="20780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. S6</a:t>
            </a:r>
          </a:p>
        </p:txBody>
      </p:sp>
      <p:sp>
        <p:nvSpPr>
          <p:cNvPr id="144" name="Rectangle 1">
            <a:extLst>
              <a:ext uri="{FF2B5EF4-FFF2-40B4-BE49-F238E27FC236}">
                <a16:creationId xmlns:a16="http://schemas.microsoft.com/office/drawing/2014/main" id="{33023028-B64F-BC1F-3D8C-541D342F58BA}"/>
              </a:ext>
            </a:extLst>
          </p:cNvPr>
          <p:cNvSpPr/>
          <p:nvPr/>
        </p:nvSpPr>
        <p:spPr>
          <a:xfrm>
            <a:off x="127735" y="4594836"/>
            <a:ext cx="983441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S6: Western blot protein analysis of the </a:t>
            </a:r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effect of HF and BHB supplementation on the circadian clock in muscle tissue.</a:t>
            </a:r>
          </a:p>
          <a:p>
            <a:pPr algn="ctr"/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6" name="קבוצה 5">
            <a:extLst>
              <a:ext uri="{FF2B5EF4-FFF2-40B4-BE49-F238E27FC236}">
                <a16:creationId xmlns:a16="http://schemas.microsoft.com/office/drawing/2014/main" id="{4AFD568D-41C8-4AAE-9C08-0407F9153474}"/>
              </a:ext>
            </a:extLst>
          </p:cNvPr>
          <p:cNvGrpSpPr/>
          <p:nvPr/>
        </p:nvGrpSpPr>
        <p:grpSpPr>
          <a:xfrm>
            <a:off x="1709581" y="822715"/>
            <a:ext cx="1367729" cy="329471"/>
            <a:chOff x="1709581" y="1009697"/>
            <a:chExt cx="1367729" cy="329471"/>
          </a:xfrm>
        </p:grpSpPr>
        <p:sp>
          <p:nvSpPr>
            <p:cNvPr id="133" name="סוגר מרובע ימני 132">
              <a:extLst>
                <a:ext uri="{FF2B5EF4-FFF2-40B4-BE49-F238E27FC236}">
                  <a16:creationId xmlns:a16="http://schemas.microsoft.com/office/drawing/2014/main" id="{B9467D85-7C62-837F-2A06-957E29059C2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97" name="TextBox 64">
              <a:extLst>
                <a:ext uri="{FF2B5EF4-FFF2-40B4-BE49-F238E27FC236}">
                  <a16:creationId xmlns:a16="http://schemas.microsoft.com/office/drawing/2014/main" id="{AA912D09-30B1-E356-7B4F-06293C79B1D6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98" name="TextBox 65">
              <a:extLst>
                <a:ext uri="{FF2B5EF4-FFF2-40B4-BE49-F238E27FC236}">
                  <a16:creationId xmlns:a16="http://schemas.microsoft.com/office/drawing/2014/main" id="{A20BC556-D3BC-7379-0531-5B4A8F52A7E6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99" name="TextBox 66">
              <a:extLst>
                <a:ext uri="{FF2B5EF4-FFF2-40B4-BE49-F238E27FC236}">
                  <a16:creationId xmlns:a16="http://schemas.microsoft.com/office/drawing/2014/main" id="{0B83B336-88AD-24DD-C3E1-540421E857AE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00" name="TextBox 67">
              <a:extLst>
                <a:ext uri="{FF2B5EF4-FFF2-40B4-BE49-F238E27FC236}">
                  <a16:creationId xmlns:a16="http://schemas.microsoft.com/office/drawing/2014/main" id="{0099CB3B-5887-94B5-417C-DE4A1F1639E9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01" name="TextBox 68">
              <a:extLst>
                <a:ext uri="{FF2B5EF4-FFF2-40B4-BE49-F238E27FC236}">
                  <a16:creationId xmlns:a16="http://schemas.microsoft.com/office/drawing/2014/main" id="{DAAA0074-528E-8F9E-4979-1323FF279B2E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84" name="TextBox 68">
            <a:extLst>
              <a:ext uri="{FF2B5EF4-FFF2-40B4-BE49-F238E27FC236}">
                <a16:creationId xmlns:a16="http://schemas.microsoft.com/office/drawing/2014/main" id="{059F3F98-4615-47B4-8364-1C126FC84F9D}"/>
              </a:ext>
            </a:extLst>
          </p:cNvPr>
          <p:cNvSpPr txBox="1"/>
          <p:nvPr/>
        </p:nvSpPr>
        <p:spPr>
          <a:xfrm>
            <a:off x="2890382" y="877097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grpSp>
        <p:nvGrpSpPr>
          <p:cNvPr id="104" name="קבוצה 103">
            <a:extLst>
              <a:ext uri="{FF2B5EF4-FFF2-40B4-BE49-F238E27FC236}">
                <a16:creationId xmlns:a16="http://schemas.microsoft.com/office/drawing/2014/main" id="{9EFA4827-C724-44BF-B18A-473DBE8EF8CF}"/>
              </a:ext>
            </a:extLst>
          </p:cNvPr>
          <p:cNvGrpSpPr/>
          <p:nvPr/>
        </p:nvGrpSpPr>
        <p:grpSpPr>
          <a:xfrm>
            <a:off x="3464317" y="825620"/>
            <a:ext cx="1367729" cy="329471"/>
            <a:chOff x="1709581" y="1009697"/>
            <a:chExt cx="1367729" cy="329471"/>
          </a:xfrm>
        </p:grpSpPr>
        <p:sp>
          <p:nvSpPr>
            <p:cNvPr id="105" name="סוגר מרובע ימני 104">
              <a:extLst>
                <a:ext uri="{FF2B5EF4-FFF2-40B4-BE49-F238E27FC236}">
                  <a16:creationId xmlns:a16="http://schemas.microsoft.com/office/drawing/2014/main" id="{BDED5688-72A1-4B2A-AA2A-3CBA0A79E27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06" name="TextBox 64">
              <a:extLst>
                <a:ext uri="{FF2B5EF4-FFF2-40B4-BE49-F238E27FC236}">
                  <a16:creationId xmlns:a16="http://schemas.microsoft.com/office/drawing/2014/main" id="{28BF52E6-BA50-487C-ACA5-6982911FAA0C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07" name="TextBox 65">
              <a:extLst>
                <a:ext uri="{FF2B5EF4-FFF2-40B4-BE49-F238E27FC236}">
                  <a16:creationId xmlns:a16="http://schemas.microsoft.com/office/drawing/2014/main" id="{FFBD7BED-404E-45F4-A258-952F5CD7E222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08" name="TextBox 66">
              <a:extLst>
                <a:ext uri="{FF2B5EF4-FFF2-40B4-BE49-F238E27FC236}">
                  <a16:creationId xmlns:a16="http://schemas.microsoft.com/office/drawing/2014/main" id="{FC9843A3-53C7-4FAA-B4B3-1F0EE56C25B7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09" name="TextBox 67">
              <a:extLst>
                <a:ext uri="{FF2B5EF4-FFF2-40B4-BE49-F238E27FC236}">
                  <a16:creationId xmlns:a16="http://schemas.microsoft.com/office/drawing/2014/main" id="{1B859FF9-24F4-458D-8A53-E997FC5B7F0E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10" name="TextBox 68">
              <a:extLst>
                <a:ext uri="{FF2B5EF4-FFF2-40B4-BE49-F238E27FC236}">
                  <a16:creationId xmlns:a16="http://schemas.microsoft.com/office/drawing/2014/main" id="{3BE4D8CB-9E84-42AD-8179-9C7C0602D6F1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11" name="TextBox 68">
            <a:extLst>
              <a:ext uri="{FF2B5EF4-FFF2-40B4-BE49-F238E27FC236}">
                <a16:creationId xmlns:a16="http://schemas.microsoft.com/office/drawing/2014/main" id="{212134D3-F29F-48F4-83F9-FD1A955BC73A}"/>
              </a:ext>
            </a:extLst>
          </p:cNvPr>
          <p:cNvSpPr txBox="1"/>
          <p:nvPr/>
        </p:nvSpPr>
        <p:spPr>
          <a:xfrm>
            <a:off x="4631437" y="880429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sp>
        <p:nvSpPr>
          <p:cNvPr id="112" name="תיבת טקסט 13">
            <a:extLst>
              <a:ext uri="{FF2B5EF4-FFF2-40B4-BE49-F238E27FC236}">
                <a16:creationId xmlns:a16="http://schemas.microsoft.com/office/drawing/2014/main" id="{B27A25D1-B7A9-4B6D-A3A0-173CDAABF010}"/>
              </a:ext>
            </a:extLst>
          </p:cNvPr>
          <p:cNvSpPr txBox="1"/>
          <p:nvPr/>
        </p:nvSpPr>
        <p:spPr>
          <a:xfrm>
            <a:off x="5842567" y="538545"/>
            <a:ext cx="407484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HF</a:t>
            </a:r>
            <a:endParaRPr lang="he-IL" sz="1600" dirty="0"/>
          </a:p>
        </p:txBody>
      </p:sp>
      <p:sp>
        <p:nvSpPr>
          <p:cNvPr id="113" name="תיבת טקסט 14">
            <a:extLst>
              <a:ext uri="{FF2B5EF4-FFF2-40B4-BE49-F238E27FC236}">
                <a16:creationId xmlns:a16="http://schemas.microsoft.com/office/drawing/2014/main" id="{4C13841B-9DC1-4201-A63D-F5355298E5B9}"/>
              </a:ext>
            </a:extLst>
          </p:cNvPr>
          <p:cNvSpPr txBox="1"/>
          <p:nvPr/>
        </p:nvSpPr>
        <p:spPr>
          <a:xfrm>
            <a:off x="7355722" y="545515"/>
            <a:ext cx="862737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HF+BHB</a:t>
            </a:r>
            <a:endParaRPr lang="he-IL" sz="1600" dirty="0"/>
          </a:p>
        </p:txBody>
      </p:sp>
      <p:grpSp>
        <p:nvGrpSpPr>
          <p:cNvPr id="114" name="קבוצה 113">
            <a:extLst>
              <a:ext uri="{FF2B5EF4-FFF2-40B4-BE49-F238E27FC236}">
                <a16:creationId xmlns:a16="http://schemas.microsoft.com/office/drawing/2014/main" id="{8181050A-528A-40E5-9454-114F8D16F038}"/>
              </a:ext>
            </a:extLst>
          </p:cNvPr>
          <p:cNvGrpSpPr/>
          <p:nvPr/>
        </p:nvGrpSpPr>
        <p:grpSpPr>
          <a:xfrm>
            <a:off x="5474607" y="825215"/>
            <a:ext cx="1367729" cy="329471"/>
            <a:chOff x="1709581" y="1009697"/>
            <a:chExt cx="1367729" cy="329471"/>
          </a:xfrm>
        </p:grpSpPr>
        <p:sp>
          <p:nvSpPr>
            <p:cNvPr id="137" name="סוגר מרובע ימני 136">
              <a:extLst>
                <a:ext uri="{FF2B5EF4-FFF2-40B4-BE49-F238E27FC236}">
                  <a16:creationId xmlns:a16="http://schemas.microsoft.com/office/drawing/2014/main" id="{392BA01C-5A4F-4E30-8375-892DADCD1EB3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39" name="TextBox 64">
              <a:extLst>
                <a:ext uri="{FF2B5EF4-FFF2-40B4-BE49-F238E27FC236}">
                  <a16:creationId xmlns:a16="http://schemas.microsoft.com/office/drawing/2014/main" id="{5CA97C4B-4E4F-4350-885F-70BA4A65C1DE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41" name="TextBox 65">
              <a:extLst>
                <a:ext uri="{FF2B5EF4-FFF2-40B4-BE49-F238E27FC236}">
                  <a16:creationId xmlns:a16="http://schemas.microsoft.com/office/drawing/2014/main" id="{910161C2-EB0C-4D02-962D-BA04D3697E41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45" name="TextBox 66">
              <a:extLst>
                <a:ext uri="{FF2B5EF4-FFF2-40B4-BE49-F238E27FC236}">
                  <a16:creationId xmlns:a16="http://schemas.microsoft.com/office/drawing/2014/main" id="{069F509B-4416-4CEC-A09D-9613C304B507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46" name="TextBox 67">
              <a:extLst>
                <a:ext uri="{FF2B5EF4-FFF2-40B4-BE49-F238E27FC236}">
                  <a16:creationId xmlns:a16="http://schemas.microsoft.com/office/drawing/2014/main" id="{D1A0B974-A9F6-4CFD-8143-8E8AC797A7A8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47" name="TextBox 68">
              <a:extLst>
                <a:ext uri="{FF2B5EF4-FFF2-40B4-BE49-F238E27FC236}">
                  <a16:creationId xmlns:a16="http://schemas.microsoft.com/office/drawing/2014/main" id="{74983962-1DF6-468A-9D7C-787E0E0D3F64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48" name="TextBox 68">
            <a:extLst>
              <a:ext uri="{FF2B5EF4-FFF2-40B4-BE49-F238E27FC236}">
                <a16:creationId xmlns:a16="http://schemas.microsoft.com/office/drawing/2014/main" id="{A21AB5A2-F4AA-4EA7-8209-B78CB1D8CCFB}"/>
              </a:ext>
            </a:extLst>
          </p:cNvPr>
          <p:cNvSpPr txBox="1"/>
          <p:nvPr/>
        </p:nvSpPr>
        <p:spPr>
          <a:xfrm>
            <a:off x="6655408" y="879597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grpSp>
        <p:nvGrpSpPr>
          <p:cNvPr id="149" name="קבוצה 148">
            <a:extLst>
              <a:ext uri="{FF2B5EF4-FFF2-40B4-BE49-F238E27FC236}">
                <a16:creationId xmlns:a16="http://schemas.microsoft.com/office/drawing/2014/main" id="{CCC49AA6-3540-41C4-80A0-D9170B688B5D}"/>
              </a:ext>
            </a:extLst>
          </p:cNvPr>
          <p:cNvGrpSpPr/>
          <p:nvPr/>
        </p:nvGrpSpPr>
        <p:grpSpPr>
          <a:xfrm>
            <a:off x="7229343" y="828120"/>
            <a:ext cx="1367729" cy="329471"/>
            <a:chOff x="1709581" y="1009697"/>
            <a:chExt cx="1367729" cy="329471"/>
          </a:xfrm>
        </p:grpSpPr>
        <p:sp>
          <p:nvSpPr>
            <p:cNvPr id="150" name="סוגר מרובע ימני 149">
              <a:extLst>
                <a:ext uri="{FF2B5EF4-FFF2-40B4-BE49-F238E27FC236}">
                  <a16:creationId xmlns:a16="http://schemas.microsoft.com/office/drawing/2014/main" id="{B9AD1C17-2C9C-4AF8-BEC7-72259B00F17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51" name="TextBox 64">
              <a:extLst>
                <a:ext uri="{FF2B5EF4-FFF2-40B4-BE49-F238E27FC236}">
                  <a16:creationId xmlns:a16="http://schemas.microsoft.com/office/drawing/2014/main" id="{4700D035-9DCE-405D-B9F2-C115B053D1EB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52" name="TextBox 65">
              <a:extLst>
                <a:ext uri="{FF2B5EF4-FFF2-40B4-BE49-F238E27FC236}">
                  <a16:creationId xmlns:a16="http://schemas.microsoft.com/office/drawing/2014/main" id="{27E089C8-3DB8-4806-8E41-986703E9923A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53" name="TextBox 66">
              <a:extLst>
                <a:ext uri="{FF2B5EF4-FFF2-40B4-BE49-F238E27FC236}">
                  <a16:creationId xmlns:a16="http://schemas.microsoft.com/office/drawing/2014/main" id="{BAD3E3FC-9994-4FF6-86D0-66A1EC6D49AD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54" name="TextBox 67">
              <a:extLst>
                <a:ext uri="{FF2B5EF4-FFF2-40B4-BE49-F238E27FC236}">
                  <a16:creationId xmlns:a16="http://schemas.microsoft.com/office/drawing/2014/main" id="{17A5D0ED-7B6B-419B-B914-2A242B34BD34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55" name="TextBox 68">
              <a:extLst>
                <a:ext uri="{FF2B5EF4-FFF2-40B4-BE49-F238E27FC236}">
                  <a16:creationId xmlns:a16="http://schemas.microsoft.com/office/drawing/2014/main" id="{18B500CA-3022-4D90-9C4B-E3B87E4FB031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56" name="TextBox 68">
            <a:extLst>
              <a:ext uri="{FF2B5EF4-FFF2-40B4-BE49-F238E27FC236}">
                <a16:creationId xmlns:a16="http://schemas.microsoft.com/office/drawing/2014/main" id="{BE1723CA-D04E-49D0-AD3D-B510BC00B2A8}"/>
              </a:ext>
            </a:extLst>
          </p:cNvPr>
          <p:cNvSpPr txBox="1"/>
          <p:nvPr/>
        </p:nvSpPr>
        <p:spPr>
          <a:xfrm>
            <a:off x="8396463" y="882929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pic>
        <p:nvPicPr>
          <p:cNvPr id="72" name="תמונה 71">
            <a:extLst>
              <a:ext uri="{FF2B5EF4-FFF2-40B4-BE49-F238E27FC236}">
                <a16:creationId xmlns:a16="http://schemas.microsoft.com/office/drawing/2014/main" id="{3D14EB1E-D1BE-4BFC-A533-61AA75834B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94574" y="1594810"/>
            <a:ext cx="304800" cy="152400"/>
          </a:xfrm>
          <a:prstGeom prst="rect">
            <a:avLst/>
          </a:prstGeom>
        </p:spPr>
      </p:pic>
      <p:sp>
        <p:nvSpPr>
          <p:cNvPr id="73" name="תיבת טקסט 53">
            <a:extLst>
              <a:ext uri="{FF2B5EF4-FFF2-40B4-BE49-F238E27FC236}">
                <a16:creationId xmlns:a16="http://schemas.microsoft.com/office/drawing/2014/main" id="{E8EC8839-AA36-4873-8D22-0999BD495BF5}"/>
              </a:ext>
            </a:extLst>
          </p:cNvPr>
          <p:cNvSpPr txBox="1"/>
          <p:nvPr/>
        </p:nvSpPr>
        <p:spPr>
          <a:xfrm>
            <a:off x="9179316" y="1518345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100 KD</a:t>
            </a:r>
            <a:endParaRPr lang="he-IL" sz="12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50800" y="1226707"/>
            <a:ext cx="3584759" cy="37188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81283" y="1792516"/>
            <a:ext cx="3554276" cy="31701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29462" y="2431343"/>
            <a:ext cx="3627434" cy="33530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209867" y="3030233"/>
            <a:ext cx="3596952" cy="35969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209867" y="3667559"/>
            <a:ext cx="3596952" cy="34750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238072" y="1173513"/>
            <a:ext cx="3737172" cy="414564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266560" y="1802670"/>
            <a:ext cx="3773751" cy="38408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370361" y="2459288"/>
            <a:ext cx="3572566" cy="33530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375299" y="3039377"/>
            <a:ext cx="3584759" cy="341406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408075" y="3667810"/>
            <a:ext cx="3517697" cy="3170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43475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2" name="Chart 231">
            <a:extLst>
              <a:ext uri="{FF2B5EF4-FFF2-40B4-BE49-F238E27FC236}">
                <a16:creationId xmlns:a16="http://schemas.microsoft.com/office/drawing/2014/main" id="{00000000-0008-0000-0C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6595017"/>
              </p:ext>
            </p:extLst>
          </p:nvPr>
        </p:nvGraphicFramePr>
        <p:xfrm>
          <a:off x="819704" y="6025765"/>
          <a:ext cx="2698559" cy="20351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1" name="Chart 230">
            <a:extLst>
              <a:ext uri="{FF2B5EF4-FFF2-40B4-BE49-F238E27FC236}">
                <a16:creationId xmlns:a16="http://schemas.microsoft.com/office/drawing/2014/main" id="{00000000-0008-0000-0A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5102844"/>
              </p:ext>
            </p:extLst>
          </p:nvPr>
        </p:nvGraphicFramePr>
        <p:xfrm>
          <a:off x="7015936" y="3369376"/>
          <a:ext cx="2652447" cy="20261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30" name="Chart 229">
            <a:extLst>
              <a:ext uri="{FF2B5EF4-FFF2-40B4-BE49-F238E27FC236}">
                <a16:creationId xmlns:a16="http://schemas.microsoft.com/office/drawing/2014/main" id="{00000000-0008-0000-08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4584022"/>
              </p:ext>
            </p:extLst>
          </p:nvPr>
        </p:nvGraphicFramePr>
        <p:xfrm>
          <a:off x="3950400" y="3384674"/>
          <a:ext cx="2674198" cy="20122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29" name="Chart 228">
            <a:extLst>
              <a:ext uri="{FF2B5EF4-FFF2-40B4-BE49-F238E27FC236}">
                <a16:creationId xmlns:a16="http://schemas.microsoft.com/office/drawing/2014/main" id="{00000000-0008-0000-06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7078609"/>
              </p:ext>
            </p:extLst>
          </p:nvPr>
        </p:nvGraphicFramePr>
        <p:xfrm>
          <a:off x="787997" y="3362452"/>
          <a:ext cx="2749689" cy="20415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28" name="Chart 227">
            <a:extLst>
              <a:ext uri="{FF2B5EF4-FFF2-40B4-BE49-F238E27FC236}">
                <a16:creationId xmlns:a16="http://schemas.microsoft.com/office/drawing/2014/main" id="{00000000-0008-0000-04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1595964"/>
              </p:ext>
            </p:extLst>
          </p:nvPr>
        </p:nvGraphicFramePr>
        <p:xfrm>
          <a:off x="7031298" y="775322"/>
          <a:ext cx="2637085" cy="19787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27" name="Chart 226">
            <a:extLst>
              <a:ext uri="{FF2B5EF4-FFF2-40B4-BE49-F238E27FC236}">
                <a16:creationId xmlns:a16="http://schemas.microsoft.com/office/drawing/2014/main" id="{00000000-0008-0000-02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34780965"/>
              </p:ext>
            </p:extLst>
          </p:nvPr>
        </p:nvGraphicFramePr>
        <p:xfrm>
          <a:off x="3950400" y="826570"/>
          <a:ext cx="2674199" cy="19367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26" name="Chart 225">
            <a:extLst>
              <a:ext uri="{FF2B5EF4-FFF2-40B4-BE49-F238E27FC236}">
                <a16:creationId xmlns:a16="http://schemas.microsoft.com/office/drawing/2014/main" id="{00000000-0008-0000-00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8519317"/>
              </p:ext>
            </p:extLst>
          </p:nvPr>
        </p:nvGraphicFramePr>
        <p:xfrm>
          <a:off x="759927" y="826570"/>
          <a:ext cx="2777759" cy="19266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8" name="Rectangle 17"/>
          <p:cNvSpPr/>
          <p:nvPr/>
        </p:nvSpPr>
        <p:spPr>
          <a:xfrm rot="16200000">
            <a:off x="-399574" y="4244087"/>
            <a:ext cx="227273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uscle </a:t>
            </a:r>
            <a:r>
              <a:rPr lang="en-US" i="1" dirty="0"/>
              <a:t>Cry1</a:t>
            </a:r>
            <a:r>
              <a:rPr lang="en-US" dirty="0"/>
              <a:t> relative mRNA levels</a:t>
            </a:r>
          </a:p>
        </p:txBody>
      </p:sp>
      <p:sp>
        <p:nvSpPr>
          <p:cNvPr id="15" name="Rectangle 14"/>
          <p:cNvSpPr/>
          <p:nvPr/>
        </p:nvSpPr>
        <p:spPr>
          <a:xfrm rot="16200000">
            <a:off x="5712530" y="1580530"/>
            <a:ext cx="230947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uscle </a:t>
            </a:r>
            <a:r>
              <a:rPr lang="en-US" i="1" dirty="0" err="1"/>
              <a:t>Bmal</a:t>
            </a:r>
            <a:r>
              <a:rPr lang="en-US" dirty="0"/>
              <a:t> relative mRNA levels</a:t>
            </a:r>
          </a:p>
        </p:txBody>
      </p:sp>
      <p:sp>
        <p:nvSpPr>
          <p:cNvPr id="12" name="Rectangle 11"/>
          <p:cNvSpPr/>
          <p:nvPr/>
        </p:nvSpPr>
        <p:spPr>
          <a:xfrm rot="16200000">
            <a:off x="2625616" y="1573192"/>
            <a:ext cx="230947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uscle </a:t>
            </a:r>
            <a:r>
              <a:rPr lang="en-US" i="1" dirty="0"/>
              <a:t>Clock</a:t>
            </a:r>
            <a:r>
              <a:rPr lang="en-US" dirty="0"/>
              <a:t> relative mRNA levels</a:t>
            </a:r>
          </a:p>
        </p:txBody>
      </p:sp>
      <p:sp>
        <p:nvSpPr>
          <p:cNvPr id="8" name="Rectangle 7"/>
          <p:cNvSpPr/>
          <p:nvPr/>
        </p:nvSpPr>
        <p:spPr>
          <a:xfrm rot="16200000">
            <a:off x="-602670" y="1556467"/>
            <a:ext cx="26140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uscle </a:t>
            </a:r>
            <a:r>
              <a:rPr lang="en-US" i="1" dirty="0" err="1"/>
              <a:t>Myogenin</a:t>
            </a:r>
            <a:r>
              <a:rPr lang="en-US" dirty="0"/>
              <a:t> relative mRNA levels</a:t>
            </a:r>
          </a:p>
        </p:txBody>
      </p:sp>
      <p:sp>
        <p:nvSpPr>
          <p:cNvPr id="270" name="תיבת טקסט 491">
            <a:extLst>
              <a:ext uri="{FF2B5EF4-FFF2-40B4-BE49-F238E27FC236}">
                <a16:creationId xmlns:a16="http://schemas.microsoft.com/office/drawing/2014/main" id="{47389762-A129-E102-990C-EC1C691C09A3}"/>
              </a:ext>
            </a:extLst>
          </p:cNvPr>
          <p:cNvSpPr txBox="1"/>
          <p:nvPr/>
        </p:nvSpPr>
        <p:spPr>
          <a:xfrm>
            <a:off x="6870260" y="533484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0" y="-540588"/>
            <a:ext cx="3341043" cy="899646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1754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559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754" b="1" dirty="0"/>
              <a:t>Supplementary Fig. S7</a:t>
            </a:r>
            <a:endParaRPr lang="en-US" sz="1754" dirty="0"/>
          </a:p>
        </p:txBody>
      </p:sp>
      <p:sp>
        <p:nvSpPr>
          <p:cNvPr id="251" name="תיבת טקסט 489">
            <a:extLst>
              <a:ext uri="{FF2B5EF4-FFF2-40B4-BE49-F238E27FC236}">
                <a16:creationId xmlns:a16="http://schemas.microsoft.com/office/drawing/2014/main" id="{5E95261A-7113-8B35-1C16-56FFA9CC0336}"/>
              </a:ext>
            </a:extLst>
          </p:cNvPr>
          <p:cNvSpPr txBox="1"/>
          <p:nvPr/>
        </p:nvSpPr>
        <p:spPr>
          <a:xfrm>
            <a:off x="799715" y="540031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2" name="תיבת טקסט 490">
            <a:extLst>
              <a:ext uri="{FF2B5EF4-FFF2-40B4-BE49-F238E27FC236}">
                <a16:creationId xmlns:a16="http://schemas.microsoft.com/office/drawing/2014/main" id="{CCAC697B-8A27-0317-E8AF-064DF803C36A}"/>
              </a:ext>
            </a:extLst>
          </p:cNvPr>
          <p:cNvSpPr txBox="1"/>
          <p:nvPr/>
        </p:nvSpPr>
        <p:spPr>
          <a:xfrm>
            <a:off x="3864102" y="547001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9" name="תיבת טקסט 491">
            <a:extLst>
              <a:ext uri="{FF2B5EF4-FFF2-40B4-BE49-F238E27FC236}">
                <a16:creationId xmlns:a16="http://schemas.microsoft.com/office/drawing/2014/main" id="{47389762-A129-E102-990C-EC1C691C09A3}"/>
              </a:ext>
            </a:extLst>
          </p:cNvPr>
          <p:cNvSpPr txBox="1"/>
          <p:nvPr/>
        </p:nvSpPr>
        <p:spPr>
          <a:xfrm>
            <a:off x="6872760" y="3143071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>
                <a:latin typeface="Calibri" panose="020F0502020204030204" pitchFamily="34" charset="0"/>
                <a:cs typeface="Calibri" panose="020F0502020204030204" pitchFamily="34" charset="0"/>
              </a:rPr>
              <a:t>F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0" name="תיבת טקסט 489">
            <a:extLst>
              <a:ext uri="{FF2B5EF4-FFF2-40B4-BE49-F238E27FC236}">
                <a16:creationId xmlns:a16="http://schemas.microsoft.com/office/drawing/2014/main" id="{5E95261A-7113-8B35-1C16-56FFA9CC0336}"/>
              </a:ext>
            </a:extLst>
          </p:cNvPr>
          <p:cNvSpPr txBox="1"/>
          <p:nvPr/>
        </p:nvSpPr>
        <p:spPr>
          <a:xfrm>
            <a:off x="802215" y="3149618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1" name="תיבת טקסט 490">
            <a:extLst>
              <a:ext uri="{FF2B5EF4-FFF2-40B4-BE49-F238E27FC236}">
                <a16:creationId xmlns:a16="http://schemas.microsoft.com/office/drawing/2014/main" id="{CCAC697B-8A27-0317-E8AF-064DF803C36A}"/>
              </a:ext>
            </a:extLst>
          </p:cNvPr>
          <p:cNvSpPr txBox="1"/>
          <p:nvPr/>
        </p:nvSpPr>
        <p:spPr>
          <a:xfrm>
            <a:off x="3866602" y="3156588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>
                <a:latin typeface="Calibri" panose="020F0502020204030204" pitchFamily="34" charset="0"/>
                <a:cs typeface="Calibri" panose="020F0502020204030204" pitchFamily="34" charset="0"/>
              </a:rPr>
              <a:t>E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816264" y="2774065"/>
            <a:ext cx="2696694" cy="194217"/>
            <a:chOff x="649518" y="2723874"/>
            <a:chExt cx="2696694" cy="194217"/>
          </a:xfrm>
        </p:grpSpPr>
        <p:sp>
          <p:nvSpPr>
            <p:cNvPr id="51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2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3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4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5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6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7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8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9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0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1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2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3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4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5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7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02" name="Group 101"/>
          <p:cNvGrpSpPr/>
          <p:nvPr/>
        </p:nvGrpSpPr>
        <p:grpSpPr>
          <a:xfrm>
            <a:off x="3904722" y="2770052"/>
            <a:ext cx="2696694" cy="194217"/>
            <a:chOff x="649518" y="2723874"/>
            <a:chExt cx="2696694" cy="194217"/>
          </a:xfrm>
        </p:grpSpPr>
        <p:sp>
          <p:nvSpPr>
            <p:cNvPr id="117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8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9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0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1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2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3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4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5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6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7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8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9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0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1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2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34" name="Group 133"/>
          <p:cNvGrpSpPr/>
          <p:nvPr/>
        </p:nvGrpSpPr>
        <p:grpSpPr>
          <a:xfrm>
            <a:off x="6960865" y="2778068"/>
            <a:ext cx="2696694" cy="194217"/>
            <a:chOff x="649518" y="2723874"/>
            <a:chExt cx="2696694" cy="194217"/>
          </a:xfrm>
        </p:grpSpPr>
        <p:sp>
          <p:nvSpPr>
            <p:cNvPr id="135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6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7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8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9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0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1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2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3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4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5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6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7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8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9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0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52" name="Group 151"/>
          <p:cNvGrpSpPr/>
          <p:nvPr/>
        </p:nvGrpSpPr>
        <p:grpSpPr>
          <a:xfrm>
            <a:off x="812248" y="5417008"/>
            <a:ext cx="2696694" cy="194217"/>
            <a:chOff x="649518" y="2723874"/>
            <a:chExt cx="2696694" cy="194217"/>
          </a:xfrm>
        </p:grpSpPr>
        <p:sp>
          <p:nvSpPr>
            <p:cNvPr id="153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4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5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6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7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8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9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0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1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2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3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4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5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6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7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8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69" name="Group 168"/>
          <p:cNvGrpSpPr/>
          <p:nvPr/>
        </p:nvGrpSpPr>
        <p:grpSpPr>
          <a:xfrm>
            <a:off x="3900706" y="5412995"/>
            <a:ext cx="2696694" cy="194217"/>
            <a:chOff x="649518" y="2723874"/>
            <a:chExt cx="2696694" cy="194217"/>
          </a:xfrm>
        </p:grpSpPr>
        <p:sp>
          <p:nvSpPr>
            <p:cNvPr id="170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1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2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3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4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5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6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7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8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9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0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1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2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3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4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5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86" name="Group 185"/>
          <p:cNvGrpSpPr/>
          <p:nvPr/>
        </p:nvGrpSpPr>
        <p:grpSpPr>
          <a:xfrm>
            <a:off x="6956849" y="5421011"/>
            <a:ext cx="2696694" cy="194217"/>
            <a:chOff x="649518" y="2723874"/>
            <a:chExt cx="2696694" cy="194217"/>
          </a:xfrm>
        </p:grpSpPr>
        <p:sp>
          <p:nvSpPr>
            <p:cNvPr id="187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8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9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0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1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2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3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4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5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6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7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8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9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0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1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2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22" name="Rectangle 21"/>
          <p:cNvSpPr/>
          <p:nvPr/>
        </p:nvSpPr>
        <p:spPr>
          <a:xfrm rot="16200000">
            <a:off x="2651114" y="4235550"/>
            <a:ext cx="22807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uscle</a:t>
            </a:r>
            <a:r>
              <a:rPr lang="he-IL" dirty="0"/>
              <a:t> </a:t>
            </a:r>
            <a:r>
              <a:rPr lang="en-US" i="1" dirty="0"/>
              <a:t>Per1 </a:t>
            </a:r>
            <a:r>
              <a:rPr lang="en-US" dirty="0"/>
              <a:t>relative mRNA levels</a:t>
            </a:r>
          </a:p>
        </p:txBody>
      </p:sp>
      <p:sp>
        <p:nvSpPr>
          <p:cNvPr id="24" name="Rectangle 23"/>
          <p:cNvSpPr/>
          <p:nvPr/>
        </p:nvSpPr>
        <p:spPr>
          <a:xfrm rot="16200000">
            <a:off x="5702108" y="4161011"/>
            <a:ext cx="22967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uscle</a:t>
            </a:r>
            <a:r>
              <a:rPr lang="he-IL" dirty="0"/>
              <a:t> </a:t>
            </a:r>
            <a:r>
              <a:rPr lang="en-US" i="1" dirty="0" err="1"/>
              <a:t>Ror</a:t>
            </a:r>
            <a:r>
              <a:rPr lang="el-GR" i="1" dirty="0"/>
              <a:t>α</a:t>
            </a:r>
            <a:r>
              <a:rPr lang="en-US" dirty="0"/>
              <a:t> relative mRNA levels</a:t>
            </a:r>
          </a:p>
        </p:txBody>
      </p:sp>
      <p:sp>
        <p:nvSpPr>
          <p:cNvPr id="206" name="Rectangle 205"/>
          <p:cNvSpPr/>
          <p:nvPr/>
        </p:nvSpPr>
        <p:spPr>
          <a:xfrm rot="16200000">
            <a:off x="-485281" y="6817464"/>
            <a:ext cx="241803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uscle </a:t>
            </a:r>
            <a:r>
              <a:rPr lang="en-US" i="1" dirty="0"/>
              <a:t>Reverb</a:t>
            </a:r>
            <a:r>
              <a:rPr lang="en-US" dirty="0"/>
              <a:t> relative mRNA levels</a:t>
            </a:r>
          </a:p>
        </p:txBody>
      </p:sp>
      <p:sp>
        <p:nvSpPr>
          <p:cNvPr id="207" name="תיבת טקסט 489">
            <a:extLst>
              <a:ext uri="{FF2B5EF4-FFF2-40B4-BE49-F238E27FC236}">
                <a16:creationId xmlns:a16="http://schemas.microsoft.com/office/drawing/2014/main" id="{5E95261A-7113-8B35-1C16-56FFA9CC0336}"/>
              </a:ext>
            </a:extLst>
          </p:cNvPr>
          <p:cNvSpPr txBox="1"/>
          <p:nvPr/>
        </p:nvSpPr>
        <p:spPr>
          <a:xfrm>
            <a:off x="789156" y="5801376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G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208" name="Group 207"/>
          <p:cNvGrpSpPr/>
          <p:nvPr/>
        </p:nvGrpSpPr>
        <p:grpSpPr>
          <a:xfrm>
            <a:off x="799189" y="8068766"/>
            <a:ext cx="2696694" cy="194217"/>
            <a:chOff x="649518" y="2723874"/>
            <a:chExt cx="2696694" cy="194217"/>
          </a:xfrm>
        </p:grpSpPr>
        <p:sp>
          <p:nvSpPr>
            <p:cNvPr id="209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0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1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2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3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4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5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6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7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8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9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20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21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22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23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24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151" name="Rectangle 150"/>
          <p:cNvSpPr/>
          <p:nvPr/>
        </p:nvSpPr>
        <p:spPr>
          <a:xfrm>
            <a:off x="297823" y="8778249"/>
            <a:ext cx="9557208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: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ffect of BHB on the circadian clock oscillation in muscle tissue. A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ogenin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. B.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ock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. C.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al1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. D.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y1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. E.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1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. F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r</a:t>
            </a:r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. G.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v-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b</a:t>
            </a:r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.</a:t>
            </a:r>
          </a:p>
        </p:txBody>
      </p:sp>
    </p:spTree>
    <p:extLst>
      <p:ext uri="{BB962C8B-B14F-4D97-AF65-F5344CB8AC3E}">
        <p14:creationId xmlns:p14="http://schemas.microsoft.com/office/powerpoint/2010/main" val="683052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תיבת טקסט 73">
            <a:extLst>
              <a:ext uri="{FF2B5EF4-FFF2-40B4-BE49-F238E27FC236}">
                <a16:creationId xmlns:a16="http://schemas.microsoft.com/office/drawing/2014/main" id="{12DD4FBC-88A5-495A-8BBD-DBE92305BD12}"/>
              </a:ext>
            </a:extLst>
          </p:cNvPr>
          <p:cNvSpPr txBox="1"/>
          <p:nvPr/>
        </p:nvSpPr>
        <p:spPr>
          <a:xfrm>
            <a:off x="259055" y="2936008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CRY1 66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3" name="תיבת טקסט 74">
            <a:extLst>
              <a:ext uri="{FF2B5EF4-FFF2-40B4-BE49-F238E27FC236}">
                <a16:creationId xmlns:a16="http://schemas.microsoft.com/office/drawing/2014/main" id="{33083F01-98B8-40E2-B9B2-C1A4ABEACEA4}"/>
              </a:ext>
            </a:extLst>
          </p:cNvPr>
          <p:cNvSpPr txBox="1"/>
          <p:nvPr/>
        </p:nvSpPr>
        <p:spPr>
          <a:xfrm>
            <a:off x="251035" y="3533580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ACTIN</a:t>
            </a: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42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4" name="טבלה 3">
            <a:extLst>
              <a:ext uri="{FF2B5EF4-FFF2-40B4-BE49-F238E27FC236}">
                <a16:creationId xmlns:a16="http://schemas.microsoft.com/office/drawing/2014/main" id="{F541CAEF-1A26-3B88-7409-B3CFEF620537}"/>
              </a:ext>
            </a:extLst>
          </p:cNvPr>
          <p:cNvGraphicFramePr>
            <a:graphicFrameLocks noGrp="1"/>
          </p:cNvGraphicFramePr>
          <p:nvPr/>
        </p:nvGraphicFramePr>
        <p:xfrm>
          <a:off x="1230309" y="534911"/>
          <a:ext cx="7620004" cy="3621507"/>
        </p:xfrm>
        <a:graphic>
          <a:graphicData uri="http://schemas.openxmlformats.org/drawingml/2006/table">
            <a:tbl>
              <a:tblPr rtl="1" firstRow="1" bandRow="1">
                <a:tableStyleId>{5940675A-B579-460E-94D1-54222C63F5DA}</a:tableStyleId>
              </a:tblPr>
              <a:tblGrid>
                <a:gridCol w="3810002">
                  <a:extLst>
                    <a:ext uri="{9D8B030D-6E8A-4147-A177-3AD203B41FA5}">
                      <a16:colId xmlns:a16="http://schemas.microsoft.com/office/drawing/2014/main" val="2673439277"/>
                    </a:ext>
                  </a:extLst>
                </a:gridCol>
                <a:gridCol w="3810002">
                  <a:extLst>
                    <a:ext uri="{9D8B030D-6E8A-4147-A177-3AD203B41FA5}">
                      <a16:colId xmlns:a16="http://schemas.microsoft.com/office/drawing/2014/main" val="112674736"/>
                    </a:ext>
                  </a:extLst>
                </a:gridCol>
              </a:tblGrid>
              <a:tr h="562362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5894319"/>
                  </a:ext>
                </a:extLst>
              </a:tr>
              <a:tr h="604506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8848110"/>
                  </a:ext>
                </a:extLst>
              </a:tr>
              <a:tr h="597523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5384007"/>
                  </a:ext>
                </a:extLst>
              </a:tr>
              <a:tr h="617863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28102718"/>
                  </a:ext>
                </a:extLst>
              </a:tr>
              <a:tr h="601579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8765973"/>
                  </a:ext>
                </a:extLst>
              </a:tr>
              <a:tr h="637674"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endParaRPr lang="he-IL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1069457"/>
                  </a:ext>
                </a:extLst>
              </a:tr>
            </a:tbl>
          </a:graphicData>
        </a:graphic>
      </p:graphicFrame>
      <p:sp>
        <p:nvSpPr>
          <p:cNvPr id="13" name="תיבת טקסט 12">
            <a:extLst>
              <a:ext uri="{FF2B5EF4-FFF2-40B4-BE49-F238E27FC236}">
                <a16:creationId xmlns:a16="http://schemas.microsoft.com/office/drawing/2014/main" id="{10084B39-BF93-0B4C-D672-02D1723073E3}"/>
              </a:ext>
            </a:extLst>
          </p:cNvPr>
          <p:cNvSpPr txBox="1"/>
          <p:nvPr/>
        </p:nvSpPr>
        <p:spPr>
          <a:xfrm>
            <a:off x="275095" y="1191439"/>
            <a:ext cx="971241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CLOCK   90-110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תיבת טקסט 13">
            <a:extLst>
              <a:ext uri="{FF2B5EF4-FFF2-40B4-BE49-F238E27FC236}">
                <a16:creationId xmlns:a16="http://schemas.microsoft.com/office/drawing/2014/main" id="{A148D558-4803-4E6A-4C0D-A61611C4CE0D}"/>
              </a:ext>
            </a:extLst>
          </p:cNvPr>
          <p:cNvSpPr txBox="1"/>
          <p:nvPr/>
        </p:nvSpPr>
        <p:spPr>
          <a:xfrm>
            <a:off x="2077541" y="536045"/>
            <a:ext cx="656718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Chow</a:t>
            </a:r>
            <a:endParaRPr lang="he-IL" sz="1600" dirty="0"/>
          </a:p>
        </p:txBody>
      </p:sp>
      <p:sp>
        <p:nvSpPr>
          <p:cNvPr id="15" name="תיבת טקסט 14">
            <a:extLst>
              <a:ext uri="{FF2B5EF4-FFF2-40B4-BE49-F238E27FC236}">
                <a16:creationId xmlns:a16="http://schemas.microsoft.com/office/drawing/2014/main" id="{8E22B857-D879-D241-DD68-2AE49A469FF4}"/>
              </a:ext>
            </a:extLst>
          </p:cNvPr>
          <p:cNvSpPr txBox="1"/>
          <p:nvPr/>
        </p:nvSpPr>
        <p:spPr>
          <a:xfrm>
            <a:off x="3590696" y="543015"/>
            <a:ext cx="1111971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 err="1"/>
              <a:t>Chow+BHB</a:t>
            </a:r>
            <a:endParaRPr lang="he-IL" sz="1600" dirty="0"/>
          </a:p>
        </p:txBody>
      </p:sp>
      <p:pic>
        <p:nvPicPr>
          <p:cNvPr id="52" name="תמונה 51">
            <a:extLst>
              <a:ext uri="{FF2B5EF4-FFF2-40B4-BE49-F238E27FC236}">
                <a16:creationId xmlns:a16="http://schemas.microsoft.com/office/drawing/2014/main" id="{8CDE9EE0-CA41-7F68-D899-A653A5C9A1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89162" y="1080299"/>
            <a:ext cx="285750" cy="180975"/>
          </a:xfrm>
          <a:prstGeom prst="rect">
            <a:avLst/>
          </a:prstGeom>
        </p:spPr>
      </p:pic>
      <p:sp>
        <p:nvSpPr>
          <p:cNvPr id="53" name="תיבת טקסט 52">
            <a:extLst>
              <a:ext uri="{FF2B5EF4-FFF2-40B4-BE49-F238E27FC236}">
                <a16:creationId xmlns:a16="http://schemas.microsoft.com/office/drawing/2014/main" id="{A8779246-1101-ACEF-38FC-2A94AFDCD7CF}"/>
              </a:ext>
            </a:extLst>
          </p:cNvPr>
          <p:cNvSpPr txBox="1"/>
          <p:nvPr/>
        </p:nvSpPr>
        <p:spPr>
          <a:xfrm>
            <a:off x="9168342" y="1035357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150 KD</a:t>
            </a:r>
            <a:endParaRPr lang="he-IL" sz="1200" dirty="0"/>
          </a:p>
        </p:txBody>
      </p:sp>
      <p:pic>
        <p:nvPicPr>
          <p:cNvPr id="54" name="תמונה 53">
            <a:extLst>
              <a:ext uri="{FF2B5EF4-FFF2-40B4-BE49-F238E27FC236}">
                <a16:creationId xmlns:a16="http://schemas.microsoft.com/office/drawing/2014/main" id="{BE8B14D5-7F92-E9C6-B04B-AB52A45F10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62753" y="2848181"/>
            <a:ext cx="361950" cy="152400"/>
          </a:xfrm>
          <a:prstGeom prst="rect">
            <a:avLst/>
          </a:prstGeom>
        </p:spPr>
      </p:pic>
      <p:sp>
        <p:nvSpPr>
          <p:cNvPr id="55" name="תיבת טקסט 54">
            <a:extLst>
              <a:ext uri="{FF2B5EF4-FFF2-40B4-BE49-F238E27FC236}">
                <a16:creationId xmlns:a16="http://schemas.microsoft.com/office/drawing/2014/main" id="{43FA4DCC-31E0-F113-B69C-C939B1412789}"/>
              </a:ext>
            </a:extLst>
          </p:cNvPr>
          <p:cNvSpPr txBox="1"/>
          <p:nvPr/>
        </p:nvSpPr>
        <p:spPr>
          <a:xfrm>
            <a:off x="9152291" y="2835734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75 KD</a:t>
            </a:r>
            <a:endParaRPr lang="he-IL" sz="1200" dirty="0"/>
          </a:p>
        </p:txBody>
      </p:sp>
      <p:pic>
        <p:nvPicPr>
          <p:cNvPr id="58" name="תמונה 57">
            <a:extLst>
              <a:ext uri="{FF2B5EF4-FFF2-40B4-BE49-F238E27FC236}">
                <a16:creationId xmlns:a16="http://schemas.microsoft.com/office/drawing/2014/main" id="{CB3F7469-FAFC-217D-D19E-6802937876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90663" y="3391526"/>
            <a:ext cx="342900" cy="171450"/>
          </a:xfrm>
          <a:prstGeom prst="rect">
            <a:avLst/>
          </a:prstGeom>
        </p:spPr>
      </p:pic>
      <p:sp>
        <p:nvSpPr>
          <p:cNvPr id="59" name="תיבת טקסט 58">
            <a:extLst>
              <a:ext uri="{FF2B5EF4-FFF2-40B4-BE49-F238E27FC236}">
                <a16:creationId xmlns:a16="http://schemas.microsoft.com/office/drawing/2014/main" id="{B88E4FDA-40FB-15EA-2598-D40993CDB69F}"/>
              </a:ext>
            </a:extLst>
          </p:cNvPr>
          <p:cNvSpPr txBox="1"/>
          <p:nvPr/>
        </p:nvSpPr>
        <p:spPr>
          <a:xfrm>
            <a:off x="9145327" y="3334440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50 KD</a:t>
            </a:r>
            <a:endParaRPr lang="he-IL" sz="1200" dirty="0"/>
          </a:p>
        </p:txBody>
      </p:sp>
      <p:pic>
        <p:nvPicPr>
          <p:cNvPr id="60" name="תמונה 59">
            <a:extLst>
              <a:ext uri="{FF2B5EF4-FFF2-40B4-BE49-F238E27FC236}">
                <a16:creationId xmlns:a16="http://schemas.microsoft.com/office/drawing/2014/main" id="{22B964ED-D404-ECF2-9BD5-A1E53C7FE1A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71918" y="4089440"/>
            <a:ext cx="314325" cy="161925"/>
          </a:xfrm>
          <a:prstGeom prst="rect">
            <a:avLst/>
          </a:prstGeom>
        </p:spPr>
      </p:pic>
      <p:sp>
        <p:nvSpPr>
          <p:cNvPr id="61" name="תיבת טקסט 60">
            <a:extLst>
              <a:ext uri="{FF2B5EF4-FFF2-40B4-BE49-F238E27FC236}">
                <a16:creationId xmlns:a16="http://schemas.microsoft.com/office/drawing/2014/main" id="{82C0C43A-C2A4-882F-9132-0BE298F81047}"/>
              </a:ext>
            </a:extLst>
          </p:cNvPr>
          <p:cNvSpPr txBox="1"/>
          <p:nvPr/>
        </p:nvSpPr>
        <p:spPr>
          <a:xfrm>
            <a:off x="9141315" y="4010903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37 KD</a:t>
            </a:r>
            <a:endParaRPr lang="he-IL" sz="1200" dirty="0"/>
          </a:p>
        </p:txBody>
      </p:sp>
      <p:sp>
        <p:nvSpPr>
          <p:cNvPr id="74" name="תיבת טקסט 73">
            <a:extLst>
              <a:ext uri="{FF2B5EF4-FFF2-40B4-BE49-F238E27FC236}">
                <a16:creationId xmlns:a16="http://schemas.microsoft.com/office/drawing/2014/main" id="{91B1BEED-6FA7-0927-1357-5075D6D3EC72}"/>
              </a:ext>
            </a:extLst>
          </p:cNvPr>
          <p:cNvSpPr txBox="1"/>
          <p:nvPr/>
        </p:nvSpPr>
        <p:spPr>
          <a:xfrm>
            <a:off x="267075" y="1789001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BMALL 78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5" name="תיבת טקסט 74">
            <a:extLst>
              <a:ext uri="{FF2B5EF4-FFF2-40B4-BE49-F238E27FC236}">
                <a16:creationId xmlns:a16="http://schemas.microsoft.com/office/drawing/2014/main" id="{00A37420-FBAE-525A-18E0-A53BFCFEEDA9}"/>
              </a:ext>
            </a:extLst>
          </p:cNvPr>
          <p:cNvSpPr txBox="1"/>
          <p:nvPr/>
        </p:nvSpPr>
        <p:spPr>
          <a:xfrm>
            <a:off x="259055" y="2386573"/>
            <a:ext cx="92183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BMALL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78kDa</a:t>
            </a:r>
            <a:endParaRPr lang="he-IL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3" name="TextBox 66">
            <a:extLst>
              <a:ext uri="{FF2B5EF4-FFF2-40B4-BE49-F238E27FC236}">
                <a16:creationId xmlns:a16="http://schemas.microsoft.com/office/drawing/2014/main" id="{0B557832-60B7-B090-7FF9-5DBC777DA6E9}"/>
              </a:ext>
            </a:extLst>
          </p:cNvPr>
          <p:cNvSpPr txBox="1"/>
          <p:nvPr/>
        </p:nvSpPr>
        <p:spPr>
          <a:xfrm>
            <a:off x="-10732" y="2814"/>
            <a:ext cx="20780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. S8</a:t>
            </a:r>
          </a:p>
        </p:txBody>
      </p:sp>
      <p:sp>
        <p:nvSpPr>
          <p:cNvPr id="144" name="Rectangle 1">
            <a:extLst>
              <a:ext uri="{FF2B5EF4-FFF2-40B4-BE49-F238E27FC236}">
                <a16:creationId xmlns:a16="http://schemas.microsoft.com/office/drawing/2014/main" id="{33023028-B64F-BC1F-3D8C-541D342F58BA}"/>
              </a:ext>
            </a:extLst>
          </p:cNvPr>
          <p:cNvSpPr/>
          <p:nvPr/>
        </p:nvSpPr>
        <p:spPr>
          <a:xfrm>
            <a:off x="127735" y="4594836"/>
            <a:ext cx="983441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S8: Western blot protein analysis of the </a:t>
            </a:r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effect of HF and BHB supplementation on the circadian clock in adipose tissue.</a:t>
            </a:r>
          </a:p>
          <a:p>
            <a:pPr algn="ctr"/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6" name="קבוצה 5">
            <a:extLst>
              <a:ext uri="{FF2B5EF4-FFF2-40B4-BE49-F238E27FC236}">
                <a16:creationId xmlns:a16="http://schemas.microsoft.com/office/drawing/2014/main" id="{4AFD568D-41C8-4AAE-9C08-0407F9153474}"/>
              </a:ext>
            </a:extLst>
          </p:cNvPr>
          <p:cNvGrpSpPr/>
          <p:nvPr/>
        </p:nvGrpSpPr>
        <p:grpSpPr>
          <a:xfrm>
            <a:off x="1709581" y="822715"/>
            <a:ext cx="1367729" cy="329471"/>
            <a:chOff x="1709581" y="1009697"/>
            <a:chExt cx="1367729" cy="329471"/>
          </a:xfrm>
        </p:grpSpPr>
        <p:sp>
          <p:nvSpPr>
            <p:cNvPr id="133" name="סוגר מרובע ימני 132">
              <a:extLst>
                <a:ext uri="{FF2B5EF4-FFF2-40B4-BE49-F238E27FC236}">
                  <a16:creationId xmlns:a16="http://schemas.microsoft.com/office/drawing/2014/main" id="{B9467D85-7C62-837F-2A06-957E29059C2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97" name="TextBox 64">
              <a:extLst>
                <a:ext uri="{FF2B5EF4-FFF2-40B4-BE49-F238E27FC236}">
                  <a16:creationId xmlns:a16="http://schemas.microsoft.com/office/drawing/2014/main" id="{AA912D09-30B1-E356-7B4F-06293C79B1D6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98" name="TextBox 65">
              <a:extLst>
                <a:ext uri="{FF2B5EF4-FFF2-40B4-BE49-F238E27FC236}">
                  <a16:creationId xmlns:a16="http://schemas.microsoft.com/office/drawing/2014/main" id="{A20BC556-D3BC-7379-0531-5B4A8F52A7E6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99" name="TextBox 66">
              <a:extLst>
                <a:ext uri="{FF2B5EF4-FFF2-40B4-BE49-F238E27FC236}">
                  <a16:creationId xmlns:a16="http://schemas.microsoft.com/office/drawing/2014/main" id="{0B83B336-88AD-24DD-C3E1-540421E857AE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00" name="TextBox 67">
              <a:extLst>
                <a:ext uri="{FF2B5EF4-FFF2-40B4-BE49-F238E27FC236}">
                  <a16:creationId xmlns:a16="http://schemas.microsoft.com/office/drawing/2014/main" id="{0099CB3B-5887-94B5-417C-DE4A1F1639E9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01" name="TextBox 68">
              <a:extLst>
                <a:ext uri="{FF2B5EF4-FFF2-40B4-BE49-F238E27FC236}">
                  <a16:creationId xmlns:a16="http://schemas.microsoft.com/office/drawing/2014/main" id="{DAAA0074-528E-8F9E-4979-1323FF279B2E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84" name="TextBox 68">
            <a:extLst>
              <a:ext uri="{FF2B5EF4-FFF2-40B4-BE49-F238E27FC236}">
                <a16:creationId xmlns:a16="http://schemas.microsoft.com/office/drawing/2014/main" id="{059F3F98-4615-47B4-8364-1C126FC84F9D}"/>
              </a:ext>
            </a:extLst>
          </p:cNvPr>
          <p:cNvSpPr txBox="1"/>
          <p:nvPr/>
        </p:nvSpPr>
        <p:spPr>
          <a:xfrm>
            <a:off x="2890382" y="877097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grpSp>
        <p:nvGrpSpPr>
          <p:cNvPr id="104" name="קבוצה 103">
            <a:extLst>
              <a:ext uri="{FF2B5EF4-FFF2-40B4-BE49-F238E27FC236}">
                <a16:creationId xmlns:a16="http://schemas.microsoft.com/office/drawing/2014/main" id="{9EFA4827-C724-44BF-B18A-473DBE8EF8CF}"/>
              </a:ext>
            </a:extLst>
          </p:cNvPr>
          <p:cNvGrpSpPr/>
          <p:nvPr/>
        </p:nvGrpSpPr>
        <p:grpSpPr>
          <a:xfrm>
            <a:off x="3464317" y="825620"/>
            <a:ext cx="1367729" cy="329471"/>
            <a:chOff x="1709581" y="1009697"/>
            <a:chExt cx="1367729" cy="329471"/>
          </a:xfrm>
        </p:grpSpPr>
        <p:sp>
          <p:nvSpPr>
            <p:cNvPr id="105" name="סוגר מרובע ימני 104">
              <a:extLst>
                <a:ext uri="{FF2B5EF4-FFF2-40B4-BE49-F238E27FC236}">
                  <a16:creationId xmlns:a16="http://schemas.microsoft.com/office/drawing/2014/main" id="{BDED5688-72A1-4B2A-AA2A-3CBA0A79E27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06" name="TextBox 64">
              <a:extLst>
                <a:ext uri="{FF2B5EF4-FFF2-40B4-BE49-F238E27FC236}">
                  <a16:creationId xmlns:a16="http://schemas.microsoft.com/office/drawing/2014/main" id="{28BF52E6-BA50-487C-ACA5-6982911FAA0C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07" name="TextBox 65">
              <a:extLst>
                <a:ext uri="{FF2B5EF4-FFF2-40B4-BE49-F238E27FC236}">
                  <a16:creationId xmlns:a16="http://schemas.microsoft.com/office/drawing/2014/main" id="{FFBD7BED-404E-45F4-A258-952F5CD7E222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08" name="TextBox 66">
              <a:extLst>
                <a:ext uri="{FF2B5EF4-FFF2-40B4-BE49-F238E27FC236}">
                  <a16:creationId xmlns:a16="http://schemas.microsoft.com/office/drawing/2014/main" id="{FC9843A3-53C7-4FAA-B4B3-1F0EE56C25B7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09" name="TextBox 67">
              <a:extLst>
                <a:ext uri="{FF2B5EF4-FFF2-40B4-BE49-F238E27FC236}">
                  <a16:creationId xmlns:a16="http://schemas.microsoft.com/office/drawing/2014/main" id="{1B859FF9-24F4-458D-8A53-E997FC5B7F0E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10" name="TextBox 68">
              <a:extLst>
                <a:ext uri="{FF2B5EF4-FFF2-40B4-BE49-F238E27FC236}">
                  <a16:creationId xmlns:a16="http://schemas.microsoft.com/office/drawing/2014/main" id="{3BE4D8CB-9E84-42AD-8179-9C7C0602D6F1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11" name="TextBox 68">
            <a:extLst>
              <a:ext uri="{FF2B5EF4-FFF2-40B4-BE49-F238E27FC236}">
                <a16:creationId xmlns:a16="http://schemas.microsoft.com/office/drawing/2014/main" id="{212134D3-F29F-48F4-83F9-FD1A955BC73A}"/>
              </a:ext>
            </a:extLst>
          </p:cNvPr>
          <p:cNvSpPr txBox="1"/>
          <p:nvPr/>
        </p:nvSpPr>
        <p:spPr>
          <a:xfrm>
            <a:off x="4631437" y="880429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sp>
        <p:nvSpPr>
          <p:cNvPr id="112" name="תיבת טקסט 13">
            <a:extLst>
              <a:ext uri="{FF2B5EF4-FFF2-40B4-BE49-F238E27FC236}">
                <a16:creationId xmlns:a16="http://schemas.microsoft.com/office/drawing/2014/main" id="{B27A25D1-B7A9-4B6D-A3A0-173CDAABF010}"/>
              </a:ext>
            </a:extLst>
          </p:cNvPr>
          <p:cNvSpPr txBox="1"/>
          <p:nvPr/>
        </p:nvSpPr>
        <p:spPr>
          <a:xfrm>
            <a:off x="5842567" y="538545"/>
            <a:ext cx="407484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HF</a:t>
            </a:r>
            <a:endParaRPr lang="he-IL" sz="1600" dirty="0"/>
          </a:p>
        </p:txBody>
      </p:sp>
      <p:sp>
        <p:nvSpPr>
          <p:cNvPr id="113" name="תיבת טקסט 14">
            <a:extLst>
              <a:ext uri="{FF2B5EF4-FFF2-40B4-BE49-F238E27FC236}">
                <a16:creationId xmlns:a16="http://schemas.microsoft.com/office/drawing/2014/main" id="{4C13841B-9DC1-4201-A63D-F5355298E5B9}"/>
              </a:ext>
            </a:extLst>
          </p:cNvPr>
          <p:cNvSpPr txBox="1"/>
          <p:nvPr/>
        </p:nvSpPr>
        <p:spPr>
          <a:xfrm>
            <a:off x="7355722" y="545515"/>
            <a:ext cx="862737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/>
              <a:t>HF+BHB</a:t>
            </a:r>
            <a:endParaRPr lang="he-IL" sz="1600" dirty="0"/>
          </a:p>
        </p:txBody>
      </p:sp>
      <p:grpSp>
        <p:nvGrpSpPr>
          <p:cNvPr id="114" name="קבוצה 113">
            <a:extLst>
              <a:ext uri="{FF2B5EF4-FFF2-40B4-BE49-F238E27FC236}">
                <a16:creationId xmlns:a16="http://schemas.microsoft.com/office/drawing/2014/main" id="{8181050A-528A-40E5-9454-114F8D16F038}"/>
              </a:ext>
            </a:extLst>
          </p:cNvPr>
          <p:cNvGrpSpPr/>
          <p:nvPr/>
        </p:nvGrpSpPr>
        <p:grpSpPr>
          <a:xfrm>
            <a:off x="5474607" y="825215"/>
            <a:ext cx="1367729" cy="329471"/>
            <a:chOff x="1709581" y="1009697"/>
            <a:chExt cx="1367729" cy="329471"/>
          </a:xfrm>
        </p:grpSpPr>
        <p:sp>
          <p:nvSpPr>
            <p:cNvPr id="137" name="סוגר מרובע ימני 136">
              <a:extLst>
                <a:ext uri="{FF2B5EF4-FFF2-40B4-BE49-F238E27FC236}">
                  <a16:creationId xmlns:a16="http://schemas.microsoft.com/office/drawing/2014/main" id="{392BA01C-5A4F-4E30-8375-892DADCD1EB3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39" name="TextBox 64">
              <a:extLst>
                <a:ext uri="{FF2B5EF4-FFF2-40B4-BE49-F238E27FC236}">
                  <a16:creationId xmlns:a16="http://schemas.microsoft.com/office/drawing/2014/main" id="{5CA97C4B-4E4F-4350-885F-70BA4A65C1DE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41" name="TextBox 65">
              <a:extLst>
                <a:ext uri="{FF2B5EF4-FFF2-40B4-BE49-F238E27FC236}">
                  <a16:creationId xmlns:a16="http://schemas.microsoft.com/office/drawing/2014/main" id="{910161C2-EB0C-4D02-962D-BA04D3697E41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45" name="TextBox 66">
              <a:extLst>
                <a:ext uri="{FF2B5EF4-FFF2-40B4-BE49-F238E27FC236}">
                  <a16:creationId xmlns:a16="http://schemas.microsoft.com/office/drawing/2014/main" id="{069F509B-4416-4CEC-A09D-9613C304B507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46" name="TextBox 67">
              <a:extLst>
                <a:ext uri="{FF2B5EF4-FFF2-40B4-BE49-F238E27FC236}">
                  <a16:creationId xmlns:a16="http://schemas.microsoft.com/office/drawing/2014/main" id="{D1A0B974-A9F6-4CFD-8143-8E8AC797A7A8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47" name="TextBox 68">
              <a:extLst>
                <a:ext uri="{FF2B5EF4-FFF2-40B4-BE49-F238E27FC236}">
                  <a16:creationId xmlns:a16="http://schemas.microsoft.com/office/drawing/2014/main" id="{74983962-1DF6-468A-9D7C-787E0E0D3F64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48" name="TextBox 68">
            <a:extLst>
              <a:ext uri="{FF2B5EF4-FFF2-40B4-BE49-F238E27FC236}">
                <a16:creationId xmlns:a16="http://schemas.microsoft.com/office/drawing/2014/main" id="{A21AB5A2-F4AA-4EA7-8209-B78CB1D8CCFB}"/>
              </a:ext>
            </a:extLst>
          </p:cNvPr>
          <p:cNvSpPr txBox="1"/>
          <p:nvPr/>
        </p:nvSpPr>
        <p:spPr>
          <a:xfrm>
            <a:off x="6655408" y="879597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grpSp>
        <p:nvGrpSpPr>
          <p:cNvPr id="149" name="קבוצה 148">
            <a:extLst>
              <a:ext uri="{FF2B5EF4-FFF2-40B4-BE49-F238E27FC236}">
                <a16:creationId xmlns:a16="http://schemas.microsoft.com/office/drawing/2014/main" id="{CCC49AA6-3540-41C4-80A0-D9170B688B5D}"/>
              </a:ext>
            </a:extLst>
          </p:cNvPr>
          <p:cNvGrpSpPr/>
          <p:nvPr/>
        </p:nvGrpSpPr>
        <p:grpSpPr>
          <a:xfrm>
            <a:off x="7229343" y="828120"/>
            <a:ext cx="1367729" cy="329471"/>
            <a:chOff x="1709581" y="1009697"/>
            <a:chExt cx="1367729" cy="329471"/>
          </a:xfrm>
        </p:grpSpPr>
        <p:sp>
          <p:nvSpPr>
            <p:cNvPr id="150" name="סוגר מרובע ימני 149">
              <a:extLst>
                <a:ext uri="{FF2B5EF4-FFF2-40B4-BE49-F238E27FC236}">
                  <a16:creationId xmlns:a16="http://schemas.microsoft.com/office/drawing/2014/main" id="{B9AD1C17-2C9C-4AF8-BEC7-72259B00F177}"/>
                </a:ext>
              </a:extLst>
            </p:cNvPr>
            <p:cNvSpPr/>
            <p:nvPr/>
          </p:nvSpPr>
          <p:spPr>
            <a:xfrm rot="16200000">
              <a:off x="2434570" y="412676"/>
              <a:ext cx="45719" cy="1239761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51" name="TextBox 64">
              <a:extLst>
                <a:ext uri="{FF2B5EF4-FFF2-40B4-BE49-F238E27FC236}">
                  <a16:creationId xmlns:a16="http://schemas.microsoft.com/office/drawing/2014/main" id="{4700D035-9DCE-405D-B9F2-C115B053D1EB}"/>
                </a:ext>
              </a:extLst>
            </p:cNvPr>
            <p:cNvSpPr txBox="1"/>
            <p:nvPr/>
          </p:nvSpPr>
          <p:spPr>
            <a:xfrm>
              <a:off x="1709581" y="1060559"/>
              <a:ext cx="2505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</a:t>
              </a:r>
            </a:p>
          </p:txBody>
        </p:sp>
        <p:sp>
          <p:nvSpPr>
            <p:cNvPr id="152" name="TextBox 65">
              <a:extLst>
                <a:ext uri="{FF2B5EF4-FFF2-40B4-BE49-F238E27FC236}">
                  <a16:creationId xmlns:a16="http://schemas.microsoft.com/office/drawing/2014/main" id="{27E089C8-3DB8-4806-8E41-986703E9923A}"/>
                </a:ext>
              </a:extLst>
            </p:cNvPr>
            <p:cNvSpPr txBox="1"/>
            <p:nvPr/>
          </p:nvSpPr>
          <p:spPr>
            <a:xfrm>
              <a:off x="1915478" y="1062169"/>
              <a:ext cx="361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4</a:t>
              </a:r>
            </a:p>
          </p:txBody>
        </p:sp>
        <p:sp>
          <p:nvSpPr>
            <p:cNvPr id="153" name="TextBox 66">
              <a:extLst>
                <a:ext uri="{FF2B5EF4-FFF2-40B4-BE49-F238E27FC236}">
                  <a16:creationId xmlns:a16="http://schemas.microsoft.com/office/drawing/2014/main" id="{BAD3E3FC-9994-4FF6-86D0-66A1EC6D49AD}"/>
                </a:ext>
              </a:extLst>
            </p:cNvPr>
            <p:cNvSpPr txBox="1"/>
            <p:nvPr/>
          </p:nvSpPr>
          <p:spPr>
            <a:xfrm>
              <a:off x="2152125" y="1061061"/>
              <a:ext cx="359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154" name="TextBox 67">
              <a:extLst>
                <a:ext uri="{FF2B5EF4-FFF2-40B4-BE49-F238E27FC236}">
                  <a16:creationId xmlns:a16="http://schemas.microsoft.com/office/drawing/2014/main" id="{17A5D0ED-7B6B-419B-B914-2A242B34BD34}"/>
                </a:ext>
              </a:extLst>
            </p:cNvPr>
            <p:cNvSpPr txBox="1"/>
            <p:nvPr/>
          </p:nvSpPr>
          <p:spPr>
            <a:xfrm>
              <a:off x="2353711" y="106139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2</a:t>
              </a:r>
            </a:p>
          </p:txBody>
        </p:sp>
        <p:sp>
          <p:nvSpPr>
            <p:cNvPr id="155" name="TextBox 68">
              <a:extLst>
                <a:ext uri="{FF2B5EF4-FFF2-40B4-BE49-F238E27FC236}">
                  <a16:creationId xmlns:a16="http://schemas.microsoft.com/office/drawing/2014/main" id="{18B500CA-3022-4D90-9C4B-E3B87E4FB031}"/>
                </a:ext>
              </a:extLst>
            </p:cNvPr>
            <p:cNvSpPr txBox="1"/>
            <p:nvPr/>
          </p:nvSpPr>
          <p:spPr>
            <a:xfrm>
              <a:off x="2618062" y="1061579"/>
              <a:ext cx="413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6</a:t>
              </a:r>
            </a:p>
          </p:txBody>
        </p:sp>
      </p:grpSp>
      <p:sp>
        <p:nvSpPr>
          <p:cNvPr id="156" name="TextBox 68">
            <a:extLst>
              <a:ext uri="{FF2B5EF4-FFF2-40B4-BE49-F238E27FC236}">
                <a16:creationId xmlns:a16="http://schemas.microsoft.com/office/drawing/2014/main" id="{BE1723CA-D04E-49D0-AD3D-B510BC00B2A8}"/>
              </a:ext>
            </a:extLst>
          </p:cNvPr>
          <p:cNvSpPr txBox="1"/>
          <p:nvPr/>
        </p:nvSpPr>
        <p:spPr>
          <a:xfrm>
            <a:off x="8396463" y="882929"/>
            <a:ext cx="413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0</a:t>
            </a:r>
          </a:p>
        </p:txBody>
      </p:sp>
      <p:pic>
        <p:nvPicPr>
          <p:cNvPr id="72" name="תמונה 71">
            <a:extLst>
              <a:ext uri="{FF2B5EF4-FFF2-40B4-BE49-F238E27FC236}">
                <a16:creationId xmlns:a16="http://schemas.microsoft.com/office/drawing/2014/main" id="{3D14EB1E-D1BE-4BFC-A533-61AA75834B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94574" y="1594810"/>
            <a:ext cx="304800" cy="152400"/>
          </a:xfrm>
          <a:prstGeom prst="rect">
            <a:avLst/>
          </a:prstGeom>
        </p:spPr>
      </p:pic>
      <p:sp>
        <p:nvSpPr>
          <p:cNvPr id="73" name="תיבת טקסט 53">
            <a:extLst>
              <a:ext uri="{FF2B5EF4-FFF2-40B4-BE49-F238E27FC236}">
                <a16:creationId xmlns:a16="http://schemas.microsoft.com/office/drawing/2014/main" id="{E8EC8839-AA36-4873-8D22-0999BD495BF5}"/>
              </a:ext>
            </a:extLst>
          </p:cNvPr>
          <p:cNvSpPr txBox="1"/>
          <p:nvPr/>
        </p:nvSpPr>
        <p:spPr>
          <a:xfrm>
            <a:off x="9179316" y="1518345"/>
            <a:ext cx="7268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100 KD</a:t>
            </a:r>
            <a:endParaRPr lang="he-IL" sz="12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44466" y="1184033"/>
            <a:ext cx="3596952" cy="42675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72638" y="1867420"/>
            <a:ext cx="3603048" cy="23166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72638" y="2511370"/>
            <a:ext cx="3633531" cy="20118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089848" y="3041036"/>
            <a:ext cx="3676207" cy="36579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50171" y="3594925"/>
            <a:ext cx="3621338" cy="46333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520829" y="1205353"/>
            <a:ext cx="3475021" cy="414564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384200" y="1846425"/>
            <a:ext cx="3596952" cy="24386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366670" y="2422969"/>
            <a:ext cx="3639627" cy="37798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262863" y="3127012"/>
            <a:ext cx="3773751" cy="225572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336021" y="3687222"/>
            <a:ext cx="3627434" cy="3048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62816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0" name="Chart 209">
            <a:extLst>
              <a:ext uri="{FF2B5EF4-FFF2-40B4-BE49-F238E27FC236}">
                <a16:creationId xmlns:a16="http://schemas.microsoft.com/office/drawing/2014/main" id="{BCEA061F-D6E9-4EE2-B116-4AA3212AB74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9555662"/>
              </p:ext>
            </p:extLst>
          </p:nvPr>
        </p:nvGraphicFramePr>
        <p:xfrm>
          <a:off x="7025476" y="3383831"/>
          <a:ext cx="2642908" cy="20049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09" name="Chart 208">
            <a:extLst>
              <a:ext uri="{FF2B5EF4-FFF2-40B4-BE49-F238E27FC236}">
                <a16:creationId xmlns:a16="http://schemas.microsoft.com/office/drawing/2014/main" id="{67A982E3-56EB-437E-ADFB-597C9A048D1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9673328"/>
              </p:ext>
            </p:extLst>
          </p:nvPr>
        </p:nvGraphicFramePr>
        <p:xfrm>
          <a:off x="3956806" y="3402273"/>
          <a:ext cx="2667793" cy="1977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08" name="Chart 207">
            <a:extLst>
              <a:ext uri="{FF2B5EF4-FFF2-40B4-BE49-F238E27FC236}">
                <a16:creationId xmlns:a16="http://schemas.microsoft.com/office/drawing/2014/main" id="{9689D936-B6D4-43CF-AE98-3F25EFFBAA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0368696"/>
              </p:ext>
            </p:extLst>
          </p:nvPr>
        </p:nvGraphicFramePr>
        <p:xfrm>
          <a:off x="766887" y="3393382"/>
          <a:ext cx="2780159" cy="19924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7" name="Chart 206">
            <a:extLst>
              <a:ext uri="{FF2B5EF4-FFF2-40B4-BE49-F238E27FC236}">
                <a16:creationId xmlns:a16="http://schemas.microsoft.com/office/drawing/2014/main" id="{693D8D20-2E1E-4373-A19D-58D2AA2E645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6013858"/>
              </p:ext>
            </p:extLst>
          </p:nvPr>
        </p:nvGraphicFramePr>
        <p:xfrm>
          <a:off x="7015827" y="775322"/>
          <a:ext cx="2652556" cy="19773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06" name="Chart 205">
            <a:extLst>
              <a:ext uri="{FF2B5EF4-FFF2-40B4-BE49-F238E27FC236}">
                <a16:creationId xmlns:a16="http://schemas.microsoft.com/office/drawing/2014/main" id="{591A2AF4-2DB1-4688-B263-03B5043969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3006782"/>
              </p:ext>
            </p:extLst>
          </p:nvPr>
        </p:nvGraphicFramePr>
        <p:xfrm>
          <a:off x="3957117" y="828100"/>
          <a:ext cx="2667483" cy="19225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05" name="Chart 204">
            <a:extLst>
              <a:ext uri="{FF2B5EF4-FFF2-40B4-BE49-F238E27FC236}">
                <a16:creationId xmlns:a16="http://schemas.microsoft.com/office/drawing/2014/main" id="{7E32D7E4-9246-426F-844C-8F07E9D2CE3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7181674"/>
              </p:ext>
            </p:extLst>
          </p:nvPr>
        </p:nvGraphicFramePr>
        <p:xfrm>
          <a:off x="782765" y="817476"/>
          <a:ext cx="2754922" cy="19332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8" name="Rectangle 17"/>
          <p:cNvSpPr/>
          <p:nvPr/>
        </p:nvSpPr>
        <p:spPr>
          <a:xfrm rot="16200000">
            <a:off x="-269378" y="4244087"/>
            <a:ext cx="201234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at </a:t>
            </a:r>
            <a:r>
              <a:rPr lang="en-US" i="1" dirty="0"/>
              <a:t>Per1</a:t>
            </a:r>
            <a:r>
              <a:rPr lang="en-US" dirty="0"/>
              <a:t> relative mRNA levels</a:t>
            </a:r>
          </a:p>
        </p:txBody>
      </p:sp>
      <p:sp>
        <p:nvSpPr>
          <p:cNvPr id="15" name="Rectangle 14"/>
          <p:cNvSpPr/>
          <p:nvPr/>
        </p:nvSpPr>
        <p:spPr>
          <a:xfrm rot="16200000">
            <a:off x="5861544" y="1580530"/>
            <a:ext cx="20114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at </a:t>
            </a:r>
            <a:r>
              <a:rPr lang="en-US" i="1" dirty="0"/>
              <a:t>Cry1</a:t>
            </a:r>
            <a:r>
              <a:rPr lang="en-US" dirty="0"/>
              <a:t> relative mRNA levels</a:t>
            </a:r>
          </a:p>
        </p:txBody>
      </p:sp>
      <p:sp>
        <p:nvSpPr>
          <p:cNvPr id="12" name="Rectangle 11"/>
          <p:cNvSpPr/>
          <p:nvPr/>
        </p:nvSpPr>
        <p:spPr>
          <a:xfrm rot="16200000">
            <a:off x="2755812" y="1573192"/>
            <a:ext cx="204908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at </a:t>
            </a:r>
            <a:r>
              <a:rPr lang="en-US" i="1" dirty="0" err="1"/>
              <a:t>Bmal</a:t>
            </a:r>
            <a:r>
              <a:rPr lang="en-US" dirty="0"/>
              <a:t> relative mRNA levels</a:t>
            </a:r>
          </a:p>
        </p:txBody>
      </p:sp>
      <p:sp>
        <p:nvSpPr>
          <p:cNvPr id="8" name="Rectangle 7"/>
          <p:cNvSpPr/>
          <p:nvPr/>
        </p:nvSpPr>
        <p:spPr>
          <a:xfrm rot="16200000">
            <a:off x="-324997" y="1556467"/>
            <a:ext cx="205870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at </a:t>
            </a:r>
            <a:r>
              <a:rPr lang="en-US" i="1" dirty="0"/>
              <a:t>Clock</a:t>
            </a:r>
            <a:r>
              <a:rPr lang="en-US" dirty="0"/>
              <a:t> relative mRNA levels</a:t>
            </a:r>
          </a:p>
        </p:txBody>
      </p:sp>
      <p:sp>
        <p:nvSpPr>
          <p:cNvPr id="270" name="תיבת טקסט 491">
            <a:extLst>
              <a:ext uri="{FF2B5EF4-FFF2-40B4-BE49-F238E27FC236}">
                <a16:creationId xmlns:a16="http://schemas.microsoft.com/office/drawing/2014/main" id="{47389762-A129-E102-990C-EC1C691C09A3}"/>
              </a:ext>
            </a:extLst>
          </p:cNvPr>
          <p:cNvSpPr txBox="1"/>
          <p:nvPr/>
        </p:nvSpPr>
        <p:spPr>
          <a:xfrm>
            <a:off x="6870260" y="533484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0" y="-540588"/>
            <a:ext cx="3341043" cy="899646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1754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559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754" b="1" dirty="0"/>
              <a:t>Supplementary Fig. S9</a:t>
            </a:r>
            <a:endParaRPr lang="en-US" sz="1754" dirty="0"/>
          </a:p>
        </p:txBody>
      </p:sp>
      <p:sp>
        <p:nvSpPr>
          <p:cNvPr id="251" name="תיבת טקסט 489">
            <a:extLst>
              <a:ext uri="{FF2B5EF4-FFF2-40B4-BE49-F238E27FC236}">
                <a16:creationId xmlns:a16="http://schemas.microsoft.com/office/drawing/2014/main" id="{5E95261A-7113-8B35-1C16-56FFA9CC0336}"/>
              </a:ext>
            </a:extLst>
          </p:cNvPr>
          <p:cNvSpPr txBox="1"/>
          <p:nvPr/>
        </p:nvSpPr>
        <p:spPr>
          <a:xfrm>
            <a:off x="799715" y="540031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2" name="תיבת טקסט 490">
            <a:extLst>
              <a:ext uri="{FF2B5EF4-FFF2-40B4-BE49-F238E27FC236}">
                <a16:creationId xmlns:a16="http://schemas.microsoft.com/office/drawing/2014/main" id="{CCAC697B-8A27-0317-E8AF-064DF803C36A}"/>
              </a:ext>
            </a:extLst>
          </p:cNvPr>
          <p:cNvSpPr txBox="1"/>
          <p:nvPr/>
        </p:nvSpPr>
        <p:spPr>
          <a:xfrm>
            <a:off x="3864102" y="547001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9" name="תיבת טקסט 491">
            <a:extLst>
              <a:ext uri="{FF2B5EF4-FFF2-40B4-BE49-F238E27FC236}">
                <a16:creationId xmlns:a16="http://schemas.microsoft.com/office/drawing/2014/main" id="{47389762-A129-E102-990C-EC1C691C09A3}"/>
              </a:ext>
            </a:extLst>
          </p:cNvPr>
          <p:cNvSpPr txBox="1"/>
          <p:nvPr/>
        </p:nvSpPr>
        <p:spPr>
          <a:xfrm>
            <a:off x="6872760" y="3143071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>
                <a:latin typeface="Calibri" panose="020F0502020204030204" pitchFamily="34" charset="0"/>
                <a:cs typeface="Calibri" panose="020F0502020204030204" pitchFamily="34" charset="0"/>
              </a:rPr>
              <a:t>F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0" name="תיבת טקסט 489">
            <a:extLst>
              <a:ext uri="{FF2B5EF4-FFF2-40B4-BE49-F238E27FC236}">
                <a16:creationId xmlns:a16="http://schemas.microsoft.com/office/drawing/2014/main" id="{5E95261A-7113-8B35-1C16-56FFA9CC0336}"/>
              </a:ext>
            </a:extLst>
          </p:cNvPr>
          <p:cNvSpPr txBox="1"/>
          <p:nvPr/>
        </p:nvSpPr>
        <p:spPr>
          <a:xfrm>
            <a:off x="802215" y="3149618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1" name="תיבת טקסט 490">
            <a:extLst>
              <a:ext uri="{FF2B5EF4-FFF2-40B4-BE49-F238E27FC236}">
                <a16:creationId xmlns:a16="http://schemas.microsoft.com/office/drawing/2014/main" id="{CCAC697B-8A27-0317-E8AF-064DF803C36A}"/>
              </a:ext>
            </a:extLst>
          </p:cNvPr>
          <p:cNvSpPr txBox="1"/>
          <p:nvPr/>
        </p:nvSpPr>
        <p:spPr>
          <a:xfrm>
            <a:off x="3866602" y="3156588"/>
            <a:ext cx="376895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600" b="1">
                <a:latin typeface="Calibri" panose="020F0502020204030204" pitchFamily="34" charset="0"/>
                <a:cs typeface="Calibri" panose="020F0502020204030204" pitchFamily="34" charset="0"/>
              </a:rPr>
              <a:t>E</a:t>
            </a:r>
            <a:endParaRPr lang="he-IL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816264" y="2774065"/>
            <a:ext cx="2696694" cy="194217"/>
            <a:chOff x="649518" y="2723874"/>
            <a:chExt cx="2696694" cy="194217"/>
          </a:xfrm>
        </p:grpSpPr>
        <p:sp>
          <p:nvSpPr>
            <p:cNvPr id="51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2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3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4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5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6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7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8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9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0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1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2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3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4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5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7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02" name="Group 101"/>
          <p:cNvGrpSpPr/>
          <p:nvPr/>
        </p:nvGrpSpPr>
        <p:grpSpPr>
          <a:xfrm>
            <a:off x="3904722" y="2770052"/>
            <a:ext cx="2696694" cy="194217"/>
            <a:chOff x="649518" y="2723874"/>
            <a:chExt cx="2696694" cy="194217"/>
          </a:xfrm>
        </p:grpSpPr>
        <p:sp>
          <p:nvSpPr>
            <p:cNvPr id="117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8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9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0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1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2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3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4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5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6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7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8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9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0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1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2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34" name="Group 133"/>
          <p:cNvGrpSpPr/>
          <p:nvPr/>
        </p:nvGrpSpPr>
        <p:grpSpPr>
          <a:xfrm>
            <a:off x="6960865" y="2778068"/>
            <a:ext cx="2696694" cy="194217"/>
            <a:chOff x="649518" y="2723874"/>
            <a:chExt cx="2696694" cy="194217"/>
          </a:xfrm>
        </p:grpSpPr>
        <p:sp>
          <p:nvSpPr>
            <p:cNvPr id="135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6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7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8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9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0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1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2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3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4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5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6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7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8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9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0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52" name="Group 151"/>
          <p:cNvGrpSpPr/>
          <p:nvPr/>
        </p:nvGrpSpPr>
        <p:grpSpPr>
          <a:xfrm>
            <a:off x="812248" y="5417008"/>
            <a:ext cx="2696694" cy="194217"/>
            <a:chOff x="649518" y="2723874"/>
            <a:chExt cx="2696694" cy="194217"/>
          </a:xfrm>
        </p:grpSpPr>
        <p:sp>
          <p:nvSpPr>
            <p:cNvPr id="153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4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5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6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7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8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9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0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1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2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3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4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5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6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7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8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69" name="Group 168"/>
          <p:cNvGrpSpPr/>
          <p:nvPr/>
        </p:nvGrpSpPr>
        <p:grpSpPr>
          <a:xfrm>
            <a:off x="3900706" y="5412995"/>
            <a:ext cx="2696694" cy="194217"/>
            <a:chOff x="649518" y="2723874"/>
            <a:chExt cx="2696694" cy="194217"/>
          </a:xfrm>
        </p:grpSpPr>
        <p:sp>
          <p:nvSpPr>
            <p:cNvPr id="170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1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2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3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4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5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6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7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8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9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0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1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2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3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4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5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86" name="Group 185"/>
          <p:cNvGrpSpPr/>
          <p:nvPr/>
        </p:nvGrpSpPr>
        <p:grpSpPr>
          <a:xfrm>
            <a:off x="6956849" y="5421011"/>
            <a:ext cx="2696694" cy="194217"/>
            <a:chOff x="649518" y="2723874"/>
            <a:chExt cx="2696694" cy="194217"/>
          </a:xfrm>
        </p:grpSpPr>
        <p:sp>
          <p:nvSpPr>
            <p:cNvPr id="187" name="Line 140">
              <a:extLst>
                <a:ext uri="{FF2B5EF4-FFF2-40B4-BE49-F238E27FC236}">
                  <a16:creationId xmlns:a16="http://schemas.microsoft.com/office/drawing/2014/main" id="{7F57C8F1-4045-ED72-E66C-89980BEBEC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518" y="2833657"/>
              <a:ext cx="188913" cy="0"/>
            </a:xfrm>
            <a:prstGeom prst="line">
              <a:avLst/>
            </a:prstGeom>
            <a:noFill/>
            <a:ln w="1428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8" name="Oval 141">
              <a:extLst>
                <a:ext uri="{FF2B5EF4-FFF2-40B4-BE49-F238E27FC236}">
                  <a16:creationId xmlns:a16="http://schemas.microsoft.com/office/drawing/2014/main" id="{890F690C-5B8E-AFE9-F4D3-4EAB2BEEA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rgbClr val="156082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9" name="Oval 142">
              <a:extLst>
                <a:ext uri="{FF2B5EF4-FFF2-40B4-BE49-F238E27FC236}">
                  <a16:creationId xmlns:a16="http://schemas.microsoft.com/office/drawing/2014/main" id="{4F2713B3-B1FC-B901-F4AB-B24FC3008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368" y="2801542"/>
              <a:ext cx="49213" cy="62626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0" name="Rectangle 143">
              <a:extLst>
                <a:ext uri="{FF2B5EF4-FFF2-40B4-BE49-F238E27FC236}">
                  <a16:creationId xmlns:a16="http://schemas.microsoft.com/office/drawing/2014/main" id="{9AB17A7F-9937-53B5-3DD7-DD6A3875E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2630" y="2731227"/>
              <a:ext cx="3536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1" name="Line 144">
              <a:extLst>
                <a:ext uri="{FF2B5EF4-FFF2-40B4-BE49-F238E27FC236}">
                  <a16:creationId xmlns:a16="http://schemas.microsoft.com/office/drawing/2014/main" id="{4DF263A3-5A45-D232-893F-29FAC30DB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2005" y="2833660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2" name="Oval 145">
              <a:extLst>
                <a:ext uri="{FF2B5EF4-FFF2-40B4-BE49-F238E27FC236}">
                  <a16:creationId xmlns:a16="http://schemas.microsoft.com/office/drawing/2014/main" id="{64D86298-EC14-7A61-B206-57868F784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0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3" name="Oval 146">
              <a:extLst>
                <a:ext uri="{FF2B5EF4-FFF2-40B4-BE49-F238E27FC236}">
                  <a16:creationId xmlns:a16="http://schemas.microsoft.com/office/drawing/2014/main" id="{C6177441-8846-8DCB-A237-F68E6420D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68" y="2801545"/>
              <a:ext cx="49213" cy="62626"/>
            </a:xfrm>
            <a:prstGeom prst="ellipse">
              <a:avLst/>
            </a:prstGeom>
            <a:solidFill>
              <a:srgbClr val="00CC00"/>
            </a:solidFill>
            <a:ln w="6350" cap="flat">
              <a:solidFill>
                <a:srgbClr val="00CC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4" name="Rectangle 147">
              <a:extLst>
                <a:ext uri="{FF2B5EF4-FFF2-40B4-BE49-F238E27FC236}">
                  <a16:creationId xmlns:a16="http://schemas.microsoft.com/office/drawing/2014/main" id="{81DD9252-A365-1E6E-02E6-060847008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" y="2723874"/>
              <a:ext cx="693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 err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how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5" name="Line 148">
              <a:extLst>
                <a:ext uri="{FF2B5EF4-FFF2-40B4-BE49-F238E27FC236}">
                  <a16:creationId xmlns:a16="http://schemas.microsoft.com/office/drawing/2014/main" id="{D3A87C56-F1F3-0E14-0B35-73BE62AF4A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207" y="2833657"/>
              <a:ext cx="187325" cy="0"/>
            </a:xfrm>
            <a:prstGeom prst="line">
              <a:avLst/>
            </a:prstGeom>
            <a:noFill/>
            <a:ln w="1428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6" name="Oval 149">
              <a:extLst>
                <a:ext uri="{FF2B5EF4-FFF2-40B4-BE49-F238E27FC236}">
                  <a16:creationId xmlns:a16="http://schemas.microsoft.com/office/drawing/2014/main" id="{137DE0AD-1BC8-5A3C-2D3F-987CB60FA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7" name="Oval 150">
              <a:extLst>
                <a:ext uri="{FF2B5EF4-FFF2-40B4-BE49-F238E27FC236}">
                  <a16:creationId xmlns:a16="http://schemas.microsoft.com/office/drawing/2014/main" id="{9E157479-3D5D-9942-38CD-6C1E828ED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469" y="2801542"/>
              <a:ext cx="49213" cy="62626"/>
            </a:xfrm>
            <a:prstGeom prst="ellipse">
              <a:avLst/>
            </a:prstGeom>
            <a:solidFill>
              <a:srgbClr val="FF0000"/>
            </a:solidFill>
            <a:ln w="6350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8" name="Rectangle 151">
              <a:extLst>
                <a:ext uri="{FF2B5EF4-FFF2-40B4-BE49-F238E27FC236}">
                  <a16:creationId xmlns:a16="http://schemas.microsoft.com/office/drawing/2014/main" id="{F6CE4073-42A1-05AD-3017-842FD8425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085" y="2729621"/>
              <a:ext cx="1667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9" name="Line 152">
              <a:extLst>
                <a:ext uri="{FF2B5EF4-FFF2-40B4-BE49-F238E27FC236}">
                  <a16:creationId xmlns:a16="http://schemas.microsoft.com/office/drawing/2014/main" id="{AC6C45A6-05CA-4DAB-9291-35FBE0E32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774" y="2833661"/>
              <a:ext cx="187325" cy="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0" name="Oval 153">
              <a:extLst>
                <a:ext uri="{FF2B5EF4-FFF2-40B4-BE49-F238E27FC236}">
                  <a16:creationId xmlns:a16="http://schemas.microsoft.com/office/drawing/2014/main" id="{6AFAB87E-B64F-333B-2684-3EBCE901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1" name="Oval 154">
              <a:extLst>
                <a:ext uri="{FF2B5EF4-FFF2-40B4-BE49-F238E27FC236}">
                  <a16:creationId xmlns:a16="http://schemas.microsoft.com/office/drawing/2014/main" id="{B35FDBEB-DBFA-C87D-C68D-4F5262A37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037" y="2801546"/>
              <a:ext cx="49213" cy="62626"/>
            </a:xfrm>
            <a:prstGeom prst="ellipse">
              <a:avLst/>
            </a:prstGeom>
            <a:solidFill>
              <a:srgbClr val="0000FF"/>
            </a:solidFill>
            <a:ln w="6350" cap="flat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 sz="12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2" name="Rectangle 155">
              <a:extLst>
                <a:ext uri="{FF2B5EF4-FFF2-40B4-BE49-F238E27FC236}">
                  <a16:creationId xmlns:a16="http://schemas.microsoft.com/office/drawing/2014/main" id="{2AE82A69-2BF1-8DF5-50AB-8EDD8C3FC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9663" y="2733425"/>
              <a:ext cx="50654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he-IL" sz="1200" dirty="0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F+BHB</a:t>
              </a:r>
              <a:endParaRPr kumimoji="0" lang="he-IL" altLang="he-IL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22" name="Rectangle 21"/>
          <p:cNvSpPr/>
          <p:nvPr/>
        </p:nvSpPr>
        <p:spPr>
          <a:xfrm rot="16200000">
            <a:off x="2773327" y="4235550"/>
            <a:ext cx="20363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at</a:t>
            </a:r>
            <a:r>
              <a:rPr lang="he-IL" dirty="0"/>
              <a:t> </a:t>
            </a:r>
            <a:r>
              <a:rPr lang="en-US" i="1" dirty="0" err="1"/>
              <a:t>Ror</a:t>
            </a:r>
            <a:r>
              <a:rPr lang="el-GR" i="1" dirty="0"/>
              <a:t>α</a:t>
            </a:r>
            <a:r>
              <a:rPr lang="en-US" i="1" dirty="0"/>
              <a:t> </a:t>
            </a:r>
            <a:r>
              <a:rPr lang="en-US" dirty="0"/>
              <a:t>relative mRNA levels</a:t>
            </a:r>
          </a:p>
        </p:txBody>
      </p:sp>
      <p:sp>
        <p:nvSpPr>
          <p:cNvPr id="24" name="Rectangle 23"/>
          <p:cNvSpPr/>
          <p:nvPr/>
        </p:nvSpPr>
        <p:spPr>
          <a:xfrm rot="16200000">
            <a:off x="5767639" y="4161011"/>
            <a:ext cx="21656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at</a:t>
            </a:r>
            <a:r>
              <a:rPr lang="he-IL" dirty="0"/>
              <a:t> </a:t>
            </a:r>
            <a:r>
              <a:rPr lang="en-US" i="1" dirty="0"/>
              <a:t>Reverb</a:t>
            </a:r>
            <a:r>
              <a:rPr lang="en-US" dirty="0"/>
              <a:t> relative mRNA levels</a:t>
            </a:r>
          </a:p>
        </p:txBody>
      </p:sp>
      <p:sp>
        <p:nvSpPr>
          <p:cNvPr id="133" name="Rectangle 132"/>
          <p:cNvSpPr/>
          <p:nvPr/>
        </p:nvSpPr>
        <p:spPr>
          <a:xfrm>
            <a:off x="296474" y="6837907"/>
            <a:ext cx="9557208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: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ffect of BHB on the circadian clock oscillation in adipose tissue. A.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ock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. B.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al1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. C.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y1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. D.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1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. E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r</a:t>
            </a:r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. F.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v-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b</a:t>
            </a:r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.</a:t>
            </a:r>
          </a:p>
        </p:txBody>
      </p:sp>
    </p:spTree>
    <p:extLst>
      <p:ext uri="{BB962C8B-B14F-4D97-AF65-F5344CB8AC3E}">
        <p14:creationId xmlns:p14="http://schemas.microsoft.com/office/powerpoint/2010/main" val="3913110026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27</TotalTime>
  <Words>992</Words>
  <Application>Microsoft Office PowerPoint</Application>
  <PresentationFormat>Custom</PresentationFormat>
  <Paragraphs>460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ptos</vt:lpstr>
      <vt:lpstr>Arial</vt:lpstr>
      <vt:lpstr>Calibri</vt:lpstr>
      <vt:lpstr>Calibri Light</vt:lpstr>
      <vt:lpstr>Times New Roman</vt:lpstr>
      <vt:lpstr>ערכת נושא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‏</dc:title>
  <dc:creator>froy</dc:creator>
  <cp:lastModifiedBy>MDPI</cp:lastModifiedBy>
  <cp:revision>232</cp:revision>
  <cp:lastPrinted>2026-01-19T06:52:38Z</cp:lastPrinted>
  <dcterms:created xsi:type="dcterms:W3CDTF">2026-01-18T09:43:04Z</dcterms:created>
  <dcterms:modified xsi:type="dcterms:W3CDTF">2026-04-09T09:50:26Z</dcterms:modified>
</cp:coreProperties>
</file>